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2" r:id="rId2"/>
  </p:sldIdLst>
  <p:sldSz cx="9906000" cy="6858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25AE8EA-5AC7-40EE-96BD-B159042F3CB2}" v="2" dt="2023-01-31T03:32:59.8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6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528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濵田　大治" userId="3dc346c6-a235-4d96-b756-7f3e038a9511" providerId="ADAL" clId="{98A46F7B-C125-401F-A531-9A38C3203D8D}"/>
    <pc:docChg chg="undo custSel addSld delSld modSld">
      <pc:chgData name="濵田　大治" userId="3dc346c6-a235-4d96-b756-7f3e038a9511" providerId="ADAL" clId="{98A46F7B-C125-401F-A531-9A38C3203D8D}" dt="2022-10-05T03:57:40.762" v="3594" actId="1076"/>
      <pc:docMkLst>
        <pc:docMk/>
      </pc:docMkLst>
      <pc:sldChg chg="modSp mod">
        <pc:chgData name="濵田　大治" userId="3dc346c6-a235-4d96-b756-7f3e038a9511" providerId="ADAL" clId="{98A46F7B-C125-401F-A531-9A38C3203D8D}" dt="2022-10-05T03:57:07.946" v="3571" actId="13926"/>
        <pc:sldMkLst>
          <pc:docMk/>
          <pc:sldMk cId="1355024604" sldId="280"/>
        </pc:sldMkLst>
        <pc:spChg chg="mod">
          <ac:chgData name="濵田　大治" userId="3dc346c6-a235-4d96-b756-7f3e038a9511" providerId="ADAL" clId="{98A46F7B-C125-401F-A531-9A38C3203D8D}" dt="2022-10-05T03:57:07.946" v="3571" actId="13926"/>
          <ac:spMkLst>
            <pc:docMk/>
            <pc:sldMk cId="1355024604" sldId="280"/>
            <ac:spMk id="3" creationId="{0174EA08-22EA-4444-9B6A-4AA766E76114}"/>
          </ac:spMkLst>
        </pc:spChg>
      </pc:sldChg>
      <pc:sldChg chg="addSp delSp modSp mod">
        <pc:chgData name="濵田　大治" userId="3dc346c6-a235-4d96-b756-7f3e038a9511" providerId="ADAL" clId="{98A46F7B-C125-401F-A531-9A38C3203D8D}" dt="2022-09-12T07:49:00.435" v="2150" actId="692"/>
        <pc:sldMkLst>
          <pc:docMk/>
          <pc:sldMk cId="336970124" sldId="282"/>
        </pc:sldMkLst>
        <pc:spChg chg="del mod">
          <ac:chgData name="濵田　大治" userId="3dc346c6-a235-4d96-b756-7f3e038a9511" providerId="ADAL" clId="{98A46F7B-C125-401F-A531-9A38C3203D8D}" dt="2022-08-25T05:31:16.984" v="141" actId="478"/>
          <ac:spMkLst>
            <pc:docMk/>
            <pc:sldMk cId="336970124" sldId="282"/>
            <ac:spMk id="5" creationId="{066069BF-4783-6006-6E2C-96A8F816859B}"/>
          </ac:spMkLst>
        </pc:spChg>
        <pc:spChg chg="del mod">
          <ac:chgData name="濵田　大治" userId="3dc346c6-a235-4d96-b756-7f3e038a9511" providerId="ADAL" clId="{98A46F7B-C125-401F-A531-9A38C3203D8D}" dt="2022-08-25T05:31:16.984" v="141" actId="478"/>
          <ac:spMkLst>
            <pc:docMk/>
            <pc:sldMk cId="336970124" sldId="282"/>
            <ac:spMk id="39" creationId="{FE5AE488-CCE9-0895-B0B0-D6ED3EF510B5}"/>
          </ac:spMkLst>
        </pc:spChg>
        <pc:spChg chg="add mod">
          <ac:chgData name="濵田　大治" userId="3dc346c6-a235-4d96-b756-7f3e038a9511" providerId="ADAL" clId="{98A46F7B-C125-401F-A531-9A38C3203D8D}" dt="2022-08-25T05:33:10.926" v="159" actId="1076"/>
          <ac:spMkLst>
            <pc:docMk/>
            <pc:sldMk cId="336970124" sldId="282"/>
            <ac:spMk id="42" creationId="{1FD365AE-E326-FC1F-D37E-99C0927A9F6E}"/>
          </ac:spMkLst>
        </pc:spChg>
        <pc:graphicFrameChg chg="add mod">
          <ac:chgData name="濵田　大治" userId="3dc346c6-a235-4d96-b756-7f3e038a9511" providerId="ADAL" clId="{98A46F7B-C125-401F-A531-9A38C3203D8D}" dt="2022-09-12T07:49:00.435" v="2150" actId="692"/>
          <ac:graphicFrameMkLst>
            <pc:docMk/>
            <pc:sldMk cId="336970124" sldId="282"/>
            <ac:graphicFrameMk id="17" creationId="{383456AE-453C-B84E-F0B6-9451AEE8B287}"/>
          </ac:graphicFrameMkLst>
        </pc:graphicFrameChg>
        <pc:picChg chg="del mod">
          <ac:chgData name="濵田　大治" userId="3dc346c6-a235-4d96-b756-7f3e038a9511" providerId="ADAL" clId="{98A46F7B-C125-401F-A531-9A38C3203D8D}" dt="2022-08-25T05:31:16.984" v="141" actId="478"/>
          <ac:picMkLst>
            <pc:docMk/>
            <pc:sldMk cId="336970124" sldId="282"/>
            <ac:picMk id="3" creationId="{4CBC79F5-F322-98B5-96DA-4A4A03512A83}"/>
          </ac:picMkLst>
        </pc:picChg>
        <pc:cxnChg chg="add mod">
          <ac:chgData name="濵田　大治" userId="3dc346c6-a235-4d96-b756-7f3e038a9511" providerId="ADAL" clId="{98A46F7B-C125-401F-A531-9A38C3203D8D}" dt="2022-08-25T05:33:02.017" v="158" actId="1076"/>
          <ac:cxnSpMkLst>
            <pc:docMk/>
            <pc:sldMk cId="336970124" sldId="282"/>
            <ac:cxnSpMk id="41" creationId="{F1A5836D-2E48-1DF9-30B6-565914C2629B}"/>
          </ac:cxnSpMkLst>
        </pc:cxnChg>
      </pc:sldChg>
      <pc:sldChg chg="addSp delSp modSp mod">
        <pc:chgData name="濵田　大治" userId="3dc346c6-a235-4d96-b756-7f3e038a9511" providerId="ADAL" clId="{98A46F7B-C125-401F-A531-9A38C3203D8D}" dt="2022-09-22T08:22:46.962" v="2941" actId="207"/>
        <pc:sldMkLst>
          <pc:docMk/>
          <pc:sldMk cId="2979523262" sldId="283"/>
        </pc:sldMkLst>
        <pc:spChg chg="mod">
          <ac:chgData name="濵田　大治" userId="3dc346c6-a235-4d96-b756-7f3e038a9511" providerId="ADAL" clId="{98A46F7B-C125-401F-A531-9A38C3203D8D}" dt="2022-09-12T08:15:40.093" v="2473" actId="1076"/>
          <ac:spMkLst>
            <pc:docMk/>
            <pc:sldMk cId="2979523262" sldId="283"/>
            <ac:spMk id="3" creationId="{F54AA5BE-82FE-CEF2-1D8E-A3024C0FCD36}"/>
          </ac:spMkLst>
        </pc:spChg>
        <pc:spChg chg="mod">
          <ac:chgData name="濵田　大治" userId="3dc346c6-a235-4d96-b756-7f3e038a9511" providerId="ADAL" clId="{98A46F7B-C125-401F-A531-9A38C3203D8D}" dt="2022-09-12T08:15:40.093" v="2473" actId="1076"/>
          <ac:spMkLst>
            <pc:docMk/>
            <pc:sldMk cId="2979523262" sldId="283"/>
            <ac:spMk id="4" creationId="{1D03B53E-8927-92C6-C562-A594A38339E7}"/>
          </ac:spMkLst>
        </pc:spChg>
        <pc:spChg chg="mod">
          <ac:chgData name="濵田　大治" userId="3dc346c6-a235-4d96-b756-7f3e038a9511" providerId="ADAL" clId="{98A46F7B-C125-401F-A531-9A38C3203D8D}" dt="2022-09-12T08:15:40.093" v="2473" actId="1076"/>
          <ac:spMkLst>
            <pc:docMk/>
            <pc:sldMk cId="2979523262" sldId="283"/>
            <ac:spMk id="5" creationId="{C41C7BB5-5101-6D2B-0059-63FE5AA99FE1}"/>
          </ac:spMkLst>
        </pc:spChg>
        <pc:spChg chg="mod">
          <ac:chgData name="濵田　大治" userId="3dc346c6-a235-4d96-b756-7f3e038a9511" providerId="ADAL" clId="{98A46F7B-C125-401F-A531-9A38C3203D8D}" dt="2022-09-12T08:15:40.093" v="2473" actId="1076"/>
          <ac:spMkLst>
            <pc:docMk/>
            <pc:sldMk cId="2979523262" sldId="283"/>
            <ac:spMk id="6" creationId="{389CD000-C20D-531A-EF94-F217FB5D100C}"/>
          </ac:spMkLst>
        </pc:spChg>
        <pc:spChg chg="mod">
          <ac:chgData name="濵田　大治" userId="3dc346c6-a235-4d96-b756-7f3e038a9511" providerId="ADAL" clId="{98A46F7B-C125-401F-A531-9A38C3203D8D}" dt="2022-09-12T08:23:26.064" v="2540" actId="1076"/>
          <ac:spMkLst>
            <pc:docMk/>
            <pc:sldMk cId="2979523262" sldId="283"/>
            <ac:spMk id="15" creationId="{7DC91D0D-5389-DA85-8BBB-A709729C9F94}"/>
          </ac:spMkLst>
        </pc:spChg>
        <pc:spChg chg="mod">
          <ac:chgData name="濵田　大治" userId="3dc346c6-a235-4d96-b756-7f3e038a9511" providerId="ADAL" clId="{98A46F7B-C125-401F-A531-9A38C3203D8D}" dt="2022-09-12T08:23:26.064" v="2540" actId="1076"/>
          <ac:spMkLst>
            <pc:docMk/>
            <pc:sldMk cId="2979523262" sldId="283"/>
            <ac:spMk id="16" creationId="{AB79E4AD-CAA1-C5B7-38B2-BF49441E4418}"/>
          </ac:spMkLst>
        </pc:spChg>
        <pc:spChg chg="add mod">
          <ac:chgData name="濵田　大治" userId="3dc346c6-a235-4d96-b756-7f3e038a9511" providerId="ADAL" clId="{98A46F7B-C125-401F-A531-9A38C3203D8D}" dt="2022-09-12T08:15:40.093" v="2473" actId="1076"/>
          <ac:spMkLst>
            <pc:docMk/>
            <pc:sldMk cId="2979523262" sldId="283"/>
            <ac:spMk id="21" creationId="{49C6D6AF-609D-65AB-BA6B-A915B4D4A57A}"/>
          </ac:spMkLst>
        </pc:spChg>
        <pc:spChg chg="add mod">
          <ac:chgData name="濵田　大治" userId="3dc346c6-a235-4d96-b756-7f3e038a9511" providerId="ADAL" clId="{98A46F7B-C125-401F-A531-9A38C3203D8D}" dt="2022-09-12T08:15:40.093" v="2473" actId="1076"/>
          <ac:spMkLst>
            <pc:docMk/>
            <pc:sldMk cId="2979523262" sldId="283"/>
            <ac:spMk id="26" creationId="{56E4051E-BBBF-E0E9-97F8-D64775D5751C}"/>
          </ac:spMkLst>
        </pc:spChg>
        <pc:spChg chg="add mod">
          <ac:chgData name="濵田　大治" userId="3dc346c6-a235-4d96-b756-7f3e038a9511" providerId="ADAL" clId="{98A46F7B-C125-401F-A531-9A38C3203D8D}" dt="2022-09-12T08:15:40.093" v="2473" actId="1076"/>
          <ac:spMkLst>
            <pc:docMk/>
            <pc:sldMk cId="2979523262" sldId="283"/>
            <ac:spMk id="30" creationId="{A51F2D3B-0521-B334-3F55-8ACB9504327F}"/>
          </ac:spMkLst>
        </pc:spChg>
        <pc:spChg chg="add mod">
          <ac:chgData name="濵田　大治" userId="3dc346c6-a235-4d96-b756-7f3e038a9511" providerId="ADAL" clId="{98A46F7B-C125-401F-A531-9A38C3203D8D}" dt="2022-09-12T08:15:40.093" v="2473" actId="1076"/>
          <ac:spMkLst>
            <pc:docMk/>
            <pc:sldMk cId="2979523262" sldId="283"/>
            <ac:spMk id="34" creationId="{D0F80462-5007-A434-EF66-8C7EED3D7478}"/>
          </ac:spMkLst>
        </pc:spChg>
        <pc:spChg chg="add mod">
          <ac:chgData name="濵田　大治" userId="3dc346c6-a235-4d96-b756-7f3e038a9511" providerId="ADAL" clId="{98A46F7B-C125-401F-A531-9A38C3203D8D}" dt="2022-09-12T08:22:01.181" v="2530" actId="1076"/>
          <ac:spMkLst>
            <pc:docMk/>
            <pc:sldMk cId="2979523262" sldId="283"/>
            <ac:spMk id="41" creationId="{2C2A5213-9315-4C4F-4CCF-C7419D75B7B5}"/>
          </ac:spMkLst>
        </pc:spChg>
        <pc:spChg chg="add mod">
          <ac:chgData name="濵田　大治" userId="3dc346c6-a235-4d96-b756-7f3e038a9511" providerId="ADAL" clId="{98A46F7B-C125-401F-A531-9A38C3203D8D}" dt="2022-09-12T08:22:01.181" v="2530" actId="1076"/>
          <ac:spMkLst>
            <pc:docMk/>
            <pc:sldMk cId="2979523262" sldId="283"/>
            <ac:spMk id="46" creationId="{D3C8B5C7-FC77-B74C-FC03-9D98BE55B928}"/>
          </ac:spMkLst>
        </pc:spChg>
        <pc:spChg chg="add mod">
          <ac:chgData name="濵田　大治" userId="3dc346c6-a235-4d96-b756-7f3e038a9511" providerId="ADAL" clId="{98A46F7B-C125-401F-A531-9A38C3203D8D}" dt="2022-09-12T08:22:01.181" v="2530" actId="1076"/>
          <ac:spMkLst>
            <pc:docMk/>
            <pc:sldMk cId="2979523262" sldId="283"/>
            <ac:spMk id="51" creationId="{A8D3C386-DAB6-0975-ED9D-5B61DAD9DBEA}"/>
          </ac:spMkLst>
        </pc:spChg>
        <pc:spChg chg="add mod">
          <ac:chgData name="濵田　大治" userId="3dc346c6-a235-4d96-b756-7f3e038a9511" providerId="ADAL" clId="{98A46F7B-C125-401F-A531-9A38C3203D8D}" dt="2022-09-12T08:23:26.064" v="2540" actId="1076"/>
          <ac:spMkLst>
            <pc:docMk/>
            <pc:sldMk cId="2979523262" sldId="283"/>
            <ac:spMk id="57" creationId="{C9C1230E-54F1-0BA9-9E8E-4EEDD6B29BFA}"/>
          </ac:spMkLst>
        </pc:spChg>
        <pc:spChg chg="add mod">
          <ac:chgData name="濵田　大治" userId="3dc346c6-a235-4d96-b756-7f3e038a9511" providerId="ADAL" clId="{98A46F7B-C125-401F-A531-9A38C3203D8D}" dt="2022-09-12T08:23:26.064" v="2540" actId="1076"/>
          <ac:spMkLst>
            <pc:docMk/>
            <pc:sldMk cId="2979523262" sldId="283"/>
            <ac:spMk id="63" creationId="{C8F39AD3-2190-A6F9-1DC6-6A4EB75C56CC}"/>
          </ac:spMkLst>
        </pc:spChg>
        <pc:spChg chg="add mod">
          <ac:chgData name="濵田　大治" userId="3dc346c6-a235-4d96-b756-7f3e038a9511" providerId="ADAL" clId="{98A46F7B-C125-401F-A531-9A38C3203D8D}" dt="2022-09-12T08:23:26.064" v="2540" actId="1076"/>
          <ac:spMkLst>
            <pc:docMk/>
            <pc:sldMk cId="2979523262" sldId="283"/>
            <ac:spMk id="64" creationId="{3FCBC1D3-626B-8F80-4574-A840F86AE9D3}"/>
          </ac:spMkLst>
        </pc:spChg>
        <pc:spChg chg="add mod">
          <ac:chgData name="濵田　大治" userId="3dc346c6-a235-4d96-b756-7f3e038a9511" providerId="ADAL" clId="{98A46F7B-C125-401F-A531-9A38C3203D8D}" dt="2022-09-12T08:23:53.476" v="2542" actId="1076"/>
          <ac:spMkLst>
            <pc:docMk/>
            <pc:sldMk cId="2979523262" sldId="283"/>
            <ac:spMk id="65" creationId="{FD5F6C71-6328-22F7-B5D7-250CAD03F027}"/>
          </ac:spMkLst>
        </pc:spChg>
        <pc:spChg chg="add mod">
          <ac:chgData name="濵田　大治" userId="3dc346c6-a235-4d96-b756-7f3e038a9511" providerId="ADAL" clId="{98A46F7B-C125-401F-A531-9A38C3203D8D}" dt="2022-09-12T08:23:53.476" v="2542" actId="1076"/>
          <ac:spMkLst>
            <pc:docMk/>
            <pc:sldMk cId="2979523262" sldId="283"/>
            <ac:spMk id="66" creationId="{7AEA117F-15B2-D7DE-3E93-845CEC96E279}"/>
          </ac:spMkLst>
        </pc:spChg>
        <pc:graphicFrameChg chg="add del mod">
          <ac:chgData name="濵田　大治" userId="3dc346c6-a235-4d96-b756-7f3e038a9511" providerId="ADAL" clId="{98A46F7B-C125-401F-A531-9A38C3203D8D}" dt="2022-09-12T07:26:07.446" v="1562" actId="478"/>
          <ac:graphicFrameMkLst>
            <pc:docMk/>
            <pc:sldMk cId="2979523262" sldId="283"/>
            <ac:graphicFrameMk id="7" creationId="{AAFCFFEB-261B-5D0D-187C-8A90F56A4EAA}"/>
          </ac:graphicFrameMkLst>
        </pc:graphicFrameChg>
        <pc:graphicFrameChg chg="add mod">
          <ac:chgData name="濵田　大治" userId="3dc346c6-a235-4d96-b756-7f3e038a9511" providerId="ADAL" clId="{98A46F7B-C125-401F-A531-9A38C3203D8D}" dt="2022-09-22T08:22:24.886" v="2933" actId="113"/>
          <ac:graphicFrameMkLst>
            <pc:docMk/>
            <pc:sldMk cId="2979523262" sldId="283"/>
            <ac:graphicFrameMk id="10" creationId="{C97CEF97-3003-775C-91A1-110355FFC37B}"/>
          </ac:graphicFrameMkLst>
        </pc:graphicFrameChg>
        <pc:graphicFrameChg chg="add mod">
          <ac:chgData name="濵田　大治" userId="3dc346c6-a235-4d96-b756-7f3e038a9511" providerId="ADAL" clId="{98A46F7B-C125-401F-A531-9A38C3203D8D}" dt="2022-09-22T08:22:30.868" v="2935" actId="207"/>
          <ac:graphicFrameMkLst>
            <pc:docMk/>
            <pc:sldMk cId="2979523262" sldId="283"/>
            <ac:graphicFrameMk id="35" creationId="{5CA2CAD2-BB5D-EC0F-584B-BCC4E828B857}"/>
          </ac:graphicFrameMkLst>
        </pc:graphicFrameChg>
        <pc:graphicFrameChg chg="add del mod">
          <ac:chgData name="濵田　大治" userId="3dc346c6-a235-4d96-b756-7f3e038a9511" providerId="ADAL" clId="{98A46F7B-C125-401F-A531-9A38C3203D8D}" dt="2022-09-12T08:07:50.970" v="2273" actId="478"/>
          <ac:graphicFrameMkLst>
            <pc:docMk/>
            <pc:sldMk cId="2979523262" sldId="283"/>
            <ac:graphicFrameMk id="36" creationId="{BF363468-E4A6-AEE8-801E-6CDE33539E3B}"/>
          </ac:graphicFrameMkLst>
        </pc:graphicFrameChg>
        <pc:graphicFrameChg chg="add mod">
          <ac:chgData name="濵田　大治" userId="3dc346c6-a235-4d96-b756-7f3e038a9511" providerId="ADAL" clId="{98A46F7B-C125-401F-A531-9A38C3203D8D}" dt="2022-09-22T08:22:41.629" v="2939" actId="207"/>
          <ac:graphicFrameMkLst>
            <pc:docMk/>
            <pc:sldMk cId="2979523262" sldId="283"/>
            <ac:graphicFrameMk id="42" creationId="{F590B0C4-DDDE-6EDF-B05C-8E0FCFD37CDC}"/>
          </ac:graphicFrameMkLst>
        </pc:graphicFrameChg>
        <pc:graphicFrameChg chg="add mod">
          <ac:chgData name="濵田　大治" userId="3dc346c6-a235-4d96-b756-7f3e038a9511" providerId="ADAL" clId="{98A46F7B-C125-401F-A531-9A38C3203D8D}" dt="2022-09-22T08:22:35.994" v="2937" actId="207"/>
          <ac:graphicFrameMkLst>
            <pc:docMk/>
            <pc:sldMk cId="2979523262" sldId="283"/>
            <ac:graphicFrameMk id="52" creationId="{F42C1C88-8CB1-0783-C0B1-04432C453024}"/>
          </ac:graphicFrameMkLst>
        </pc:graphicFrameChg>
        <pc:graphicFrameChg chg="add mod">
          <ac:chgData name="濵田　大治" userId="3dc346c6-a235-4d96-b756-7f3e038a9511" providerId="ADAL" clId="{98A46F7B-C125-401F-A531-9A38C3203D8D}" dt="2022-09-22T08:22:46.962" v="2941" actId="207"/>
          <ac:graphicFrameMkLst>
            <pc:docMk/>
            <pc:sldMk cId="2979523262" sldId="283"/>
            <ac:graphicFrameMk id="58" creationId="{AB06D072-A4AE-D21A-5D52-546D0F447422}"/>
          </ac:graphicFrameMkLst>
        </pc:graphicFrameChg>
        <pc:picChg chg="del mod">
          <ac:chgData name="濵田　大治" userId="3dc346c6-a235-4d96-b756-7f3e038a9511" providerId="ADAL" clId="{98A46F7B-C125-401F-A531-9A38C3203D8D}" dt="2022-09-12T07:49:26.944" v="2152" actId="478"/>
          <ac:picMkLst>
            <pc:docMk/>
            <pc:sldMk cId="2979523262" sldId="283"/>
            <ac:picMk id="2" creationId="{E9A2D59D-E6DB-5BBB-B920-915A1AFCD21E}"/>
          </ac:picMkLst>
        </pc:picChg>
        <pc:picChg chg="del mod">
          <ac:chgData name="濵田　大治" userId="3dc346c6-a235-4d96-b756-7f3e038a9511" providerId="ADAL" clId="{98A46F7B-C125-401F-A531-9A38C3203D8D}" dt="2022-09-12T08:06:59.516" v="2242" actId="478"/>
          <ac:picMkLst>
            <pc:docMk/>
            <pc:sldMk cId="2979523262" sldId="283"/>
            <ac:picMk id="11" creationId="{686DA49E-1FEB-9167-1DFF-D9E48B3CDDE1}"/>
          </ac:picMkLst>
        </pc:picChg>
        <pc:picChg chg="del mod">
          <ac:chgData name="濵田　大治" userId="3dc346c6-a235-4d96-b756-7f3e038a9511" providerId="ADAL" clId="{98A46F7B-C125-401F-A531-9A38C3203D8D}" dt="2022-09-12T08:15:17.007" v="2471" actId="478"/>
          <ac:picMkLst>
            <pc:docMk/>
            <pc:sldMk cId="2979523262" sldId="283"/>
            <ac:picMk id="13" creationId="{5F1C6DFD-9149-1898-AE6F-EA3524D8C82E}"/>
          </ac:picMkLst>
        </pc:picChg>
        <pc:picChg chg="del mod">
          <ac:chgData name="濵田　大治" userId="3dc346c6-a235-4d96-b756-7f3e038a9511" providerId="ADAL" clId="{98A46F7B-C125-401F-A531-9A38C3203D8D}" dt="2022-09-12T08:18:35.327" v="2500" actId="478"/>
          <ac:picMkLst>
            <pc:docMk/>
            <pc:sldMk cId="2979523262" sldId="283"/>
            <ac:picMk id="14" creationId="{8DC74140-25FB-487B-D9CE-2DB3DE3E8F86}"/>
          </ac:picMkLst>
        </pc:picChg>
        <pc:cxnChg chg="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8" creationId="{2EC2CF49-F050-BEA4-6B10-ED5568EAFB07}"/>
          </ac:cxnSpMkLst>
        </pc:cxnChg>
        <pc:cxnChg chg="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9" creationId="{AE9FE443-7EBF-8D67-D0F3-69CC3A4A0B7B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17" creationId="{01B76D7A-FFCC-0CB0-834D-AA530D99F1B8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18" creationId="{BDA38934-C0E0-D8B8-65F0-CB3CC7F3228C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20" creationId="{F458C1C5-4287-6445-3792-C3F2367F8993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22" creationId="{A86E6CA3-D7E7-5FBE-A1F5-F563576F390C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23" creationId="{EECDDD4D-76BE-4D47-3A5C-A44C4277330F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24" creationId="{51D6C3B3-1AA8-1884-A316-F7D04853D89A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25" creationId="{D7EBD22D-58FD-59D4-956C-3CE702868831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27" creationId="{58B63A0E-50A8-9E66-CCD9-1E35392D5826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28" creationId="{CA2457F5-4AD9-F50D-765E-002DD61C4832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29" creationId="{B9DE831C-39A5-5EB4-EC5E-FDB6B67B1222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31" creationId="{CAF364F9-BC65-54FE-3C0B-80AD4F55C381}"/>
          </ac:cxnSpMkLst>
        </pc:cxnChg>
        <pc:cxnChg chg="add mod">
          <ac:chgData name="濵田　大治" userId="3dc346c6-a235-4d96-b756-7f3e038a9511" providerId="ADAL" clId="{98A46F7B-C125-401F-A531-9A38C3203D8D}" dt="2022-09-12T08:21:36.434" v="2527" actId="1076"/>
          <ac:cxnSpMkLst>
            <pc:docMk/>
            <pc:sldMk cId="2979523262" sldId="283"/>
            <ac:cxnSpMk id="32" creationId="{BC95FE01-DAF4-C713-BA78-D45E35637D3A}"/>
          </ac:cxnSpMkLst>
        </pc:cxnChg>
        <pc:cxnChg chg="add mod">
          <ac:chgData name="濵田　大治" userId="3dc346c6-a235-4d96-b756-7f3e038a9511" providerId="ADAL" clId="{98A46F7B-C125-401F-A531-9A38C3203D8D}" dt="2022-09-12T08:15:40.093" v="2473" actId="1076"/>
          <ac:cxnSpMkLst>
            <pc:docMk/>
            <pc:sldMk cId="2979523262" sldId="283"/>
            <ac:cxnSpMk id="33" creationId="{9EB516DC-AA4A-1DAF-D3FB-A35C4D12F65E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37" creationId="{E6BFF4CD-213B-93C8-EBDC-6A50F3EA2795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38" creationId="{02FBF5B9-E6BA-0331-D5B0-068AEE7804F9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39" creationId="{C9B68817-09AD-BC94-95E8-13097F0D9393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40" creationId="{42EE33A9-840D-3828-ED6D-4ACFAA82EE5D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43" creationId="{CFDBF331-DCC5-18BA-D726-87932ECCEF89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44" creationId="{423255AA-47C3-2E41-A5F1-3E1E73DF3F18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45" creationId="{78785335-A417-51DF-41A2-86B764AAA66C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47" creationId="{FC875678-BDD7-DE99-CDD2-C25E3AA4F855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48" creationId="{6D9103FE-019E-D460-3414-A74FFAAB31F7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49" creationId="{3FE886B6-AA13-2E8F-66A7-DF0ED7B7322E}"/>
          </ac:cxnSpMkLst>
        </pc:cxnChg>
        <pc:cxnChg chg="add mod">
          <ac:chgData name="濵田　大治" userId="3dc346c6-a235-4d96-b756-7f3e038a9511" providerId="ADAL" clId="{98A46F7B-C125-401F-A531-9A38C3203D8D}" dt="2022-09-12T08:22:01.181" v="2530" actId="1076"/>
          <ac:cxnSpMkLst>
            <pc:docMk/>
            <pc:sldMk cId="2979523262" sldId="283"/>
            <ac:cxnSpMk id="50" creationId="{485224EF-BC0C-3D34-F136-E22CC9153242}"/>
          </ac:cxnSpMkLst>
        </pc:cxnChg>
        <pc:cxnChg chg="add mod">
          <ac:chgData name="濵田　大治" userId="3dc346c6-a235-4d96-b756-7f3e038a9511" providerId="ADAL" clId="{98A46F7B-C125-401F-A531-9A38C3203D8D}" dt="2022-09-12T08:23:26.064" v="2540" actId="1076"/>
          <ac:cxnSpMkLst>
            <pc:docMk/>
            <pc:sldMk cId="2979523262" sldId="283"/>
            <ac:cxnSpMk id="53" creationId="{DF442269-68A9-2FDD-179F-2B16AEF259FB}"/>
          </ac:cxnSpMkLst>
        </pc:cxnChg>
        <pc:cxnChg chg="add mod">
          <ac:chgData name="濵田　大治" userId="3dc346c6-a235-4d96-b756-7f3e038a9511" providerId="ADAL" clId="{98A46F7B-C125-401F-A531-9A38C3203D8D}" dt="2022-09-12T08:23:26.064" v="2540" actId="1076"/>
          <ac:cxnSpMkLst>
            <pc:docMk/>
            <pc:sldMk cId="2979523262" sldId="283"/>
            <ac:cxnSpMk id="54" creationId="{AFCD7881-61B5-CC85-324F-DE3DAE6E8C3A}"/>
          </ac:cxnSpMkLst>
        </pc:cxnChg>
        <pc:cxnChg chg="add mod">
          <ac:chgData name="濵田　大治" userId="3dc346c6-a235-4d96-b756-7f3e038a9511" providerId="ADAL" clId="{98A46F7B-C125-401F-A531-9A38C3203D8D}" dt="2022-09-12T08:23:26.064" v="2540" actId="1076"/>
          <ac:cxnSpMkLst>
            <pc:docMk/>
            <pc:sldMk cId="2979523262" sldId="283"/>
            <ac:cxnSpMk id="55" creationId="{78A82833-751D-AD67-66A9-90FC28672F13}"/>
          </ac:cxnSpMkLst>
        </pc:cxnChg>
        <pc:cxnChg chg="add mod">
          <ac:chgData name="濵田　大治" userId="3dc346c6-a235-4d96-b756-7f3e038a9511" providerId="ADAL" clId="{98A46F7B-C125-401F-A531-9A38C3203D8D}" dt="2022-09-12T08:23:26.064" v="2540" actId="1076"/>
          <ac:cxnSpMkLst>
            <pc:docMk/>
            <pc:sldMk cId="2979523262" sldId="283"/>
            <ac:cxnSpMk id="56" creationId="{BEECEE46-6B77-022B-C3BC-547F49EB5742}"/>
          </ac:cxnSpMkLst>
        </pc:cxnChg>
        <pc:cxnChg chg="add mod">
          <ac:chgData name="濵田　大治" userId="3dc346c6-a235-4d96-b756-7f3e038a9511" providerId="ADAL" clId="{98A46F7B-C125-401F-A531-9A38C3203D8D}" dt="2022-09-12T08:23:26.064" v="2540" actId="1076"/>
          <ac:cxnSpMkLst>
            <pc:docMk/>
            <pc:sldMk cId="2979523262" sldId="283"/>
            <ac:cxnSpMk id="59" creationId="{10A1C8E3-2E6F-D4A1-72B0-685874D23DE2}"/>
          </ac:cxnSpMkLst>
        </pc:cxnChg>
        <pc:cxnChg chg="add mod">
          <ac:chgData name="濵田　大治" userId="3dc346c6-a235-4d96-b756-7f3e038a9511" providerId="ADAL" clId="{98A46F7B-C125-401F-A531-9A38C3203D8D}" dt="2022-09-12T08:23:26.064" v="2540" actId="1076"/>
          <ac:cxnSpMkLst>
            <pc:docMk/>
            <pc:sldMk cId="2979523262" sldId="283"/>
            <ac:cxnSpMk id="60" creationId="{0EECB5E5-2E99-7B2F-80B4-9820FC7E285D}"/>
          </ac:cxnSpMkLst>
        </pc:cxnChg>
        <pc:cxnChg chg="add mod">
          <ac:chgData name="濵田　大治" userId="3dc346c6-a235-4d96-b756-7f3e038a9511" providerId="ADAL" clId="{98A46F7B-C125-401F-A531-9A38C3203D8D}" dt="2022-09-12T08:23:26.064" v="2540" actId="1076"/>
          <ac:cxnSpMkLst>
            <pc:docMk/>
            <pc:sldMk cId="2979523262" sldId="283"/>
            <ac:cxnSpMk id="61" creationId="{1052FC8D-4754-AB70-427C-4D0463D260A2}"/>
          </ac:cxnSpMkLst>
        </pc:cxnChg>
        <pc:cxnChg chg="add mod">
          <ac:chgData name="濵田　大治" userId="3dc346c6-a235-4d96-b756-7f3e038a9511" providerId="ADAL" clId="{98A46F7B-C125-401F-A531-9A38C3203D8D}" dt="2022-09-12T08:23:26.064" v="2540" actId="1076"/>
          <ac:cxnSpMkLst>
            <pc:docMk/>
            <pc:sldMk cId="2979523262" sldId="283"/>
            <ac:cxnSpMk id="62" creationId="{E1851F2C-CCEB-4737-C07B-921BD483ABAC}"/>
          </ac:cxnSpMkLst>
        </pc:cxnChg>
      </pc:sldChg>
      <pc:sldChg chg="addSp delSp modSp mod">
        <pc:chgData name="濵田　大治" userId="3dc346c6-a235-4d96-b756-7f3e038a9511" providerId="ADAL" clId="{98A46F7B-C125-401F-A531-9A38C3203D8D}" dt="2022-09-22T08:22:09.297" v="2931" actId="207"/>
        <pc:sldMkLst>
          <pc:docMk/>
          <pc:sldMk cId="370349542" sldId="284"/>
        </pc:sldMkLst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6" creationId="{50392E60-F1D7-6A9C-8C41-B4E456CEA58B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9" creationId="{514008EB-F99A-50BD-54BF-8B13574AE1C6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10" creationId="{F4206149-7623-F856-E28C-225D4E0C665B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11" creationId="{5C93715D-5287-2991-BF5A-9166E58B6D4F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14" creationId="{350518F7-9D7C-F02F-85CE-49C6AE8EECB0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15" creationId="{2FAA7476-501D-5FFA-F3A8-4A6ADBAF869A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18" creationId="{65BAD798-7FF8-B709-5532-FEDE1817086C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19" creationId="{AEDDDD88-A33F-4FDB-0184-217EEA3F6A22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22" creationId="{39CDFC45-9182-C856-1F1B-1F4A0B319A0D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23" creationId="{40082559-9772-A5A4-375B-5B9C870D7325}"/>
          </ac:spMkLst>
        </pc:spChg>
        <pc:spChg chg="del mod">
          <ac:chgData name="濵田　大治" userId="3dc346c6-a235-4d96-b756-7f3e038a9511" providerId="ADAL" clId="{98A46F7B-C125-401F-A531-9A38C3203D8D}" dt="2022-08-25T06:38:11.278" v="560" actId="478"/>
          <ac:spMkLst>
            <pc:docMk/>
            <pc:sldMk cId="370349542" sldId="284"/>
            <ac:spMk id="25" creationId="{E69779AF-7BD3-C1D6-0D29-E3A3106E2E52}"/>
          </ac:spMkLst>
        </pc:spChg>
        <pc:spChg chg="del mod">
          <ac:chgData name="濵田　大治" userId="3dc346c6-a235-4d96-b756-7f3e038a9511" providerId="ADAL" clId="{98A46F7B-C125-401F-A531-9A38C3203D8D}" dt="2022-08-25T06:38:11.278" v="560" actId="478"/>
          <ac:spMkLst>
            <pc:docMk/>
            <pc:sldMk cId="370349542" sldId="284"/>
            <ac:spMk id="26" creationId="{08A2FA63-1197-9CCC-836B-1DA05D0278C9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28" creationId="{31CB8C27-8A7D-FE23-AD78-60C975CBBAA1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29" creationId="{8DE3CE98-BFF1-E0A8-B7D7-1B8430900B76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31" creationId="{4292A164-7BFA-E53C-C89A-E5D53AD6D06B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32" creationId="{A2B27E04-940A-271B-1FD8-AC3AE91ADCF9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33" creationId="{F526D65F-59A6-7CB1-927F-673904B8A4F7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34" creationId="{92E05CF8-562D-FCB3-7696-E8B03E9FF439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35" creationId="{125B709E-797E-6FC2-6BD0-5FD69F1459D4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36" creationId="{1B422273-BE6C-CB78-EF13-B13A438899ED}"/>
          </ac:spMkLst>
        </pc:spChg>
        <pc:spChg chg="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37" creationId="{47B8558F-7738-D44A-5856-EC7BAB419440}"/>
          </ac:spMkLst>
        </pc:spChg>
        <pc:spChg chg="del mod">
          <ac:chgData name="濵田　大治" userId="3dc346c6-a235-4d96-b756-7f3e038a9511" providerId="ADAL" clId="{98A46F7B-C125-401F-A531-9A38C3203D8D}" dt="2022-08-25T05:54:36.668" v="504" actId="478"/>
          <ac:spMkLst>
            <pc:docMk/>
            <pc:sldMk cId="370349542" sldId="284"/>
            <ac:spMk id="41" creationId="{2DD54333-09E4-7AAE-9867-80B7C3A6B2A1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42" creationId="{E2CDC0F9-C2FB-67BB-8DBC-788B224EFF42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44" creationId="{C58D185C-3976-59F3-04BE-C71FF765B8BE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45" creationId="{040983CD-716C-2931-2A2C-3F7D12269972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47" creationId="{E5C24639-D667-9F67-CDF8-EFE9B91B55CB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48" creationId="{89CEB66B-3A5E-37FC-B2A9-3907379E989E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50" creationId="{C511026E-7245-4774-7E2F-398530FDF415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51" creationId="{3BAE1A22-9F94-C511-2174-E397C017E575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52" creationId="{9DBF03CC-1A7A-62E5-48A5-80EAA4245FBA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53" creationId="{58B12391-6A9C-65F2-83C6-7A3F159AB60E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54" creationId="{CCAFDA85-340D-A848-56AE-2494BF1A0B0C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55" creationId="{7B78450D-B73F-09B6-2D51-80C686862A7C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57" creationId="{CFF6A257-EA62-0D7B-E762-7A56DEE0F09C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58" creationId="{EC5441F1-E1E6-9F8F-BA68-C11D0AB7D4DE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59" creationId="{4F0FD032-3AF1-D06A-1443-E50B62336306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60" creationId="{9AC98895-90F4-8248-584E-38370D64D015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71" creationId="{8F950881-4377-3A3D-F262-5B4142D23DC0}"/>
          </ac:spMkLst>
        </pc:spChg>
        <pc:spChg chg="add mod">
          <ac:chgData name="濵田　大治" userId="3dc346c6-a235-4d96-b756-7f3e038a9511" providerId="ADAL" clId="{98A46F7B-C125-401F-A531-9A38C3203D8D}" dt="2022-08-25T07:32:11.945" v="1424" actId="1076"/>
          <ac:spMkLst>
            <pc:docMk/>
            <pc:sldMk cId="370349542" sldId="284"/>
            <ac:spMk id="76" creationId="{8E6FE66D-0681-8C07-485B-7A9DB8FA2C9E}"/>
          </ac:spMkLst>
        </pc:spChg>
        <pc:spChg chg="add del mod">
          <ac:chgData name="濵田　大治" userId="3dc346c6-a235-4d96-b756-7f3e038a9511" providerId="ADAL" clId="{98A46F7B-C125-401F-A531-9A38C3203D8D}" dt="2022-08-25T07:27:57.493" v="1363" actId="478"/>
          <ac:spMkLst>
            <pc:docMk/>
            <pc:sldMk cId="370349542" sldId="284"/>
            <ac:spMk id="77" creationId="{43F5E90A-9A7E-ED55-8E1B-EDA2239D5972}"/>
          </ac:spMkLst>
        </pc:spChg>
        <pc:spChg chg="add del mod">
          <ac:chgData name="濵田　大治" userId="3dc346c6-a235-4d96-b756-7f3e038a9511" providerId="ADAL" clId="{98A46F7B-C125-401F-A531-9A38C3203D8D}" dt="2022-08-25T07:27:57.493" v="1363" actId="478"/>
          <ac:spMkLst>
            <pc:docMk/>
            <pc:sldMk cId="370349542" sldId="284"/>
            <ac:spMk id="78" creationId="{3C4E11F6-CA07-BBC9-80B7-9CC9388372F1}"/>
          </ac:spMkLst>
        </pc:spChg>
        <pc:spChg chg="add del mod">
          <ac:chgData name="濵田　大治" userId="3dc346c6-a235-4d96-b756-7f3e038a9511" providerId="ADAL" clId="{98A46F7B-C125-401F-A531-9A38C3203D8D}" dt="2022-08-25T07:27:57.493" v="1363" actId="478"/>
          <ac:spMkLst>
            <pc:docMk/>
            <pc:sldMk cId="370349542" sldId="284"/>
            <ac:spMk id="79" creationId="{C167BAA5-162A-422E-9847-F67A402507F4}"/>
          </ac:spMkLst>
        </pc:spChg>
        <pc:spChg chg="add del mod">
          <ac:chgData name="濵田　大治" userId="3dc346c6-a235-4d96-b756-7f3e038a9511" providerId="ADAL" clId="{98A46F7B-C125-401F-A531-9A38C3203D8D}" dt="2022-08-25T07:27:57.493" v="1363" actId="478"/>
          <ac:spMkLst>
            <pc:docMk/>
            <pc:sldMk cId="370349542" sldId="284"/>
            <ac:spMk id="80" creationId="{C35ED596-9622-2419-1B71-6AD1B9F3EF62}"/>
          </ac:spMkLst>
        </pc:spChg>
        <pc:spChg chg="add del mod">
          <ac:chgData name="濵田　大治" userId="3dc346c6-a235-4d96-b756-7f3e038a9511" providerId="ADAL" clId="{98A46F7B-C125-401F-A531-9A38C3203D8D}" dt="2022-08-25T07:27:57.493" v="1363" actId="478"/>
          <ac:spMkLst>
            <pc:docMk/>
            <pc:sldMk cId="370349542" sldId="284"/>
            <ac:spMk id="81" creationId="{2A2BC589-6044-E1AE-28EA-6FD9C282616F}"/>
          </ac:spMkLst>
        </pc:spChg>
        <pc:spChg chg="add del mod">
          <ac:chgData name="濵田　大治" userId="3dc346c6-a235-4d96-b756-7f3e038a9511" providerId="ADAL" clId="{98A46F7B-C125-401F-A531-9A38C3203D8D}" dt="2022-08-25T07:27:57.493" v="1363" actId="478"/>
          <ac:spMkLst>
            <pc:docMk/>
            <pc:sldMk cId="370349542" sldId="284"/>
            <ac:spMk id="82" creationId="{1C18E4F9-8FD2-5AC5-A994-5D06E72E4443}"/>
          </ac:spMkLst>
        </pc:spChg>
        <pc:spChg chg="add mod">
          <ac:chgData name="濵田　大治" userId="3dc346c6-a235-4d96-b756-7f3e038a9511" providerId="ADAL" clId="{98A46F7B-C125-401F-A531-9A38C3203D8D}" dt="2022-09-22T08:15:08.869" v="2863" actId="404"/>
          <ac:spMkLst>
            <pc:docMk/>
            <pc:sldMk cId="370349542" sldId="284"/>
            <ac:spMk id="90" creationId="{08055E23-D22F-5C7D-9074-731F66D38B14}"/>
          </ac:spMkLst>
        </pc:spChg>
        <pc:spChg chg="add mod">
          <ac:chgData name="濵田　大治" userId="3dc346c6-a235-4d96-b756-7f3e038a9511" providerId="ADAL" clId="{98A46F7B-C125-401F-A531-9A38C3203D8D}" dt="2022-09-22T08:15:43.728" v="2877" actId="404"/>
          <ac:spMkLst>
            <pc:docMk/>
            <pc:sldMk cId="370349542" sldId="284"/>
            <ac:spMk id="91" creationId="{81149F67-F63F-E684-C81F-952E532B76EE}"/>
          </ac:spMkLst>
        </pc:spChg>
        <pc:spChg chg="add mod">
          <ac:chgData name="濵田　大治" userId="3dc346c6-a235-4d96-b756-7f3e038a9511" providerId="ADAL" clId="{98A46F7B-C125-401F-A531-9A38C3203D8D}" dt="2022-09-22T08:16:14.174" v="2895" actId="404"/>
          <ac:spMkLst>
            <pc:docMk/>
            <pc:sldMk cId="370349542" sldId="284"/>
            <ac:spMk id="92" creationId="{8861AE48-0A02-50A0-557A-F1C40BE80951}"/>
          </ac:spMkLst>
        </pc:spChg>
        <pc:spChg chg="add mod">
          <ac:chgData name="濵田　大治" userId="3dc346c6-a235-4d96-b756-7f3e038a9511" providerId="ADAL" clId="{98A46F7B-C125-401F-A531-9A38C3203D8D}" dt="2022-09-22T08:18:21.972" v="2927" actId="20577"/>
          <ac:spMkLst>
            <pc:docMk/>
            <pc:sldMk cId="370349542" sldId="284"/>
            <ac:spMk id="93" creationId="{1F800B29-95D8-A61C-6C9C-925B74DBCA86}"/>
          </ac:spMkLst>
        </pc:spChg>
        <pc:spChg chg="add mod">
          <ac:chgData name="濵田　大治" userId="3dc346c6-a235-4d96-b756-7f3e038a9511" providerId="ADAL" clId="{98A46F7B-C125-401F-A531-9A38C3203D8D}" dt="2022-09-22T08:18:57.931" v="2929" actId="20577"/>
          <ac:spMkLst>
            <pc:docMk/>
            <pc:sldMk cId="370349542" sldId="284"/>
            <ac:spMk id="94" creationId="{E140E05E-A452-D810-47D4-744D74379877}"/>
          </ac:spMkLst>
        </pc:spChg>
        <pc:spChg chg="add del mod">
          <ac:chgData name="濵田　大治" userId="3dc346c6-a235-4d96-b756-7f3e038a9511" providerId="ADAL" clId="{98A46F7B-C125-401F-A531-9A38C3203D8D}" dt="2022-08-25T07:35:01.986" v="1452" actId="478"/>
          <ac:spMkLst>
            <pc:docMk/>
            <pc:sldMk cId="370349542" sldId="284"/>
            <ac:spMk id="95" creationId="{1BDEE792-7861-4B15-B995-366153905B3D}"/>
          </ac:spMkLst>
        </pc:spChg>
        <pc:spChg chg="add del mod">
          <ac:chgData name="濵田　大治" userId="3dc346c6-a235-4d96-b756-7f3e038a9511" providerId="ADAL" clId="{98A46F7B-C125-401F-A531-9A38C3203D8D}" dt="2022-08-25T07:35:02.914" v="1453" actId="478"/>
          <ac:spMkLst>
            <pc:docMk/>
            <pc:sldMk cId="370349542" sldId="284"/>
            <ac:spMk id="96" creationId="{5890C938-8D20-13B4-9804-BB6990D9628C}"/>
          </ac:spMkLst>
        </pc:spChg>
        <pc:spChg chg="add del mod">
          <ac:chgData name="濵田　大治" userId="3dc346c6-a235-4d96-b756-7f3e038a9511" providerId="ADAL" clId="{98A46F7B-C125-401F-A531-9A38C3203D8D}" dt="2022-08-25T07:35:00.223" v="1451" actId="478"/>
          <ac:spMkLst>
            <pc:docMk/>
            <pc:sldMk cId="370349542" sldId="284"/>
            <ac:spMk id="97" creationId="{12647C4E-9A7D-FC38-E6F6-553F4A931245}"/>
          </ac:spMkLst>
        </pc:spChg>
        <pc:spChg chg="add del mod">
          <ac:chgData name="濵田　大治" userId="3dc346c6-a235-4d96-b756-7f3e038a9511" providerId="ADAL" clId="{98A46F7B-C125-401F-A531-9A38C3203D8D}" dt="2022-08-25T07:34:59.234" v="1450" actId="478"/>
          <ac:spMkLst>
            <pc:docMk/>
            <pc:sldMk cId="370349542" sldId="284"/>
            <ac:spMk id="98" creationId="{62A5435C-0CCC-F422-DB3C-FA2DF87B98A5}"/>
          </ac:spMkLst>
        </pc:spChg>
        <pc:spChg chg="add mod">
          <ac:chgData name="濵田　大治" userId="3dc346c6-a235-4d96-b756-7f3e038a9511" providerId="ADAL" clId="{98A46F7B-C125-401F-A531-9A38C3203D8D}" dt="2022-08-25T07:38:08.867" v="1501" actId="1076"/>
          <ac:spMkLst>
            <pc:docMk/>
            <pc:sldMk cId="370349542" sldId="284"/>
            <ac:spMk id="99" creationId="{B7C70644-EA6A-0C84-285D-5B1BD71032B5}"/>
          </ac:spMkLst>
        </pc:spChg>
        <pc:spChg chg="add mod">
          <ac:chgData name="濵田　大治" userId="3dc346c6-a235-4d96-b756-7f3e038a9511" providerId="ADAL" clId="{98A46F7B-C125-401F-A531-9A38C3203D8D}" dt="2022-08-25T07:43:22.413" v="1559" actId="1076"/>
          <ac:spMkLst>
            <pc:docMk/>
            <pc:sldMk cId="370349542" sldId="284"/>
            <ac:spMk id="100" creationId="{4B1583D3-E2E0-6D44-B2DA-B0D4D121E014}"/>
          </ac:spMkLst>
        </pc:spChg>
        <pc:spChg chg="add mod">
          <ac:chgData name="濵田　大治" userId="3dc346c6-a235-4d96-b756-7f3e038a9511" providerId="ADAL" clId="{98A46F7B-C125-401F-A531-9A38C3203D8D}" dt="2022-08-25T07:43:11.800" v="1557" actId="1076"/>
          <ac:spMkLst>
            <pc:docMk/>
            <pc:sldMk cId="370349542" sldId="284"/>
            <ac:spMk id="101" creationId="{FD1645BC-C064-1A4B-8498-1B1FAD8C012C}"/>
          </ac:spMkLst>
        </pc:spChg>
        <pc:spChg chg="add mod">
          <ac:chgData name="濵田　大治" userId="3dc346c6-a235-4d96-b756-7f3e038a9511" providerId="ADAL" clId="{98A46F7B-C125-401F-A531-9A38C3203D8D}" dt="2022-08-25T07:43:02.770" v="1556" actId="1076"/>
          <ac:spMkLst>
            <pc:docMk/>
            <pc:sldMk cId="370349542" sldId="284"/>
            <ac:spMk id="102" creationId="{5B912DE7-6553-D7E5-29C5-78F780EC7663}"/>
          </ac:spMkLst>
        </pc:spChg>
        <pc:spChg chg="add mod">
          <ac:chgData name="濵田　大治" userId="3dc346c6-a235-4d96-b756-7f3e038a9511" providerId="ADAL" clId="{98A46F7B-C125-401F-A531-9A38C3203D8D}" dt="2022-08-25T07:43:17.648" v="1558" actId="1076"/>
          <ac:spMkLst>
            <pc:docMk/>
            <pc:sldMk cId="370349542" sldId="284"/>
            <ac:spMk id="103" creationId="{D561028E-CEAC-7572-69F7-113C41651D1D}"/>
          </ac:spMkLst>
        </pc:spChg>
        <pc:graphicFrameChg chg="add mod">
          <ac:chgData name="濵田　大治" userId="3dc346c6-a235-4d96-b756-7f3e038a9511" providerId="ADAL" clId="{98A46F7B-C125-401F-A531-9A38C3203D8D}" dt="2022-09-22T08:22:04.012" v="2930" actId="207"/>
          <ac:graphicFrameMkLst>
            <pc:docMk/>
            <pc:sldMk cId="370349542" sldId="284"/>
            <ac:graphicFrameMk id="4" creationId="{31676909-C25A-7D76-1B19-F25830AA56C2}"/>
          </ac:graphicFrameMkLst>
        </pc:graphicFrameChg>
        <pc:graphicFrameChg chg="add mod">
          <ac:chgData name="濵田　大治" userId="3dc346c6-a235-4d96-b756-7f3e038a9511" providerId="ADAL" clId="{98A46F7B-C125-401F-A531-9A38C3203D8D}" dt="2022-09-22T08:22:09.297" v="2931" actId="207"/>
          <ac:graphicFrameMkLst>
            <pc:docMk/>
            <pc:sldMk cId="370349542" sldId="284"/>
            <ac:graphicFrameMk id="65" creationId="{D82705C3-08FB-FC98-F61A-E0B573FDF8F0}"/>
          </ac:graphicFrameMkLst>
        </pc:graphicFrameChg>
        <pc:picChg chg="del mod">
          <ac:chgData name="濵田　大治" userId="3dc346c6-a235-4d96-b756-7f3e038a9511" providerId="ADAL" clId="{98A46F7B-C125-401F-A531-9A38C3203D8D}" dt="2022-08-25T05:51:36.201" v="411" actId="478"/>
          <ac:picMkLst>
            <pc:docMk/>
            <pc:sldMk cId="370349542" sldId="284"/>
            <ac:picMk id="5" creationId="{31546A0B-9054-75AE-9172-3C70BF8F5572}"/>
          </ac:picMkLst>
        </pc:picChg>
        <pc:picChg chg="del mod">
          <ac:chgData name="濵田　大治" userId="3dc346c6-a235-4d96-b756-7f3e038a9511" providerId="ADAL" clId="{98A46F7B-C125-401F-A531-9A38C3203D8D}" dt="2022-08-25T05:54:36.668" v="504" actId="478"/>
          <ac:picMkLst>
            <pc:docMk/>
            <pc:sldMk cId="370349542" sldId="284"/>
            <ac:picMk id="40" creationId="{532FB4AE-6025-D93B-EFB7-CF1D8443FFC2}"/>
          </ac:picMkLst>
        </pc:picChg>
        <pc:picChg chg="add del mod modCrop">
          <ac:chgData name="濵田　大治" userId="3dc346c6-a235-4d96-b756-7f3e038a9511" providerId="ADAL" clId="{98A46F7B-C125-401F-A531-9A38C3203D8D}" dt="2022-08-25T07:25:00.791" v="1333" actId="478"/>
          <ac:picMkLst>
            <pc:docMk/>
            <pc:sldMk cId="370349542" sldId="284"/>
            <ac:picMk id="83" creationId="{754AC276-4AE8-7CA0-6796-D26FB0145907}"/>
          </ac:picMkLst>
        </pc:picChg>
        <pc:picChg chg="add mod">
          <ac:chgData name="濵田　大治" userId="3dc346c6-a235-4d96-b756-7f3e038a9511" providerId="ADAL" clId="{98A46F7B-C125-401F-A531-9A38C3203D8D}" dt="2022-08-25T07:30:09.726" v="1382" actId="1076"/>
          <ac:picMkLst>
            <pc:docMk/>
            <pc:sldMk cId="370349542" sldId="284"/>
            <ac:picMk id="84" creationId="{EAB7AC82-AE67-98AC-0F82-88F08EA8A1ED}"/>
          </ac:picMkLst>
        </pc:picChg>
        <pc:picChg chg="add mod">
          <ac:chgData name="濵田　大治" userId="3dc346c6-a235-4d96-b756-7f3e038a9511" providerId="ADAL" clId="{98A46F7B-C125-401F-A531-9A38C3203D8D}" dt="2022-08-25T07:30:09.726" v="1382" actId="1076"/>
          <ac:picMkLst>
            <pc:docMk/>
            <pc:sldMk cId="370349542" sldId="284"/>
            <ac:picMk id="85" creationId="{98C81337-8A92-AC37-175F-133C6B1FBCFD}"/>
          </ac:picMkLst>
        </pc:picChg>
        <pc:picChg chg="add mod">
          <ac:chgData name="濵田　大治" userId="3dc346c6-a235-4d96-b756-7f3e038a9511" providerId="ADAL" clId="{98A46F7B-C125-401F-A531-9A38C3203D8D}" dt="2022-08-25T07:26:58.430" v="1351"/>
          <ac:picMkLst>
            <pc:docMk/>
            <pc:sldMk cId="370349542" sldId="284"/>
            <ac:picMk id="86" creationId="{B739057A-DE90-C58F-F3A3-EA9054B030F9}"/>
          </ac:picMkLst>
        </pc:picChg>
        <pc:picChg chg="add mod">
          <ac:chgData name="濵田　大治" userId="3dc346c6-a235-4d96-b756-7f3e038a9511" providerId="ADAL" clId="{98A46F7B-C125-401F-A531-9A38C3203D8D}" dt="2022-08-25T07:30:09.726" v="1382" actId="1076"/>
          <ac:picMkLst>
            <pc:docMk/>
            <pc:sldMk cId="370349542" sldId="284"/>
            <ac:picMk id="87" creationId="{B11EAD6C-18B7-4A71-7257-552BE6B1EE5E}"/>
          </ac:picMkLst>
        </pc:picChg>
        <pc:picChg chg="add mod">
          <ac:chgData name="濵田　大治" userId="3dc346c6-a235-4d96-b756-7f3e038a9511" providerId="ADAL" clId="{98A46F7B-C125-401F-A531-9A38C3203D8D}" dt="2022-08-25T07:31:38.381" v="1415" actId="1076"/>
          <ac:picMkLst>
            <pc:docMk/>
            <pc:sldMk cId="370349542" sldId="284"/>
            <ac:picMk id="88" creationId="{D4573F38-E5D8-6705-F250-C4A7BA252ACE}"/>
          </ac:picMkLst>
        </pc:picChg>
        <pc:picChg chg="add mod">
          <ac:chgData name="濵田　大治" userId="3dc346c6-a235-4d96-b756-7f3e038a9511" providerId="ADAL" clId="{98A46F7B-C125-401F-A531-9A38C3203D8D}" dt="2022-08-25T07:30:09.726" v="1382" actId="1076"/>
          <ac:picMkLst>
            <pc:docMk/>
            <pc:sldMk cId="370349542" sldId="284"/>
            <ac:picMk id="89" creationId="{ABC93ED3-9A59-0B3A-EBBC-33AE67C30724}"/>
          </ac:picMkLst>
        </pc:picChg>
        <pc:cxnChg chg="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8" creationId="{8169E841-1E1B-6671-3A7B-8A1C4136AA31}"/>
          </ac:cxnSpMkLst>
        </pc:cxnChg>
        <pc:cxnChg chg="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12" creationId="{AEAA3C97-E6B0-BCA3-A68C-D45210D347A1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13" creationId="{E16B50B4-B80A-AAE0-7EB3-75A12C364E5A}"/>
          </ac:cxnSpMkLst>
        </pc:cxnChg>
        <pc:cxnChg chg="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16" creationId="{1F301259-62FF-F140-2D62-D1D356E3CE83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17" creationId="{5CE2EDCC-1F1A-9BC6-D61C-26E9ACEEF094}"/>
          </ac:cxnSpMkLst>
        </pc:cxnChg>
        <pc:cxnChg chg="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20" creationId="{C2F9B441-42D2-3B22-6D9E-B36DF4E60325}"/>
          </ac:cxnSpMkLst>
        </pc:cxnChg>
        <pc:cxnChg chg="del mod">
          <ac:chgData name="濵田　大治" userId="3dc346c6-a235-4d96-b756-7f3e038a9511" providerId="ADAL" clId="{98A46F7B-C125-401F-A531-9A38C3203D8D}" dt="2022-08-25T06:38:11.278" v="560" actId="478"/>
          <ac:cxnSpMkLst>
            <pc:docMk/>
            <pc:sldMk cId="370349542" sldId="284"/>
            <ac:cxnSpMk id="24" creationId="{E52473DE-6E98-869F-78FC-E20BF7B053BB}"/>
          </ac:cxnSpMkLst>
        </pc:cxnChg>
        <pc:cxnChg chg="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27" creationId="{8BFCA7F4-EC9E-4973-A1A6-4559EDFA667B}"/>
          </ac:cxnSpMkLst>
        </pc:cxnChg>
        <pc:cxnChg chg="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30" creationId="{18A73CF5-CF0F-8B4A-1A16-3E15ADB369C1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38" creationId="{0EFA763B-BD3D-E3CC-44FD-393F8083D36F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39" creationId="{D08EBDA7-0804-22C0-5F17-5569A22B5026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43" creationId="{858664AF-8E57-E2A4-6AD6-8F43C6CA2514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46" creationId="{C77D7BF8-DBDA-3C95-D7AC-F61C91DF138D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49" creationId="{A4ECD674-A068-4E75-8AEC-78B6FD815889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56" creationId="{C2162FC7-91CB-7108-60AC-7CADF24DAEB9}"/>
          </ac:cxnSpMkLst>
        </pc:cxnChg>
        <pc:cxnChg chg="add del mod">
          <ac:chgData name="濵田　大治" userId="3dc346c6-a235-4d96-b756-7f3e038a9511" providerId="ADAL" clId="{98A46F7B-C125-401F-A531-9A38C3203D8D}" dt="2022-08-25T06:39:22.335" v="575" actId="478"/>
          <ac:cxnSpMkLst>
            <pc:docMk/>
            <pc:sldMk cId="370349542" sldId="284"/>
            <ac:cxnSpMk id="62" creationId="{01A4440E-1DC6-506C-28A5-10DB38E66DF6}"/>
          </ac:cxnSpMkLst>
        </pc:cxnChg>
        <pc:cxnChg chg="add del mod">
          <ac:chgData name="濵田　大治" userId="3dc346c6-a235-4d96-b756-7f3e038a9511" providerId="ADAL" clId="{98A46F7B-C125-401F-A531-9A38C3203D8D}" dt="2022-08-25T06:41:39.157" v="671" actId="478"/>
          <ac:cxnSpMkLst>
            <pc:docMk/>
            <pc:sldMk cId="370349542" sldId="284"/>
            <ac:cxnSpMk id="64" creationId="{AE4C3931-27B2-5237-928E-01206386F09A}"/>
          </ac:cxnSpMkLst>
        </pc:cxnChg>
        <pc:cxnChg chg="add del mod">
          <ac:chgData name="濵田　大治" userId="3dc346c6-a235-4d96-b756-7f3e038a9511" providerId="ADAL" clId="{98A46F7B-C125-401F-A531-9A38C3203D8D}" dt="2022-08-25T07:02:46.140" v="727"/>
          <ac:cxnSpMkLst>
            <pc:docMk/>
            <pc:sldMk cId="370349542" sldId="284"/>
            <ac:cxnSpMk id="66" creationId="{2DA19BF0-5B35-B5C0-B0E3-B28A54F5B188}"/>
          </ac:cxnSpMkLst>
        </pc:cxnChg>
        <pc:cxnChg chg="add del mod">
          <ac:chgData name="濵田　大治" userId="3dc346c6-a235-4d96-b756-7f3e038a9511" providerId="ADAL" clId="{98A46F7B-C125-401F-A531-9A38C3203D8D}" dt="2022-08-25T07:02:46.140" v="727"/>
          <ac:cxnSpMkLst>
            <pc:docMk/>
            <pc:sldMk cId="370349542" sldId="284"/>
            <ac:cxnSpMk id="67" creationId="{D3FE9AA5-EA70-51F1-CA25-5EE3845A3448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68" creationId="{F9A4BD06-9D27-6C2A-25CA-926C42457088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69" creationId="{F1D3EA8E-506E-EB36-332B-A957FB4F0E89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70" creationId="{A3572C5E-C8B3-00B8-0407-FDFB422E96F5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72" creationId="{7A001E2C-6D0F-DBF1-67D4-FCCCD15D48C7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73" creationId="{89F23B70-9470-8DA1-FC5F-24D051348C2E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74" creationId="{36BCE96C-B412-CB55-8182-344CF0607B7B}"/>
          </ac:cxnSpMkLst>
        </pc:cxnChg>
        <pc:cxnChg chg="add mod">
          <ac:chgData name="濵田　大治" userId="3dc346c6-a235-4d96-b756-7f3e038a9511" providerId="ADAL" clId="{98A46F7B-C125-401F-A531-9A38C3203D8D}" dt="2022-08-25T07:32:11.945" v="1424" actId="1076"/>
          <ac:cxnSpMkLst>
            <pc:docMk/>
            <pc:sldMk cId="370349542" sldId="284"/>
            <ac:cxnSpMk id="75" creationId="{A7C97EFF-3368-EB62-54F5-9C04FE257AE8}"/>
          </ac:cxnSpMkLst>
        </pc:cxnChg>
      </pc:sldChg>
      <pc:sldChg chg="addSp delSp modSp new mod">
        <pc:chgData name="濵田　大治" userId="3dc346c6-a235-4d96-b756-7f3e038a9511" providerId="ADAL" clId="{98A46F7B-C125-401F-A531-9A38C3203D8D}" dt="2022-10-03T11:04:12.461" v="3562" actId="1076"/>
        <pc:sldMkLst>
          <pc:docMk/>
          <pc:sldMk cId="20767843" sldId="285"/>
        </pc:sldMkLst>
        <pc:spChg chg="add mod">
          <ac:chgData name="濵田　大治" userId="3dc346c6-a235-4d96-b756-7f3e038a9511" providerId="ADAL" clId="{98A46F7B-C125-401F-A531-9A38C3203D8D}" dt="2022-10-03T11:04:12.461" v="3562" actId="1076"/>
          <ac:spMkLst>
            <pc:docMk/>
            <pc:sldMk cId="20767843" sldId="285"/>
            <ac:spMk id="4" creationId="{2B1757D0-08E1-F10C-CA43-D74FAC993A3C}"/>
          </ac:spMkLst>
        </pc:spChg>
        <pc:spChg chg="add mod">
          <ac:chgData name="濵田　大治" userId="3dc346c6-a235-4d96-b756-7f3e038a9511" providerId="ADAL" clId="{98A46F7B-C125-401F-A531-9A38C3203D8D}" dt="2022-10-03T11:04:12.461" v="3562" actId="1076"/>
          <ac:spMkLst>
            <pc:docMk/>
            <pc:sldMk cId="20767843" sldId="285"/>
            <ac:spMk id="5" creationId="{53E4558C-7741-238C-1C1E-9A6D4AAD0E71}"/>
          </ac:spMkLst>
        </pc:spChg>
        <pc:spChg chg="add mod">
          <ac:chgData name="濵田　大治" userId="3dc346c6-a235-4d96-b756-7f3e038a9511" providerId="ADAL" clId="{98A46F7B-C125-401F-A531-9A38C3203D8D}" dt="2022-10-03T11:04:12.461" v="3562" actId="1076"/>
          <ac:spMkLst>
            <pc:docMk/>
            <pc:sldMk cId="20767843" sldId="285"/>
            <ac:spMk id="6" creationId="{902CAC6B-4483-45B1-8A73-B3E14EAD40D4}"/>
          </ac:spMkLst>
        </pc:spChg>
        <pc:spChg chg="add mod">
          <ac:chgData name="濵田　大治" userId="3dc346c6-a235-4d96-b756-7f3e038a9511" providerId="ADAL" clId="{98A46F7B-C125-401F-A531-9A38C3203D8D}" dt="2022-10-03T11:04:12.461" v="3562" actId="1076"/>
          <ac:spMkLst>
            <pc:docMk/>
            <pc:sldMk cId="20767843" sldId="285"/>
            <ac:spMk id="9" creationId="{1B9397A4-594F-23DD-BFDF-230E66B6DDF8}"/>
          </ac:spMkLst>
        </pc:spChg>
        <pc:spChg chg="add mod">
          <ac:chgData name="濵田　大治" userId="3dc346c6-a235-4d96-b756-7f3e038a9511" providerId="ADAL" clId="{98A46F7B-C125-401F-A531-9A38C3203D8D}" dt="2022-10-03T11:04:12.461" v="3562" actId="1076"/>
          <ac:spMkLst>
            <pc:docMk/>
            <pc:sldMk cId="20767843" sldId="285"/>
            <ac:spMk id="10" creationId="{49B66938-D85A-E77A-4A19-6C536250DD5E}"/>
          </ac:spMkLst>
        </pc:spChg>
        <pc:spChg chg="add mod">
          <ac:chgData name="濵田　大治" userId="3dc346c6-a235-4d96-b756-7f3e038a9511" providerId="ADAL" clId="{98A46F7B-C125-401F-A531-9A38C3203D8D}" dt="2022-10-03T11:04:12.461" v="3562" actId="1076"/>
          <ac:spMkLst>
            <pc:docMk/>
            <pc:sldMk cId="20767843" sldId="285"/>
            <ac:spMk id="11" creationId="{172A7772-6245-5E6E-5516-715C791D92F8}"/>
          </ac:spMkLst>
        </pc:spChg>
        <pc:spChg chg="add mod">
          <ac:chgData name="濵田　大治" userId="3dc346c6-a235-4d96-b756-7f3e038a9511" providerId="ADAL" clId="{98A46F7B-C125-401F-A531-9A38C3203D8D}" dt="2022-10-03T11:04:12.461" v="3562" actId="1076"/>
          <ac:spMkLst>
            <pc:docMk/>
            <pc:sldMk cId="20767843" sldId="285"/>
            <ac:spMk id="12" creationId="{744E6190-EEE4-585B-B5D6-1AAF3F368CCD}"/>
          </ac:spMkLst>
        </pc:spChg>
        <pc:spChg chg="add mod">
          <ac:chgData name="濵田　大治" userId="3dc346c6-a235-4d96-b756-7f3e038a9511" providerId="ADAL" clId="{98A46F7B-C125-401F-A531-9A38C3203D8D}" dt="2022-10-03T11:04:12.461" v="3562" actId="1076"/>
          <ac:spMkLst>
            <pc:docMk/>
            <pc:sldMk cId="20767843" sldId="285"/>
            <ac:spMk id="13" creationId="{B4EC76B3-A5DD-B6B2-315A-9845294B1A60}"/>
          </ac:spMkLst>
        </pc:spChg>
        <pc:spChg chg="add mod">
          <ac:chgData name="濵田　大治" userId="3dc346c6-a235-4d96-b756-7f3e038a9511" providerId="ADAL" clId="{98A46F7B-C125-401F-A531-9A38C3203D8D}" dt="2022-10-03T11:04:12.461" v="3562" actId="1076"/>
          <ac:spMkLst>
            <pc:docMk/>
            <pc:sldMk cId="20767843" sldId="285"/>
            <ac:spMk id="14" creationId="{3B616A17-C307-0DA7-9CB9-6BDF332B7F07}"/>
          </ac:spMkLst>
        </pc:spChg>
        <pc:spChg chg="add del mod">
          <ac:chgData name="濵田　大治" userId="3dc346c6-a235-4d96-b756-7f3e038a9511" providerId="ADAL" clId="{98A46F7B-C125-401F-A531-9A38C3203D8D}" dt="2022-10-03T11:04:02.478" v="3560" actId="478"/>
          <ac:spMkLst>
            <pc:docMk/>
            <pc:sldMk cId="20767843" sldId="285"/>
            <ac:spMk id="18" creationId="{F6A1205C-E122-5E04-9580-C0A043DCA5C0}"/>
          </ac:spMkLst>
        </pc:spChg>
        <pc:spChg chg="add del mod">
          <ac:chgData name="濵田　大治" userId="3dc346c6-a235-4d96-b756-7f3e038a9511" providerId="ADAL" clId="{98A46F7B-C125-401F-A531-9A38C3203D8D}" dt="2022-10-03T11:04:02.478" v="3560" actId="478"/>
          <ac:spMkLst>
            <pc:docMk/>
            <pc:sldMk cId="20767843" sldId="285"/>
            <ac:spMk id="20" creationId="{3BBDDC07-D936-D78D-311B-38A6F5FD5740}"/>
          </ac:spMkLst>
        </pc:spChg>
        <pc:spChg chg="add del mod">
          <ac:chgData name="濵田　大治" userId="3dc346c6-a235-4d96-b756-7f3e038a9511" providerId="ADAL" clId="{98A46F7B-C125-401F-A531-9A38C3203D8D}" dt="2022-10-03T11:04:02.478" v="3560" actId="478"/>
          <ac:spMkLst>
            <pc:docMk/>
            <pc:sldMk cId="20767843" sldId="285"/>
            <ac:spMk id="22" creationId="{CBFDAD21-D638-5B7D-C0AA-323A3B20C710}"/>
          </ac:spMkLst>
        </pc:spChg>
        <pc:spChg chg="add del mod">
          <ac:chgData name="濵田　大治" userId="3dc346c6-a235-4d96-b756-7f3e038a9511" providerId="ADAL" clId="{98A46F7B-C125-401F-A531-9A38C3203D8D}" dt="2022-10-03T11:04:02.478" v="3560" actId="478"/>
          <ac:spMkLst>
            <pc:docMk/>
            <pc:sldMk cId="20767843" sldId="285"/>
            <ac:spMk id="24" creationId="{C3004127-ECB7-4E75-8B3C-77630BEAE485}"/>
          </ac:spMkLst>
        </pc:spChg>
        <pc:spChg chg="add mod">
          <ac:chgData name="濵田　大治" userId="3dc346c6-a235-4d96-b756-7f3e038a9511" providerId="ADAL" clId="{98A46F7B-C125-401F-A531-9A38C3203D8D}" dt="2022-10-03T11:04:12.461" v="3562" actId="1076"/>
          <ac:spMkLst>
            <pc:docMk/>
            <pc:sldMk cId="20767843" sldId="285"/>
            <ac:spMk id="25" creationId="{5FA97CA4-78C7-BCE5-DB4A-10891B65336A}"/>
          </ac:spMkLst>
        </pc:spChg>
        <pc:spChg chg="add del mod">
          <ac:chgData name="濵田　大治" userId="3dc346c6-a235-4d96-b756-7f3e038a9511" providerId="ADAL" clId="{98A46F7B-C125-401F-A531-9A38C3203D8D}" dt="2022-10-03T11:04:04.399" v="3561" actId="478"/>
          <ac:spMkLst>
            <pc:docMk/>
            <pc:sldMk cId="20767843" sldId="285"/>
            <ac:spMk id="26" creationId="{F1618EA4-7442-E417-E611-74F5F47A56A7}"/>
          </ac:spMkLst>
        </pc:spChg>
        <pc:picChg chg="add mod modCrop">
          <ac:chgData name="濵田　大治" userId="3dc346c6-a235-4d96-b756-7f3e038a9511" providerId="ADAL" clId="{98A46F7B-C125-401F-A531-9A38C3203D8D}" dt="2022-10-03T11:04:12.461" v="3562" actId="1076"/>
          <ac:picMkLst>
            <pc:docMk/>
            <pc:sldMk cId="20767843" sldId="285"/>
            <ac:picMk id="3" creationId="{B0D8DD82-38AC-ED9B-2BBB-ED3024FD5FEC}"/>
          </ac:picMkLst>
        </pc:picChg>
        <pc:picChg chg="add del">
          <ac:chgData name="濵田　大治" userId="3dc346c6-a235-4d96-b756-7f3e038a9511" providerId="ADAL" clId="{98A46F7B-C125-401F-A531-9A38C3203D8D}" dt="2022-09-22T08:03:25.140" v="2722"/>
          <ac:picMkLst>
            <pc:docMk/>
            <pc:sldMk cId="20767843" sldId="285"/>
            <ac:picMk id="15" creationId="{C32DC2A9-A562-8593-47A6-0C25AC5F05E1}"/>
          </ac:picMkLst>
        </pc:picChg>
        <pc:picChg chg="add del mod">
          <ac:chgData name="濵田　大治" userId="3dc346c6-a235-4d96-b756-7f3e038a9511" providerId="ADAL" clId="{98A46F7B-C125-401F-A531-9A38C3203D8D}" dt="2022-10-03T11:04:02.478" v="3560" actId="478"/>
          <ac:picMkLst>
            <pc:docMk/>
            <pc:sldMk cId="20767843" sldId="285"/>
            <ac:picMk id="16" creationId="{D2B3184C-4C26-7D0F-FED0-EF9C6B31AEC8}"/>
          </ac:picMkLst>
        </pc:picChg>
        <pc:cxnChg chg="add mod">
          <ac:chgData name="濵田　大治" userId="3dc346c6-a235-4d96-b756-7f3e038a9511" providerId="ADAL" clId="{98A46F7B-C125-401F-A531-9A38C3203D8D}" dt="2022-10-03T11:04:12.461" v="3562" actId="1076"/>
          <ac:cxnSpMkLst>
            <pc:docMk/>
            <pc:sldMk cId="20767843" sldId="285"/>
            <ac:cxnSpMk id="8" creationId="{04979F09-FF3F-3D2D-6C3A-8B655ABD6371}"/>
          </ac:cxnSpMkLst>
        </pc:cxnChg>
        <pc:cxnChg chg="add del mod">
          <ac:chgData name="濵田　大治" userId="3dc346c6-a235-4d96-b756-7f3e038a9511" providerId="ADAL" clId="{98A46F7B-C125-401F-A531-9A38C3203D8D}" dt="2022-10-03T11:04:02.478" v="3560" actId="478"/>
          <ac:cxnSpMkLst>
            <pc:docMk/>
            <pc:sldMk cId="20767843" sldId="285"/>
            <ac:cxnSpMk id="17" creationId="{6CBBF945-4D3B-01BC-2505-D1ADB7D1DCDA}"/>
          </ac:cxnSpMkLst>
        </pc:cxnChg>
        <pc:cxnChg chg="add del mod">
          <ac:chgData name="濵田　大治" userId="3dc346c6-a235-4d96-b756-7f3e038a9511" providerId="ADAL" clId="{98A46F7B-C125-401F-A531-9A38C3203D8D}" dt="2022-10-03T11:04:02.478" v="3560" actId="478"/>
          <ac:cxnSpMkLst>
            <pc:docMk/>
            <pc:sldMk cId="20767843" sldId="285"/>
            <ac:cxnSpMk id="19" creationId="{93B1A38C-4DE6-252D-FDB3-DDFBF5EA81BB}"/>
          </ac:cxnSpMkLst>
        </pc:cxnChg>
        <pc:cxnChg chg="add del mod">
          <ac:chgData name="濵田　大治" userId="3dc346c6-a235-4d96-b756-7f3e038a9511" providerId="ADAL" clId="{98A46F7B-C125-401F-A531-9A38C3203D8D}" dt="2022-10-03T11:04:02.478" v="3560" actId="478"/>
          <ac:cxnSpMkLst>
            <pc:docMk/>
            <pc:sldMk cId="20767843" sldId="285"/>
            <ac:cxnSpMk id="21" creationId="{8EF9CBCE-CACF-0A9F-78CD-B2917288FF5D}"/>
          </ac:cxnSpMkLst>
        </pc:cxnChg>
        <pc:cxnChg chg="add del mod">
          <ac:chgData name="濵田　大治" userId="3dc346c6-a235-4d96-b756-7f3e038a9511" providerId="ADAL" clId="{98A46F7B-C125-401F-A531-9A38C3203D8D}" dt="2022-10-03T11:04:02.478" v="3560" actId="478"/>
          <ac:cxnSpMkLst>
            <pc:docMk/>
            <pc:sldMk cId="20767843" sldId="285"/>
            <ac:cxnSpMk id="23" creationId="{1E257ABD-90AF-4AB9-A567-34B86237CB09}"/>
          </ac:cxnSpMkLst>
        </pc:cxnChg>
      </pc:sldChg>
      <pc:sldChg chg="new del">
        <pc:chgData name="濵田　大治" userId="3dc346c6-a235-4d96-b756-7f3e038a9511" providerId="ADAL" clId="{98A46F7B-C125-401F-A531-9A38C3203D8D}" dt="2022-09-22T08:23:35.959" v="2943" actId="2696"/>
        <pc:sldMkLst>
          <pc:docMk/>
          <pc:sldMk cId="1501413430" sldId="286"/>
        </pc:sldMkLst>
      </pc:sldChg>
      <pc:sldChg chg="modSp mod">
        <pc:chgData name="濵田　大治" userId="3dc346c6-a235-4d96-b756-7f3e038a9511" providerId="ADAL" clId="{98A46F7B-C125-401F-A531-9A38C3203D8D}" dt="2022-10-05T03:57:40.762" v="3594" actId="1076"/>
        <pc:sldMkLst>
          <pc:docMk/>
          <pc:sldMk cId="1876780258" sldId="286"/>
        </pc:sldMkLst>
        <pc:spChg chg="mod">
          <ac:chgData name="濵田　大治" userId="3dc346c6-a235-4d96-b756-7f3e038a9511" providerId="ADAL" clId="{98A46F7B-C125-401F-A531-9A38C3203D8D}" dt="2022-10-05T03:57:40.762" v="3594" actId="1076"/>
          <ac:spMkLst>
            <pc:docMk/>
            <pc:sldMk cId="1876780258" sldId="286"/>
            <ac:spMk id="22" creationId="{00000000-0000-0000-0000-000000000000}"/>
          </ac:spMkLst>
        </pc:spChg>
      </pc:sldChg>
      <pc:sldChg chg="addSp delSp modSp new mod">
        <pc:chgData name="濵田　大治" userId="3dc346c6-a235-4d96-b756-7f3e038a9511" providerId="ADAL" clId="{98A46F7B-C125-401F-A531-9A38C3203D8D}" dt="2022-10-03T11:06:10.742" v="3568" actId="20577"/>
        <pc:sldMkLst>
          <pc:docMk/>
          <pc:sldMk cId="2608898302" sldId="289"/>
        </pc:sldMkLst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16" creationId="{3AA36673-C103-DCDC-3D82-ED946469AAC1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18" creationId="{A1369F4B-2DBD-C3DD-1C5A-594B0179E620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20" creationId="{E7340AA9-8DD0-04F1-A5C0-BC7600B97B43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22" creationId="{454B2342-2AE2-7EC8-D539-3E01F6CC2E63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24" creationId="{27E09B44-8133-A831-5B60-585B10BE95B5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26" creationId="{5C9F84FF-6255-8436-4B21-F35B8B4716D9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27" creationId="{135F8628-DDE6-CF89-4EA5-35873006318A}"/>
          </ac:spMkLst>
        </pc:spChg>
        <pc:spChg chg="add del mod">
          <ac:chgData name="濵田　大治" userId="3dc346c6-a235-4d96-b756-7f3e038a9511" providerId="ADAL" clId="{98A46F7B-C125-401F-A531-9A38C3203D8D}" dt="2022-10-03T10:49:09.842" v="3283" actId="478"/>
          <ac:spMkLst>
            <pc:docMk/>
            <pc:sldMk cId="2608898302" sldId="289"/>
            <ac:spMk id="28" creationId="{0AB5D39E-B841-0804-3B43-8E4148AFBF46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29" creationId="{B40EADCC-8745-3EF3-9FB5-8EF7D01E1AD0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30" creationId="{9BB0052B-875A-7139-27D2-C2DEB5F03BA7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31" creationId="{72430DAE-E0CB-EC6A-556A-C8819E372989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34" creationId="{D6E07DB0-E923-C23E-C78A-3FB96A0E1378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36" creationId="{79DDEE6D-65B3-681C-3C8D-65E33F314973}"/>
          </ac:spMkLst>
        </pc:spChg>
        <pc:spChg chg="add mod">
          <ac:chgData name="濵田　大治" userId="3dc346c6-a235-4d96-b756-7f3e038a9511" providerId="ADAL" clId="{98A46F7B-C125-401F-A531-9A38C3203D8D}" dt="2022-10-03T11:06:10.742" v="3568" actId="20577"/>
          <ac:spMkLst>
            <pc:docMk/>
            <pc:sldMk cId="2608898302" sldId="289"/>
            <ac:spMk id="37" creationId="{6BE110A4-181C-CA8A-B06C-6E76259CC301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38" creationId="{202E5DE8-6B2D-B9F0-7478-5F88180AF820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42" creationId="{88DA36CD-690D-5F5A-AD1F-41A6BB5AA55E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43" creationId="{0E0F4E93-8314-7804-5B03-27B5C2D6D38C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44" creationId="{3EE40934-D143-5AC2-B839-D5AAB7A523F3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46" creationId="{D67D7FDC-04A6-A12D-994F-58C2F560833D}"/>
          </ac:spMkLst>
        </pc:spChg>
        <pc:spChg chg="add mod">
          <ac:chgData name="濵田　大治" userId="3dc346c6-a235-4d96-b756-7f3e038a9511" providerId="ADAL" clId="{98A46F7B-C125-401F-A531-9A38C3203D8D}" dt="2022-10-03T10:51:42.759" v="3291" actId="1076"/>
          <ac:spMkLst>
            <pc:docMk/>
            <pc:sldMk cId="2608898302" sldId="289"/>
            <ac:spMk id="48" creationId="{AA1AAD6B-9B27-49DC-92A2-064BC2263948}"/>
          </ac:spMkLst>
        </pc:spChg>
        <pc:spChg chg="add mod">
          <ac:chgData name="濵田　大治" userId="3dc346c6-a235-4d96-b756-7f3e038a9511" providerId="ADAL" clId="{98A46F7B-C125-401F-A531-9A38C3203D8D}" dt="2022-10-03T10:52:45.886" v="3383" actId="1076"/>
          <ac:spMkLst>
            <pc:docMk/>
            <pc:sldMk cId="2608898302" sldId="289"/>
            <ac:spMk id="49" creationId="{F356D6C9-05E0-DC00-3E4C-12665C9D73F4}"/>
          </ac:spMkLst>
        </pc:spChg>
        <pc:picChg chg="add del mod modCrop">
          <ac:chgData name="濵田　大治" userId="3dc346c6-a235-4d96-b756-7f3e038a9511" providerId="ADAL" clId="{98A46F7B-C125-401F-A531-9A38C3203D8D}" dt="2022-10-03T08:12:39.074" v="3028" actId="478"/>
          <ac:picMkLst>
            <pc:docMk/>
            <pc:sldMk cId="2608898302" sldId="289"/>
            <ac:picMk id="3" creationId="{3D1E23D5-B495-53D8-0C06-515E9C91A23A}"/>
          </ac:picMkLst>
        </pc:picChg>
        <pc:picChg chg="add del mod modCrop">
          <ac:chgData name="濵田　大治" userId="3dc346c6-a235-4d96-b756-7f3e038a9511" providerId="ADAL" clId="{98A46F7B-C125-401F-A531-9A38C3203D8D}" dt="2022-10-03T08:12:30.694" v="3025" actId="478"/>
          <ac:picMkLst>
            <pc:docMk/>
            <pc:sldMk cId="2608898302" sldId="289"/>
            <ac:picMk id="5" creationId="{4F8DB4A1-98F6-4561-A4CA-4A47DE2A7381}"/>
          </ac:picMkLst>
        </pc:picChg>
        <pc:picChg chg="add del mod modCrop">
          <ac:chgData name="濵田　大治" userId="3dc346c6-a235-4d96-b756-7f3e038a9511" providerId="ADAL" clId="{98A46F7B-C125-401F-A531-9A38C3203D8D}" dt="2022-10-03T08:12:08.008" v="3018" actId="478"/>
          <ac:picMkLst>
            <pc:docMk/>
            <pc:sldMk cId="2608898302" sldId="289"/>
            <ac:picMk id="7" creationId="{8A85BE64-48EA-F511-2FD1-586EA46FD8ED}"/>
          </ac:picMkLst>
        </pc:picChg>
        <pc:picChg chg="add del mod modCrop">
          <ac:chgData name="濵田　大治" userId="3dc346c6-a235-4d96-b756-7f3e038a9511" providerId="ADAL" clId="{98A46F7B-C125-401F-A531-9A38C3203D8D}" dt="2022-10-03T08:07:40.563" v="2984" actId="478"/>
          <ac:picMkLst>
            <pc:docMk/>
            <pc:sldMk cId="2608898302" sldId="289"/>
            <ac:picMk id="9" creationId="{6D0C0918-C2B4-2A96-CBA7-0DF8E0DCD8C2}"/>
          </ac:picMkLst>
        </pc:picChg>
        <pc:picChg chg="add del mod modCrop">
          <ac:chgData name="濵田　大治" userId="3dc346c6-a235-4d96-b756-7f3e038a9511" providerId="ADAL" clId="{98A46F7B-C125-401F-A531-9A38C3203D8D}" dt="2022-10-03T08:12:30.031" v="3024" actId="478"/>
          <ac:picMkLst>
            <pc:docMk/>
            <pc:sldMk cId="2608898302" sldId="289"/>
            <ac:picMk id="10" creationId="{05AFC4DD-EEA1-8CC1-60E4-6602885F9DDD}"/>
          </ac:picMkLst>
        </pc:picChg>
        <pc:picChg chg="add mod">
          <ac:chgData name="濵田　大治" userId="3dc346c6-a235-4d96-b756-7f3e038a9511" providerId="ADAL" clId="{98A46F7B-C125-401F-A531-9A38C3203D8D}" dt="2022-10-03T10:51:42.759" v="3291" actId="1076"/>
          <ac:picMkLst>
            <pc:docMk/>
            <pc:sldMk cId="2608898302" sldId="289"/>
            <ac:picMk id="11" creationId="{20BCE99C-31E3-4AB0-12CD-6A4B7203A604}"/>
          </ac:picMkLst>
        </pc:picChg>
        <pc:picChg chg="add mod">
          <ac:chgData name="濵田　大治" userId="3dc346c6-a235-4d96-b756-7f3e038a9511" providerId="ADAL" clId="{98A46F7B-C125-401F-A531-9A38C3203D8D}" dt="2022-10-03T10:51:42.759" v="3291" actId="1076"/>
          <ac:picMkLst>
            <pc:docMk/>
            <pc:sldMk cId="2608898302" sldId="289"/>
            <ac:picMk id="12" creationId="{4313FE41-71D5-FF93-6246-5294BF9918F1}"/>
          </ac:picMkLst>
        </pc:picChg>
        <pc:picChg chg="add mod">
          <ac:chgData name="濵田　大治" userId="3dc346c6-a235-4d96-b756-7f3e038a9511" providerId="ADAL" clId="{98A46F7B-C125-401F-A531-9A38C3203D8D}" dt="2022-10-03T10:51:42.759" v="3291" actId="1076"/>
          <ac:picMkLst>
            <pc:docMk/>
            <pc:sldMk cId="2608898302" sldId="289"/>
            <ac:picMk id="13" creationId="{A00F68E9-E5F2-84E6-9561-4D6421AE392F}"/>
          </ac:picMkLst>
        </pc:picChg>
        <pc:picChg chg="add mod">
          <ac:chgData name="濵田　大治" userId="3dc346c6-a235-4d96-b756-7f3e038a9511" providerId="ADAL" clId="{98A46F7B-C125-401F-A531-9A38C3203D8D}" dt="2022-10-03T10:51:42.759" v="3291" actId="1076"/>
          <ac:picMkLst>
            <pc:docMk/>
            <pc:sldMk cId="2608898302" sldId="289"/>
            <ac:picMk id="14" creationId="{86FD1A33-51B9-C56C-CE94-DAB0F2560EB8}"/>
          </ac:picMkLst>
        </pc:pic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15" creationId="{D8F7E128-F59B-3085-2C22-E3B622F18D8F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17" creationId="{C66EAD69-5729-2095-9540-E68FE3ABF898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19" creationId="{DA30FA1A-0BA0-A2C8-BCB2-2F7BADB0CCAC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21" creationId="{72FB1999-07BF-B311-3AAA-ACAB6664FBBB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23" creationId="{2FC2AF30-4DD2-2CEB-1ECA-4615CABB68ED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25" creationId="{3429BE06-7B7F-22E8-CB1D-DFB70B863648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33" creationId="{3170F866-4075-CD58-25EB-433C3181BAB0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35" creationId="{24FC3817-01ED-FD3D-C1C6-184209F28370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40" creationId="{89EAFD86-5B2B-BBAC-BA56-39D7C8CFEA04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41" creationId="{E95BB7AA-72AF-D1BE-5E12-79BF849D7DAB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45" creationId="{E2D8FE89-D441-642C-8124-A684E427B0E2}"/>
          </ac:cxnSpMkLst>
        </pc:cxnChg>
        <pc:cxnChg chg="add mod">
          <ac:chgData name="濵田　大治" userId="3dc346c6-a235-4d96-b756-7f3e038a9511" providerId="ADAL" clId="{98A46F7B-C125-401F-A531-9A38C3203D8D}" dt="2022-10-03T10:51:42.759" v="3291" actId="1076"/>
          <ac:cxnSpMkLst>
            <pc:docMk/>
            <pc:sldMk cId="2608898302" sldId="289"/>
            <ac:cxnSpMk id="47" creationId="{B93CDC38-82EC-F6B2-CBCE-D34BA12C8800}"/>
          </ac:cxnSpMkLst>
        </pc:cxnChg>
      </pc:sldChg>
      <pc:sldChg chg="addSp delSp modSp new mod">
        <pc:chgData name="濵田　大治" userId="3dc346c6-a235-4d96-b756-7f3e038a9511" providerId="ADAL" clId="{98A46F7B-C125-401F-A531-9A38C3203D8D}" dt="2022-10-03T10:59:53.027" v="3553" actId="1076"/>
        <pc:sldMkLst>
          <pc:docMk/>
          <pc:sldMk cId="1749713719" sldId="290"/>
        </pc:sldMkLst>
        <pc:spChg chg="add mod">
          <ac:chgData name="濵田　大治" userId="3dc346c6-a235-4d96-b756-7f3e038a9511" providerId="ADAL" clId="{98A46F7B-C125-401F-A531-9A38C3203D8D}" dt="2022-10-03T10:59:53.027" v="3553" actId="1076"/>
          <ac:spMkLst>
            <pc:docMk/>
            <pc:sldMk cId="1749713719" sldId="290"/>
            <ac:spMk id="8" creationId="{976B994D-3E3F-1BAB-260D-A4365E1ECF16}"/>
          </ac:spMkLst>
        </pc:spChg>
        <pc:spChg chg="add mod">
          <ac:chgData name="濵田　大治" userId="3dc346c6-a235-4d96-b756-7f3e038a9511" providerId="ADAL" clId="{98A46F7B-C125-401F-A531-9A38C3203D8D}" dt="2022-10-03T10:59:53.027" v="3553" actId="1076"/>
          <ac:spMkLst>
            <pc:docMk/>
            <pc:sldMk cId="1749713719" sldId="290"/>
            <ac:spMk id="9" creationId="{9F846702-3F58-5C87-E50B-4637DB81D40C}"/>
          </ac:spMkLst>
        </pc:spChg>
        <pc:spChg chg="add mod">
          <ac:chgData name="濵田　大治" userId="3dc346c6-a235-4d96-b756-7f3e038a9511" providerId="ADAL" clId="{98A46F7B-C125-401F-A531-9A38C3203D8D}" dt="2022-10-03T10:59:53.027" v="3553" actId="1076"/>
          <ac:spMkLst>
            <pc:docMk/>
            <pc:sldMk cId="1749713719" sldId="290"/>
            <ac:spMk id="10" creationId="{57D2DA64-8F15-9F5D-8740-2B37E1622679}"/>
          </ac:spMkLst>
        </pc:spChg>
        <pc:spChg chg="add mod">
          <ac:chgData name="濵田　大治" userId="3dc346c6-a235-4d96-b756-7f3e038a9511" providerId="ADAL" clId="{98A46F7B-C125-401F-A531-9A38C3203D8D}" dt="2022-10-03T10:59:53.027" v="3553" actId="1076"/>
          <ac:spMkLst>
            <pc:docMk/>
            <pc:sldMk cId="1749713719" sldId="290"/>
            <ac:spMk id="11" creationId="{3F5912B8-FF8D-169C-C128-A5B6CB4F1264}"/>
          </ac:spMkLst>
        </pc:spChg>
        <pc:picChg chg="add mod">
          <ac:chgData name="濵田　大治" userId="3dc346c6-a235-4d96-b756-7f3e038a9511" providerId="ADAL" clId="{98A46F7B-C125-401F-A531-9A38C3203D8D}" dt="2022-10-03T10:59:53.027" v="3553" actId="1076"/>
          <ac:picMkLst>
            <pc:docMk/>
            <pc:sldMk cId="1749713719" sldId="290"/>
            <ac:picMk id="2" creationId="{49FAFADE-018D-135B-6F87-C15FC73C4809}"/>
          </ac:picMkLst>
        </pc:picChg>
        <pc:picChg chg="add mod">
          <ac:chgData name="濵田　大治" userId="3dc346c6-a235-4d96-b756-7f3e038a9511" providerId="ADAL" clId="{98A46F7B-C125-401F-A531-9A38C3203D8D}" dt="2022-10-03T10:59:53.027" v="3553" actId="1076"/>
          <ac:picMkLst>
            <pc:docMk/>
            <pc:sldMk cId="1749713719" sldId="290"/>
            <ac:picMk id="3" creationId="{904F0F85-9716-5CBE-8155-071BA7825C91}"/>
          </ac:picMkLst>
        </pc:picChg>
        <pc:picChg chg="add mod">
          <ac:chgData name="濵田　大治" userId="3dc346c6-a235-4d96-b756-7f3e038a9511" providerId="ADAL" clId="{98A46F7B-C125-401F-A531-9A38C3203D8D}" dt="2022-10-03T10:59:53.027" v="3553" actId="1076"/>
          <ac:picMkLst>
            <pc:docMk/>
            <pc:sldMk cId="1749713719" sldId="290"/>
            <ac:picMk id="4" creationId="{27FC7799-ADBA-139E-69F4-372E2DE67FD9}"/>
          </ac:picMkLst>
        </pc:picChg>
        <pc:picChg chg="add del mod modCrop">
          <ac:chgData name="濵田　大治" userId="3dc346c6-a235-4d96-b756-7f3e038a9511" providerId="ADAL" clId="{98A46F7B-C125-401F-A531-9A38C3203D8D}" dt="2022-10-03T10:57:53.999" v="3507" actId="478"/>
          <ac:picMkLst>
            <pc:docMk/>
            <pc:sldMk cId="1749713719" sldId="290"/>
            <ac:picMk id="6" creationId="{86948AFD-5AAE-24D0-F896-C19025FEBED7}"/>
          </ac:picMkLst>
        </pc:picChg>
        <pc:picChg chg="add mod">
          <ac:chgData name="濵田　大治" userId="3dc346c6-a235-4d96-b756-7f3e038a9511" providerId="ADAL" clId="{98A46F7B-C125-401F-A531-9A38C3203D8D}" dt="2022-10-03T10:59:53.027" v="3553" actId="1076"/>
          <ac:picMkLst>
            <pc:docMk/>
            <pc:sldMk cId="1749713719" sldId="290"/>
            <ac:picMk id="7" creationId="{D41D3D47-A0D1-D5BD-20F7-3915D00E890C}"/>
          </ac:picMkLst>
        </pc:picChg>
      </pc:sldChg>
      <pc:sldChg chg="addSp modSp new mod">
        <pc:chgData name="濵田　大治" userId="3dc346c6-a235-4d96-b756-7f3e038a9511" providerId="ADAL" clId="{98A46F7B-C125-401F-A531-9A38C3203D8D}" dt="2022-10-03T11:03:56.345" v="3559" actId="1076"/>
        <pc:sldMkLst>
          <pc:docMk/>
          <pc:sldMk cId="601484075" sldId="291"/>
        </pc:sldMkLst>
        <pc:spChg chg="add mod">
          <ac:chgData name="濵田　大治" userId="3dc346c6-a235-4d96-b756-7f3e038a9511" providerId="ADAL" clId="{98A46F7B-C125-401F-A531-9A38C3203D8D}" dt="2022-10-03T11:03:56.345" v="3559" actId="1076"/>
          <ac:spMkLst>
            <pc:docMk/>
            <pc:sldMk cId="601484075" sldId="291"/>
            <ac:spMk id="4" creationId="{4409D460-56FA-5ACE-A405-A0152B95528C}"/>
          </ac:spMkLst>
        </pc:spChg>
        <pc:spChg chg="add mod">
          <ac:chgData name="濵田　大治" userId="3dc346c6-a235-4d96-b756-7f3e038a9511" providerId="ADAL" clId="{98A46F7B-C125-401F-A531-9A38C3203D8D}" dt="2022-10-03T11:03:56.345" v="3559" actId="1076"/>
          <ac:spMkLst>
            <pc:docMk/>
            <pc:sldMk cId="601484075" sldId="291"/>
            <ac:spMk id="6" creationId="{8B795518-236C-0B11-9715-67B4A9522A08}"/>
          </ac:spMkLst>
        </pc:spChg>
        <pc:spChg chg="add mod">
          <ac:chgData name="濵田　大治" userId="3dc346c6-a235-4d96-b756-7f3e038a9511" providerId="ADAL" clId="{98A46F7B-C125-401F-A531-9A38C3203D8D}" dt="2022-10-03T11:03:56.345" v="3559" actId="1076"/>
          <ac:spMkLst>
            <pc:docMk/>
            <pc:sldMk cId="601484075" sldId="291"/>
            <ac:spMk id="8" creationId="{2F2A1530-DF4E-4318-E9F1-606C8FAA739A}"/>
          </ac:spMkLst>
        </pc:spChg>
        <pc:spChg chg="add mod">
          <ac:chgData name="濵田　大治" userId="3dc346c6-a235-4d96-b756-7f3e038a9511" providerId="ADAL" clId="{98A46F7B-C125-401F-A531-9A38C3203D8D}" dt="2022-10-03T11:03:56.345" v="3559" actId="1076"/>
          <ac:spMkLst>
            <pc:docMk/>
            <pc:sldMk cId="601484075" sldId="291"/>
            <ac:spMk id="10" creationId="{9319133A-D9B0-9A36-E5F5-9AF294168177}"/>
          </ac:spMkLst>
        </pc:spChg>
        <pc:spChg chg="add mod">
          <ac:chgData name="濵田　大治" userId="3dc346c6-a235-4d96-b756-7f3e038a9511" providerId="ADAL" clId="{98A46F7B-C125-401F-A531-9A38C3203D8D}" dt="2022-10-03T11:03:56.345" v="3559" actId="1076"/>
          <ac:spMkLst>
            <pc:docMk/>
            <pc:sldMk cId="601484075" sldId="291"/>
            <ac:spMk id="11" creationId="{B992EAC8-66A5-50AB-E8BE-E6A84954C277}"/>
          </ac:spMkLst>
        </pc:spChg>
        <pc:picChg chg="add mod">
          <ac:chgData name="濵田　大治" userId="3dc346c6-a235-4d96-b756-7f3e038a9511" providerId="ADAL" clId="{98A46F7B-C125-401F-A531-9A38C3203D8D}" dt="2022-10-03T11:03:56.345" v="3559" actId="1076"/>
          <ac:picMkLst>
            <pc:docMk/>
            <pc:sldMk cId="601484075" sldId="291"/>
            <ac:picMk id="2" creationId="{F748EB65-1EBC-52FC-3517-8CF28D55EC5F}"/>
          </ac:picMkLst>
        </pc:picChg>
        <pc:cxnChg chg="add mod">
          <ac:chgData name="濵田　大治" userId="3dc346c6-a235-4d96-b756-7f3e038a9511" providerId="ADAL" clId="{98A46F7B-C125-401F-A531-9A38C3203D8D}" dt="2022-10-03T11:03:56.345" v="3559" actId="1076"/>
          <ac:cxnSpMkLst>
            <pc:docMk/>
            <pc:sldMk cId="601484075" sldId="291"/>
            <ac:cxnSpMk id="3" creationId="{11FA098F-E993-6514-8B7F-A05232F1F136}"/>
          </ac:cxnSpMkLst>
        </pc:cxnChg>
        <pc:cxnChg chg="add mod">
          <ac:chgData name="濵田　大治" userId="3dc346c6-a235-4d96-b756-7f3e038a9511" providerId="ADAL" clId="{98A46F7B-C125-401F-A531-9A38C3203D8D}" dt="2022-10-03T11:03:56.345" v="3559" actId="1076"/>
          <ac:cxnSpMkLst>
            <pc:docMk/>
            <pc:sldMk cId="601484075" sldId="291"/>
            <ac:cxnSpMk id="5" creationId="{246B0A33-35E5-876D-3867-35C65A483A66}"/>
          </ac:cxnSpMkLst>
        </pc:cxnChg>
        <pc:cxnChg chg="add mod">
          <ac:chgData name="濵田　大治" userId="3dc346c6-a235-4d96-b756-7f3e038a9511" providerId="ADAL" clId="{98A46F7B-C125-401F-A531-9A38C3203D8D}" dt="2022-10-03T11:03:56.345" v="3559" actId="1076"/>
          <ac:cxnSpMkLst>
            <pc:docMk/>
            <pc:sldMk cId="601484075" sldId="291"/>
            <ac:cxnSpMk id="7" creationId="{D6250F37-C311-0CCB-193A-A8FB8694E169}"/>
          </ac:cxnSpMkLst>
        </pc:cxnChg>
        <pc:cxnChg chg="add mod">
          <ac:chgData name="濵田　大治" userId="3dc346c6-a235-4d96-b756-7f3e038a9511" providerId="ADAL" clId="{98A46F7B-C125-401F-A531-9A38C3203D8D}" dt="2022-10-03T11:03:56.345" v="3559" actId="1076"/>
          <ac:cxnSpMkLst>
            <pc:docMk/>
            <pc:sldMk cId="601484075" sldId="291"/>
            <ac:cxnSpMk id="9" creationId="{733EEA31-7AAD-4AD9-1998-274531CF0191}"/>
          </ac:cxnSpMkLst>
        </pc:cxnChg>
      </pc:sldChg>
    </pc:docChg>
  </pc:docChgLst>
  <pc:docChgLst>
    <pc:chgData name="濵田　大治" userId="3dc346c6-a235-4d96-b756-7f3e038a9511" providerId="ADAL" clId="{222B0C45-443E-4686-B439-70284A2F34B6}"/>
    <pc:docChg chg="undo custSel addSld modSld">
      <pc:chgData name="濵田　大治" userId="3dc346c6-a235-4d96-b756-7f3e038a9511" providerId="ADAL" clId="{222B0C45-443E-4686-B439-70284A2F34B6}" dt="2022-05-11T04:50:22.070" v="920" actId="1076"/>
      <pc:docMkLst>
        <pc:docMk/>
      </pc:docMkLst>
      <pc:sldChg chg="new">
        <pc:chgData name="濵田　大治" userId="3dc346c6-a235-4d96-b756-7f3e038a9511" providerId="ADAL" clId="{222B0C45-443E-4686-B439-70284A2F34B6}" dt="2022-03-16T06:16:36.316" v="0" actId="680"/>
        <pc:sldMkLst>
          <pc:docMk/>
          <pc:sldMk cId="222806438" sldId="270"/>
        </pc:sldMkLst>
      </pc:sldChg>
      <pc:sldChg chg="addSp delSp modSp new mod">
        <pc:chgData name="濵田　大治" userId="3dc346c6-a235-4d96-b756-7f3e038a9511" providerId="ADAL" clId="{222B0C45-443E-4686-B439-70284A2F34B6}" dt="2022-03-16T10:15:37.164" v="614" actId="1036"/>
        <pc:sldMkLst>
          <pc:docMk/>
          <pc:sldMk cId="1127126126" sldId="271"/>
        </pc:sldMkLst>
        <pc:spChg chg="mod">
          <ac:chgData name="濵田　大治" userId="3dc346c6-a235-4d96-b756-7f3e038a9511" providerId="ADAL" clId="{222B0C45-443E-4686-B439-70284A2F34B6}" dt="2022-03-16T06:36:39.275" v="447" actId="14100"/>
          <ac:spMkLst>
            <pc:docMk/>
            <pc:sldMk cId="1127126126" sldId="271"/>
            <ac:spMk id="2" creationId="{692A22F2-6D85-44DE-9544-96B835DB2D75}"/>
          </ac:spMkLst>
        </pc:spChg>
        <pc:spChg chg="mod">
          <ac:chgData name="濵田　大治" userId="3dc346c6-a235-4d96-b756-7f3e038a9511" providerId="ADAL" clId="{222B0C45-443E-4686-B439-70284A2F34B6}" dt="2022-03-16T06:50:36.817" v="517" actId="20577"/>
          <ac:spMkLst>
            <pc:docMk/>
            <pc:sldMk cId="1127126126" sldId="271"/>
            <ac:spMk id="3" creationId="{0174EA08-22EA-4444-9B6A-4AA766E76114}"/>
          </ac:spMkLst>
        </pc:spChg>
        <pc:spChg chg="add mod">
          <ac:chgData name="濵田　大治" userId="3dc346c6-a235-4d96-b756-7f3e038a9511" providerId="ADAL" clId="{222B0C45-443E-4686-B439-70284A2F34B6}" dt="2022-03-16T06:42:25.709" v="449" actId="1076"/>
          <ac:spMkLst>
            <pc:docMk/>
            <pc:sldMk cId="1127126126" sldId="271"/>
            <ac:spMk id="4" creationId="{A4CE1D67-01A2-405D-8F73-8194EBB96D6E}"/>
          </ac:spMkLst>
        </pc:spChg>
        <pc:spChg chg="add mod">
          <ac:chgData name="濵田　大治" userId="3dc346c6-a235-4d96-b756-7f3e038a9511" providerId="ADAL" clId="{222B0C45-443E-4686-B439-70284A2F34B6}" dt="2022-03-16T06:42:25.709" v="449" actId="1076"/>
          <ac:spMkLst>
            <pc:docMk/>
            <pc:sldMk cId="1127126126" sldId="271"/>
            <ac:spMk id="5" creationId="{CFB9BF18-8442-48C1-8202-A5E4EE5D85E6}"/>
          </ac:spMkLst>
        </pc:spChg>
        <pc:spChg chg="add mod">
          <ac:chgData name="濵田　大治" userId="3dc346c6-a235-4d96-b756-7f3e038a9511" providerId="ADAL" clId="{222B0C45-443E-4686-B439-70284A2F34B6}" dt="2022-03-16T06:42:25.709" v="449" actId="1076"/>
          <ac:spMkLst>
            <pc:docMk/>
            <pc:sldMk cId="1127126126" sldId="271"/>
            <ac:spMk id="6" creationId="{D98CB406-33DA-4EB9-A4AD-B662A906C4BC}"/>
          </ac:spMkLst>
        </pc:spChg>
        <pc:spChg chg="add mod">
          <ac:chgData name="濵田　大治" userId="3dc346c6-a235-4d96-b756-7f3e038a9511" providerId="ADAL" clId="{222B0C45-443E-4686-B439-70284A2F34B6}" dt="2022-03-16T06:42:25.709" v="449" actId="1076"/>
          <ac:spMkLst>
            <pc:docMk/>
            <pc:sldMk cId="1127126126" sldId="271"/>
            <ac:spMk id="10" creationId="{08F25A8D-B682-4564-B8F9-F4A896800114}"/>
          </ac:spMkLst>
        </pc:spChg>
        <pc:spChg chg="add mod">
          <ac:chgData name="濵田　大治" userId="3dc346c6-a235-4d96-b756-7f3e038a9511" providerId="ADAL" clId="{222B0C45-443E-4686-B439-70284A2F34B6}" dt="2022-03-16T06:47:40.029" v="464" actId="1076"/>
          <ac:spMkLst>
            <pc:docMk/>
            <pc:sldMk cId="1127126126" sldId="271"/>
            <ac:spMk id="14" creationId="{EB7AA6B5-58B6-4876-9AD3-3708C726F024}"/>
          </ac:spMkLst>
        </pc:spChg>
        <pc:spChg chg="add del mod">
          <ac:chgData name="濵田　大治" userId="3dc346c6-a235-4d96-b756-7f3e038a9511" providerId="ADAL" clId="{222B0C45-443E-4686-B439-70284A2F34B6}" dt="2022-03-16T06:48:19.023" v="492" actId="478"/>
          <ac:spMkLst>
            <pc:docMk/>
            <pc:sldMk cId="1127126126" sldId="271"/>
            <ac:spMk id="15" creationId="{690FF493-DF2D-49B1-B4F9-C71860697509}"/>
          </ac:spMkLst>
        </pc:spChg>
        <pc:spChg chg="add mod">
          <ac:chgData name="濵田　大治" userId="3dc346c6-a235-4d96-b756-7f3e038a9511" providerId="ADAL" clId="{222B0C45-443E-4686-B439-70284A2F34B6}" dt="2022-03-16T06:49:05.135" v="501" actId="1076"/>
          <ac:spMkLst>
            <pc:docMk/>
            <pc:sldMk cId="1127126126" sldId="271"/>
            <ac:spMk id="18" creationId="{7D4C7E72-338A-4D9C-BD04-3292A5A5104E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20" creationId="{1613CEAE-9418-4313-8537-0BF9E7164EDC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21" creationId="{E9F85505-F283-49F1-8A74-237A8FEA9FC3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22" creationId="{D92372CF-7303-4147-9C9F-E4C545EF3A13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23" creationId="{63530E9C-0C23-4A5E-9693-48F2AE5C6831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24" creationId="{8BE47E5D-9665-43B3-B100-A64DF3392566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25" creationId="{F65698DC-1144-453B-84EA-75C0D7AF1F9F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26" creationId="{F4945D81-85D0-4D6A-9999-16A76C35FA08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27" creationId="{6F16224C-9989-4450-A76E-2CD74A6ADEB0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28" creationId="{E5B7042F-0E5C-4AD6-B37C-1E34B167B8CE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29" creationId="{666AB90D-9F64-4645-A168-82C2D7497075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30" creationId="{F33B9DCD-3091-4956-A35E-94AA872F36A8}"/>
          </ac:spMkLst>
        </pc:spChg>
        <pc:spChg chg="add mod">
          <ac:chgData name="濵田　大治" userId="3dc346c6-a235-4d96-b756-7f3e038a9511" providerId="ADAL" clId="{222B0C45-443E-4686-B439-70284A2F34B6}" dt="2022-03-16T06:49:44.023" v="504" actId="1076"/>
          <ac:spMkLst>
            <pc:docMk/>
            <pc:sldMk cId="1127126126" sldId="271"/>
            <ac:spMk id="34" creationId="{F3A69DFE-CF56-4E3A-8620-55B97D67F675}"/>
          </ac:spMkLst>
        </pc:spChg>
        <pc:spChg chg="add mod">
          <ac:chgData name="濵田　大治" userId="3dc346c6-a235-4d96-b756-7f3e038a9511" providerId="ADAL" clId="{222B0C45-443E-4686-B439-70284A2F34B6}" dt="2022-03-16T10:15:37.164" v="614" actId="1036"/>
          <ac:spMkLst>
            <pc:docMk/>
            <pc:sldMk cId="1127126126" sldId="271"/>
            <ac:spMk id="35" creationId="{9A54D9E4-38DF-49BB-95E0-976B6FEE65FE}"/>
          </ac:spMkLst>
        </pc:spChg>
        <pc:spChg chg="add mod">
          <ac:chgData name="濵田　大治" userId="3dc346c6-a235-4d96-b756-7f3e038a9511" providerId="ADAL" clId="{222B0C45-443E-4686-B439-70284A2F34B6}" dt="2022-03-16T10:15:37.164" v="614" actId="1036"/>
          <ac:spMkLst>
            <pc:docMk/>
            <pc:sldMk cId="1127126126" sldId="271"/>
            <ac:spMk id="36" creationId="{3E63641E-B4CB-4B53-A54A-68D14493E043}"/>
          </ac:spMkLst>
        </pc:spChg>
        <pc:spChg chg="add mod">
          <ac:chgData name="濵田　大治" userId="3dc346c6-a235-4d96-b756-7f3e038a9511" providerId="ADAL" clId="{222B0C45-443E-4686-B439-70284A2F34B6}" dt="2022-03-16T10:15:37.164" v="614" actId="1036"/>
          <ac:spMkLst>
            <pc:docMk/>
            <pc:sldMk cId="1127126126" sldId="271"/>
            <ac:spMk id="40" creationId="{56DA81E2-2A1C-4520-8C74-180EDF1A6807}"/>
          </ac:spMkLst>
        </pc:spChg>
        <pc:spChg chg="add mod">
          <ac:chgData name="濵田　大治" userId="3dc346c6-a235-4d96-b756-7f3e038a9511" providerId="ADAL" clId="{222B0C45-443E-4686-B439-70284A2F34B6}" dt="2022-03-16T10:15:37.164" v="614" actId="1036"/>
          <ac:spMkLst>
            <pc:docMk/>
            <pc:sldMk cId="1127126126" sldId="271"/>
            <ac:spMk id="41" creationId="{6CD1B970-3229-4DF5-9240-C6344A4EFF72}"/>
          </ac:spMkLst>
        </pc:spChg>
        <pc:spChg chg="add mod">
          <ac:chgData name="濵田　大治" userId="3dc346c6-a235-4d96-b756-7f3e038a9511" providerId="ADAL" clId="{222B0C45-443E-4686-B439-70284A2F34B6}" dt="2022-03-16T06:50:08.734" v="506" actId="1076"/>
          <ac:spMkLst>
            <pc:docMk/>
            <pc:sldMk cId="1127126126" sldId="271"/>
            <ac:spMk id="42" creationId="{AEE60B3C-D3B9-433A-A5C2-D6061ED73FAA}"/>
          </ac:spMkLst>
        </pc:spChg>
        <pc:spChg chg="add mod">
          <ac:chgData name="濵田　大治" userId="3dc346c6-a235-4d96-b756-7f3e038a9511" providerId="ADAL" clId="{222B0C45-443E-4686-B439-70284A2F34B6}" dt="2022-03-16T06:50:08.734" v="506" actId="1076"/>
          <ac:spMkLst>
            <pc:docMk/>
            <pc:sldMk cId="1127126126" sldId="271"/>
            <ac:spMk id="43" creationId="{109D074F-B7FF-414E-8626-ACF1D8D37509}"/>
          </ac:spMkLst>
        </pc:spChg>
        <pc:spChg chg="add mod">
          <ac:chgData name="濵田　大治" userId="3dc346c6-a235-4d96-b756-7f3e038a9511" providerId="ADAL" clId="{222B0C45-443E-4686-B439-70284A2F34B6}" dt="2022-03-16T06:50:08.734" v="506" actId="1076"/>
          <ac:spMkLst>
            <pc:docMk/>
            <pc:sldMk cId="1127126126" sldId="271"/>
            <ac:spMk id="47" creationId="{0F5CAE15-4239-406F-8A84-CF63F1BA798D}"/>
          </ac:spMkLst>
        </pc:spChg>
        <pc:spChg chg="add mod">
          <ac:chgData name="濵田　大治" userId="3dc346c6-a235-4d96-b756-7f3e038a9511" providerId="ADAL" clId="{222B0C45-443E-4686-B439-70284A2F34B6}" dt="2022-03-16T06:50:08.734" v="506" actId="1076"/>
          <ac:spMkLst>
            <pc:docMk/>
            <pc:sldMk cId="1127126126" sldId="271"/>
            <ac:spMk id="48" creationId="{DEA5078E-C935-4B36-9A52-7D99A7BFC421}"/>
          </ac:spMkLst>
        </pc:spChg>
        <pc:spChg chg="add mod">
          <ac:chgData name="濵田　大治" userId="3dc346c6-a235-4d96-b756-7f3e038a9511" providerId="ADAL" clId="{222B0C45-443E-4686-B439-70284A2F34B6}" dt="2022-03-16T10:15:26.107" v="576" actId="1076"/>
          <ac:spMkLst>
            <pc:docMk/>
            <pc:sldMk cId="1127126126" sldId="271"/>
            <ac:spMk id="49" creationId="{FF41D394-FFB2-4AC8-A76E-E04419C69BF1}"/>
          </ac:spMkLst>
        </pc:spChg>
        <pc:spChg chg="add mod">
          <ac:chgData name="濵田　大治" userId="3dc346c6-a235-4d96-b756-7f3e038a9511" providerId="ADAL" clId="{222B0C45-443E-4686-B439-70284A2F34B6}" dt="2022-03-16T10:15:37.164" v="614" actId="1036"/>
          <ac:spMkLst>
            <pc:docMk/>
            <pc:sldMk cId="1127126126" sldId="271"/>
            <ac:spMk id="50" creationId="{B840C553-9D61-48F7-977A-CAC84F1F6E2C}"/>
          </ac:spMkLst>
        </pc:spChg>
        <pc:spChg chg="add del mod">
          <ac:chgData name="濵田　大治" userId="3dc346c6-a235-4d96-b756-7f3e038a9511" providerId="ADAL" clId="{222B0C45-443E-4686-B439-70284A2F34B6}" dt="2022-03-16T10:15:09.384" v="522" actId="478"/>
          <ac:spMkLst>
            <pc:docMk/>
            <pc:sldMk cId="1127126126" sldId="271"/>
            <ac:spMk id="51" creationId="{24C037AC-1C5F-4CE9-9105-2720FF76DF75}"/>
          </ac:spMkLst>
        </pc:spChg>
        <pc:spChg chg="add mod">
          <ac:chgData name="濵田　大治" userId="3dc346c6-a235-4d96-b756-7f3e038a9511" providerId="ADAL" clId="{222B0C45-443E-4686-B439-70284A2F34B6}" dt="2022-03-16T10:15:37.164" v="614" actId="1036"/>
          <ac:spMkLst>
            <pc:docMk/>
            <pc:sldMk cId="1127126126" sldId="271"/>
            <ac:spMk id="52" creationId="{6E8B6DE9-2830-45D2-9583-5F68878C7837}"/>
          </ac:spMkLst>
        </pc:spChg>
        <pc:spChg chg="add mod">
          <ac:chgData name="濵田　大治" userId="3dc346c6-a235-4d96-b756-7f3e038a9511" providerId="ADAL" clId="{222B0C45-443E-4686-B439-70284A2F34B6}" dt="2022-03-16T10:15:37.164" v="614" actId="1036"/>
          <ac:spMkLst>
            <pc:docMk/>
            <pc:sldMk cId="1127126126" sldId="271"/>
            <ac:spMk id="53" creationId="{01EBA11C-B80D-436F-8654-9EE2E06D0DEC}"/>
          </ac:spMkLst>
        </pc:spChg>
        <pc:grpChg chg="add mod">
          <ac:chgData name="濵田　大治" userId="3dc346c6-a235-4d96-b756-7f3e038a9511" providerId="ADAL" clId="{222B0C45-443E-4686-B439-70284A2F34B6}" dt="2022-03-16T06:42:25.709" v="449" actId="1076"/>
          <ac:grpSpMkLst>
            <pc:docMk/>
            <pc:sldMk cId="1127126126" sldId="271"/>
            <ac:grpSpMk id="7" creationId="{D0FC0B3E-47C0-4AC7-8551-0921635F4895}"/>
          </ac:grpSpMkLst>
        </pc:grpChg>
        <pc:grpChg chg="add mod">
          <ac:chgData name="濵田　大治" userId="3dc346c6-a235-4d96-b756-7f3e038a9511" providerId="ADAL" clId="{222B0C45-443E-4686-B439-70284A2F34B6}" dt="2022-03-16T06:49:44.023" v="504" actId="1076"/>
          <ac:grpSpMkLst>
            <pc:docMk/>
            <pc:sldMk cId="1127126126" sldId="271"/>
            <ac:grpSpMk id="31" creationId="{D53C7F3D-BA0B-4FAC-900F-71CD863FA140}"/>
          </ac:grpSpMkLst>
        </pc:grpChg>
        <pc:grpChg chg="add mod">
          <ac:chgData name="濵田　大治" userId="3dc346c6-a235-4d96-b756-7f3e038a9511" providerId="ADAL" clId="{222B0C45-443E-4686-B439-70284A2F34B6}" dt="2022-03-16T10:15:37.164" v="614" actId="1036"/>
          <ac:grpSpMkLst>
            <pc:docMk/>
            <pc:sldMk cId="1127126126" sldId="271"/>
            <ac:grpSpMk id="37" creationId="{92D1ABA3-962B-40DE-BC7E-66E32F9756D5}"/>
          </ac:grpSpMkLst>
        </pc:grpChg>
        <pc:grpChg chg="add mod">
          <ac:chgData name="濵田　大治" userId="3dc346c6-a235-4d96-b756-7f3e038a9511" providerId="ADAL" clId="{222B0C45-443E-4686-B439-70284A2F34B6}" dt="2022-03-16T06:50:08.734" v="506" actId="1076"/>
          <ac:grpSpMkLst>
            <pc:docMk/>
            <pc:sldMk cId="1127126126" sldId="271"/>
            <ac:grpSpMk id="44" creationId="{3286733B-3773-4CDE-9B48-30D3ED63FF79}"/>
          </ac:grpSpMkLst>
        </pc:grpChg>
        <pc:cxnChg chg="mod">
          <ac:chgData name="濵田　大治" userId="3dc346c6-a235-4d96-b756-7f3e038a9511" providerId="ADAL" clId="{222B0C45-443E-4686-B439-70284A2F34B6}" dt="2022-03-16T06:42:19.362" v="448"/>
          <ac:cxnSpMkLst>
            <pc:docMk/>
            <pc:sldMk cId="1127126126" sldId="271"/>
            <ac:cxnSpMk id="8" creationId="{F85F4094-C771-4CDD-ABA0-8CB65F30A7C9}"/>
          </ac:cxnSpMkLst>
        </pc:cxnChg>
        <pc:cxnChg chg="mod">
          <ac:chgData name="濵田　大治" userId="3dc346c6-a235-4d96-b756-7f3e038a9511" providerId="ADAL" clId="{222B0C45-443E-4686-B439-70284A2F34B6}" dt="2022-03-16T06:42:19.362" v="448"/>
          <ac:cxnSpMkLst>
            <pc:docMk/>
            <pc:sldMk cId="1127126126" sldId="271"/>
            <ac:cxnSpMk id="9" creationId="{EBD759D7-8AC2-421A-8336-204C48452D2D}"/>
          </ac:cxnSpMkLst>
        </pc:cxnChg>
        <pc:cxnChg chg="add del mod">
          <ac:chgData name="濵田　大治" userId="3dc346c6-a235-4d96-b756-7f3e038a9511" providerId="ADAL" clId="{222B0C45-443E-4686-B439-70284A2F34B6}" dt="2022-03-16T06:47:47.042" v="466" actId="478"/>
          <ac:cxnSpMkLst>
            <pc:docMk/>
            <pc:sldMk cId="1127126126" sldId="271"/>
            <ac:cxnSpMk id="12" creationId="{F0E57FB2-4083-4D18-A208-465EB014D50B}"/>
          </ac:cxnSpMkLst>
        </pc:cxnChg>
        <pc:cxnChg chg="add del mod">
          <ac:chgData name="濵田　大治" userId="3dc346c6-a235-4d96-b756-7f3e038a9511" providerId="ADAL" clId="{222B0C45-443E-4686-B439-70284A2F34B6}" dt="2022-03-16T06:47:45.982" v="465" actId="478"/>
          <ac:cxnSpMkLst>
            <pc:docMk/>
            <pc:sldMk cId="1127126126" sldId="271"/>
            <ac:cxnSpMk id="13" creationId="{6BD640B7-0172-42D9-9A80-07F11925D401}"/>
          </ac:cxnSpMkLst>
        </pc:cxnChg>
        <pc:cxnChg chg="add mod">
          <ac:chgData name="濵田　大治" userId="3dc346c6-a235-4d96-b756-7f3e038a9511" providerId="ADAL" clId="{222B0C45-443E-4686-B439-70284A2F34B6}" dt="2022-03-16T06:49:09.041" v="502" actId="14100"/>
          <ac:cxnSpMkLst>
            <pc:docMk/>
            <pc:sldMk cId="1127126126" sldId="271"/>
            <ac:cxnSpMk id="17" creationId="{B1FB1F04-3A26-45EC-A741-C22690D26E65}"/>
          </ac:cxnSpMkLst>
        </pc:cxnChg>
        <pc:cxnChg chg="mod">
          <ac:chgData name="濵田　大治" userId="3dc346c6-a235-4d96-b756-7f3e038a9511" providerId="ADAL" clId="{222B0C45-443E-4686-B439-70284A2F34B6}" dt="2022-03-16T06:49:35.651" v="503"/>
          <ac:cxnSpMkLst>
            <pc:docMk/>
            <pc:sldMk cId="1127126126" sldId="271"/>
            <ac:cxnSpMk id="32" creationId="{2E6997BA-29E7-4AB6-8E8B-667DBDE84051}"/>
          </ac:cxnSpMkLst>
        </pc:cxnChg>
        <pc:cxnChg chg="mod">
          <ac:chgData name="濵田　大治" userId="3dc346c6-a235-4d96-b756-7f3e038a9511" providerId="ADAL" clId="{222B0C45-443E-4686-B439-70284A2F34B6}" dt="2022-03-16T06:49:35.651" v="503"/>
          <ac:cxnSpMkLst>
            <pc:docMk/>
            <pc:sldMk cId="1127126126" sldId="271"/>
            <ac:cxnSpMk id="33" creationId="{83B879BC-3D66-4D05-9EBB-457D92B2E9F2}"/>
          </ac:cxnSpMkLst>
        </pc:cxnChg>
        <pc:cxnChg chg="mod">
          <ac:chgData name="濵田　大治" userId="3dc346c6-a235-4d96-b756-7f3e038a9511" providerId="ADAL" clId="{222B0C45-443E-4686-B439-70284A2F34B6}" dt="2022-03-16T06:50:03.414" v="505"/>
          <ac:cxnSpMkLst>
            <pc:docMk/>
            <pc:sldMk cId="1127126126" sldId="271"/>
            <ac:cxnSpMk id="38" creationId="{8D1F3EE1-996D-4D98-87DF-9282C453ED35}"/>
          </ac:cxnSpMkLst>
        </pc:cxnChg>
        <pc:cxnChg chg="mod">
          <ac:chgData name="濵田　大治" userId="3dc346c6-a235-4d96-b756-7f3e038a9511" providerId="ADAL" clId="{222B0C45-443E-4686-B439-70284A2F34B6}" dt="2022-03-16T06:50:03.414" v="505"/>
          <ac:cxnSpMkLst>
            <pc:docMk/>
            <pc:sldMk cId="1127126126" sldId="271"/>
            <ac:cxnSpMk id="39" creationId="{B741EDC6-F8AA-45B1-9FF2-A44A7DE2C476}"/>
          </ac:cxnSpMkLst>
        </pc:cxnChg>
        <pc:cxnChg chg="mod">
          <ac:chgData name="濵田　大治" userId="3dc346c6-a235-4d96-b756-7f3e038a9511" providerId="ADAL" clId="{222B0C45-443E-4686-B439-70284A2F34B6}" dt="2022-03-16T06:50:03.414" v="505"/>
          <ac:cxnSpMkLst>
            <pc:docMk/>
            <pc:sldMk cId="1127126126" sldId="271"/>
            <ac:cxnSpMk id="45" creationId="{918CD718-41A9-4601-A951-6D7F3AD7E1FF}"/>
          </ac:cxnSpMkLst>
        </pc:cxnChg>
        <pc:cxnChg chg="mod">
          <ac:chgData name="濵田　大治" userId="3dc346c6-a235-4d96-b756-7f3e038a9511" providerId="ADAL" clId="{222B0C45-443E-4686-B439-70284A2F34B6}" dt="2022-03-16T06:50:03.414" v="505"/>
          <ac:cxnSpMkLst>
            <pc:docMk/>
            <pc:sldMk cId="1127126126" sldId="271"/>
            <ac:cxnSpMk id="46" creationId="{A987DA67-A1DB-4B50-8FE4-81750F8FE723}"/>
          </ac:cxnSpMkLst>
        </pc:cxnChg>
      </pc:sldChg>
      <pc:sldChg chg="addSp delSp modSp mod">
        <pc:chgData name="濵田　大治" userId="3dc346c6-a235-4d96-b756-7f3e038a9511" providerId="ADAL" clId="{222B0C45-443E-4686-B439-70284A2F34B6}" dt="2022-05-11T04:50:22.070" v="920" actId="1076"/>
        <pc:sldMkLst>
          <pc:docMk/>
          <pc:sldMk cId="148004252" sldId="277"/>
        </pc:sldMkLst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" creationId="{49285A78-98B2-8AD6-345F-116EE5BEF92B}"/>
          </ac:spMkLst>
        </pc:spChg>
        <pc:spChg chg="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5" creationId="{00000000-0000-0000-0000-000000000000}"/>
          </ac:spMkLst>
        </pc:spChg>
        <pc:spChg chg="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9" creationId="{00000000-0000-0000-0000-000000000000}"/>
          </ac:spMkLst>
        </pc:spChg>
        <pc:spChg chg="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11" creationId="{00000000-0000-0000-0000-000000000000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12" creationId="{D9EA6560-EABA-040E-CF71-6DBA9FCE7DAD}"/>
          </ac:spMkLst>
        </pc:spChg>
        <pc:spChg chg="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14" creationId="{00000000-0000-0000-0000-000000000000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15" creationId="{FC790773-721A-4311-C61E-A64CBE1D453E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16" creationId="{AAC6266C-C659-861F-B6ED-7A95099A3B94}"/>
          </ac:spMkLst>
        </pc:spChg>
        <pc:spChg chg="add del mod">
          <ac:chgData name="濵田　大治" userId="3dc346c6-a235-4d96-b756-7f3e038a9511" providerId="ADAL" clId="{222B0C45-443E-4686-B439-70284A2F34B6}" dt="2022-05-11T03:56:48.184" v="756" actId="478"/>
          <ac:spMkLst>
            <pc:docMk/>
            <pc:sldMk cId="148004252" sldId="277"/>
            <ac:spMk id="17" creationId="{210B5216-8492-63C5-1FA9-5087FA9E6B1B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0" creationId="{5483A296-19A7-95DF-6456-B62BC573267E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1" creationId="{F37BFE20-CE1C-04A3-72B7-52373093820D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2" creationId="{1A7F4D6B-B5EB-10A4-7F47-D85E66FA9FA2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3" creationId="{E2474441-B704-BCAD-018C-D9751D4030C6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4" creationId="{22E0FF65-614C-BAAD-BEF0-A4C59355263B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5" creationId="{3E78C8AA-A227-E76F-C581-3E259523B5DD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6" creationId="{BF1A9C5C-A1AF-23BA-C8F7-2539627DEF0E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7" creationId="{BA29378F-73B3-F63F-B9B4-A0A23F49F87D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8" creationId="{F0FB865E-8821-7AA0-5610-0034E616BBE5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29" creationId="{9D00C697-73B7-8326-BE7C-B5C6310DF7E4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30" creationId="{F5883EF2-26E4-C84F-3234-F3E77CF7D617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31" creationId="{924CE0C0-C6C2-55A1-4B03-9597FEA90454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32" creationId="{B83061F3-D134-8748-1ACC-ADD0D0B1CC6F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33" creationId="{993E1591-A9E5-214C-2EF5-A03214CB6563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34" creationId="{DBD47F0D-C52E-FC38-0B85-B8B6696DB37A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35" creationId="{59815C96-9D23-4DCE-F094-EC48EC0C04E2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36" creationId="{C207A261-44EC-FA32-794D-D07CCF77B85F}"/>
          </ac:spMkLst>
        </pc:spChg>
        <pc:spChg chg="add mod">
          <ac:chgData name="濵田　大治" userId="3dc346c6-a235-4d96-b756-7f3e038a9511" providerId="ADAL" clId="{222B0C45-443E-4686-B439-70284A2F34B6}" dt="2022-05-11T04:50:22.070" v="920" actId="1076"/>
          <ac:spMkLst>
            <pc:docMk/>
            <pc:sldMk cId="148004252" sldId="277"/>
            <ac:spMk id="37" creationId="{FB1DFE69-4A93-FD1F-1BC6-6AFE3612CA9C}"/>
          </ac:spMkLst>
        </pc:spChg>
        <pc:spChg chg="add del mod">
          <ac:chgData name="濵田　大治" userId="3dc346c6-a235-4d96-b756-7f3e038a9511" providerId="ADAL" clId="{222B0C45-443E-4686-B439-70284A2F34B6}" dt="2022-05-11T04:49:52.007" v="917" actId="478"/>
          <ac:spMkLst>
            <pc:docMk/>
            <pc:sldMk cId="148004252" sldId="277"/>
            <ac:spMk id="38" creationId="{E33ADD0F-AA3F-8AA1-AFAB-7CD4EE78B8BD}"/>
          </ac:spMkLst>
        </pc:spChg>
        <pc:spChg chg="add del mod">
          <ac:chgData name="濵田　大治" userId="3dc346c6-a235-4d96-b756-7f3e038a9511" providerId="ADAL" clId="{222B0C45-443E-4686-B439-70284A2F34B6}" dt="2022-05-11T04:49:49.815" v="916" actId="478"/>
          <ac:spMkLst>
            <pc:docMk/>
            <pc:sldMk cId="148004252" sldId="277"/>
            <ac:spMk id="39" creationId="{03117D24-E102-C7AA-C2A7-C7F6F0127EE7}"/>
          </ac:spMkLst>
        </pc:spChg>
        <pc:spChg chg="add del mod">
          <ac:chgData name="濵田　大治" userId="3dc346c6-a235-4d96-b756-7f3e038a9511" providerId="ADAL" clId="{222B0C45-443E-4686-B439-70284A2F34B6}" dt="2022-05-11T04:49:46.806" v="915" actId="478"/>
          <ac:spMkLst>
            <pc:docMk/>
            <pc:sldMk cId="148004252" sldId="277"/>
            <ac:spMk id="40" creationId="{8A512E30-CE5A-7F17-9642-DE561A1DEEB8}"/>
          </ac:spMkLst>
        </pc:spChg>
        <pc:spChg chg="add del mod">
          <ac:chgData name="濵田　大治" userId="3dc346c6-a235-4d96-b756-7f3e038a9511" providerId="ADAL" clId="{222B0C45-443E-4686-B439-70284A2F34B6}" dt="2022-05-11T04:49:55.138" v="918" actId="478"/>
          <ac:spMkLst>
            <pc:docMk/>
            <pc:sldMk cId="148004252" sldId="277"/>
            <ac:spMk id="41" creationId="{F419E392-8915-858E-43D7-62F9B35E2AAF}"/>
          </ac:spMkLst>
        </pc:spChg>
        <pc:picChg chg="mod">
          <ac:chgData name="濵田　大治" userId="3dc346c6-a235-4d96-b756-7f3e038a9511" providerId="ADAL" clId="{222B0C45-443E-4686-B439-70284A2F34B6}" dt="2022-05-11T04:50:22.070" v="920" actId="1076"/>
          <ac:picMkLst>
            <pc:docMk/>
            <pc:sldMk cId="148004252" sldId="277"/>
            <ac:picMk id="3" creationId="{00000000-0000-0000-0000-000000000000}"/>
          </ac:picMkLst>
        </pc:picChg>
        <pc:picChg chg="mod">
          <ac:chgData name="濵田　大治" userId="3dc346c6-a235-4d96-b756-7f3e038a9511" providerId="ADAL" clId="{222B0C45-443E-4686-B439-70284A2F34B6}" dt="2022-05-11T04:50:22.070" v="920" actId="1076"/>
          <ac:picMkLst>
            <pc:docMk/>
            <pc:sldMk cId="148004252" sldId="277"/>
            <ac:picMk id="6" creationId="{00000000-0000-0000-0000-000000000000}"/>
          </ac:picMkLst>
        </pc:picChg>
        <pc:cxnChg chg="add mod">
          <ac:chgData name="濵田　大治" userId="3dc346c6-a235-4d96-b756-7f3e038a9511" providerId="ADAL" clId="{222B0C45-443E-4686-B439-70284A2F34B6}" dt="2022-05-11T04:50:22.070" v="920" actId="1076"/>
          <ac:cxnSpMkLst>
            <pc:docMk/>
            <pc:sldMk cId="148004252" sldId="277"/>
            <ac:cxnSpMk id="7" creationId="{04B894B1-BE22-DB31-7CDE-920F43B7C3B3}"/>
          </ac:cxnSpMkLst>
        </pc:cxnChg>
        <pc:cxnChg chg="mod">
          <ac:chgData name="濵田　大治" userId="3dc346c6-a235-4d96-b756-7f3e038a9511" providerId="ADAL" clId="{222B0C45-443E-4686-B439-70284A2F34B6}" dt="2022-05-11T04:50:22.070" v="920" actId="1076"/>
          <ac:cxnSpMkLst>
            <pc:docMk/>
            <pc:sldMk cId="148004252" sldId="277"/>
            <ac:cxnSpMk id="8" creationId="{00000000-0000-0000-0000-000000000000}"/>
          </ac:cxnSpMkLst>
        </pc:cxnChg>
        <pc:cxnChg chg="mod">
          <ac:chgData name="濵田　大治" userId="3dc346c6-a235-4d96-b756-7f3e038a9511" providerId="ADAL" clId="{222B0C45-443E-4686-B439-70284A2F34B6}" dt="2022-05-11T04:50:22.070" v="920" actId="1076"/>
          <ac:cxnSpMkLst>
            <pc:docMk/>
            <pc:sldMk cId="148004252" sldId="277"/>
            <ac:cxnSpMk id="10" creationId="{00000000-0000-0000-0000-000000000000}"/>
          </ac:cxnSpMkLst>
        </pc:cxnChg>
        <pc:cxnChg chg="mod">
          <ac:chgData name="濵田　大治" userId="3dc346c6-a235-4d96-b756-7f3e038a9511" providerId="ADAL" clId="{222B0C45-443E-4686-B439-70284A2F34B6}" dt="2022-05-11T04:50:22.070" v="920" actId="1076"/>
          <ac:cxnSpMkLst>
            <pc:docMk/>
            <pc:sldMk cId="148004252" sldId="277"/>
            <ac:cxnSpMk id="13" creationId="{00000000-0000-0000-0000-000000000000}"/>
          </ac:cxnSpMkLst>
        </pc:cxnChg>
        <pc:cxnChg chg="add del mod">
          <ac:chgData name="濵田　大治" userId="3dc346c6-a235-4d96-b756-7f3e038a9511" providerId="ADAL" clId="{222B0C45-443E-4686-B439-70284A2F34B6}" dt="2022-05-11T04:49:58.780" v="919" actId="478"/>
          <ac:cxnSpMkLst>
            <pc:docMk/>
            <pc:sldMk cId="148004252" sldId="277"/>
            <ac:cxnSpMk id="19" creationId="{C623E8AE-5C1B-348B-CE09-02F4DDFB12AC}"/>
          </ac:cxnSpMkLst>
        </pc:cxnChg>
      </pc:sldChg>
    </pc:docChg>
  </pc:docChgLst>
  <pc:docChgLst>
    <pc:chgData name="濵田　大治" userId="S::k5905755@kadai.jp::3dc346c6-a235-4d96-b756-7f3e038a9511" providerId="AD" clId="Web-{E9172964-C3AC-7B46-F7D2-C4223233ED1A}"/>
    <pc:docChg chg="modSld">
      <pc:chgData name="濵田　大治" userId="S::k5905755@kadai.jp::3dc346c6-a235-4d96-b756-7f3e038a9511" providerId="AD" clId="Web-{E9172964-C3AC-7B46-F7D2-C4223233ED1A}" dt="2022-03-25T02:56:56.828" v="264" actId="20577"/>
      <pc:docMkLst>
        <pc:docMk/>
      </pc:docMkLst>
      <pc:sldChg chg="addSp delSp modSp">
        <pc:chgData name="濵田　大治" userId="S::k5905755@kadai.jp::3dc346c6-a235-4d96-b756-7f3e038a9511" providerId="AD" clId="Web-{E9172964-C3AC-7B46-F7D2-C4223233ED1A}" dt="2022-03-25T02:56:56.828" v="264" actId="20577"/>
        <pc:sldMkLst>
          <pc:docMk/>
          <pc:sldMk cId="1127126126" sldId="271"/>
        </pc:sldMkLst>
        <pc:spChg chg="mod">
          <ac:chgData name="濵田　大治" userId="S::k5905755@kadai.jp::3dc346c6-a235-4d96-b756-7f3e038a9511" providerId="AD" clId="Web-{E9172964-C3AC-7B46-F7D2-C4223233ED1A}" dt="2022-03-25T02:56:56.828" v="264" actId="20577"/>
          <ac:spMkLst>
            <pc:docMk/>
            <pc:sldMk cId="1127126126" sldId="271"/>
            <ac:spMk id="3" creationId="{0174EA08-22EA-4444-9B6A-4AA766E76114}"/>
          </ac:spMkLst>
        </pc:spChg>
        <pc:spChg chg="mod">
          <ac:chgData name="濵田　大治" userId="S::k5905755@kadai.jp::3dc346c6-a235-4d96-b756-7f3e038a9511" providerId="AD" clId="Web-{E9172964-C3AC-7B46-F7D2-C4223233ED1A}" dt="2022-03-25T02:48:18.346" v="197" actId="1076"/>
          <ac:spMkLst>
            <pc:docMk/>
            <pc:sldMk cId="1127126126" sldId="271"/>
            <ac:spMk id="4" creationId="{A4CE1D67-01A2-405D-8F73-8194EBB96D6E}"/>
          </ac:spMkLst>
        </pc:spChg>
        <pc:spChg chg="mod">
          <ac:chgData name="濵田　大治" userId="S::k5905755@kadai.jp::3dc346c6-a235-4d96-b756-7f3e038a9511" providerId="AD" clId="Web-{E9172964-C3AC-7B46-F7D2-C4223233ED1A}" dt="2022-03-25T02:48:56.707" v="222" actId="1076"/>
          <ac:spMkLst>
            <pc:docMk/>
            <pc:sldMk cId="1127126126" sldId="271"/>
            <ac:spMk id="5" creationId="{CFB9BF18-8442-48C1-8202-A5E4EE5D85E6}"/>
          </ac:spMkLst>
        </pc:spChg>
        <pc:spChg chg="mod">
          <ac:chgData name="濵田　大治" userId="S::k5905755@kadai.jp::3dc346c6-a235-4d96-b756-7f3e038a9511" providerId="AD" clId="Web-{E9172964-C3AC-7B46-F7D2-C4223233ED1A}" dt="2022-03-25T02:48:56.707" v="223" actId="1076"/>
          <ac:spMkLst>
            <pc:docMk/>
            <pc:sldMk cId="1127126126" sldId="271"/>
            <ac:spMk id="6" creationId="{D98CB406-33DA-4EB9-A4AD-B662A906C4BC}"/>
          </ac:spMkLst>
        </pc:spChg>
        <pc:spChg chg="mod">
          <ac:chgData name="濵田　大治" userId="S::k5905755@kadai.jp::3dc346c6-a235-4d96-b756-7f3e038a9511" providerId="AD" clId="Web-{E9172964-C3AC-7B46-F7D2-C4223233ED1A}" dt="2022-03-25T02:48:56.707" v="225" actId="1076"/>
          <ac:spMkLst>
            <pc:docMk/>
            <pc:sldMk cId="1127126126" sldId="271"/>
            <ac:spMk id="10" creationId="{08F25A8D-B682-4564-B8F9-F4A896800114}"/>
          </ac:spMkLst>
        </pc:spChg>
        <pc:spChg chg="add mod">
          <ac:chgData name="濵田　大治" userId="S::k5905755@kadai.jp::3dc346c6-a235-4d96-b756-7f3e038a9511" providerId="AD" clId="Web-{E9172964-C3AC-7B46-F7D2-C4223233ED1A}" dt="2022-03-25T02:36:35.657" v="140" actId="1076"/>
          <ac:spMkLst>
            <pc:docMk/>
            <pc:sldMk cId="1127126126" sldId="271"/>
            <ac:spMk id="11" creationId="{40ABFE53-9F2D-BF65-DFA0-F86525698315}"/>
          </ac:spMkLst>
        </pc:spChg>
        <pc:spChg chg="del mod">
          <ac:chgData name="濵田　大治" userId="S::k5905755@kadai.jp::3dc346c6-a235-4d96-b756-7f3e038a9511" providerId="AD" clId="Web-{E9172964-C3AC-7B46-F7D2-C4223233ED1A}" dt="2022-03-25T02:55:52.561" v="239"/>
          <ac:spMkLst>
            <pc:docMk/>
            <pc:sldMk cId="1127126126" sldId="271"/>
            <ac:spMk id="14" creationId="{EB7AA6B5-58B6-4876-9AD3-3708C726F024}"/>
          </ac:spMkLst>
        </pc:spChg>
        <pc:spChg chg="del mod">
          <ac:chgData name="濵田　大治" userId="S::k5905755@kadai.jp::3dc346c6-a235-4d96-b756-7f3e038a9511" providerId="AD" clId="Web-{E9172964-C3AC-7B46-F7D2-C4223233ED1A}" dt="2022-03-25T02:55:51.482" v="238"/>
          <ac:spMkLst>
            <pc:docMk/>
            <pc:sldMk cId="1127126126" sldId="271"/>
            <ac:spMk id="18" creationId="{7D4C7E72-338A-4D9C-BD04-3292A5A5104E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256" v="55" actId="1076"/>
          <ac:spMkLst>
            <pc:docMk/>
            <pc:sldMk cId="1127126126" sldId="271"/>
            <ac:spMk id="20" creationId="{1613CEAE-9418-4313-8537-0BF9E7164EDC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271" v="56" actId="1076"/>
          <ac:spMkLst>
            <pc:docMk/>
            <pc:sldMk cId="1127126126" sldId="271"/>
            <ac:spMk id="21" creationId="{E9F85505-F283-49F1-8A74-237A8FEA9FC3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303" v="57" actId="1076"/>
          <ac:spMkLst>
            <pc:docMk/>
            <pc:sldMk cId="1127126126" sldId="271"/>
            <ac:spMk id="22" creationId="{D92372CF-7303-4147-9C9F-E4C545EF3A13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318" v="58" actId="1076"/>
          <ac:spMkLst>
            <pc:docMk/>
            <pc:sldMk cId="1127126126" sldId="271"/>
            <ac:spMk id="23" creationId="{63530E9C-0C23-4A5E-9693-48F2AE5C6831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349" v="59" actId="1076"/>
          <ac:spMkLst>
            <pc:docMk/>
            <pc:sldMk cId="1127126126" sldId="271"/>
            <ac:spMk id="24" creationId="{8BE47E5D-9665-43B3-B100-A64DF3392566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365" v="60" actId="1076"/>
          <ac:spMkLst>
            <pc:docMk/>
            <pc:sldMk cId="1127126126" sldId="271"/>
            <ac:spMk id="25" creationId="{F65698DC-1144-453B-84EA-75C0D7AF1F9F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396" v="61" actId="1076"/>
          <ac:spMkLst>
            <pc:docMk/>
            <pc:sldMk cId="1127126126" sldId="271"/>
            <ac:spMk id="26" creationId="{F4945D81-85D0-4D6A-9999-16A76C35FA08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428" v="62" actId="1076"/>
          <ac:spMkLst>
            <pc:docMk/>
            <pc:sldMk cId="1127126126" sldId="271"/>
            <ac:spMk id="27" creationId="{6F16224C-9989-4450-A76E-2CD74A6ADEB0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443" v="63" actId="1076"/>
          <ac:spMkLst>
            <pc:docMk/>
            <pc:sldMk cId="1127126126" sldId="271"/>
            <ac:spMk id="28" creationId="{E5B7042F-0E5C-4AD6-B37C-1E34B167B8CE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474" v="64" actId="1076"/>
          <ac:spMkLst>
            <pc:docMk/>
            <pc:sldMk cId="1127126126" sldId="271"/>
            <ac:spMk id="29" creationId="{666AB90D-9F64-4645-A168-82C2D7497075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506" v="65" actId="1076"/>
          <ac:spMkLst>
            <pc:docMk/>
            <pc:sldMk cId="1127126126" sldId="271"/>
            <ac:spMk id="30" creationId="{F33B9DCD-3091-4956-A35E-94AA872F36A8}"/>
          </ac:spMkLst>
        </pc:spChg>
        <pc:spChg chg="mod">
          <ac:chgData name="濵田　大治" userId="S::k5905755@kadai.jp::3dc346c6-a235-4d96-b756-7f3e038a9511" providerId="AD" clId="Web-{E9172964-C3AC-7B46-F7D2-C4223233ED1A}" dt="2022-03-25T02:29:19.553" v="67" actId="1076"/>
          <ac:spMkLst>
            <pc:docMk/>
            <pc:sldMk cId="1127126126" sldId="271"/>
            <ac:spMk id="34" creationId="{F3A69DFE-CF56-4E3A-8620-55B97D67F675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570" v="116" actId="1076"/>
          <ac:spMkLst>
            <pc:docMk/>
            <pc:sldMk cId="1127126126" sldId="271"/>
            <ac:spMk id="35" creationId="{9A54D9E4-38DF-49BB-95E0-976B6FEE65FE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602" v="117" actId="1076"/>
          <ac:spMkLst>
            <pc:docMk/>
            <pc:sldMk cId="1127126126" sldId="271"/>
            <ac:spMk id="36" creationId="{3E63641E-B4CB-4B53-A54A-68D14493E043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664" v="119" actId="1076"/>
          <ac:spMkLst>
            <pc:docMk/>
            <pc:sldMk cId="1127126126" sldId="271"/>
            <ac:spMk id="40" creationId="{56DA81E2-2A1C-4520-8C74-180EDF1A6807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680" v="120" actId="1076"/>
          <ac:spMkLst>
            <pc:docMk/>
            <pc:sldMk cId="1127126126" sldId="271"/>
            <ac:spMk id="41" creationId="{6CD1B970-3229-4DF5-9240-C6344A4EFF72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711" v="121" actId="1076"/>
          <ac:spMkLst>
            <pc:docMk/>
            <pc:sldMk cId="1127126126" sldId="271"/>
            <ac:spMk id="42" creationId="{AEE60B3C-D3B9-433A-A5C2-D6061ED73FAA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742" v="122" actId="1076"/>
          <ac:spMkLst>
            <pc:docMk/>
            <pc:sldMk cId="1127126126" sldId="271"/>
            <ac:spMk id="43" creationId="{109D074F-B7FF-414E-8626-ACF1D8D37509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789" v="124" actId="1076"/>
          <ac:spMkLst>
            <pc:docMk/>
            <pc:sldMk cId="1127126126" sldId="271"/>
            <ac:spMk id="47" creationId="{0F5CAE15-4239-406F-8A84-CF63F1BA798D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820" v="125" actId="1076"/>
          <ac:spMkLst>
            <pc:docMk/>
            <pc:sldMk cId="1127126126" sldId="271"/>
            <ac:spMk id="48" creationId="{DEA5078E-C935-4B36-9A52-7D99A7BFC421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852" v="126" actId="1076"/>
          <ac:spMkLst>
            <pc:docMk/>
            <pc:sldMk cId="1127126126" sldId="271"/>
            <ac:spMk id="49" creationId="{FF41D394-FFB2-4AC8-A76E-E04419C69BF1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883" v="127" actId="1076"/>
          <ac:spMkLst>
            <pc:docMk/>
            <pc:sldMk cId="1127126126" sldId="271"/>
            <ac:spMk id="50" creationId="{B840C553-9D61-48F7-977A-CAC84F1F6E2C}"/>
          </ac:spMkLst>
        </pc:spChg>
        <pc:spChg chg="add mod">
          <ac:chgData name="濵田　大治" userId="S::k5905755@kadai.jp::3dc346c6-a235-4d96-b756-7f3e038a9511" providerId="AD" clId="Web-{E9172964-C3AC-7B46-F7D2-C4223233ED1A}" dt="2022-03-25T02:29:57.382" v="92" actId="1076"/>
          <ac:spMkLst>
            <pc:docMk/>
            <pc:sldMk cId="1127126126" sldId="271"/>
            <ac:spMk id="51" creationId="{4DD7670E-397B-A427-F384-04710EF8E3EE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899" v="128" actId="1076"/>
          <ac:spMkLst>
            <pc:docMk/>
            <pc:sldMk cId="1127126126" sldId="271"/>
            <ac:spMk id="52" creationId="{6E8B6DE9-2830-45D2-9583-5F68878C7837}"/>
          </ac:spMkLst>
        </pc:spChg>
        <pc:spChg chg="mod">
          <ac:chgData name="濵田　大治" userId="S::k5905755@kadai.jp::3dc346c6-a235-4d96-b756-7f3e038a9511" providerId="AD" clId="Web-{E9172964-C3AC-7B46-F7D2-C4223233ED1A}" dt="2022-03-25T02:30:50.930" v="129" actId="1076"/>
          <ac:spMkLst>
            <pc:docMk/>
            <pc:sldMk cId="1127126126" sldId="271"/>
            <ac:spMk id="53" creationId="{01EBA11C-B80D-436F-8654-9EE2E06D0DEC}"/>
          </ac:spMkLst>
        </pc:spChg>
        <pc:spChg chg="add mod">
          <ac:chgData name="濵田　大治" userId="S::k5905755@kadai.jp::3dc346c6-a235-4d96-b756-7f3e038a9511" providerId="AD" clId="Web-{E9172964-C3AC-7B46-F7D2-C4223233ED1A}" dt="2022-03-25T02:29:57.460" v="94" actId="1076"/>
          <ac:spMkLst>
            <pc:docMk/>
            <pc:sldMk cId="1127126126" sldId="271"/>
            <ac:spMk id="57" creationId="{1F76A221-880C-582D-40E8-96D52E14EBC4}"/>
          </ac:spMkLst>
        </pc:spChg>
        <pc:spChg chg="add del mod">
          <ac:chgData name="濵田　大治" userId="S::k5905755@kadai.jp::3dc346c6-a235-4d96-b756-7f3e038a9511" providerId="AD" clId="Web-{E9172964-C3AC-7B46-F7D2-C4223233ED1A}" dt="2022-03-25T02:38:10.831" v="157"/>
          <ac:spMkLst>
            <pc:docMk/>
            <pc:sldMk cId="1127126126" sldId="271"/>
            <ac:spMk id="58" creationId="{E8B0836F-42BE-7D77-A24B-3D8B66C91183}"/>
          </ac:spMkLst>
        </pc:spChg>
        <pc:spChg chg="add del mod">
          <ac:chgData name="濵田　大治" userId="S::k5905755@kadai.jp::3dc346c6-a235-4d96-b756-7f3e038a9511" providerId="AD" clId="Web-{E9172964-C3AC-7B46-F7D2-C4223233ED1A}" dt="2022-03-25T02:38:10.831" v="156"/>
          <ac:spMkLst>
            <pc:docMk/>
            <pc:sldMk cId="1127126126" sldId="271"/>
            <ac:spMk id="59" creationId="{29F3BC4B-CE66-9E00-B1EC-039F8E0F910A}"/>
          </ac:spMkLst>
        </pc:spChg>
        <pc:spChg chg="add del mod">
          <ac:chgData name="濵田　大治" userId="S::k5905755@kadai.jp::3dc346c6-a235-4d96-b756-7f3e038a9511" providerId="AD" clId="Web-{E9172964-C3AC-7B46-F7D2-C4223233ED1A}" dt="2022-03-25T02:38:10.831" v="154"/>
          <ac:spMkLst>
            <pc:docMk/>
            <pc:sldMk cId="1127126126" sldId="271"/>
            <ac:spMk id="63" creationId="{F93E6818-54BC-39A6-3235-C2875FEEC354}"/>
          </ac:spMkLst>
        </pc:spChg>
        <pc:spChg chg="add del mod">
          <ac:chgData name="濵田　大治" userId="S::k5905755@kadai.jp::3dc346c6-a235-4d96-b756-7f3e038a9511" providerId="AD" clId="Web-{E9172964-C3AC-7B46-F7D2-C4223233ED1A}" dt="2022-03-25T02:38:10.831" v="153"/>
          <ac:spMkLst>
            <pc:docMk/>
            <pc:sldMk cId="1127126126" sldId="271"/>
            <ac:spMk id="64" creationId="{62875C27-485D-6F00-4E91-7A6583FDC1D3}"/>
          </ac:spMkLst>
        </pc:spChg>
        <pc:spChg chg="add del mod">
          <ac:chgData name="濵田　大治" userId="S::k5905755@kadai.jp::3dc346c6-a235-4d96-b756-7f3e038a9511" providerId="AD" clId="Web-{E9172964-C3AC-7B46-F7D2-C4223233ED1A}" dt="2022-03-25T02:38:10.831" v="152"/>
          <ac:spMkLst>
            <pc:docMk/>
            <pc:sldMk cId="1127126126" sldId="271"/>
            <ac:spMk id="65" creationId="{4584F12D-AA02-DFF4-2B80-CB9025C7030E}"/>
          </ac:spMkLst>
        </pc:spChg>
        <pc:spChg chg="add del mod">
          <ac:chgData name="濵田　大治" userId="S::k5905755@kadai.jp::3dc346c6-a235-4d96-b756-7f3e038a9511" providerId="AD" clId="Web-{E9172964-C3AC-7B46-F7D2-C4223233ED1A}" dt="2022-03-25T02:38:10.831" v="151"/>
          <ac:spMkLst>
            <pc:docMk/>
            <pc:sldMk cId="1127126126" sldId="271"/>
            <ac:spMk id="66" creationId="{348B855A-514F-8BD9-BF5D-0D896A63CA18}"/>
          </ac:spMkLst>
        </pc:spChg>
        <pc:spChg chg="add del mod">
          <ac:chgData name="濵田　大治" userId="S::k5905755@kadai.jp::3dc346c6-a235-4d96-b756-7f3e038a9511" providerId="AD" clId="Web-{E9172964-C3AC-7B46-F7D2-C4223233ED1A}" dt="2022-03-25T02:38:06.941" v="150"/>
          <ac:spMkLst>
            <pc:docMk/>
            <pc:sldMk cId="1127126126" sldId="271"/>
            <ac:spMk id="67" creationId="{C2F33E91-4881-CC21-C554-45E8FBF9E8C6}"/>
          </ac:spMkLst>
        </pc:spChg>
        <pc:spChg chg="add mod">
          <ac:chgData name="濵田　大治" userId="S::k5905755@kadai.jp::3dc346c6-a235-4d96-b756-7f3e038a9511" providerId="AD" clId="Web-{E9172964-C3AC-7B46-F7D2-C4223233ED1A}" dt="2022-03-25T02:38:29.847" v="166" actId="1076"/>
          <ac:spMkLst>
            <pc:docMk/>
            <pc:sldMk cId="1127126126" sldId="271"/>
            <ac:spMk id="68" creationId="{CFE3F001-E18C-2159-7B98-DEF7485F51A0}"/>
          </ac:spMkLst>
        </pc:spChg>
        <pc:spChg chg="add mod">
          <ac:chgData name="濵田　大治" userId="S::k5905755@kadai.jp::3dc346c6-a235-4d96-b756-7f3e038a9511" providerId="AD" clId="Web-{E9172964-C3AC-7B46-F7D2-C4223233ED1A}" dt="2022-03-25T02:38:29.879" v="167" actId="1076"/>
          <ac:spMkLst>
            <pc:docMk/>
            <pc:sldMk cId="1127126126" sldId="271"/>
            <ac:spMk id="69" creationId="{56B8F99E-E307-2148-D297-ED3D5AA76C41}"/>
          </ac:spMkLst>
        </pc:spChg>
        <pc:spChg chg="add mod">
          <ac:chgData name="濵田　大治" userId="S::k5905755@kadai.jp::3dc346c6-a235-4d96-b756-7f3e038a9511" providerId="AD" clId="Web-{E9172964-C3AC-7B46-F7D2-C4223233ED1A}" dt="2022-03-25T02:38:29.926" v="169" actId="1076"/>
          <ac:spMkLst>
            <pc:docMk/>
            <pc:sldMk cId="1127126126" sldId="271"/>
            <ac:spMk id="73" creationId="{6F25E4CC-1A2A-A84D-00F2-334AA521223F}"/>
          </ac:spMkLst>
        </pc:spChg>
        <pc:spChg chg="add mod">
          <ac:chgData name="濵田　大治" userId="S::k5905755@kadai.jp::3dc346c6-a235-4d96-b756-7f3e038a9511" providerId="AD" clId="Web-{E9172964-C3AC-7B46-F7D2-C4223233ED1A}" dt="2022-03-25T02:38:29.957" v="170" actId="1076"/>
          <ac:spMkLst>
            <pc:docMk/>
            <pc:sldMk cId="1127126126" sldId="271"/>
            <ac:spMk id="74" creationId="{8F484F48-FD50-807C-768E-54302410C224}"/>
          </ac:spMkLst>
        </pc:spChg>
        <pc:spChg chg="add mod">
          <ac:chgData name="濵田　大治" userId="S::k5905755@kadai.jp::3dc346c6-a235-4d96-b756-7f3e038a9511" providerId="AD" clId="Web-{E9172964-C3AC-7B46-F7D2-C4223233ED1A}" dt="2022-03-25T02:38:29.988" v="171" actId="1076"/>
          <ac:spMkLst>
            <pc:docMk/>
            <pc:sldMk cId="1127126126" sldId="271"/>
            <ac:spMk id="75" creationId="{D64DC131-AA13-73B7-CD9B-1F6D885CF7DE}"/>
          </ac:spMkLst>
        </pc:spChg>
        <pc:spChg chg="add mod">
          <ac:chgData name="濵田　大治" userId="S::k5905755@kadai.jp::3dc346c6-a235-4d96-b756-7f3e038a9511" providerId="AD" clId="Web-{E9172964-C3AC-7B46-F7D2-C4223233ED1A}" dt="2022-03-25T02:38:30.019" v="172" actId="1076"/>
          <ac:spMkLst>
            <pc:docMk/>
            <pc:sldMk cId="1127126126" sldId="271"/>
            <ac:spMk id="76" creationId="{C0728648-FF83-29DA-B2F8-FCCE1C172ED5}"/>
          </ac:spMkLst>
        </pc:spChg>
        <pc:spChg chg="add mod">
          <ac:chgData name="濵田　大治" userId="S::k5905755@kadai.jp::3dc346c6-a235-4d96-b756-7f3e038a9511" providerId="AD" clId="Web-{E9172964-C3AC-7B46-F7D2-C4223233ED1A}" dt="2022-03-25T02:38:30.051" v="173" actId="1076"/>
          <ac:spMkLst>
            <pc:docMk/>
            <pc:sldMk cId="1127126126" sldId="271"/>
            <ac:spMk id="77" creationId="{43354B84-9FEE-BBBA-DEC9-A0D1DBD77AD5}"/>
          </ac:spMkLst>
        </pc:spChg>
        <pc:spChg chg="add mod">
          <ac:chgData name="濵田　大治" userId="S::k5905755@kadai.jp::3dc346c6-a235-4d96-b756-7f3e038a9511" providerId="AD" clId="Web-{E9172964-C3AC-7B46-F7D2-C4223233ED1A}" dt="2022-03-25T02:39:17.708" v="175" actId="1076"/>
          <ac:spMkLst>
            <pc:docMk/>
            <pc:sldMk cId="1127126126" sldId="271"/>
            <ac:spMk id="78" creationId="{2D8D709E-C731-6CF6-389D-CB0431846EA2}"/>
          </ac:spMkLst>
        </pc:spChg>
        <pc:spChg chg="add mod">
          <ac:chgData name="濵田　大治" userId="S::k5905755@kadai.jp::3dc346c6-a235-4d96-b756-7f3e038a9511" providerId="AD" clId="Web-{E9172964-C3AC-7B46-F7D2-C4223233ED1A}" dt="2022-03-25T02:49:07.004" v="226" actId="1076"/>
          <ac:spMkLst>
            <pc:docMk/>
            <pc:sldMk cId="1127126126" sldId="271"/>
            <ac:spMk id="79" creationId="{8B6F2E37-3181-92FB-0D93-D56648DEAB24}"/>
          </ac:spMkLst>
        </pc:spChg>
        <pc:spChg chg="add mod">
          <ac:chgData name="濵田　大治" userId="S::k5905755@kadai.jp::3dc346c6-a235-4d96-b756-7f3e038a9511" providerId="AD" clId="Web-{E9172964-C3AC-7B46-F7D2-C4223233ED1A}" dt="2022-03-25T02:49:07.035" v="227" actId="1076"/>
          <ac:spMkLst>
            <pc:docMk/>
            <pc:sldMk cId="1127126126" sldId="271"/>
            <ac:spMk id="80" creationId="{370A997B-0B4D-B67A-E213-8ED5DD95F9DB}"/>
          </ac:spMkLst>
        </pc:spChg>
        <pc:spChg chg="add mod">
          <ac:chgData name="濵田　大治" userId="S::k5905755@kadai.jp::3dc346c6-a235-4d96-b756-7f3e038a9511" providerId="AD" clId="Web-{E9172964-C3AC-7B46-F7D2-C4223233ED1A}" dt="2022-03-25T02:49:07.113" v="229" actId="1076"/>
          <ac:spMkLst>
            <pc:docMk/>
            <pc:sldMk cId="1127126126" sldId="271"/>
            <ac:spMk id="84" creationId="{E33318BD-72C7-80A7-2898-8CA8E7A30D8E}"/>
          </ac:spMkLst>
        </pc:spChg>
        <pc:spChg chg="add mod">
          <ac:chgData name="濵田　大治" userId="S::k5905755@kadai.jp::3dc346c6-a235-4d96-b756-7f3e038a9511" providerId="AD" clId="Web-{E9172964-C3AC-7B46-F7D2-C4223233ED1A}" dt="2022-03-25T02:49:07.144" v="230" actId="1076"/>
          <ac:spMkLst>
            <pc:docMk/>
            <pc:sldMk cId="1127126126" sldId="271"/>
            <ac:spMk id="85" creationId="{DE60A898-50B3-E205-4911-E57D61D9FB81}"/>
          </ac:spMkLst>
        </pc:spChg>
        <pc:spChg chg="add mod">
          <ac:chgData name="濵田　大治" userId="S::k5905755@kadai.jp::3dc346c6-a235-4d96-b756-7f3e038a9511" providerId="AD" clId="Web-{E9172964-C3AC-7B46-F7D2-C4223233ED1A}" dt="2022-03-25T02:53:42.010" v="234" actId="20577"/>
          <ac:spMkLst>
            <pc:docMk/>
            <pc:sldMk cId="1127126126" sldId="271"/>
            <ac:spMk id="86" creationId="{305622FA-FD3C-1584-07BA-5B94640BDF3B}"/>
          </ac:spMkLst>
        </pc:spChg>
        <pc:spChg chg="add mod">
          <ac:chgData name="濵田　大治" userId="S::k5905755@kadai.jp::3dc346c6-a235-4d96-b756-7f3e038a9511" providerId="AD" clId="Web-{E9172964-C3AC-7B46-F7D2-C4223233ED1A}" dt="2022-03-25T02:49:07.254" v="233" actId="1076"/>
          <ac:spMkLst>
            <pc:docMk/>
            <pc:sldMk cId="1127126126" sldId="271"/>
            <ac:spMk id="90" creationId="{310C7A91-C73B-A948-64A3-5EC92512F0FF}"/>
          </ac:spMkLst>
        </pc:spChg>
        <pc:spChg chg="add mod">
          <ac:chgData name="濵田　大治" userId="S::k5905755@kadai.jp::3dc346c6-a235-4d96-b756-7f3e038a9511" providerId="AD" clId="Web-{E9172964-C3AC-7B46-F7D2-C4223233ED1A}" dt="2022-03-25T02:55:47.092" v="236" actId="1076"/>
          <ac:spMkLst>
            <pc:docMk/>
            <pc:sldMk cId="1127126126" sldId="271"/>
            <ac:spMk id="91" creationId="{9FB7F4EF-41D1-731A-2977-2711C57AE1A4}"/>
          </ac:spMkLst>
        </pc:spChg>
        <pc:grpChg chg="mod">
          <ac:chgData name="濵田　大治" userId="S::k5905755@kadai.jp::3dc346c6-a235-4d96-b756-7f3e038a9511" providerId="AD" clId="Web-{E9172964-C3AC-7B46-F7D2-C4223233ED1A}" dt="2022-03-25T02:48:56.707" v="224" actId="1076"/>
          <ac:grpSpMkLst>
            <pc:docMk/>
            <pc:sldMk cId="1127126126" sldId="271"/>
            <ac:grpSpMk id="7" creationId="{D0FC0B3E-47C0-4AC7-8551-0921635F4895}"/>
          </ac:grpSpMkLst>
        </pc:grpChg>
        <pc:grpChg chg="mod">
          <ac:chgData name="濵田　大治" userId="S::k5905755@kadai.jp::3dc346c6-a235-4d96-b756-7f3e038a9511" providerId="AD" clId="Web-{E9172964-C3AC-7B46-F7D2-C4223233ED1A}" dt="2022-03-25T02:29:19.521" v="66" actId="1076"/>
          <ac:grpSpMkLst>
            <pc:docMk/>
            <pc:sldMk cId="1127126126" sldId="271"/>
            <ac:grpSpMk id="31" creationId="{D53C7F3D-BA0B-4FAC-900F-71CD863FA140}"/>
          </ac:grpSpMkLst>
        </pc:grpChg>
        <pc:grpChg chg="mod">
          <ac:chgData name="濵田　大治" userId="S::k5905755@kadai.jp::3dc346c6-a235-4d96-b756-7f3e038a9511" providerId="AD" clId="Web-{E9172964-C3AC-7B46-F7D2-C4223233ED1A}" dt="2022-03-25T02:30:50.633" v="118" actId="1076"/>
          <ac:grpSpMkLst>
            <pc:docMk/>
            <pc:sldMk cId="1127126126" sldId="271"/>
            <ac:grpSpMk id="37" creationId="{92D1ABA3-962B-40DE-BC7E-66E32F9756D5}"/>
          </ac:grpSpMkLst>
        </pc:grpChg>
        <pc:grpChg chg="mod">
          <ac:chgData name="濵田　大治" userId="S::k5905755@kadai.jp::3dc346c6-a235-4d96-b756-7f3e038a9511" providerId="AD" clId="Web-{E9172964-C3AC-7B46-F7D2-C4223233ED1A}" dt="2022-03-25T02:30:50.774" v="123" actId="1076"/>
          <ac:grpSpMkLst>
            <pc:docMk/>
            <pc:sldMk cId="1127126126" sldId="271"/>
            <ac:grpSpMk id="44" creationId="{3286733B-3773-4CDE-9B48-30D3ED63FF79}"/>
          </ac:grpSpMkLst>
        </pc:grpChg>
        <pc:grpChg chg="add mod">
          <ac:chgData name="濵田　大治" userId="S::k5905755@kadai.jp::3dc346c6-a235-4d96-b756-7f3e038a9511" providerId="AD" clId="Web-{E9172964-C3AC-7B46-F7D2-C4223233ED1A}" dt="2022-03-25T02:29:57.429" v="93" actId="1076"/>
          <ac:grpSpMkLst>
            <pc:docMk/>
            <pc:sldMk cId="1127126126" sldId="271"/>
            <ac:grpSpMk id="54" creationId="{C9EC6521-CD75-25DE-BD39-3EA468DAA599}"/>
          </ac:grpSpMkLst>
        </pc:grpChg>
        <pc:grpChg chg="add del mod">
          <ac:chgData name="濵田　大治" userId="S::k5905755@kadai.jp::3dc346c6-a235-4d96-b756-7f3e038a9511" providerId="AD" clId="Web-{E9172964-C3AC-7B46-F7D2-C4223233ED1A}" dt="2022-03-25T02:38:10.831" v="155"/>
          <ac:grpSpMkLst>
            <pc:docMk/>
            <pc:sldMk cId="1127126126" sldId="271"/>
            <ac:grpSpMk id="60" creationId="{5D4D4249-2C1B-3228-DCCC-E773DB60AAE6}"/>
          </ac:grpSpMkLst>
        </pc:grpChg>
        <pc:grpChg chg="add mod">
          <ac:chgData name="濵田　大治" userId="S::k5905755@kadai.jp::3dc346c6-a235-4d96-b756-7f3e038a9511" providerId="AD" clId="Web-{E9172964-C3AC-7B46-F7D2-C4223233ED1A}" dt="2022-03-25T02:38:29.910" v="168" actId="1076"/>
          <ac:grpSpMkLst>
            <pc:docMk/>
            <pc:sldMk cId="1127126126" sldId="271"/>
            <ac:grpSpMk id="70" creationId="{71C5A840-674F-F534-C49D-3FE5F2B91877}"/>
          </ac:grpSpMkLst>
        </pc:grpChg>
        <pc:grpChg chg="add mod">
          <ac:chgData name="濵田　大治" userId="S::k5905755@kadai.jp::3dc346c6-a235-4d96-b756-7f3e038a9511" providerId="AD" clId="Web-{E9172964-C3AC-7B46-F7D2-C4223233ED1A}" dt="2022-03-25T02:49:07.066" v="228" actId="1076"/>
          <ac:grpSpMkLst>
            <pc:docMk/>
            <pc:sldMk cId="1127126126" sldId="271"/>
            <ac:grpSpMk id="81" creationId="{DA05EEE2-EE72-566D-5371-CCAB96379562}"/>
          </ac:grpSpMkLst>
        </pc:grpChg>
        <pc:grpChg chg="add mod">
          <ac:chgData name="濵田　大治" userId="S::k5905755@kadai.jp::3dc346c6-a235-4d96-b756-7f3e038a9511" providerId="AD" clId="Web-{E9172964-C3AC-7B46-F7D2-C4223233ED1A}" dt="2022-03-25T02:49:07.223" v="232" actId="1076"/>
          <ac:grpSpMkLst>
            <pc:docMk/>
            <pc:sldMk cId="1127126126" sldId="271"/>
            <ac:grpSpMk id="87" creationId="{D3CAB43C-D857-055D-DDFB-78003E7B5A1F}"/>
          </ac:grpSpMkLst>
        </pc:grpChg>
        <pc:cxnChg chg="del mod">
          <ac:chgData name="濵田　大治" userId="S::k5905755@kadai.jp::3dc346c6-a235-4d96-b756-7f3e038a9511" providerId="AD" clId="Web-{E9172964-C3AC-7B46-F7D2-C4223233ED1A}" dt="2022-03-25T02:55:50.420" v="237"/>
          <ac:cxnSpMkLst>
            <pc:docMk/>
            <pc:sldMk cId="1127126126" sldId="271"/>
            <ac:cxnSpMk id="17" creationId="{B1FB1F04-3A26-45EC-A741-C22690D26E65}"/>
          </ac:cxnSpMkLst>
        </pc:cxnChg>
        <pc:cxnChg chg="mod">
          <ac:chgData name="濵田　大治" userId="S::k5905755@kadai.jp::3dc346c6-a235-4d96-b756-7f3e038a9511" providerId="AD" clId="Web-{E9172964-C3AC-7B46-F7D2-C4223233ED1A}" dt="2022-03-25T02:29:53.100" v="90"/>
          <ac:cxnSpMkLst>
            <pc:docMk/>
            <pc:sldMk cId="1127126126" sldId="271"/>
            <ac:cxnSpMk id="55" creationId="{19E2D467-09F0-3010-5A23-DD5C7927FF24}"/>
          </ac:cxnSpMkLst>
        </pc:cxnChg>
        <pc:cxnChg chg="mod">
          <ac:chgData name="濵田　大治" userId="S::k5905755@kadai.jp::3dc346c6-a235-4d96-b756-7f3e038a9511" providerId="AD" clId="Web-{E9172964-C3AC-7B46-F7D2-C4223233ED1A}" dt="2022-03-25T02:29:53.100" v="90"/>
          <ac:cxnSpMkLst>
            <pc:docMk/>
            <pc:sldMk cId="1127126126" sldId="271"/>
            <ac:cxnSpMk id="56" creationId="{B414AA86-7638-4407-4D13-29A44485105C}"/>
          </ac:cxnSpMkLst>
        </pc:cxnChg>
        <pc:cxnChg chg="mod">
          <ac:chgData name="濵田　大治" userId="S::k5905755@kadai.jp::3dc346c6-a235-4d96-b756-7f3e038a9511" providerId="AD" clId="Web-{E9172964-C3AC-7B46-F7D2-C4223233ED1A}" dt="2022-03-25T02:30:17.398" v="97"/>
          <ac:cxnSpMkLst>
            <pc:docMk/>
            <pc:sldMk cId="1127126126" sldId="271"/>
            <ac:cxnSpMk id="61" creationId="{72329940-D077-3678-38FD-BA4C3339B8C2}"/>
          </ac:cxnSpMkLst>
        </pc:cxnChg>
        <pc:cxnChg chg="mod">
          <ac:chgData name="濵田　大治" userId="S::k5905755@kadai.jp::3dc346c6-a235-4d96-b756-7f3e038a9511" providerId="AD" clId="Web-{E9172964-C3AC-7B46-F7D2-C4223233ED1A}" dt="2022-03-25T02:30:17.398" v="97"/>
          <ac:cxnSpMkLst>
            <pc:docMk/>
            <pc:sldMk cId="1127126126" sldId="271"/>
            <ac:cxnSpMk id="62" creationId="{45F91696-1285-EB5B-61BB-0393219B963B}"/>
          </ac:cxnSpMkLst>
        </pc:cxnChg>
        <pc:cxnChg chg="mod">
          <ac:chgData name="濵田　大治" userId="S::k5905755@kadai.jp::3dc346c6-a235-4d96-b756-7f3e038a9511" providerId="AD" clId="Web-{E9172964-C3AC-7B46-F7D2-C4223233ED1A}" dt="2022-03-25T02:38:24.941" v="160"/>
          <ac:cxnSpMkLst>
            <pc:docMk/>
            <pc:sldMk cId="1127126126" sldId="271"/>
            <ac:cxnSpMk id="71" creationId="{D0411CB8-1D56-56FA-F375-4636EDB33D78}"/>
          </ac:cxnSpMkLst>
        </pc:cxnChg>
        <pc:cxnChg chg="mod">
          <ac:chgData name="濵田　大治" userId="S::k5905755@kadai.jp::3dc346c6-a235-4d96-b756-7f3e038a9511" providerId="AD" clId="Web-{E9172964-C3AC-7B46-F7D2-C4223233ED1A}" dt="2022-03-25T02:38:24.941" v="160"/>
          <ac:cxnSpMkLst>
            <pc:docMk/>
            <pc:sldMk cId="1127126126" sldId="271"/>
            <ac:cxnSpMk id="72" creationId="{3F62AF1E-AF94-90AB-BD08-5C0EF5D0F2DD}"/>
          </ac:cxnSpMkLst>
        </pc:cxnChg>
        <pc:cxnChg chg="mod">
          <ac:chgData name="濵田　大治" userId="S::k5905755@kadai.jp::3dc346c6-a235-4d96-b756-7f3e038a9511" providerId="AD" clId="Web-{E9172964-C3AC-7B46-F7D2-C4223233ED1A}" dt="2022-03-25T02:45:37.592" v="178"/>
          <ac:cxnSpMkLst>
            <pc:docMk/>
            <pc:sldMk cId="1127126126" sldId="271"/>
            <ac:cxnSpMk id="82" creationId="{74E4E3AD-E852-EC2C-CC7A-AA0B1809FB48}"/>
          </ac:cxnSpMkLst>
        </pc:cxnChg>
        <pc:cxnChg chg="mod">
          <ac:chgData name="濵田　大治" userId="S::k5905755@kadai.jp::3dc346c6-a235-4d96-b756-7f3e038a9511" providerId="AD" clId="Web-{E9172964-C3AC-7B46-F7D2-C4223233ED1A}" dt="2022-03-25T02:45:37.592" v="178"/>
          <ac:cxnSpMkLst>
            <pc:docMk/>
            <pc:sldMk cId="1127126126" sldId="271"/>
            <ac:cxnSpMk id="83" creationId="{9B84FA27-7661-AC5D-C7F7-EF379F75661D}"/>
          </ac:cxnSpMkLst>
        </pc:cxnChg>
        <pc:cxnChg chg="mod">
          <ac:chgData name="濵田　大治" userId="S::k5905755@kadai.jp::3dc346c6-a235-4d96-b756-7f3e038a9511" providerId="AD" clId="Web-{E9172964-C3AC-7B46-F7D2-C4223233ED1A}" dt="2022-03-25T02:45:57.280" v="186"/>
          <ac:cxnSpMkLst>
            <pc:docMk/>
            <pc:sldMk cId="1127126126" sldId="271"/>
            <ac:cxnSpMk id="88" creationId="{D664511C-D2EE-32AD-0CAD-AAEE40BFC53F}"/>
          </ac:cxnSpMkLst>
        </pc:cxnChg>
        <pc:cxnChg chg="mod">
          <ac:chgData name="濵田　大治" userId="S::k5905755@kadai.jp::3dc346c6-a235-4d96-b756-7f3e038a9511" providerId="AD" clId="Web-{E9172964-C3AC-7B46-F7D2-C4223233ED1A}" dt="2022-03-25T02:45:57.280" v="186"/>
          <ac:cxnSpMkLst>
            <pc:docMk/>
            <pc:sldMk cId="1127126126" sldId="271"/>
            <ac:cxnSpMk id="89" creationId="{0705674E-81CA-8375-D195-6CED6ED8547F}"/>
          </ac:cxnSpMkLst>
        </pc:cxnChg>
      </pc:sldChg>
    </pc:docChg>
  </pc:docChgLst>
  <pc:docChgLst>
    <pc:chgData name="濵田　大治" userId="3dc346c6-a235-4d96-b756-7f3e038a9511" providerId="ADAL" clId="{16C5B60C-457B-4942-9EE7-7F330CB3EBE8}"/>
    <pc:docChg chg="undo custSel addSld modSld">
      <pc:chgData name="濵田　大治" userId="3dc346c6-a235-4d96-b756-7f3e038a9511" providerId="ADAL" clId="{16C5B60C-457B-4942-9EE7-7F330CB3EBE8}" dt="2022-10-06T05:46:03.067" v="376" actId="14100"/>
      <pc:docMkLst>
        <pc:docMk/>
      </pc:docMkLst>
      <pc:sldChg chg="mod">
        <pc:chgData name="濵田　大治" userId="3dc346c6-a235-4d96-b756-7f3e038a9511" providerId="ADAL" clId="{16C5B60C-457B-4942-9EE7-7F330CB3EBE8}" dt="2022-10-06T04:22:50.857" v="1" actId="27918"/>
        <pc:sldMkLst>
          <pc:docMk/>
          <pc:sldMk cId="2979523262" sldId="283"/>
        </pc:sldMkLst>
      </pc:sldChg>
      <pc:sldChg chg="addSp modSp mod">
        <pc:chgData name="濵田　大治" userId="3dc346c6-a235-4d96-b756-7f3e038a9511" providerId="ADAL" clId="{16C5B60C-457B-4942-9EE7-7F330CB3EBE8}" dt="2022-10-06T05:46:03.067" v="376" actId="14100"/>
        <pc:sldMkLst>
          <pc:docMk/>
          <pc:sldMk cId="1975120684" sldId="292"/>
        </pc:sldMkLst>
        <pc:spChg chg="mod">
          <ac:chgData name="濵田　大治" userId="3dc346c6-a235-4d96-b756-7f3e038a9511" providerId="ADAL" clId="{16C5B60C-457B-4942-9EE7-7F330CB3EBE8}" dt="2022-10-06T05:42:52.026" v="264" actId="20577"/>
          <ac:spMkLst>
            <pc:docMk/>
            <pc:sldMk cId="1975120684" sldId="292"/>
            <ac:spMk id="2" creationId="{D680AA8B-347C-CC4D-853F-6277E5EA1ABD}"/>
          </ac:spMkLst>
        </pc:spChg>
        <pc:spChg chg="mod">
          <ac:chgData name="濵田　大治" userId="3dc346c6-a235-4d96-b756-7f3e038a9511" providerId="ADAL" clId="{16C5B60C-457B-4942-9EE7-7F330CB3EBE8}" dt="2022-10-06T05:41:11.820" v="241" actId="1076"/>
          <ac:spMkLst>
            <pc:docMk/>
            <pc:sldMk cId="1975120684" sldId="292"/>
            <ac:spMk id="3" creationId="{00000000-0000-0000-0000-000000000000}"/>
          </ac:spMkLst>
        </pc:spChg>
        <pc:spChg chg="add mod">
          <ac:chgData name="濵田　大治" userId="3dc346c6-a235-4d96-b756-7f3e038a9511" providerId="ADAL" clId="{16C5B60C-457B-4942-9EE7-7F330CB3EBE8}" dt="2022-10-06T05:40:54.134" v="239" actId="1076"/>
          <ac:spMkLst>
            <pc:docMk/>
            <pc:sldMk cId="1975120684" sldId="292"/>
            <ac:spMk id="5" creationId="{1C3F5119-D4DE-6F9E-E4AA-EC9464ABF2CA}"/>
          </ac:spMkLst>
        </pc:spChg>
        <pc:spChg chg="add mod">
          <ac:chgData name="濵田　大治" userId="3dc346c6-a235-4d96-b756-7f3e038a9511" providerId="ADAL" clId="{16C5B60C-457B-4942-9EE7-7F330CB3EBE8}" dt="2022-10-06T05:43:05.275" v="266" actId="1076"/>
          <ac:spMkLst>
            <pc:docMk/>
            <pc:sldMk cId="1975120684" sldId="292"/>
            <ac:spMk id="9" creationId="{8BC67C80-92C8-46AF-52A3-A2550BE19A63}"/>
          </ac:spMkLst>
        </pc:spChg>
        <pc:spChg chg="add mod">
          <ac:chgData name="濵田　大治" userId="3dc346c6-a235-4d96-b756-7f3e038a9511" providerId="ADAL" clId="{16C5B60C-457B-4942-9EE7-7F330CB3EBE8}" dt="2022-10-06T05:45:32.567" v="346" actId="1076"/>
          <ac:spMkLst>
            <pc:docMk/>
            <pc:sldMk cId="1975120684" sldId="292"/>
            <ac:spMk id="11" creationId="{C1F6DF7A-C743-AF3A-E573-123015047A7E}"/>
          </ac:spMkLst>
        </pc:spChg>
        <pc:spChg chg="mod">
          <ac:chgData name="濵田　大治" userId="3dc346c6-a235-4d96-b756-7f3e038a9511" providerId="ADAL" clId="{16C5B60C-457B-4942-9EE7-7F330CB3EBE8}" dt="2022-10-06T05:45:52.436" v="352" actId="20577"/>
          <ac:spMkLst>
            <pc:docMk/>
            <pc:sldMk cId="1975120684" sldId="292"/>
            <ac:spMk id="12" creationId="{D680AA8B-347C-CC4D-853F-6277E5EA1ABD}"/>
          </ac:spMkLst>
        </pc:spChg>
        <pc:spChg chg="mod">
          <ac:chgData name="濵田　大治" userId="3dc346c6-a235-4d96-b756-7f3e038a9511" providerId="ADAL" clId="{16C5B60C-457B-4942-9EE7-7F330CB3EBE8}" dt="2022-10-06T05:44:58.267" v="336" actId="1076"/>
          <ac:spMkLst>
            <pc:docMk/>
            <pc:sldMk cId="1975120684" sldId="292"/>
            <ac:spMk id="13" creationId="{00000000-0000-0000-0000-000000000000}"/>
          </ac:spMkLst>
        </pc:spChg>
        <pc:spChg chg="mod">
          <ac:chgData name="濵田　大治" userId="3dc346c6-a235-4d96-b756-7f3e038a9511" providerId="ADAL" clId="{16C5B60C-457B-4942-9EE7-7F330CB3EBE8}" dt="2022-10-06T05:45:47.624" v="348" actId="1076"/>
          <ac:spMkLst>
            <pc:docMk/>
            <pc:sldMk cId="1975120684" sldId="292"/>
            <ac:spMk id="15" creationId="{00000000-0000-0000-0000-000000000000}"/>
          </ac:spMkLst>
        </pc:spChg>
        <pc:spChg chg="mod">
          <ac:chgData name="濵田　大治" userId="3dc346c6-a235-4d96-b756-7f3e038a9511" providerId="ADAL" clId="{16C5B60C-457B-4942-9EE7-7F330CB3EBE8}" dt="2022-10-06T05:46:03.067" v="376" actId="14100"/>
          <ac:spMkLst>
            <pc:docMk/>
            <pc:sldMk cId="1975120684" sldId="292"/>
            <ac:spMk id="16" creationId="{D680AA8B-347C-CC4D-853F-6277E5EA1ABD}"/>
          </ac:spMkLst>
        </pc:spChg>
        <pc:spChg chg="add mod">
          <ac:chgData name="濵田　大治" userId="3dc346c6-a235-4d96-b756-7f3e038a9511" providerId="ADAL" clId="{16C5B60C-457B-4942-9EE7-7F330CB3EBE8}" dt="2022-10-06T05:45:41.557" v="347" actId="1076"/>
          <ac:spMkLst>
            <pc:docMk/>
            <pc:sldMk cId="1975120684" sldId="292"/>
            <ac:spMk id="17" creationId="{58C89A73-185B-68C9-F7BA-984DFA7F4DB4}"/>
          </ac:spMkLst>
        </pc:spChg>
        <pc:spChg chg="mod">
          <ac:chgData name="濵田　大治" userId="3dc346c6-a235-4d96-b756-7f3e038a9511" providerId="ADAL" clId="{16C5B60C-457B-4942-9EE7-7F330CB3EBE8}" dt="2022-10-06T05:44:51.176" v="332" actId="1036"/>
          <ac:spMkLst>
            <pc:docMk/>
            <pc:sldMk cId="1975120684" sldId="292"/>
            <ac:spMk id="19" creationId="{00000000-0000-0000-0000-000000000000}"/>
          </ac:spMkLst>
        </pc:spChg>
        <pc:spChg chg="mod">
          <ac:chgData name="濵田　大治" userId="3dc346c6-a235-4d96-b756-7f3e038a9511" providerId="ADAL" clId="{16C5B60C-457B-4942-9EE7-7F330CB3EBE8}" dt="2022-10-06T05:44:40.663" v="329" actId="1076"/>
          <ac:spMkLst>
            <pc:docMk/>
            <pc:sldMk cId="1975120684" sldId="292"/>
            <ac:spMk id="22" creationId="{00000000-0000-0000-0000-000000000000}"/>
          </ac:spMkLst>
        </pc:spChg>
        <pc:cxnChg chg="mod">
          <ac:chgData name="濵田　大治" userId="3dc346c6-a235-4d96-b756-7f3e038a9511" providerId="ADAL" clId="{16C5B60C-457B-4942-9EE7-7F330CB3EBE8}" dt="2022-10-06T05:45:09.121" v="340" actId="14100"/>
          <ac:cxnSpMkLst>
            <pc:docMk/>
            <pc:sldMk cId="1975120684" sldId="292"/>
            <ac:cxnSpMk id="14" creationId="{00000000-0000-0000-0000-000000000000}"/>
          </ac:cxnSpMkLst>
        </pc:cxnChg>
      </pc:sldChg>
      <pc:sldChg chg="addSp delSp modSp add mod">
        <pc:chgData name="濵田　大治" userId="3dc346c6-a235-4d96-b756-7f3e038a9511" providerId="ADAL" clId="{16C5B60C-457B-4942-9EE7-7F330CB3EBE8}" dt="2022-10-06T04:46:30.672" v="231" actId="478"/>
        <pc:sldMkLst>
          <pc:docMk/>
          <pc:sldMk cId="2961920430" sldId="293"/>
        </pc:sldMkLst>
        <pc:spChg chg="mod">
          <ac:chgData name="濵田　大治" userId="3dc346c6-a235-4d96-b756-7f3e038a9511" providerId="ADAL" clId="{16C5B60C-457B-4942-9EE7-7F330CB3EBE8}" dt="2022-10-06T04:40:02.949" v="91" actId="1076"/>
          <ac:spMkLst>
            <pc:docMk/>
            <pc:sldMk cId="2961920430" sldId="293"/>
            <ac:spMk id="3" creationId="{F54AA5BE-82FE-CEF2-1D8E-A3024C0FCD36}"/>
          </ac:spMkLst>
        </pc:spChg>
        <pc:spChg chg="mod">
          <ac:chgData name="濵田　大治" userId="3dc346c6-a235-4d96-b756-7f3e038a9511" providerId="ADAL" clId="{16C5B60C-457B-4942-9EE7-7F330CB3EBE8}" dt="2022-10-06T04:39:36.228" v="72" actId="20577"/>
          <ac:spMkLst>
            <pc:docMk/>
            <pc:sldMk cId="2961920430" sldId="293"/>
            <ac:spMk id="5" creationId="{C41C7BB5-5101-6D2B-0059-63FE5AA99FE1}"/>
          </ac:spMkLst>
        </pc:spChg>
        <pc:spChg chg="add mod">
          <ac:chgData name="濵田　大治" userId="3dc346c6-a235-4d96-b756-7f3e038a9511" providerId="ADAL" clId="{16C5B60C-457B-4942-9EE7-7F330CB3EBE8}" dt="2022-10-06T04:46:25.550" v="230" actId="20577"/>
          <ac:spMkLst>
            <pc:docMk/>
            <pc:sldMk cId="2961920430" sldId="293"/>
            <ac:spMk id="12" creationId="{D1104CA1-0260-EC73-C8D9-0BE6CD650DDA}"/>
          </ac:spMkLst>
        </pc:spChg>
        <pc:spChg chg="mod">
          <ac:chgData name="濵田　大治" userId="3dc346c6-a235-4d96-b756-7f3e038a9511" providerId="ADAL" clId="{16C5B60C-457B-4942-9EE7-7F330CB3EBE8}" dt="2022-10-06T04:42:39.464" v="160" actId="1076"/>
          <ac:spMkLst>
            <pc:docMk/>
            <pc:sldMk cId="2961920430" sldId="293"/>
            <ac:spMk id="21" creationId="{49C6D6AF-609D-65AB-BA6B-A915B4D4A57A}"/>
          </ac:spMkLst>
        </pc:spChg>
        <pc:spChg chg="del mod">
          <ac:chgData name="濵田　大治" userId="3dc346c6-a235-4d96-b756-7f3e038a9511" providerId="ADAL" clId="{16C5B60C-457B-4942-9EE7-7F330CB3EBE8}" dt="2022-10-06T04:46:30.672" v="231" actId="478"/>
          <ac:spMkLst>
            <pc:docMk/>
            <pc:sldMk cId="2961920430" sldId="293"/>
            <ac:spMk id="26" creationId="{56E4051E-BBBF-E0E9-97F8-D64775D5751C}"/>
          </ac:spMkLst>
        </pc:spChg>
        <pc:spChg chg="mod">
          <ac:chgData name="濵田　大治" userId="3dc346c6-a235-4d96-b756-7f3e038a9511" providerId="ADAL" clId="{16C5B60C-457B-4942-9EE7-7F330CB3EBE8}" dt="2022-10-06T04:45:18.328" v="213" actId="947"/>
          <ac:spMkLst>
            <pc:docMk/>
            <pc:sldMk cId="2961920430" sldId="293"/>
            <ac:spMk id="30" creationId="{A51F2D3B-0521-B334-3F55-8ACB9504327F}"/>
          </ac:spMkLst>
        </pc:spChg>
        <pc:spChg chg="del mod">
          <ac:chgData name="濵田　大治" userId="3dc346c6-a235-4d96-b756-7f3e038a9511" providerId="ADAL" clId="{16C5B60C-457B-4942-9EE7-7F330CB3EBE8}" dt="2022-10-06T04:46:30.672" v="231" actId="478"/>
          <ac:spMkLst>
            <pc:docMk/>
            <pc:sldMk cId="2961920430" sldId="293"/>
            <ac:spMk id="34" creationId="{D0F80462-5007-A434-EF66-8C7EED3D7478}"/>
          </ac:spMkLst>
        </pc:spChg>
        <pc:cxnChg chg="add mod">
          <ac:chgData name="濵田　大治" userId="3dc346c6-a235-4d96-b756-7f3e038a9511" providerId="ADAL" clId="{16C5B60C-457B-4942-9EE7-7F330CB3EBE8}" dt="2022-10-06T04:46:01.393" v="221" actId="14100"/>
          <ac:cxnSpMkLst>
            <pc:docMk/>
            <pc:sldMk cId="2961920430" sldId="293"/>
            <ac:cxnSpMk id="2" creationId="{972592CF-4010-AF8E-AC89-B1A778822006}"/>
          </ac:cxnSpMkLst>
        </pc:cxnChg>
        <pc:cxnChg chg="add mod">
          <ac:chgData name="濵田　大治" userId="3dc346c6-a235-4d96-b756-7f3e038a9511" providerId="ADAL" clId="{16C5B60C-457B-4942-9EE7-7F330CB3EBE8}" dt="2022-10-06T04:45:50.963" v="215" actId="1076"/>
          <ac:cxnSpMkLst>
            <pc:docMk/>
            <pc:sldMk cId="2961920430" sldId="293"/>
            <ac:cxnSpMk id="7" creationId="{2C19BB2E-7A95-32AC-3043-79F4AE6A9106}"/>
          </ac:cxnSpMkLst>
        </pc:cxnChg>
        <pc:cxnChg chg="mod">
          <ac:chgData name="濵田　大治" userId="3dc346c6-a235-4d96-b756-7f3e038a9511" providerId="ADAL" clId="{16C5B60C-457B-4942-9EE7-7F330CB3EBE8}" dt="2022-10-06T04:39:45.373" v="90" actId="14100"/>
          <ac:cxnSpMkLst>
            <pc:docMk/>
            <pc:sldMk cId="2961920430" sldId="293"/>
            <ac:cxnSpMk id="9" creationId="{AE9FE443-7EBF-8D67-D0F3-69CC3A4A0B7B}"/>
          </ac:cxnSpMkLst>
        </pc:cxnChg>
        <pc:cxnChg chg="add mod">
          <ac:chgData name="濵田　大治" userId="3dc346c6-a235-4d96-b756-7f3e038a9511" providerId="ADAL" clId="{16C5B60C-457B-4942-9EE7-7F330CB3EBE8}" dt="2022-10-06T04:45:50.963" v="215" actId="1076"/>
          <ac:cxnSpMkLst>
            <pc:docMk/>
            <pc:sldMk cId="2961920430" sldId="293"/>
            <ac:cxnSpMk id="11" creationId="{0751C614-B2DE-A58D-4BAD-47DBA3D806E6}"/>
          </ac:cxnSpMkLst>
        </pc:cxnChg>
        <pc:cxnChg chg="mod">
          <ac:chgData name="濵田　大治" userId="3dc346c6-a235-4d96-b756-7f3e038a9511" providerId="ADAL" clId="{16C5B60C-457B-4942-9EE7-7F330CB3EBE8}" dt="2022-10-06T04:40:37.497" v="93" actId="1076"/>
          <ac:cxnSpMkLst>
            <pc:docMk/>
            <pc:sldMk cId="2961920430" sldId="293"/>
            <ac:cxnSpMk id="17" creationId="{01B76D7A-FFCC-0CB0-834D-AA530D99F1B8}"/>
          </ac:cxnSpMkLst>
        </pc:cxnChg>
        <pc:cxnChg chg="mod">
          <ac:chgData name="濵田　大治" userId="3dc346c6-a235-4d96-b756-7f3e038a9511" providerId="ADAL" clId="{16C5B60C-457B-4942-9EE7-7F330CB3EBE8}" dt="2022-10-06T04:42:33.995" v="159" actId="1035"/>
          <ac:cxnSpMkLst>
            <pc:docMk/>
            <pc:sldMk cId="2961920430" sldId="293"/>
            <ac:cxnSpMk id="18" creationId="{BDA38934-C0E0-D8B8-65F0-CB3CC7F3228C}"/>
          </ac:cxnSpMkLst>
        </pc:cxnChg>
        <pc:cxnChg chg="mod">
          <ac:chgData name="濵田　大治" userId="3dc346c6-a235-4d96-b756-7f3e038a9511" providerId="ADAL" clId="{16C5B60C-457B-4942-9EE7-7F330CB3EBE8}" dt="2022-10-06T04:42:17.320" v="150" actId="14100"/>
          <ac:cxnSpMkLst>
            <pc:docMk/>
            <pc:sldMk cId="2961920430" sldId="293"/>
            <ac:cxnSpMk id="20" creationId="{F458C1C5-4287-6445-3792-C3F2367F8993}"/>
          </ac:cxnSpMkLst>
        </pc:cxnChg>
        <pc:cxnChg chg="del mod">
          <ac:chgData name="濵田　大治" userId="3dc346c6-a235-4d96-b756-7f3e038a9511" providerId="ADAL" clId="{16C5B60C-457B-4942-9EE7-7F330CB3EBE8}" dt="2022-10-06T04:46:30.672" v="231" actId="478"/>
          <ac:cxnSpMkLst>
            <pc:docMk/>
            <pc:sldMk cId="2961920430" sldId="293"/>
            <ac:cxnSpMk id="22" creationId="{A86E6CA3-D7E7-5FBE-A1F5-F563576F390C}"/>
          </ac:cxnSpMkLst>
        </pc:cxnChg>
        <pc:cxnChg chg="del mod">
          <ac:chgData name="濵田　大治" userId="3dc346c6-a235-4d96-b756-7f3e038a9511" providerId="ADAL" clId="{16C5B60C-457B-4942-9EE7-7F330CB3EBE8}" dt="2022-10-06T04:46:30.672" v="231" actId="478"/>
          <ac:cxnSpMkLst>
            <pc:docMk/>
            <pc:sldMk cId="2961920430" sldId="293"/>
            <ac:cxnSpMk id="23" creationId="{EECDDD4D-76BE-4D47-3A5C-A44C4277330F}"/>
          </ac:cxnSpMkLst>
        </pc:cxnChg>
        <pc:cxnChg chg="del mod">
          <ac:chgData name="濵田　大治" userId="3dc346c6-a235-4d96-b756-7f3e038a9511" providerId="ADAL" clId="{16C5B60C-457B-4942-9EE7-7F330CB3EBE8}" dt="2022-10-06T04:46:30.672" v="231" actId="478"/>
          <ac:cxnSpMkLst>
            <pc:docMk/>
            <pc:sldMk cId="2961920430" sldId="293"/>
            <ac:cxnSpMk id="24" creationId="{51D6C3B3-1AA8-1884-A316-F7D04853D89A}"/>
          </ac:cxnSpMkLst>
        </pc:cxnChg>
        <pc:cxnChg chg="del mod">
          <ac:chgData name="濵田　大治" userId="3dc346c6-a235-4d96-b756-7f3e038a9511" providerId="ADAL" clId="{16C5B60C-457B-4942-9EE7-7F330CB3EBE8}" dt="2022-10-06T04:46:30.672" v="231" actId="478"/>
          <ac:cxnSpMkLst>
            <pc:docMk/>
            <pc:sldMk cId="2961920430" sldId="293"/>
            <ac:cxnSpMk id="25" creationId="{D7EBD22D-58FD-59D4-956C-3CE702868831}"/>
          </ac:cxnSpMkLst>
        </pc:cxnChg>
        <pc:cxnChg chg="mod">
          <ac:chgData name="濵田　大治" userId="3dc346c6-a235-4d96-b756-7f3e038a9511" providerId="ADAL" clId="{16C5B60C-457B-4942-9EE7-7F330CB3EBE8}" dt="2022-10-06T04:43:16.853" v="174" actId="1035"/>
          <ac:cxnSpMkLst>
            <pc:docMk/>
            <pc:sldMk cId="2961920430" sldId="293"/>
            <ac:cxnSpMk id="27" creationId="{58B63A0E-50A8-9E66-CCD9-1E35392D5826}"/>
          </ac:cxnSpMkLst>
        </pc:cxnChg>
        <pc:cxnChg chg="mod">
          <ac:chgData name="濵田　大治" userId="3dc346c6-a235-4d96-b756-7f3e038a9511" providerId="ADAL" clId="{16C5B60C-457B-4942-9EE7-7F330CB3EBE8}" dt="2022-10-06T04:43:42.884" v="203" actId="14100"/>
          <ac:cxnSpMkLst>
            <pc:docMk/>
            <pc:sldMk cId="2961920430" sldId="293"/>
            <ac:cxnSpMk id="28" creationId="{CA2457F5-4AD9-F50D-765E-002DD61C4832}"/>
          </ac:cxnSpMkLst>
        </pc:cxnChg>
        <pc:cxnChg chg="mod">
          <ac:chgData name="濵田　大治" userId="3dc346c6-a235-4d96-b756-7f3e038a9511" providerId="ADAL" clId="{16C5B60C-457B-4942-9EE7-7F330CB3EBE8}" dt="2022-10-06T04:43:32.400" v="178" actId="14100"/>
          <ac:cxnSpMkLst>
            <pc:docMk/>
            <pc:sldMk cId="2961920430" sldId="293"/>
            <ac:cxnSpMk id="29" creationId="{B9DE831C-39A5-5EB4-EC5E-FDB6B67B1222}"/>
          </ac:cxnSpMkLst>
        </pc:cxnChg>
        <pc:cxnChg chg="del mod">
          <ac:chgData name="濵田　大治" userId="3dc346c6-a235-4d96-b756-7f3e038a9511" providerId="ADAL" clId="{16C5B60C-457B-4942-9EE7-7F330CB3EBE8}" dt="2022-10-06T04:46:30.672" v="231" actId="478"/>
          <ac:cxnSpMkLst>
            <pc:docMk/>
            <pc:sldMk cId="2961920430" sldId="293"/>
            <ac:cxnSpMk id="31" creationId="{CAF364F9-BC65-54FE-3C0B-80AD4F55C381}"/>
          </ac:cxnSpMkLst>
        </pc:cxnChg>
        <pc:cxnChg chg="del mod">
          <ac:chgData name="濵田　大治" userId="3dc346c6-a235-4d96-b756-7f3e038a9511" providerId="ADAL" clId="{16C5B60C-457B-4942-9EE7-7F330CB3EBE8}" dt="2022-10-06T04:46:30.672" v="231" actId="478"/>
          <ac:cxnSpMkLst>
            <pc:docMk/>
            <pc:sldMk cId="2961920430" sldId="293"/>
            <ac:cxnSpMk id="32" creationId="{BC95FE01-DAF4-C713-BA78-D45E35637D3A}"/>
          </ac:cxnSpMkLst>
        </pc:cxnChg>
        <pc:cxnChg chg="del mod">
          <ac:chgData name="濵田　大治" userId="3dc346c6-a235-4d96-b756-7f3e038a9511" providerId="ADAL" clId="{16C5B60C-457B-4942-9EE7-7F330CB3EBE8}" dt="2022-10-06T04:46:30.672" v="231" actId="478"/>
          <ac:cxnSpMkLst>
            <pc:docMk/>
            <pc:sldMk cId="2961920430" sldId="293"/>
            <ac:cxnSpMk id="33" creationId="{9EB516DC-AA4A-1DAF-D3FB-A35C4D12F65E}"/>
          </ac:cxnSpMkLst>
        </pc:cxnChg>
      </pc:sldChg>
    </pc:docChg>
  </pc:docChgLst>
  <pc:docChgLst>
    <pc:chgData name="濵田　大治" userId="3dc346c6-a235-4d96-b756-7f3e038a9511" providerId="ADAL" clId="{16F79AFB-0C9A-4CDF-9DFF-5F175AD2A2C7}"/>
    <pc:docChg chg="undo custSel addSld modSld sldOrd">
      <pc:chgData name="濵田　大治" userId="3dc346c6-a235-4d96-b756-7f3e038a9511" providerId="ADAL" clId="{16F79AFB-0C9A-4CDF-9DFF-5F175AD2A2C7}" dt="2022-07-13T06:11:17.831" v="2133" actId="1076"/>
      <pc:docMkLst>
        <pc:docMk/>
      </pc:docMkLst>
      <pc:sldChg chg="addSp delSp modSp new mod">
        <pc:chgData name="濵田　大治" userId="3dc346c6-a235-4d96-b756-7f3e038a9511" providerId="ADAL" clId="{16F79AFB-0C9A-4CDF-9DFF-5F175AD2A2C7}" dt="2022-07-12T10:32:22.483" v="1254" actId="478"/>
        <pc:sldMkLst>
          <pc:docMk/>
          <pc:sldMk cId="2178963254" sldId="279"/>
        </pc:sldMkLst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2" creationId="{54EFE906-A6CA-8FFA-E5F4-11FDF3B9D021}"/>
          </ac:spMkLst>
        </pc:spChg>
        <pc:spChg chg="add del mod">
          <ac:chgData name="濵田　大治" userId="3dc346c6-a235-4d96-b756-7f3e038a9511" providerId="ADAL" clId="{16F79AFB-0C9A-4CDF-9DFF-5F175AD2A2C7}" dt="2022-07-12T10:26:50.405" v="837" actId="478"/>
          <ac:spMkLst>
            <pc:docMk/>
            <pc:sldMk cId="2178963254" sldId="279"/>
            <ac:spMk id="3" creationId="{DA3AAC7A-BE5C-9A0E-E7BD-EA042B7C95F5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4" creationId="{7B6AA86F-325E-E40F-F8A2-0E2534F8166A}"/>
          </ac:spMkLst>
        </pc:spChg>
        <pc:spChg chg="add del mod">
          <ac:chgData name="濵田　大治" userId="3dc346c6-a235-4d96-b756-7f3e038a9511" providerId="ADAL" clId="{16F79AFB-0C9A-4CDF-9DFF-5F175AD2A2C7}" dt="2022-07-12T10:28:19.967" v="931" actId="478"/>
          <ac:spMkLst>
            <pc:docMk/>
            <pc:sldMk cId="2178963254" sldId="279"/>
            <ac:spMk id="5" creationId="{0C680DDE-5785-9A93-02E3-8B8FAA913119}"/>
          </ac:spMkLst>
        </pc:spChg>
        <pc:spChg chg="add del mod">
          <ac:chgData name="濵田　大治" userId="3dc346c6-a235-4d96-b756-7f3e038a9511" providerId="ADAL" clId="{16F79AFB-0C9A-4CDF-9DFF-5F175AD2A2C7}" dt="2022-07-12T10:28:10.983" v="926" actId="478"/>
          <ac:spMkLst>
            <pc:docMk/>
            <pc:sldMk cId="2178963254" sldId="279"/>
            <ac:spMk id="6" creationId="{B2E1B72F-F18F-2742-0F32-414F502DC562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7" creationId="{BE14467E-FFD5-EE15-99C9-E7D93CFF850F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8" creationId="{51E46781-6ED2-B919-93E9-31259CFBDDDE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9" creationId="{C7EF422F-64CF-8EFA-E5FC-9EE8B43BF07C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10" creationId="{D22150CD-3EAA-55DF-2E58-C7BE9BBFBEFA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11" creationId="{93E24B78-E37E-A296-F8BC-1B91F1B600CC}"/>
          </ac:spMkLst>
        </pc:spChg>
        <pc:spChg chg="add del mod">
          <ac:chgData name="濵田　大治" userId="3dc346c6-a235-4d96-b756-7f3e038a9511" providerId="ADAL" clId="{16F79AFB-0C9A-4CDF-9DFF-5F175AD2A2C7}" dt="2022-07-12T10:27:15.869" v="902" actId="478"/>
          <ac:spMkLst>
            <pc:docMk/>
            <pc:sldMk cId="2178963254" sldId="279"/>
            <ac:spMk id="15" creationId="{67BB6852-1E8E-0FEE-CDE5-F2F525F374C7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16" creationId="{BF8D6754-B59A-AA41-BABB-4368A145A064}"/>
          </ac:spMkLst>
        </pc:spChg>
        <pc:spChg chg="add del mod">
          <ac:chgData name="濵田　大治" userId="3dc346c6-a235-4d96-b756-7f3e038a9511" providerId="ADAL" clId="{16F79AFB-0C9A-4CDF-9DFF-5F175AD2A2C7}" dt="2022-07-12T10:27:31.756" v="908" actId="478"/>
          <ac:spMkLst>
            <pc:docMk/>
            <pc:sldMk cId="2178963254" sldId="279"/>
            <ac:spMk id="20" creationId="{37010803-FCC4-5500-09DC-1CDBB7EF85DD}"/>
          </ac:spMkLst>
        </pc:spChg>
        <pc:spChg chg="add del mod">
          <ac:chgData name="濵田　大治" userId="3dc346c6-a235-4d96-b756-7f3e038a9511" providerId="ADAL" clId="{16F79AFB-0C9A-4CDF-9DFF-5F175AD2A2C7}" dt="2022-07-12T10:26:45.483" v="835" actId="478"/>
          <ac:spMkLst>
            <pc:docMk/>
            <pc:sldMk cId="2178963254" sldId="279"/>
            <ac:spMk id="21" creationId="{16B07E0F-E247-2174-A8BE-6A04FDA620F9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22" creationId="{EC373EA9-329E-8242-4DC0-D33334449D1C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23" creationId="{FE13790A-EFED-6095-49B6-FA7CBD4FEE78}"/>
          </ac:spMkLst>
        </pc:spChg>
        <pc:spChg chg="add del mod">
          <ac:chgData name="濵田　大治" userId="3dc346c6-a235-4d96-b756-7f3e038a9511" providerId="ADAL" clId="{16F79AFB-0C9A-4CDF-9DFF-5F175AD2A2C7}" dt="2022-07-12T10:28:01.250" v="924" actId="478"/>
          <ac:spMkLst>
            <pc:docMk/>
            <pc:sldMk cId="2178963254" sldId="279"/>
            <ac:spMk id="27" creationId="{746A90CC-479E-F019-3C06-2493C6C66C24}"/>
          </ac:spMkLst>
        </pc:spChg>
        <pc:spChg chg="add del mod">
          <ac:chgData name="濵田　大治" userId="3dc346c6-a235-4d96-b756-7f3e038a9511" providerId="ADAL" clId="{16F79AFB-0C9A-4CDF-9DFF-5F175AD2A2C7}" dt="2022-07-12T10:28:17.045" v="930" actId="478"/>
          <ac:spMkLst>
            <pc:docMk/>
            <pc:sldMk cId="2178963254" sldId="279"/>
            <ac:spMk id="28" creationId="{6E7D8CDD-B35F-BB0B-C36A-8243B7C14035}"/>
          </ac:spMkLst>
        </pc:spChg>
        <pc:spChg chg="add del mod">
          <ac:chgData name="濵田　大治" userId="3dc346c6-a235-4d96-b756-7f3e038a9511" providerId="ADAL" clId="{16F79AFB-0C9A-4CDF-9DFF-5F175AD2A2C7}" dt="2022-07-12T10:28:12.546" v="927" actId="478"/>
          <ac:spMkLst>
            <pc:docMk/>
            <pc:sldMk cId="2178963254" sldId="279"/>
            <ac:spMk id="29" creationId="{1155080A-FF0A-89B7-FF9B-8F0953D71128}"/>
          </ac:spMkLst>
        </pc:spChg>
        <pc:spChg chg="add del mod">
          <ac:chgData name="濵田　大治" userId="3dc346c6-a235-4d96-b756-7f3e038a9511" providerId="ADAL" clId="{16F79AFB-0C9A-4CDF-9DFF-5F175AD2A2C7}" dt="2022-07-12T10:28:14.202" v="928" actId="478"/>
          <ac:spMkLst>
            <pc:docMk/>
            <pc:sldMk cId="2178963254" sldId="279"/>
            <ac:spMk id="30" creationId="{DA65AC0C-5201-49F8-B335-4C0C01F903BD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31" creationId="{B5E3830E-0C50-E87A-297E-D0C1EE3598CE}"/>
          </ac:spMkLst>
        </pc:spChg>
        <pc:spChg chg="add del mod">
          <ac:chgData name="濵田　大治" userId="3dc346c6-a235-4d96-b756-7f3e038a9511" providerId="ADAL" clId="{16F79AFB-0C9A-4CDF-9DFF-5F175AD2A2C7}" dt="2022-07-12T10:32:22.483" v="1254" actId="478"/>
          <ac:spMkLst>
            <pc:docMk/>
            <pc:sldMk cId="2178963254" sldId="279"/>
            <ac:spMk id="32" creationId="{50833857-D34E-8A18-19A5-A52D90706CDB}"/>
          </ac:spMkLst>
        </pc:spChg>
        <pc:spChg chg="add del mod">
          <ac:chgData name="濵田　大治" userId="3dc346c6-a235-4d96-b756-7f3e038a9511" providerId="ADAL" clId="{16F79AFB-0C9A-4CDF-9DFF-5F175AD2A2C7}" dt="2022-07-12T10:27:40.130" v="910" actId="478"/>
          <ac:spMkLst>
            <pc:docMk/>
            <pc:sldMk cId="2178963254" sldId="279"/>
            <ac:spMk id="36" creationId="{0835C00C-B7F1-93FD-087F-C2C19406BB34}"/>
          </ac:spMkLst>
        </pc:spChg>
        <pc:spChg chg="add del mod">
          <ac:chgData name="濵田　大治" userId="3dc346c6-a235-4d96-b756-7f3e038a9511" providerId="ADAL" clId="{16F79AFB-0C9A-4CDF-9DFF-5F175AD2A2C7}" dt="2022-07-12T10:28:15.717" v="929" actId="478"/>
          <ac:spMkLst>
            <pc:docMk/>
            <pc:sldMk cId="2178963254" sldId="279"/>
            <ac:spMk id="37" creationId="{4C999CBA-97C0-2C04-F078-6C9424F0D14A}"/>
          </ac:spMkLst>
        </pc:spChg>
        <pc:grpChg chg="add del mod">
          <ac:chgData name="濵田　大治" userId="3dc346c6-a235-4d96-b756-7f3e038a9511" providerId="ADAL" clId="{16F79AFB-0C9A-4CDF-9DFF-5F175AD2A2C7}" dt="2022-07-12T10:27:16.994" v="903" actId="478"/>
          <ac:grpSpMkLst>
            <pc:docMk/>
            <pc:sldMk cId="2178963254" sldId="279"/>
            <ac:grpSpMk id="12" creationId="{0DADC2CA-BA77-A08F-59CE-B10218D98CE8}"/>
          </ac:grpSpMkLst>
        </pc:grpChg>
        <pc:grpChg chg="add del mod">
          <ac:chgData name="濵田　大治" userId="3dc346c6-a235-4d96-b756-7f3e038a9511" providerId="ADAL" clId="{16F79AFB-0C9A-4CDF-9DFF-5F175AD2A2C7}" dt="2022-07-12T10:27:32.834" v="909" actId="478"/>
          <ac:grpSpMkLst>
            <pc:docMk/>
            <pc:sldMk cId="2178963254" sldId="279"/>
            <ac:grpSpMk id="17" creationId="{D98339DF-72C4-DDDD-2171-88A9C4791544}"/>
          </ac:grpSpMkLst>
        </pc:grpChg>
        <pc:grpChg chg="add del mod">
          <ac:chgData name="濵田　大治" userId="3dc346c6-a235-4d96-b756-7f3e038a9511" providerId="ADAL" clId="{16F79AFB-0C9A-4CDF-9DFF-5F175AD2A2C7}" dt="2022-07-12T10:28:02.593" v="925" actId="478"/>
          <ac:grpSpMkLst>
            <pc:docMk/>
            <pc:sldMk cId="2178963254" sldId="279"/>
            <ac:grpSpMk id="24" creationId="{C4B6E16A-538F-C85A-6818-757937C0342D}"/>
          </ac:grpSpMkLst>
        </pc:grpChg>
        <pc:grpChg chg="add del mod">
          <ac:chgData name="濵田　大治" userId="3dc346c6-a235-4d96-b756-7f3e038a9511" providerId="ADAL" clId="{16F79AFB-0C9A-4CDF-9DFF-5F175AD2A2C7}" dt="2022-07-12T10:27:41.177" v="911" actId="478"/>
          <ac:grpSpMkLst>
            <pc:docMk/>
            <pc:sldMk cId="2178963254" sldId="279"/>
            <ac:grpSpMk id="33" creationId="{1F0E7E5A-58E4-C4E0-890A-C465A9D901B5}"/>
          </ac:grpSpMkLst>
        </pc:grpChg>
        <pc:cxnChg chg="mod">
          <ac:chgData name="濵田　大治" userId="3dc346c6-a235-4d96-b756-7f3e038a9511" providerId="ADAL" clId="{16F79AFB-0C9A-4CDF-9DFF-5F175AD2A2C7}" dt="2022-07-12T10:26:42.774" v="834"/>
          <ac:cxnSpMkLst>
            <pc:docMk/>
            <pc:sldMk cId="2178963254" sldId="279"/>
            <ac:cxnSpMk id="13" creationId="{210A4403-EF79-03DD-215F-CBEE35789149}"/>
          </ac:cxnSpMkLst>
        </pc:cxnChg>
        <pc:cxnChg chg="mod">
          <ac:chgData name="濵田　大治" userId="3dc346c6-a235-4d96-b756-7f3e038a9511" providerId="ADAL" clId="{16F79AFB-0C9A-4CDF-9DFF-5F175AD2A2C7}" dt="2022-07-12T10:26:42.774" v="834"/>
          <ac:cxnSpMkLst>
            <pc:docMk/>
            <pc:sldMk cId="2178963254" sldId="279"/>
            <ac:cxnSpMk id="14" creationId="{4AA4ADB1-9B69-FD1B-48D7-223E8A5CF1A2}"/>
          </ac:cxnSpMkLst>
        </pc:cxnChg>
        <pc:cxnChg chg="mod">
          <ac:chgData name="濵田　大治" userId="3dc346c6-a235-4d96-b756-7f3e038a9511" providerId="ADAL" clId="{16F79AFB-0C9A-4CDF-9DFF-5F175AD2A2C7}" dt="2022-07-12T10:26:42.774" v="834"/>
          <ac:cxnSpMkLst>
            <pc:docMk/>
            <pc:sldMk cId="2178963254" sldId="279"/>
            <ac:cxnSpMk id="18" creationId="{9F82C220-5917-7D8F-FB77-7A356B5641A5}"/>
          </ac:cxnSpMkLst>
        </pc:cxnChg>
        <pc:cxnChg chg="mod">
          <ac:chgData name="濵田　大治" userId="3dc346c6-a235-4d96-b756-7f3e038a9511" providerId="ADAL" clId="{16F79AFB-0C9A-4CDF-9DFF-5F175AD2A2C7}" dt="2022-07-12T10:26:42.774" v="834"/>
          <ac:cxnSpMkLst>
            <pc:docMk/>
            <pc:sldMk cId="2178963254" sldId="279"/>
            <ac:cxnSpMk id="19" creationId="{1ED523FF-F9C2-973F-047A-F8DAEB492F10}"/>
          </ac:cxnSpMkLst>
        </pc:cxnChg>
        <pc:cxnChg chg="mod">
          <ac:chgData name="濵田　大治" userId="3dc346c6-a235-4d96-b756-7f3e038a9511" providerId="ADAL" clId="{16F79AFB-0C9A-4CDF-9DFF-5F175AD2A2C7}" dt="2022-07-12T10:26:42.774" v="834"/>
          <ac:cxnSpMkLst>
            <pc:docMk/>
            <pc:sldMk cId="2178963254" sldId="279"/>
            <ac:cxnSpMk id="25" creationId="{2A7FEF47-4DD4-36FD-073A-1549A31FF1BD}"/>
          </ac:cxnSpMkLst>
        </pc:cxnChg>
        <pc:cxnChg chg="mod">
          <ac:chgData name="濵田　大治" userId="3dc346c6-a235-4d96-b756-7f3e038a9511" providerId="ADAL" clId="{16F79AFB-0C9A-4CDF-9DFF-5F175AD2A2C7}" dt="2022-07-12T10:26:42.774" v="834"/>
          <ac:cxnSpMkLst>
            <pc:docMk/>
            <pc:sldMk cId="2178963254" sldId="279"/>
            <ac:cxnSpMk id="26" creationId="{F1284263-4691-DA5D-F2F7-1F6F6EAD28EB}"/>
          </ac:cxnSpMkLst>
        </pc:cxnChg>
        <pc:cxnChg chg="mod">
          <ac:chgData name="濵田　大治" userId="3dc346c6-a235-4d96-b756-7f3e038a9511" providerId="ADAL" clId="{16F79AFB-0C9A-4CDF-9DFF-5F175AD2A2C7}" dt="2022-07-12T10:26:42.774" v="834"/>
          <ac:cxnSpMkLst>
            <pc:docMk/>
            <pc:sldMk cId="2178963254" sldId="279"/>
            <ac:cxnSpMk id="34" creationId="{86AC2444-AD3B-3EEC-5110-7E1E623610BB}"/>
          </ac:cxnSpMkLst>
        </pc:cxnChg>
        <pc:cxnChg chg="mod">
          <ac:chgData name="濵田　大治" userId="3dc346c6-a235-4d96-b756-7f3e038a9511" providerId="ADAL" clId="{16F79AFB-0C9A-4CDF-9DFF-5F175AD2A2C7}" dt="2022-07-12T10:26:42.774" v="834"/>
          <ac:cxnSpMkLst>
            <pc:docMk/>
            <pc:sldMk cId="2178963254" sldId="279"/>
            <ac:cxnSpMk id="35" creationId="{0F2161BB-1745-7EF0-0094-4EE4C0CAD11C}"/>
          </ac:cxnSpMkLst>
        </pc:cxnChg>
        <pc:cxnChg chg="add del mod">
          <ac:chgData name="濵田　大治" userId="3dc346c6-a235-4d96-b756-7f3e038a9511" providerId="ADAL" clId="{16F79AFB-0C9A-4CDF-9DFF-5F175AD2A2C7}" dt="2022-07-12T10:31:22.422" v="1247" actId="478"/>
          <ac:cxnSpMkLst>
            <pc:docMk/>
            <pc:sldMk cId="2178963254" sldId="279"/>
            <ac:cxnSpMk id="39" creationId="{E0436831-80DD-AA64-866B-BAED799C097C}"/>
          </ac:cxnSpMkLst>
        </pc:cxnChg>
        <pc:cxnChg chg="add del mod">
          <ac:chgData name="濵田　大治" userId="3dc346c6-a235-4d96-b756-7f3e038a9511" providerId="ADAL" clId="{16F79AFB-0C9A-4CDF-9DFF-5F175AD2A2C7}" dt="2022-07-12T10:31:20.985" v="1246" actId="478"/>
          <ac:cxnSpMkLst>
            <pc:docMk/>
            <pc:sldMk cId="2178963254" sldId="279"/>
            <ac:cxnSpMk id="41" creationId="{85AEB13F-5AB5-8FEF-A3FE-661968CADE71}"/>
          </ac:cxnSpMkLst>
        </pc:cxnChg>
      </pc:sldChg>
      <pc:sldChg chg="delSp modSp add mod ord">
        <pc:chgData name="濵田　大治" userId="3dc346c6-a235-4d96-b756-7f3e038a9511" providerId="ADAL" clId="{16F79AFB-0C9A-4CDF-9DFF-5F175AD2A2C7}" dt="2022-07-13T05:32:13.974" v="2099" actId="20577"/>
        <pc:sldMkLst>
          <pc:docMk/>
          <pc:sldMk cId="1355024604" sldId="280"/>
        </pc:sldMkLst>
        <pc:spChg chg="mod">
          <ac:chgData name="濵田　大治" userId="3dc346c6-a235-4d96-b756-7f3e038a9511" providerId="ADAL" clId="{16F79AFB-0C9A-4CDF-9DFF-5F175AD2A2C7}" dt="2022-07-13T05:32:13.974" v="2099" actId="20577"/>
          <ac:spMkLst>
            <pc:docMk/>
            <pc:sldMk cId="1355024604" sldId="280"/>
            <ac:spMk id="3" creationId="{0174EA08-22EA-4444-9B6A-4AA766E76114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11" creationId="{40ABFE53-9F2D-BF65-DFA0-F86525698315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20" creationId="{1613CEAE-9418-4313-8537-0BF9E7164EDC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21" creationId="{E9F85505-F283-49F1-8A74-237A8FEA9FC3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22" creationId="{D92372CF-7303-4147-9C9F-E4C545EF3A13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23" creationId="{63530E9C-0C23-4A5E-9693-48F2AE5C6831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24" creationId="{8BE47E5D-9665-43B3-B100-A64DF3392566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26" creationId="{F4945D81-85D0-4D6A-9999-16A76C35FA08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27" creationId="{6F16224C-9989-4450-A76E-2CD74A6ADEB0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28" creationId="{E5B7042F-0E5C-4AD6-B37C-1E34B167B8CE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29" creationId="{666AB90D-9F64-4645-A168-82C2D7497075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30" creationId="{F33B9DCD-3091-4956-A35E-94AA872F36A8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34" creationId="{F3A69DFE-CF56-4E3A-8620-55B97D67F675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51" creationId="{4DD7670E-397B-A427-F384-04710EF8E3EE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57" creationId="{1F76A221-880C-582D-40E8-96D52E14EBC4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92" creationId="{AEE60B3C-D3B9-433A-A5C2-D6061ED73FAA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93" creationId="{109D074F-B7FF-414E-8626-ACF1D8D37509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97" creationId="{0F5CAE15-4239-406F-8A84-CF63F1BA798D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98" creationId="{DEA5078E-C935-4B36-9A52-7D99A7BFC421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99" creationId="{8BE47E5D-9665-43B3-B100-A64DF3392566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100" creationId="{DEA5078E-C935-4B36-9A52-7D99A7BFC421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101" creationId="{F4945D81-85D0-4D6A-9999-16A76C35FA08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102" creationId="{4DD7670E-397B-A427-F384-04710EF8E3EE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106" creationId="{1F76A221-880C-582D-40E8-96D52E14EBC4}"/>
          </ac:spMkLst>
        </pc:spChg>
        <pc:spChg chg="del">
          <ac:chgData name="濵田　大治" userId="3dc346c6-a235-4d96-b756-7f3e038a9511" providerId="ADAL" clId="{16F79AFB-0C9A-4CDF-9DFF-5F175AD2A2C7}" dt="2022-07-12T08:37:25.534" v="4" actId="478"/>
          <ac:spMkLst>
            <pc:docMk/>
            <pc:sldMk cId="1355024604" sldId="280"/>
            <ac:spMk id="107" creationId="{DEA5078E-C935-4B36-9A52-7D99A7BFC421}"/>
          </ac:spMkLst>
        </pc:spChg>
        <pc:grpChg chg="del">
          <ac:chgData name="濵田　大治" userId="3dc346c6-a235-4d96-b756-7f3e038a9511" providerId="ADAL" clId="{16F79AFB-0C9A-4CDF-9DFF-5F175AD2A2C7}" dt="2022-07-12T08:37:25.534" v="4" actId="478"/>
          <ac:grpSpMkLst>
            <pc:docMk/>
            <pc:sldMk cId="1355024604" sldId="280"/>
            <ac:grpSpMk id="31" creationId="{D53C7F3D-BA0B-4FAC-900F-71CD863FA140}"/>
          </ac:grpSpMkLst>
        </pc:grpChg>
        <pc:grpChg chg="del">
          <ac:chgData name="濵田　大治" userId="3dc346c6-a235-4d96-b756-7f3e038a9511" providerId="ADAL" clId="{16F79AFB-0C9A-4CDF-9DFF-5F175AD2A2C7}" dt="2022-07-12T08:37:25.534" v="4" actId="478"/>
          <ac:grpSpMkLst>
            <pc:docMk/>
            <pc:sldMk cId="1355024604" sldId="280"/>
            <ac:grpSpMk id="54" creationId="{C9EC6521-CD75-25DE-BD39-3EA468DAA599}"/>
          </ac:grpSpMkLst>
        </pc:grpChg>
        <pc:grpChg chg="del">
          <ac:chgData name="濵田　大治" userId="3dc346c6-a235-4d96-b756-7f3e038a9511" providerId="ADAL" clId="{16F79AFB-0C9A-4CDF-9DFF-5F175AD2A2C7}" dt="2022-07-12T08:37:25.534" v="4" actId="478"/>
          <ac:grpSpMkLst>
            <pc:docMk/>
            <pc:sldMk cId="1355024604" sldId="280"/>
            <ac:grpSpMk id="94" creationId="{3286733B-3773-4CDE-9B48-30D3ED63FF79}"/>
          </ac:grpSpMkLst>
        </pc:grpChg>
        <pc:grpChg chg="del">
          <ac:chgData name="濵田　大治" userId="3dc346c6-a235-4d96-b756-7f3e038a9511" providerId="ADAL" clId="{16F79AFB-0C9A-4CDF-9DFF-5F175AD2A2C7}" dt="2022-07-12T08:37:25.534" v="4" actId="478"/>
          <ac:grpSpMkLst>
            <pc:docMk/>
            <pc:sldMk cId="1355024604" sldId="280"/>
            <ac:grpSpMk id="103" creationId="{C9EC6521-CD75-25DE-BD39-3EA468DAA599}"/>
          </ac:grpSpMkLst>
        </pc:grpChg>
      </pc:sldChg>
      <pc:sldChg chg="addSp modSp new mod ord">
        <pc:chgData name="濵田　大治" userId="3dc346c6-a235-4d96-b756-7f3e038a9511" providerId="ADAL" clId="{16F79AFB-0C9A-4CDF-9DFF-5F175AD2A2C7}" dt="2022-07-12T10:34:49.888" v="1348" actId="1076"/>
        <pc:sldMkLst>
          <pc:docMk/>
          <pc:sldMk cId="3116643837" sldId="281"/>
        </pc:sldMkLst>
        <pc:spChg chg="add mod">
          <ac:chgData name="濵田　大治" userId="3dc346c6-a235-4d96-b756-7f3e038a9511" providerId="ADAL" clId="{16F79AFB-0C9A-4CDF-9DFF-5F175AD2A2C7}" dt="2022-07-12T10:06:38.422" v="490" actId="1076"/>
          <ac:spMkLst>
            <pc:docMk/>
            <pc:sldMk cId="3116643837" sldId="281"/>
            <ac:spMk id="6" creationId="{EFF60E8A-E7E8-8110-66F5-27097F9C7BF0}"/>
          </ac:spMkLst>
        </pc:spChg>
        <pc:spChg chg="add mod">
          <ac:chgData name="濵田　大治" userId="3dc346c6-a235-4d96-b756-7f3e038a9511" providerId="ADAL" clId="{16F79AFB-0C9A-4CDF-9DFF-5F175AD2A2C7}" dt="2022-07-12T10:06:38.422" v="490" actId="1076"/>
          <ac:spMkLst>
            <pc:docMk/>
            <pc:sldMk cId="3116643837" sldId="281"/>
            <ac:spMk id="7" creationId="{8141950E-215C-9984-E61F-C65CE18D49E5}"/>
          </ac:spMkLst>
        </pc:spChg>
        <pc:spChg chg="add mod">
          <ac:chgData name="濵田　大治" userId="3dc346c6-a235-4d96-b756-7f3e038a9511" providerId="ADAL" clId="{16F79AFB-0C9A-4CDF-9DFF-5F175AD2A2C7}" dt="2022-07-12T10:34:49.888" v="1348" actId="1076"/>
          <ac:spMkLst>
            <pc:docMk/>
            <pc:sldMk cId="3116643837" sldId="281"/>
            <ac:spMk id="8" creationId="{1D6C011C-00AB-1441-EC17-5A873DF1B22C}"/>
          </ac:spMkLst>
        </pc:spChg>
        <pc:picChg chg="add mod">
          <ac:chgData name="濵田　大治" userId="3dc346c6-a235-4d96-b756-7f3e038a9511" providerId="ADAL" clId="{16F79AFB-0C9A-4CDF-9DFF-5F175AD2A2C7}" dt="2022-07-12T10:06:38.422" v="490" actId="1076"/>
          <ac:picMkLst>
            <pc:docMk/>
            <pc:sldMk cId="3116643837" sldId="281"/>
            <ac:picMk id="3" creationId="{D55227C6-76EE-F70F-0471-6D172698AEE7}"/>
          </ac:picMkLst>
        </pc:picChg>
        <pc:picChg chg="add mod">
          <ac:chgData name="濵田　大治" userId="3dc346c6-a235-4d96-b756-7f3e038a9511" providerId="ADAL" clId="{16F79AFB-0C9A-4CDF-9DFF-5F175AD2A2C7}" dt="2022-07-12T10:06:38.422" v="490" actId="1076"/>
          <ac:picMkLst>
            <pc:docMk/>
            <pc:sldMk cId="3116643837" sldId="281"/>
            <ac:picMk id="5" creationId="{F53800EB-0A8C-7DE6-4C81-715D89716772}"/>
          </ac:picMkLst>
        </pc:picChg>
      </pc:sldChg>
      <pc:sldChg chg="addSp delSp modSp add mod">
        <pc:chgData name="濵田　大治" userId="3dc346c6-a235-4d96-b756-7f3e038a9511" providerId="ADAL" clId="{16F79AFB-0C9A-4CDF-9DFF-5F175AD2A2C7}" dt="2022-07-13T04:23:17.967" v="1394" actId="1076"/>
        <pc:sldMkLst>
          <pc:docMk/>
          <pc:sldMk cId="336970124" sldId="282"/>
        </pc:sldMkLst>
        <pc:spChg chg="add mod">
          <ac:chgData name="濵田　大治" userId="3dc346c6-a235-4d96-b756-7f3e038a9511" providerId="ADAL" clId="{16F79AFB-0C9A-4CDF-9DFF-5F175AD2A2C7}" dt="2022-07-13T04:23:17.967" v="1394" actId="1076"/>
          <ac:spMkLst>
            <pc:docMk/>
            <pc:sldMk cId="336970124" sldId="282"/>
            <ac:spMk id="5" creationId="{066069BF-4783-6006-6E2C-96A8F816859B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7" creationId="{06A2F348-5310-7A85-3925-56505CD01DD5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9" creationId="{681E5E1E-642E-7958-969E-E35D210A73B1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11" creationId="{924449CA-FC9B-DB44-489A-BC2D86C74A53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13" creationId="{2CE60BAE-0BA6-8738-5FB7-0A8CCB97D06F}"/>
          </ac:spMkLst>
        </pc:spChg>
        <pc:spChg chg="add del mod">
          <ac:chgData name="濵田　大治" userId="3dc346c6-a235-4d96-b756-7f3e038a9511" providerId="ADAL" clId="{16F79AFB-0C9A-4CDF-9DFF-5F175AD2A2C7}" dt="2022-07-12T10:24:28.749" v="830" actId="478"/>
          <ac:spMkLst>
            <pc:docMk/>
            <pc:sldMk cId="336970124" sldId="282"/>
            <ac:spMk id="14" creationId="{E02A8E7F-842E-BAAC-1954-EFBBAF965E48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15" creationId="{ADA949F5-3C94-B50A-3006-6E7B26E6FDA1}"/>
          </ac:spMkLst>
        </pc:spChg>
        <pc:spChg chg="add del mod">
          <ac:chgData name="濵田　大治" userId="3dc346c6-a235-4d96-b756-7f3e038a9511" providerId="ADAL" clId="{16F79AFB-0C9A-4CDF-9DFF-5F175AD2A2C7}" dt="2022-07-12T10:31:44.050" v="1248" actId="478"/>
          <ac:spMkLst>
            <pc:docMk/>
            <pc:sldMk cId="336970124" sldId="282"/>
            <ac:spMk id="16" creationId="{8D82EA89-90E3-C8F9-25E5-4F6792CF966E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22" creationId="{7104F61A-2C66-7BD6-4639-34ADCCC1F546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23" creationId="{69D95A9E-A02F-D3CA-D3FC-564863B52F20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24" creationId="{CB20B121-5619-F0FF-6495-54F29F39FD15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25" creationId="{55339621-3B48-5AB9-CD18-40FDE3617A16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26" creationId="{D86292A2-BBCA-4CC5-50DD-21BFD0FFA7FE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27" creationId="{3E722C35-E944-4056-15DE-9A1FED70FE4E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28" creationId="{91016081-BDDA-46C2-D502-BE6E25B85504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29" creationId="{A5687621-BD2A-1FAB-C633-19CC731EE3A9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30" creationId="{D680AA8B-347C-CC4D-853F-6277E5EA1ABD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31" creationId="{E1BC9CDC-5AB0-5E90-BA6C-B1B8D89B1FCD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32" creationId="{6EBF53D7-26EA-8C3F-E522-BACE1A52893B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33" creationId="{D295A7F6-2BE9-6307-74BE-1965989E416B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34" creationId="{8BC28173-2EC1-4256-AF14-D2CA7B3D8B0C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35" creationId="{7DBE75C4-4AFC-A1C2-C1ED-0B8867EFE9F5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36" creationId="{EF4A6398-B7A0-AFC5-40BF-5734D60D0717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37" creationId="{322BAA17-CE20-A0F3-7DEB-756C14DA36CF}"/>
          </ac:spMkLst>
        </pc:spChg>
        <pc:spChg chg="add mod">
          <ac:chgData name="濵田　大治" userId="3dc346c6-a235-4d96-b756-7f3e038a9511" providerId="ADAL" clId="{16F79AFB-0C9A-4CDF-9DFF-5F175AD2A2C7}" dt="2022-07-13T04:23:10.495" v="1393" actId="1076"/>
          <ac:spMkLst>
            <pc:docMk/>
            <pc:sldMk cId="336970124" sldId="282"/>
            <ac:spMk id="38" creationId="{FECE59FA-A34D-A10F-FAF8-45F82ED572CE}"/>
          </ac:spMkLst>
        </pc:spChg>
        <pc:spChg chg="add mod">
          <ac:chgData name="濵田　大治" userId="3dc346c6-a235-4d96-b756-7f3e038a9511" providerId="ADAL" clId="{16F79AFB-0C9A-4CDF-9DFF-5F175AD2A2C7}" dt="2022-07-13T04:23:17.967" v="1394" actId="1076"/>
          <ac:spMkLst>
            <pc:docMk/>
            <pc:sldMk cId="336970124" sldId="282"/>
            <ac:spMk id="39" creationId="{FE5AE488-CCE9-0895-B0B0-D6ED3EF510B5}"/>
          </ac:spMkLst>
        </pc:spChg>
        <pc:picChg chg="add mod">
          <ac:chgData name="濵田　大治" userId="3dc346c6-a235-4d96-b756-7f3e038a9511" providerId="ADAL" clId="{16F79AFB-0C9A-4CDF-9DFF-5F175AD2A2C7}" dt="2022-07-13T04:23:10.495" v="1393" actId="1076"/>
          <ac:picMkLst>
            <pc:docMk/>
            <pc:sldMk cId="336970124" sldId="282"/>
            <ac:picMk id="2" creationId="{BD941B63-FF16-7F0D-4035-BC90F2E5DCCD}"/>
          </ac:picMkLst>
        </pc:picChg>
        <pc:picChg chg="add mod">
          <ac:chgData name="濵田　大治" userId="3dc346c6-a235-4d96-b756-7f3e038a9511" providerId="ADAL" clId="{16F79AFB-0C9A-4CDF-9DFF-5F175AD2A2C7}" dt="2022-07-13T04:23:17.967" v="1394" actId="1076"/>
          <ac:picMkLst>
            <pc:docMk/>
            <pc:sldMk cId="336970124" sldId="282"/>
            <ac:picMk id="3" creationId="{4CBC79F5-F322-98B5-96DA-4A4A03512A83}"/>
          </ac:picMkLst>
        </pc:picChg>
        <pc:picChg chg="del mod modCrop">
          <ac:chgData name="濵田　大治" userId="3dc346c6-a235-4d96-b756-7f3e038a9511" providerId="ADAL" clId="{16F79AFB-0C9A-4CDF-9DFF-5F175AD2A2C7}" dt="2022-07-12T10:01:37.165" v="246" actId="478"/>
          <ac:picMkLst>
            <pc:docMk/>
            <pc:sldMk cId="336970124" sldId="282"/>
            <ac:picMk id="3" creationId="{D55227C6-76EE-F70F-0471-6D172698AEE7}"/>
          </ac:picMkLst>
        </pc:picChg>
        <pc:picChg chg="add mod">
          <ac:chgData name="濵田　大治" userId="3dc346c6-a235-4d96-b756-7f3e038a9511" providerId="ADAL" clId="{16F79AFB-0C9A-4CDF-9DFF-5F175AD2A2C7}" dt="2022-07-13T04:23:10.495" v="1393" actId="1076"/>
          <ac:picMkLst>
            <pc:docMk/>
            <pc:sldMk cId="336970124" sldId="282"/>
            <ac:picMk id="4" creationId="{A28CA441-2446-6A6B-2466-2BEA85F21083}"/>
          </ac:picMkLst>
        </pc:picChg>
        <pc:picChg chg="del mod modCrop">
          <ac:chgData name="濵田　大治" userId="3dc346c6-a235-4d96-b756-7f3e038a9511" providerId="ADAL" clId="{16F79AFB-0C9A-4CDF-9DFF-5F175AD2A2C7}" dt="2022-07-12T10:01:37.165" v="246" actId="478"/>
          <ac:picMkLst>
            <pc:docMk/>
            <pc:sldMk cId="336970124" sldId="282"/>
            <ac:picMk id="5" creationId="{F53800EB-0A8C-7DE6-4C81-715D89716772}"/>
          </ac:picMkLst>
        </pc:picChg>
        <pc:cxnChg chg="add mod">
          <ac:chgData name="濵田　大治" userId="3dc346c6-a235-4d96-b756-7f3e038a9511" providerId="ADAL" clId="{16F79AFB-0C9A-4CDF-9DFF-5F175AD2A2C7}" dt="2022-07-13T04:23:10.495" v="1393" actId="1076"/>
          <ac:cxnSpMkLst>
            <pc:docMk/>
            <pc:sldMk cId="336970124" sldId="282"/>
            <ac:cxnSpMk id="6" creationId="{BF792176-66E8-E606-867B-89F782A1495B}"/>
          </ac:cxnSpMkLst>
        </pc:cxnChg>
        <pc:cxnChg chg="add mod">
          <ac:chgData name="濵田　大治" userId="3dc346c6-a235-4d96-b756-7f3e038a9511" providerId="ADAL" clId="{16F79AFB-0C9A-4CDF-9DFF-5F175AD2A2C7}" dt="2022-07-13T04:23:10.495" v="1393" actId="1076"/>
          <ac:cxnSpMkLst>
            <pc:docMk/>
            <pc:sldMk cId="336970124" sldId="282"/>
            <ac:cxnSpMk id="8" creationId="{1FCD1B9D-3C7B-9A85-5DB5-E7925514EF07}"/>
          </ac:cxnSpMkLst>
        </pc:cxnChg>
        <pc:cxnChg chg="add mod">
          <ac:chgData name="濵田　大治" userId="3dc346c6-a235-4d96-b756-7f3e038a9511" providerId="ADAL" clId="{16F79AFB-0C9A-4CDF-9DFF-5F175AD2A2C7}" dt="2022-07-13T04:23:10.495" v="1393" actId="1076"/>
          <ac:cxnSpMkLst>
            <pc:docMk/>
            <pc:sldMk cId="336970124" sldId="282"/>
            <ac:cxnSpMk id="10" creationId="{0BBDBE72-7692-9C33-9278-161A7F6FFFD5}"/>
          </ac:cxnSpMkLst>
        </pc:cxnChg>
        <pc:cxnChg chg="add mod">
          <ac:chgData name="濵田　大治" userId="3dc346c6-a235-4d96-b756-7f3e038a9511" providerId="ADAL" clId="{16F79AFB-0C9A-4CDF-9DFF-5F175AD2A2C7}" dt="2022-07-13T04:23:10.495" v="1393" actId="1076"/>
          <ac:cxnSpMkLst>
            <pc:docMk/>
            <pc:sldMk cId="336970124" sldId="282"/>
            <ac:cxnSpMk id="12" creationId="{A3B2A46C-C835-999C-EF70-8920E84438F0}"/>
          </ac:cxnSpMkLst>
        </pc:cxnChg>
        <pc:cxnChg chg="add mod">
          <ac:chgData name="濵田　大治" userId="3dc346c6-a235-4d96-b756-7f3e038a9511" providerId="ADAL" clId="{16F79AFB-0C9A-4CDF-9DFF-5F175AD2A2C7}" dt="2022-07-13T04:23:10.495" v="1393" actId="1076"/>
          <ac:cxnSpMkLst>
            <pc:docMk/>
            <pc:sldMk cId="336970124" sldId="282"/>
            <ac:cxnSpMk id="18" creationId="{5DD42ABD-701F-7802-8C6F-8BBAD13E396C}"/>
          </ac:cxnSpMkLst>
        </pc:cxnChg>
        <pc:cxnChg chg="add mod">
          <ac:chgData name="濵田　大治" userId="3dc346c6-a235-4d96-b756-7f3e038a9511" providerId="ADAL" clId="{16F79AFB-0C9A-4CDF-9DFF-5F175AD2A2C7}" dt="2022-07-13T04:23:10.495" v="1393" actId="1076"/>
          <ac:cxnSpMkLst>
            <pc:docMk/>
            <pc:sldMk cId="336970124" sldId="282"/>
            <ac:cxnSpMk id="19" creationId="{63B5D1D9-6811-61F0-AEC8-89A2E2EE49CF}"/>
          </ac:cxnSpMkLst>
        </pc:cxnChg>
        <pc:cxnChg chg="add mod">
          <ac:chgData name="濵田　大治" userId="3dc346c6-a235-4d96-b756-7f3e038a9511" providerId="ADAL" clId="{16F79AFB-0C9A-4CDF-9DFF-5F175AD2A2C7}" dt="2022-07-13T04:23:10.495" v="1393" actId="1076"/>
          <ac:cxnSpMkLst>
            <pc:docMk/>
            <pc:sldMk cId="336970124" sldId="282"/>
            <ac:cxnSpMk id="20" creationId="{62413F86-812C-1D0E-DE39-72F76AAA76AC}"/>
          </ac:cxnSpMkLst>
        </pc:cxnChg>
        <pc:cxnChg chg="add mod">
          <ac:chgData name="濵田　大治" userId="3dc346c6-a235-4d96-b756-7f3e038a9511" providerId="ADAL" clId="{16F79AFB-0C9A-4CDF-9DFF-5F175AD2A2C7}" dt="2022-07-13T04:23:10.495" v="1393" actId="1076"/>
          <ac:cxnSpMkLst>
            <pc:docMk/>
            <pc:sldMk cId="336970124" sldId="282"/>
            <ac:cxnSpMk id="21" creationId="{1E4B9EA2-F9A5-E38E-8033-6FCE5A9618B3}"/>
          </ac:cxnSpMkLst>
        </pc:cxnChg>
      </pc:sldChg>
      <pc:sldChg chg="addSp delSp modSp new mod">
        <pc:chgData name="濵田　大治" userId="3dc346c6-a235-4d96-b756-7f3e038a9511" providerId="ADAL" clId="{16F79AFB-0C9A-4CDF-9DFF-5F175AD2A2C7}" dt="2022-07-13T06:11:17.831" v="2133" actId="1076"/>
        <pc:sldMkLst>
          <pc:docMk/>
          <pc:sldMk cId="2979523262" sldId="283"/>
        </pc:sldMkLst>
        <pc:spChg chg="add mod">
          <ac:chgData name="濵田　大治" userId="3dc346c6-a235-4d96-b756-7f3e038a9511" providerId="ADAL" clId="{16F79AFB-0C9A-4CDF-9DFF-5F175AD2A2C7}" dt="2022-07-13T06:10:18.334" v="2123" actId="1076"/>
          <ac:spMkLst>
            <pc:docMk/>
            <pc:sldMk cId="2979523262" sldId="283"/>
            <ac:spMk id="3" creationId="{F54AA5BE-82FE-CEF2-1D8E-A3024C0FCD36}"/>
          </ac:spMkLst>
        </pc:spChg>
        <pc:spChg chg="add mod">
          <ac:chgData name="濵田　大治" userId="3dc346c6-a235-4d96-b756-7f3e038a9511" providerId="ADAL" clId="{16F79AFB-0C9A-4CDF-9DFF-5F175AD2A2C7}" dt="2022-07-13T05:32:43.472" v="2100" actId="1076"/>
          <ac:spMkLst>
            <pc:docMk/>
            <pc:sldMk cId="2979523262" sldId="283"/>
            <ac:spMk id="4" creationId="{1D03B53E-8927-92C6-C562-A594A38339E7}"/>
          </ac:spMkLst>
        </pc:spChg>
        <pc:spChg chg="add mod">
          <ac:chgData name="濵田　大治" userId="3dc346c6-a235-4d96-b756-7f3e038a9511" providerId="ADAL" clId="{16F79AFB-0C9A-4CDF-9DFF-5F175AD2A2C7}" dt="2022-07-13T05:32:43.472" v="2100" actId="1076"/>
          <ac:spMkLst>
            <pc:docMk/>
            <pc:sldMk cId="2979523262" sldId="283"/>
            <ac:spMk id="5" creationId="{C41C7BB5-5101-6D2B-0059-63FE5AA99FE1}"/>
          </ac:spMkLst>
        </pc:spChg>
        <pc:spChg chg="add mod">
          <ac:chgData name="濵田　大治" userId="3dc346c6-a235-4d96-b756-7f3e038a9511" providerId="ADAL" clId="{16F79AFB-0C9A-4CDF-9DFF-5F175AD2A2C7}" dt="2022-07-13T05:32:43.472" v="2100" actId="1076"/>
          <ac:spMkLst>
            <pc:docMk/>
            <pc:sldMk cId="2979523262" sldId="283"/>
            <ac:spMk id="6" creationId="{389CD000-C20D-531A-EF94-F217FB5D100C}"/>
          </ac:spMkLst>
        </pc:spChg>
        <pc:spChg chg="add mod">
          <ac:chgData name="濵田　大治" userId="3dc346c6-a235-4d96-b756-7f3e038a9511" providerId="ADAL" clId="{16F79AFB-0C9A-4CDF-9DFF-5F175AD2A2C7}" dt="2022-07-13T06:11:17.831" v="2133" actId="1076"/>
          <ac:spMkLst>
            <pc:docMk/>
            <pc:sldMk cId="2979523262" sldId="283"/>
            <ac:spMk id="15" creationId="{7DC91D0D-5389-DA85-8BBB-A709729C9F94}"/>
          </ac:spMkLst>
        </pc:spChg>
        <pc:spChg chg="add mod">
          <ac:chgData name="濵田　大治" userId="3dc346c6-a235-4d96-b756-7f3e038a9511" providerId="ADAL" clId="{16F79AFB-0C9A-4CDF-9DFF-5F175AD2A2C7}" dt="2022-07-13T06:11:17.831" v="2133" actId="1076"/>
          <ac:spMkLst>
            <pc:docMk/>
            <pc:sldMk cId="2979523262" sldId="283"/>
            <ac:spMk id="16" creationId="{AB79E4AD-CAA1-C5B7-38B2-BF49441E4418}"/>
          </ac:spMkLst>
        </pc:spChg>
        <pc:picChg chg="add mod">
          <ac:chgData name="濵田　大治" userId="3dc346c6-a235-4d96-b756-7f3e038a9511" providerId="ADAL" clId="{16F79AFB-0C9A-4CDF-9DFF-5F175AD2A2C7}" dt="2022-07-13T05:32:43.472" v="2100" actId="1076"/>
          <ac:picMkLst>
            <pc:docMk/>
            <pc:sldMk cId="2979523262" sldId="283"/>
            <ac:picMk id="2" creationId="{E9A2D59D-E6DB-5BBB-B920-915A1AFCD21E}"/>
          </ac:picMkLst>
        </pc:picChg>
        <pc:picChg chg="add del mod">
          <ac:chgData name="濵田　大治" userId="3dc346c6-a235-4d96-b756-7f3e038a9511" providerId="ADAL" clId="{16F79AFB-0C9A-4CDF-9DFF-5F175AD2A2C7}" dt="2022-07-13T05:51:17.452" v="2105" actId="478"/>
          <ac:picMkLst>
            <pc:docMk/>
            <pc:sldMk cId="2979523262" sldId="283"/>
            <ac:picMk id="10" creationId="{70BA3097-5E8D-B482-81F2-52994FCA5F68}"/>
          </ac:picMkLst>
        </pc:picChg>
        <pc:picChg chg="add mod">
          <ac:chgData name="濵田　大治" userId="3dc346c6-a235-4d96-b756-7f3e038a9511" providerId="ADAL" clId="{16F79AFB-0C9A-4CDF-9DFF-5F175AD2A2C7}" dt="2022-07-13T06:11:17.831" v="2133" actId="1076"/>
          <ac:picMkLst>
            <pc:docMk/>
            <pc:sldMk cId="2979523262" sldId="283"/>
            <ac:picMk id="11" creationId="{686DA49E-1FEB-9167-1DFF-D9E48B3CDDE1}"/>
          </ac:picMkLst>
        </pc:picChg>
        <pc:picChg chg="add del mod">
          <ac:chgData name="濵田　大治" userId="3dc346c6-a235-4d96-b756-7f3e038a9511" providerId="ADAL" clId="{16F79AFB-0C9A-4CDF-9DFF-5F175AD2A2C7}" dt="2022-07-13T06:05:01.672" v="2112" actId="478"/>
          <ac:picMkLst>
            <pc:docMk/>
            <pc:sldMk cId="2979523262" sldId="283"/>
            <ac:picMk id="12" creationId="{6E3613F1-7BB0-D26F-A12F-F1C43C33C72E}"/>
          </ac:picMkLst>
        </pc:picChg>
        <pc:picChg chg="add mod">
          <ac:chgData name="濵田　大治" userId="3dc346c6-a235-4d96-b756-7f3e038a9511" providerId="ADAL" clId="{16F79AFB-0C9A-4CDF-9DFF-5F175AD2A2C7}" dt="2022-07-13T06:11:17.831" v="2133" actId="1076"/>
          <ac:picMkLst>
            <pc:docMk/>
            <pc:sldMk cId="2979523262" sldId="283"/>
            <ac:picMk id="13" creationId="{5F1C6DFD-9149-1898-AE6F-EA3524D8C82E}"/>
          </ac:picMkLst>
        </pc:picChg>
        <pc:picChg chg="add mod">
          <ac:chgData name="濵田　大治" userId="3dc346c6-a235-4d96-b756-7f3e038a9511" providerId="ADAL" clId="{16F79AFB-0C9A-4CDF-9DFF-5F175AD2A2C7}" dt="2022-07-13T06:11:17.831" v="2133" actId="1076"/>
          <ac:picMkLst>
            <pc:docMk/>
            <pc:sldMk cId="2979523262" sldId="283"/>
            <ac:picMk id="14" creationId="{8DC74140-25FB-487B-D9CE-2DB3DE3E8F86}"/>
          </ac:picMkLst>
        </pc:picChg>
        <pc:cxnChg chg="add mod">
          <ac:chgData name="濵田　大治" userId="3dc346c6-a235-4d96-b756-7f3e038a9511" providerId="ADAL" clId="{16F79AFB-0C9A-4CDF-9DFF-5F175AD2A2C7}" dt="2022-07-13T05:32:43.472" v="2100" actId="1076"/>
          <ac:cxnSpMkLst>
            <pc:docMk/>
            <pc:sldMk cId="2979523262" sldId="283"/>
            <ac:cxnSpMk id="8" creationId="{2EC2CF49-F050-BEA4-6B10-ED5568EAFB07}"/>
          </ac:cxnSpMkLst>
        </pc:cxnChg>
        <pc:cxnChg chg="add mod">
          <ac:chgData name="濵田　大治" userId="3dc346c6-a235-4d96-b756-7f3e038a9511" providerId="ADAL" clId="{16F79AFB-0C9A-4CDF-9DFF-5F175AD2A2C7}" dt="2022-07-13T05:32:43.472" v="2100" actId="1076"/>
          <ac:cxnSpMkLst>
            <pc:docMk/>
            <pc:sldMk cId="2979523262" sldId="283"/>
            <ac:cxnSpMk id="9" creationId="{AE9FE443-7EBF-8D67-D0F3-69CC3A4A0B7B}"/>
          </ac:cxnSpMkLst>
        </pc:cxnChg>
      </pc:sldChg>
      <pc:sldChg chg="addSp delSp modSp new mod">
        <pc:chgData name="濵田　大治" userId="3dc346c6-a235-4d96-b756-7f3e038a9511" providerId="ADAL" clId="{16F79AFB-0C9A-4CDF-9DFF-5F175AD2A2C7}" dt="2022-07-13T05:20:39.587" v="2080" actId="14100"/>
        <pc:sldMkLst>
          <pc:docMk/>
          <pc:sldMk cId="370349542" sldId="284"/>
        </pc:sldMkLst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6" creationId="{50392E60-F1D7-6A9C-8C41-B4E456CEA58B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9" creationId="{514008EB-F99A-50BD-54BF-8B13574AE1C6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10" creationId="{F4206149-7623-F856-E28C-225D4E0C665B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11" creationId="{5C93715D-5287-2991-BF5A-9166E58B6D4F}"/>
          </ac:spMkLst>
        </pc:spChg>
        <pc:spChg chg="add del mod">
          <ac:chgData name="濵田　大治" userId="3dc346c6-a235-4d96-b756-7f3e038a9511" providerId="ADAL" clId="{16F79AFB-0C9A-4CDF-9DFF-5F175AD2A2C7}" dt="2022-07-13T05:09:25.345" v="1868" actId="478"/>
          <ac:spMkLst>
            <pc:docMk/>
            <pc:sldMk cId="370349542" sldId="284"/>
            <ac:spMk id="13" creationId="{AF2F84C5-D162-5A74-5B2B-031D725F7EEA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14" creationId="{350518F7-9D7C-F02F-85CE-49C6AE8EECB0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15" creationId="{2FAA7476-501D-5FFA-F3A8-4A6ADBAF869A}"/>
          </ac:spMkLst>
        </pc:spChg>
        <pc:spChg chg="add del mod">
          <ac:chgData name="濵田　大治" userId="3dc346c6-a235-4d96-b756-7f3e038a9511" providerId="ADAL" clId="{16F79AFB-0C9A-4CDF-9DFF-5F175AD2A2C7}" dt="2022-07-13T05:09:50.056" v="1876" actId="478"/>
          <ac:spMkLst>
            <pc:docMk/>
            <pc:sldMk cId="370349542" sldId="284"/>
            <ac:spMk id="17" creationId="{33BD7B14-8F21-54F1-6BBD-61456E7E3FB0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18" creationId="{65BAD798-7FF8-B709-5532-FEDE1817086C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19" creationId="{AEDDDD88-A33F-4FDB-0184-217EEA3F6A22}"/>
          </ac:spMkLst>
        </pc:spChg>
        <pc:spChg chg="add del mod">
          <ac:chgData name="濵田　大治" userId="3dc346c6-a235-4d96-b756-7f3e038a9511" providerId="ADAL" clId="{16F79AFB-0C9A-4CDF-9DFF-5F175AD2A2C7}" dt="2022-07-13T05:09:52.086" v="1877" actId="478"/>
          <ac:spMkLst>
            <pc:docMk/>
            <pc:sldMk cId="370349542" sldId="284"/>
            <ac:spMk id="21" creationId="{B0DF854E-C70F-4E9C-4283-0E049EDEAB1C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22" creationId="{39CDFC45-9182-C856-1F1B-1F4A0B319A0D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23" creationId="{40082559-9772-A5A4-375B-5B9C870D7325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25" creationId="{E69779AF-7BD3-C1D6-0D29-E3A3106E2E52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26" creationId="{08A2FA63-1197-9CCC-836B-1DA05D0278C9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28" creationId="{31CB8C27-8A7D-FE23-AD78-60C975CBBAA1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29" creationId="{8DE3CE98-BFF1-E0A8-B7D7-1B8430900B76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31" creationId="{4292A164-7BFA-E53C-C89A-E5D53AD6D06B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32" creationId="{A2B27E04-940A-271B-1FD8-AC3AE91ADCF9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33" creationId="{F526D65F-59A6-7CB1-927F-673904B8A4F7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34" creationId="{92E05CF8-562D-FCB3-7696-E8B03E9FF439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35" creationId="{125B709E-797E-6FC2-6BD0-5FD69F1459D4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36" creationId="{1B422273-BE6C-CB78-EF13-B13A438899ED}"/>
          </ac:spMkLst>
        </pc:spChg>
        <pc:spChg chg="add mod">
          <ac:chgData name="濵田　大治" userId="3dc346c6-a235-4d96-b756-7f3e038a9511" providerId="ADAL" clId="{16F79AFB-0C9A-4CDF-9DFF-5F175AD2A2C7}" dt="2022-07-13T05:19:25.685" v="2058" actId="1076"/>
          <ac:spMkLst>
            <pc:docMk/>
            <pc:sldMk cId="370349542" sldId="284"/>
            <ac:spMk id="37" creationId="{47B8558F-7738-D44A-5856-EC7BAB419440}"/>
          </ac:spMkLst>
        </pc:spChg>
        <pc:spChg chg="add mod">
          <ac:chgData name="濵田　大治" userId="3dc346c6-a235-4d96-b756-7f3e038a9511" providerId="ADAL" clId="{16F79AFB-0C9A-4CDF-9DFF-5F175AD2A2C7}" dt="2022-07-13T05:20:39.587" v="2080" actId="14100"/>
          <ac:spMkLst>
            <pc:docMk/>
            <pc:sldMk cId="370349542" sldId="284"/>
            <ac:spMk id="41" creationId="{2DD54333-09E4-7AAE-9867-80B7C3A6B2A1}"/>
          </ac:spMkLst>
        </pc:spChg>
        <pc:picChg chg="add del mod">
          <ac:chgData name="濵田　大治" userId="3dc346c6-a235-4d96-b756-7f3e038a9511" providerId="ADAL" clId="{16F79AFB-0C9A-4CDF-9DFF-5F175AD2A2C7}" dt="2022-07-13T05:00:03.024" v="1582" actId="478"/>
          <ac:picMkLst>
            <pc:docMk/>
            <pc:sldMk cId="370349542" sldId="284"/>
            <ac:picMk id="2" creationId="{6929B266-0CA9-24EB-02A1-7E90A10E9CA5}"/>
          </ac:picMkLst>
        </pc:picChg>
        <pc:picChg chg="add del mod">
          <ac:chgData name="濵田　大治" userId="3dc346c6-a235-4d96-b756-7f3e038a9511" providerId="ADAL" clId="{16F79AFB-0C9A-4CDF-9DFF-5F175AD2A2C7}" dt="2022-07-13T05:02:45.154" v="1679" actId="478"/>
          <ac:picMkLst>
            <pc:docMk/>
            <pc:sldMk cId="370349542" sldId="284"/>
            <ac:picMk id="3" creationId="{63BDB551-0CFA-2676-B190-954357425292}"/>
          </ac:picMkLst>
        </pc:picChg>
        <pc:picChg chg="add del mod">
          <ac:chgData name="濵田　大治" userId="3dc346c6-a235-4d96-b756-7f3e038a9511" providerId="ADAL" clId="{16F79AFB-0C9A-4CDF-9DFF-5F175AD2A2C7}" dt="2022-07-13T05:03:28.078" v="1684" actId="478"/>
          <ac:picMkLst>
            <pc:docMk/>
            <pc:sldMk cId="370349542" sldId="284"/>
            <ac:picMk id="4" creationId="{46F14908-6549-38BB-160E-C1751CB66DD9}"/>
          </ac:picMkLst>
        </pc:picChg>
        <pc:picChg chg="add mod">
          <ac:chgData name="濵田　大治" userId="3dc346c6-a235-4d96-b756-7f3e038a9511" providerId="ADAL" clId="{16F79AFB-0C9A-4CDF-9DFF-5F175AD2A2C7}" dt="2022-07-13T05:19:25.685" v="2058" actId="1076"/>
          <ac:picMkLst>
            <pc:docMk/>
            <pc:sldMk cId="370349542" sldId="284"/>
            <ac:picMk id="5" creationId="{31546A0B-9054-75AE-9172-3C70BF8F5572}"/>
          </ac:picMkLst>
        </pc:picChg>
        <pc:picChg chg="add del mod modCrop">
          <ac:chgData name="濵田　大治" userId="3dc346c6-a235-4d96-b756-7f3e038a9511" providerId="ADAL" clId="{16F79AFB-0C9A-4CDF-9DFF-5F175AD2A2C7}" dt="2022-07-13T05:19:06.786" v="2055" actId="478"/>
          <ac:picMkLst>
            <pc:docMk/>
            <pc:sldMk cId="370349542" sldId="284"/>
            <ac:picMk id="39" creationId="{1664F516-836F-40A8-6F3C-DA0894B95F63}"/>
          </ac:picMkLst>
        </pc:picChg>
        <pc:picChg chg="add mod">
          <ac:chgData name="濵田　大治" userId="3dc346c6-a235-4d96-b756-7f3e038a9511" providerId="ADAL" clId="{16F79AFB-0C9A-4CDF-9DFF-5F175AD2A2C7}" dt="2022-07-13T05:19:31.471" v="2059" actId="1076"/>
          <ac:picMkLst>
            <pc:docMk/>
            <pc:sldMk cId="370349542" sldId="284"/>
            <ac:picMk id="40" creationId="{532FB4AE-6025-D93B-EFB7-CF1D8443FFC2}"/>
          </ac:picMkLst>
        </pc:picChg>
        <pc:cxnChg chg="add mod">
          <ac:chgData name="濵田　大治" userId="3dc346c6-a235-4d96-b756-7f3e038a9511" providerId="ADAL" clId="{16F79AFB-0C9A-4CDF-9DFF-5F175AD2A2C7}" dt="2022-07-13T05:19:25.685" v="2058" actId="1076"/>
          <ac:cxnSpMkLst>
            <pc:docMk/>
            <pc:sldMk cId="370349542" sldId="284"/>
            <ac:cxnSpMk id="8" creationId="{8169E841-1E1B-6671-3A7B-8A1C4136AA31}"/>
          </ac:cxnSpMkLst>
        </pc:cxnChg>
        <pc:cxnChg chg="add mod">
          <ac:chgData name="濵田　大治" userId="3dc346c6-a235-4d96-b756-7f3e038a9511" providerId="ADAL" clId="{16F79AFB-0C9A-4CDF-9DFF-5F175AD2A2C7}" dt="2022-07-13T05:19:25.685" v="2058" actId="1076"/>
          <ac:cxnSpMkLst>
            <pc:docMk/>
            <pc:sldMk cId="370349542" sldId="284"/>
            <ac:cxnSpMk id="12" creationId="{AEAA3C97-E6B0-BCA3-A68C-D45210D347A1}"/>
          </ac:cxnSpMkLst>
        </pc:cxnChg>
        <pc:cxnChg chg="add mod">
          <ac:chgData name="濵田　大治" userId="3dc346c6-a235-4d96-b756-7f3e038a9511" providerId="ADAL" clId="{16F79AFB-0C9A-4CDF-9DFF-5F175AD2A2C7}" dt="2022-07-13T05:19:25.685" v="2058" actId="1076"/>
          <ac:cxnSpMkLst>
            <pc:docMk/>
            <pc:sldMk cId="370349542" sldId="284"/>
            <ac:cxnSpMk id="16" creationId="{1F301259-62FF-F140-2D62-D1D356E3CE83}"/>
          </ac:cxnSpMkLst>
        </pc:cxnChg>
        <pc:cxnChg chg="add mod">
          <ac:chgData name="濵田　大治" userId="3dc346c6-a235-4d96-b756-7f3e038a9511" providerId="ADAL" clId="{16F79AFB-0C9A-4CDF-9DFF-5F175AD2A2C7}" dt="2022-07-13T05:19:25.685" v="2058" actId="1076"/>
          <ac:cxnSpMkLst>
            <pc:docMk/>
            <pc:sldMk cId="370349542" sldId="284"/>
            <ac:cxnSpMk id="20" creationId="{C2F9B441-42D2-3B22-6D9E-B36DF4E60325}"/>
          </ac:cxnSpMkLst>
        </pc:cxnChg>
        <pc:cxnChg chg="add mod">
          <ac:chgData name="濵田　大治" userId="3dc346c6-a235-4d96-b756-7f3e038a9511" providerId="ADAL" clId="{16F79AFB-0C9A-4CDF-9DFF-5F175AD2A2C7}" dt="2022-07-13T05:19:25.685" v="2058" actId="1076"/>
          <ac:cxnSpMkLst>
            <pc:docMk/>
            <pc:sldMk cId="370349542" sldId="284"/>
            <ac:cxnSpMk id="24" creationId="{E52473DE-6E98-869F-78FC-E20BF7B053BB}"/>
          </ac:cxnSpMkLst>
        </pc:cxnChg>
        <pc:cxnChg chg="add mod">
          <ac:chgData name="濵田　大治" userId="3dc346c6-a235-4d96-b756-7f3e038a9511" providerId="ADAL" clId="{16F79AFB-0C9A-4CDF-9DFF-5F175AD2A2C7}" dt="2022-07-13T05:19:25.685" v="2058" actId="1076"/>
          <ac:cxnSpMkLst>
            <pc:docMk/>
            <pc:sldMk cId="370349542" sldId="284"/>
            <ac:cxnSpMk id="27" creationId="{8BFCA7F4-EC9E-4973-A1A6-4559EDFA667B}"/>
          </ac:cxnSpMkLst>
        </pc:cxnChg>
        <pc:cxnChg chg="add mod">
          <ac:chgData name="濵田　大治" userId="3dc346c6-a235-4d96-b756-7f3e038a9511" providerId="ADAL" clId="{16F79AFB-0C9A-4CDF-9DFF-5F175AD2A2C7}" dt="2022-07-13T05:19:25.685" v="2058" actId="1076"/>
          <ac:cxnSpMkLst>
            <pc:docMk/>
            <pc:sldMk cId="370349542" sldId="284"/>
            <ac:cxnSpMk id="30" creationId="{18A73CF5-CF0F-8B4A-1A16-3E15ADB369C1}"/>
          </ac:cxnSpMkLst>
        </pc:cxnChg>
      </pc:sldChg>
    </pc:docChg>
  </pc:docChgLst>
  <pc:docChgLst>
    <pc:chgData name="濵田　大治" userId="3dc346c6-a235-4d96-b756-7f3e038a9511" providerId="ADAL" clId="{1EBDE304-35EE-40FC-9E4E-E8E4589FA0B8}"/>
    <pc:docChg chg="undo custSel modSld">
      <pc:chgData name="濵田　大治" userId="3dc346c6-a235-4d96-b756-7f3e038a9511" providerId="ADAL" clId="{1EBDE304-35EE-40FC-9E4E-E8E4589FA0B8}" dt="2022-07-21T06:26:33.098" v="342" actId="1076"/>
      <pc:docMkLst>
        <pc:docMk/>
      </pc:docMkLst>
      <pc:sldChg chg="addSp delSp modSp mod">
        <pc:chgData name="濵田　大治" userId="3dc346c6-a235-4d96-b756-7f3e038a9511" providerId="ADAL" clId="{1EBDE304-35EE-40FC-9E4E-E8E4589FA0B8}" dt="2022-07-21T06:26:33.098" v="342" actId="1076"/>
        <pc:sldMkLst>
          <pc:docMk/>
          <pc:sldMk cId="1355024604" sldId="280"/>
        </pc:sldMkLst>
        <pc:spChg chg="add del mod">
          <ac:chgData name="濵田　大治" userId="3dc346c6-a235-4d96-b756-7f3e038a9511" providerId="ADAL" clId="{1EBDE304-35EE-40FC-9E4E-E8E4589FA0B8}" dt="2022-07-21T05:02:06.679" v="26" actId="478"/>
          <ac:spMkLst>
            <pc:docMk/>
            <pc:sldMk cId="1355024604" sldId="280"/>
            <ac:spMk id="2" creationId="{A2E1DC96-4E4B-9B68-C0FB-4FEB28DEE62D}"/>
          </ac:spMkLst>
        </pc:spChg>
        <pc:spChg chg="mod">
          <ac:chgData name="濵田　大治" userId="3dc346c6-a235-4d96-b756-7f3e038a9511" providerId="ADAL" clId="{1EBDE304-35EE-40FC-9E4E-E8E4589FA0B8}" dt="2022-07-21T06:26:30.345" v="341" actId="1076"/>
          <ac:spMkLst>
            <pc:docMk/>
            <pc:sldMk cId="1355024604" sldId="280"/>
            <ac:spMk id="3" creationId="{0174EA08-22EA-4444-9B6A-4AA766E76114}"/>
          </ac:spMkLst>
        </pc:spChg>
        <pc:spChg chg="add mod">
          <ac:chgData name="濵田　大治" userId="3dc346c6-a235-4d96-b756-7f3e038a9511" providerId="ADAL" clId="{1EBDE304-35EE-40FC-9E4E-E8E4589FA0B8}" dt="2022-07-21T06:26:33.098" v="342" actId="1076"/>
          <ac:spMkLst>
            <pc:docMk/>
            <pc:sldMk cId="1355024604" sldId="280"/>
            <ac:spMk id="4" creationId="{AD145255-171D-1CB9-304E-3F22C331462A}"/>
          </ac:spMkLst>
        </pc:spChg>
      </pc:sldChg>
    </pc:docChg>
  </pc:docChgLst>
  <pc:docChgLst>
    <pc:chgData name="濵田　大治" userId="3dc346c6-a235-4d96-b756-7f3e038a9511" providerId="ADAL" clId="{EB08264F-7DBF-4F6D-8CCD-DE925D9217C7}"/>
    <pc:docChg chg="undo redo custSel addSld delSld modSld sldOrd">
      <pc:chgData name="濵田　大治" userId="3dc346c6-a235-4d96-b756-7f3e038a9511" providerId="ADAL" clId="{EB08264F-7DBF-4F6D-8CCD-DE925D9217C7}" dt="2022-02-26T02:53:09.354" v="3769" actId="20577"/>
      <pc:docMkLst>
        <pc:docMk/>
      </pc:docMkLst>
      <pc:sldChg chg="ord">
        <pc:chgData name="濵田　大治" userId="3dc346c6-a235-4d96-b756-7f3e038a9511" providerId="ADAL" clId="{EB08264F-7DBF-4F6D-8CCD-DE925D9217C7}" dt="2022-02-24T05:10:39.299" v="3083"/>
        <pc:sldMkLst>
          <pc:docMk/>
          <pc:sldMk cId="2859862691" sldId="259"/>
        </pc:sldMkLst>
      </pc:sldChg>
      <pc:sldChg chg="del">
        <pc:chgData name="濵田　大治" userId="3dc346c6-a235-4d96-b756-7f3e038a9511" providerId="ADAL" clId="{EB08264F-7DBF-4F6D-8CCD-DE925D9217C7}" dt="2022-02-24T05:10:58.883" v="3084" actId="2696"/>
        <pc:sldMkLst>
          <pc:docMk/>
          <pc:sldMk cId="4236205881" sldId="260"/>
        </pc:sldMkLst>
      </pc:sldChg>
      <pc:sldChg chg="addSp delSp modSp new mod">
        <pc:chgData name="濵田　大治" userId="3dc346c6-a235-4d96-b756-7f3e038a9511" providerId="ADAL" clId="{EB08264F-7DBF-4F6D-8CCD-DE925D9217C7}" dt="2022-02-26T02:53:09.354" v="3769" actId="20577"/>
        <pc:sldMkLst>
          <pc:docMk/>
          <pc:sldMk cId="2443302714" sldId="263"/>
        </pc:sldMkLst>
        <pc:spChg chg="add mod">
          <ac:chgData name="濵田　大治" userId="3dc346c6-a235-4d96-b756-7f3e038a9511" providerId="ADAL" clId="{EB08264F-7DBF-4F6D-8CCD-DE925D9217C7}" dt="2022-02-24T05:29:41.717" v="3423" actId="1076"/>
          <ac:spMkLst>
            <pc:docMk/>
            <pc:sldMk cId="2443302714" sldId="263"/>
            <ac:spMk id="2" creationId="{2896B4DB-6CE2-420F-8249-89BF99BCA07F}"/>
          </ac:spMkLst>
        </pc:spChg>
        <pc:spChg chg="add mod">
          <ac:chgData name="濵田　大治" userId="3dc346c6-a235-4d96-b756-7f3e038a9511" providerId="ADAL" clId="{EB08264F-7DBF-4F6D-8CCD-DE925D9217C7}" dt="2022-02-24T05:29:41.717" v="3423" actId="1076"/>
          <ac:spMkLst>
            <pc:docMk/>
            <pc:sldMk cId="2443302714" sldId="263"/>
            <ac:spMk id="3" creationId="{31251457-C54A-43D6-8E05-09B1E054CED3}"/>
          </ac:spMkLst>
        </pc:spChg>
        <pc:spChg chg="add mod">
          <ac:chgData name="濵田　大治" userId="3dc346c6-a235-4d96-b756-7f3e038a9511" providerId="ADAL" clId="{EB08264F-7DBF-4F6D-8CCD-DE925D9217C7}" dt="2022-02-24T06:30:48.217" v="3748" actId="20577"/>
          <ac:spMkLst>
            <pc:docMk/>
            <pc:sldMk cId="2443302714" sldId="263"/>
            <ac:spMk id="4" creationId="{9534B0CB-5DE0-40BD-BB53-DBA242160679}"/>
          </ac:spMkLst>
        </pc:spChg>
        <pc:spChg chg="add mod">
          <ac:chgData name="濵田　大治" userId="3dc346c6-a235-4d96-b756-7f3e038a9511" providerId="ADAL" clId="{EB08264F-7DBF-4F6D-8CCD-DE925D9217C7}" dt="2022-02-24T05:29:41.717" v="3423" actId="1076"/>
          <ac:spMkLst>
            <pc:docMk/>
            <pc:sldMk cId="2443302714" sldId="263"/>
            <ac:spMk id="5" creationId="{AA4C0F82-5A0E-4AB0-B0EE-56912AFD4277}"/>
          </ac:spMkLst>
        </pc:spChg>
        <pc:spChg chg="add mod">
          <ac:chgData name="濵田　大治" userId="3dc346c6-a235-4d96-b756-7f3e038a9511" providerId="ADAL" clId="{EB08264F-7DBF-4F6D-8CCD-DE925D9217C7}" dt="2022-02-24T05:29:41.717" v="3423" actId="1076"/>
          <ac:spMkLst>
            <pc:docMk/>
            <pc:sldMk cId="2443302714" sldId="263"/>
            <ac:spMk id="6" creationId="{F1F94F7A-4EAC-407D-AA17-69E829493D2B}"/>
          </ac:spMkLst>
        </pc:spChg>
        <pc:spChg chg="add mod">
          <ac:chgData name="濵田　大治" userId="3dc346c6-a235-4d96-b756-7f3e038a9511" providerId="ADAL" clId="{EB08264F-7DBF-4F6D-8CCD-DE925D9217C7}" dt="2022-02-24T05:29:41.717" v="3423" actId="1076"/>
          <ac:spMkLst>
            <pc:docMk/>
            <pc:sldMk cId="2443302714" sldId="263"/>
            <ac:spMk id="7" creationId="{CA96ED5C-5B23-45E7-8812-E6E82E656A1D}"/>
          </ac:spMkLst>
        </pc:spChg>
        <pc:spChg chg="add mod">
          <ac:chgData name="濵田　大治" userId="3dc346c6-a235-4d96-b756-7f3e038a9511" providerId="ADAL" clId="{EB08264F-7DBF-4F6D-8CCD-DE925D9217C7}" dt="2022-02-24T05:29:41.717" v="3423" actId="1076"/>
          <ac:spMkLst>
            <pc:docMk/>
            <pc:sldMk cId="2443302714" sldId="263"/>
            <ac:spMk id="8" creationId="{6BA8425D-12BA-4BF6-B375-F7C9F7C6FA2A}"/>
          </ac:spMkLst>
        </pc:spChg>
        <pc:spChg chg="add mod">
          <ac:chgData name="濵田　大治" userId="3dc346c6-a235-4d96-b756-7f3e038a9511" providerId="ADAL" clId="{EB08264F-7DBF-4F6D-8CCD-DE925D9217C7}" dt="2022-02-24T06:30:38.134" v="3742" actId="20577"/>
          <ac:spMkLst>
            <pc:docMk/>
            <pc:sldMk cId="2443302714" sldId="263"/>
            <ac:spMk id="9" creationId="{D3E00E89-391A-4F80-B325-879C42481FC0}"/>
          </ac:spMkLst>
        </pc:spChg>
        <pc:spChg chg="add mod">
          <ac:chgData name="濵田　大治" userId="3dc346c6-a235-4d96-b756-7f3e038a9511" providerId="ADAL" clId="{EB08264F-7DBF-4F6D-8CCD-DE925D9217C7}" dt="2022-02-24T06:30:42.673" v="3744" actId="20577"/>
          <ac:spMkLst>
            <pc:docMk/>
            <pc:sldMk cId="2443302714" sldId="263"/>
            <ac:spMk id="10" creationId="{59CB3D21-2E44-4D2A-95FE-870E62AA6397}"/>
          </ac:spMkLst>
        </pc:spChg>
        <pc:spChg chg="add mod">
          <ac:chgData name="濵田　大治" userId="3dc346c6-a235-4d96-b756-7f3e038a9511" providerId="ADAL" clId="{EB08264F-7DBF-4F6D-8CCD-DE925D9217C7}" dt="2022-02-24T06:30:40.358" v="3743" actId="20577"/>
          <ac:spMkLst>
            <pc:docMk/>
            <pc:sldMk cId="2443302714" sldId="263"/>
            <ac:spMk id="11" creationId="{73C5921B-729D-4CC1-86DD-5F48AC4C6735}"/>
          </ac:spMkLst>
        </pc:spChg>
        <pc:spChg chg="add mod">
          <ac:chgData name="濵田　大治" userId="3dc346c6-a235-4d96-b756-7f3e038a9511" providerId="ADAL" clId="{EB08264F-7DBF-4F6D-8CCD-DE925D9217C7}" dt="2022-02-24T06:30:44.190" v="3745" actId="20577"/>
          <ac:spMkLst>
            <pc:docMk/>
            <pc:sldMk cId="2443302714" sldId="263"/>
            <ac:spMk id="12" creationId="{20231CFC-0CF7-46CA-83C7-3486B63F0378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16" creationId="{5DE5446B-AD35-479A-B9B6-8242B1A191FD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17" creationId="{66B0107C-8EE4-4DE8-A77C-2377543B8DF3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18" creationId="{62552257-3FFF-49CA-BA36-D1237C5E591B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19" creationId="{8A726F83-6997-45DF-93D3-CB587FF6A8B6}"/>
          </ac:spMkLst>
        </pc:spChg>
        <pc:spChg chg="add mod">
          <ac:chgData name="濵田　大治" userId="3dc346c6-a235-4d96-b756-7f3e038a9511" providerId="ADAL" clId="{EB08264F-7DBF-4F6D-8CCD-DE925D9217C7}" dt="2022-02-24T05:29:41.717" v="3423" actId="1076"/>
          <ac:spMkLst>
            <pc:docMk/>
            <pc:sldMk cId="2443302714" sldId="263"/>
            <ac:spMk id="26" creationId="{E9A2F6A1-03AB-4E61-AF78-34A9B4D7F920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27" creationId="{298031F2-AFA9-42B1-A72F-360E8853E498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28" creationId="{F9BC43DF-41DD-418E-A4AB-D6D4BDDC85E9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29" creationId="{FFDCD78C-2BCB-427A-835F-A00360639C43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30" creationId="{0D810859-A772-4DC1-96BB-362F41C198E0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31" creationId="{2765A1BC-6B97-44B8-9B8E-0875F5EB4427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32" creationId="{7A6FFD9E-E2F1-4CE0-9AB8-452164B8E0F2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33" creationId="{E4E03004-FF48-453B-B75A-A1CD983C0BAA}"/>
          </ac:spMkLst>
        </pc:spChg>
        <pc:spChg chg="add mod ord">
          <ac:chgData name="濵田　大治" userId="3dc346c6-a235-4d96-b756-7f3e038a9511" providerId="ADAL" clId="{EB08264F-7DBF-4F6D-8CCD-DE925D9217C7}" dt="2022-02-24T05:45:11.658" v="3444" actId="1076"/>
          <ac:spMkLst>
            <pc:docMk/>
            <pc:sldMk cId="2443302714" sldId="263"/>
            <ac:spMk id="41" creationId="{CC6170FB-A3F9-4798-96FC-C2BEFF85AF51}"/>
          </ac:spMkLst>
        </pc:spChg>
        <pc:spChg chg="add mod ord">
          <ac:chgData name="濵田　大治" userId="3dc346c6-a235-4d96-b756-7f3e038a9511" providerId="ADAL" clId="{EB08264F-7DBF-4F6D-8CCD-DE925D9217C7}" dt="2022-02-24T05:45:11.658" v="3444" actId="1076"/>
          <ac:spMkLst>
            <pc:docMk/>
            <pc:sldMk cId="2443302714" sldId="263"/>
            <ac:spMk id="43" creationId="{96AAE091-C565-48B0-B168-AB1E2B112708}"/>
          </ac:spMkLst>
        </pc:spChg>
        <pc:spChg chg="add mod ord">
          <ac:chgData name="濵田　大治" userId="3dc346c6-a235-4d96-b756-7f3e038a9511" providerId="ADAL" clId="{EB08264F-7DBF-4F6D-8CCD-DE925D9217C7}" dt="2022-02-24T05:45:11.658" v="3444" actId="1076"/>
          <ac:spMkLst>
            <pc:docMk/>
            <pc:sldMk cId="2443302714" sldId="263"/>
            <ac:spMk id="45" creationId="{CF332227-D845-4FE5-9376-716E7CF247CA}"/>
          </ac:spMkLst>
        </pc:spChg>
        <pc:spChg chg="add del mod">
          <ac:chgData name="濵田　大治" userId="3dc346c6-a235-4d96-b756-7f3e038a9511" providerId="ADAL" clId="{EB08264F-7DBF-4F6D-8CCD-DE925D9217C7}" dt="2022-02-24T05:23:51.369" v="3367" actId="478"/>
          <ac:spMkLst>
            <pc:docMk/>
            <pc:sldMk cId="2443302714" sldId="263"/>
            <ac:spMk id="46" creationId="{1CC6E7AF-38C1-4F90-A4D8-A091F8725F69}"/>
          </ac:spMkLst>
        </pc:spChg>
        <pc:spChg chg="add mod">
          <ac:chgData name="濵田　大治" userId="3dc346c6-a235-4d96-b756-7f3e038a9511" providerId="ADAL" clId="{EB08264F-7DBF-4F6D-8CCD-DE925D9217C7}" dt="2022-02-24T05:44:56.840" v="3443" actId="1076"/>
          <ac:spMkLst>
            <pc:docMk/>
            <pc:sldMk cId="2443302714" sldId="263"/>
            <ac:spMk id="46" creationId="{3E8E663C-2FF0-4008-AE99-08D6A5EAB164}"/>
          </ac:spMkLst>
        </pc:spChg>
        <pc:spChg chg="add del mod">
          <ac:chgData name="濵田　大治" userId="3dc346c6-a235-4d96-b756-7f3e038a9511" providerId="ADAL" clId="{EB08264F-7DBF-4F6D-8CCD-DE925D9217C7}" dt="2022-02-24T05:17:53.783" v="3090" actId="478"/>
          <ac:spMkLst>
            <pc:docMk/>
            <pc:sldMk cId="2443302714" sldId="263"/>
            <ac:spMk id="47" creationId="{E5C3FEAF-E5E5-4ECE-A67F-576136EF2687}"/>
          </ac:spMkLst>
        </pc:spChg>
        <pc:spChg chg="add mod">
          <ac:chgData name="濵田　大治" userId="3dc346c6-a235-4d96-b756-7f3e038a9511" providerId="ADAL" clId="{EB08264F-7DBF-4F6D-8CCD-DE925D9217C7}" dt="2022-02-24T05:45:11.658" v="3444" actId="1076"/>
          <ac:spMkLst>
            <pc:docMk/>
            <pc:sldMk cId="2443302714" sldId="263"/>
            <ac:spMk id="48" creationId="{0CA8A280-DE38-4E89-8431-54FF212B596A}"/>
          </ac:spMkLst>
        </pc:spChg>
        <pc:spChg chg="add del mod">
          <ac:chgData name="濵田　大治" userId="3dc346c6-a235-4d96-b756-7f3e038a9511" providerId="ADAL" clId="{EB08264F-7DBF-4F6D-8CCD-DE925D9217C7}" dt="2022-02-24T05:23:46.211" v="3365" actId="478"/>
          <ac:spMkLst>
            <pc:docMk/>
            <pc:sldMk cId="2443302714" sldId="263"/>
            <ac:spMk id="51" creationId="{E4D9894A-112F-4A29-BC99-F9310B6CD638}"/>
          </ac:spMkLst>
        </pc:spChg>
        <pc:spChg chg="add del mod">
          <ac:chgData name="濵田　大治" userId="3dc346c6-a235-4d96-b756-7f3e038a9511" providerId="ADAL" clId="{EB08264F-7DBF-4F6D-8CCD-DE925D9217C7}" dt="2022-02-24T05:23:46.211" v="3365" actId="478"/>
          <ac:spMkLst>
            <pc:docMk/>
            <pc:sldMk cId="2443302714" sldId="263"/>
            <ac:spMk id="53" creationId="{47C50191-E574-45CD-BAAC-E487843FC263}"/>
          </ac:spMkLst>
        </pc:spChg>
        <pc:spChg chg="add mod">
          <ac:chgData name="濵田　大治" userId="3dc346c6-a235-4d96-b756-7f3e038a9511" providerId="ADAL" clId="{EB08264F-7DBF-4F6D-8CCD-DE925D9217C7}" dt="2022-02-24T05:29:51.575" v="3424" actId="1076"/>
          <ac:spMkLst>
            <pc:docMk/>
            <pc:sldMk cId="2443302714" sldId="263"/>
            <ac:spMk id="54" creationId="{9EC711A3-5758-40C3-9536-B3FAD9BCD828}"/>
          </ac:spMkLst>
        </pc:spChg>
        <pc:spChg chg="add mod">
          <ac:chgData name="濵田　大治" userId="3dc346c6-a235-4d96-b756-7f3e038a9511" providerId="ADAL" clId="{EB08264F-7DBF-4F6D-8CCD-DE925D9217C7}" dt="2022-02-26T02:53:09.354" v="3769" actId="20577"/>
          <ac:spMkLst>
            <pc:docMk/>
            <pc:sldMk cId="2443302714" sldId="263"/>
            <ac:spMk id="55" creationId="{17EEBF16-0A0C-4D52-8CC0-286D87A54A49}"/>
          </ac:spMkLst>
        </pc:spChg>
        <pc:spChg chg="add mod">
          <ac:chgData name="濵田　大治" userId="3dc346c6-a235-4d96-b756-7f3e038a9511" providerId="ADAL" clId="{EB08264F-7DBF-4F6D-8CCD-DE925D9217C7}" dt="2022-02-24T05:45:11.658" v="3444" actId="1076"/>
          <ac:spMkLst>
            <pc:docMk/>
            <pc:sldMk cId="2443302714" sldId="263"/>
            <ac:spMk id="57" creationId="{1EFF6E8A-54EE-486B-8488-7B1CC97D8519}"/>
          </ac:spMkLst>
        </pc:spChg>
        <pc:grpChg chg="add del mod">
          <ac:chgData name="濵田　大治" userId="3dc346c6-a235-4d96-b756-7f3e038a9511" providerId="ADAL" clId="{EB08264F-7DBF-4F6D-8CCD-DE925D9217C7}" dt="2022-02-10T05:04:23.118" v="425" actId="165"/>
          <ac:grpSpMkLst>
            <pc:docMk/>
            <pc:sldMk cId="2443302714" sldId="263"/>
            <ac:grpSpMk id="24" creationId="{A2EA96D7-9B8F-4EB9-B739-7450D4710EDA}"/>
          </ac:grpSpMkLst>
        </pc:grpChg>
        <pc:grpChg chg="add mod">
          <ac:chgData name="濵田　大治" userId="3dc346c6-a235-4d96-b756-7f3e038a9511" providerId="ADAL" clId="{EB08264F-7DBF-4F6D-8CCD-DE925D9217C7}" dt="2022-02-24T05:29:41.717" v="3423" actId="1076"/>
          <ac:grpSpMkLst>
            <pc:docMk/>
            <pc:sldMk cId="2443302714" sldId="263"/>
            <ac:grpSpMk id="25" creationId="{C6D54AB0-591C-412F-B247-2D958D6E899F}"/>
          </ac:grpSpMkLst>
        </pc:grpChg>
        <pc:picChg chg="add del mod">
          <ac:chgData name="濵田　大治" userId="3dc346c6-a235-4d96-b756-7f3e038a9511" providerId="ADAL" clId="{EB08264F-7DBF-4F6D-8CCD-DE925D9217C7}" dt="2022-02-24T05:51:34.381" v="3445" actId="478"/>
          <ac:picMkLst>
            <pc:docMk/>
            <pc:sldMk cId="2443302714" sldId="263"/>
            <ac:picMk id="13" creationId="{18FEDD53-E371-42FF-A3F9-910139533B39}"/>
          </ac:picMkLst>
        </pc:picChg>
        <pc:picChg chg="add del mod modCrop">
          <ac:chgData name="濵田　大治" userId="3dc346c6-a235-4d96-b756-7f3e038a9511" providerId="ADAL" clId="{EB08264F-7DBF-4F6D-8CCD-DE925D9217C7}" dt="2022-02-24T05:23:27.489" v="3361" actId="478"/>
          <ac:picMkLst>
            <pc:docMk/>
            <pc:sldMk cId="2443302714" sldId="263"/>
            <ac:picMk id="14" creationId="{6B873FAF-65F1-4D97-89C6-174C5806A569}"/>
          </ac:picMkLst>
        </pc:picChg>
        <pc:picChg chg="add del mod modCrop">
          <ac:chgData name="濵田　大治" userId="3dc346c6-a235-4d96-b756-7f3e038a9511" providerId="ADAL" clId="{EB08264F-7DBF-4F6D-8CCD-DE925D9217C7}" dt="2022-02-10T04:36:20.154" v="237" actId="478"/>
          <ac:picMkLst>
            <pc:docMk/>
            <pc:sldMk cId="2443302714" sldId="263"/>
            <ac:picMk id="14" creationId="{C0244B6B-F2E7-43DA-855A-867D2207E422}"/>
          </ac:picMkLst>
        </pc:picChg>
        <pc:picChg chg="add del mod">
          <ac:chgData name="濵田　大治" userId="3dc346c6-a235-4d96-b756-7f3e038a9511" providerId="ADAL" clId="{EB08264F-7DBF-4F6D-8CCD-DE925D9217C7}" dt="2022-02-24T05:52:51.953" v="3449" actId="478"/>
          <ac:picMkLst>
            <pc:docMk/>
            <pc:sldMk cId="2443302714" sldId="263"/>
            <ac:picMk id="14" creationId="{D7916003-F989-4369-8EA4-6AE449BE0847}"/>
          </ac:picMkLst>
        </pc:picChg>
        <pc:picChg chg="add mod">
          <ac:chgData name="濵田　大治" userId="3dc346c6-a235-4d96-b756-7f3e038a9511" providerId="ADAL" clId="{EB08264F-7DBF-4F6D-8CCD-DE925D9217C7}" dt="2022-02-24T05:29:51.575" v="3424" actId="1076"/>
          <ac:picMkLst>
            <pc:docMk/>
            <pc:sldMk cId="2443302714" sldId="263"/>
            <ac:picMk id="15" creationId="{73D30DA6-515C-409E-9D19-D26B776E304E}"/>
          </ac:picMkLst>
        </pc:picChg>
        <pc:picChg chg="add del mod">
          <ac:chgData name="濵田　大治" userId="3dc346c6-a235-4d96-b756-7f3e038a9511" providerId="ADAL" clId="{EB08264F-7DBF-4F6D-8CCD-DE925D9217C7}" dt="2022-02-24T05:53:52.422" v="3453" actId="478"/>
          <ac:picMkLst>
            <pc:docMk/>
            <pc:sldMk cId="2443302714" sldId="263"/>
            <ac:picMk id="20" creationId="{BE604CEE-064A-466A-9666-D4F2900D6577}"/>
          </ac:picMkLst>
        </pc:picChg>
        <pc:picChg chg="add del mod modCrop">
          <ac:chgData name="濵田　大治" userId="3dc346c6-a235-4d96-b756-7f3e038a9511" providerId="ADAL" clId="{EB08264F-7DBF-4F6D-8CCD-DE925D9217C7}" dt="2022-02-24T05:21:38.897" v="3224" actId="478"/>
          <ac:picMkLst>
            <pc:docMk/>
            <pc:sldMk cId="2443302714" sldId="263"/>
            <ac:picMk id="22" creationId="{12B08359-709A-484A-B282-DF14BB9472CB}"/>
          </ac:picMkLst>
        </pc:picChg>
        <pc:picChg chg="add mod">
          <ac:chgData name="濵田　大治" userId="3dc346c6-a235-4d96-b756-7f3e038a9511" providerId="ADAL" clId="{EB08264F-7DBF-4F6D-8CCD-DE925D9217C7}" dt="2022-02-24T05:54:07.703" v="3456" actId="1076"/>
          <ac:picMkLst>
            <pc:docMk/>
            <pc:sldMk cId="2443302714" sldId="263"/>
            <ac:picMk id="22" creationId="{6D1C8F0B-1F5B-4532-9D6E-56B190CE97EF}"/>
          </ac:picMkLst>
        </pc:picChg>
        <pc:picChg chg="add mod">
          <ac:chgData name="濵田　大治" userId="3dc346c6-a235-4d96-b756-7f3e038a9511" providerId="ADAL" clId="{EB08264F-7DBF-4F6D-8CCD-DE925D9217C7}" dt="2022-02-24T05:45:11.658" v="3444" actId="1076"/>
          <ac:picMkLst>
            <pc:docMk/>
            <pc:sldMk cId="2443302714" sldId="263"/>
            <ac:picMk id="24" creationId="{78FAD7C5-8897-47D0-89FC-2EDB31C7F1A1}"/>
          </ac:picMkLst>
        </pc:picChg>
        <pc:picChg chg="add mod">
          <ac:chgData name="濵田　大治" userId="3dc346c6-a235-4d96-b756-7f3e038a9511" providerId="ADAL" clId="{EB08264F-7DBF-4F6D-8CCD-DE925D9217C7}" dt="2022-02-24T05:45:11.658" v="3444" actId="1076"/>
          <ac:picMkLst>
            <pc:docMk/>
            <pc:sldMk cId="2443302714" sldId="263"/>
            <ac:picMk id="34" creationId="{E74FA2BC-55D1-466C-B0BB-F2EEE5A4A1AB}"/>
          </ac:picMkLst>
        </pc:picChg>
        <pc:picChg chg="add del mod modCrop">
          <ac:chgData name="濵田　大治" userId="3dc346c6-a235-4d96-b756-7f3e038a9511" providerId="ADAL" clId="{EB08264F-7DBF-4F6D-8CCD-DE925D9217C7}" dt="2022-02-10T05:37:53.781" v="1056" actId="478"/>
          <ac:picMkLst>
            <pc:docMk/>
            <pc:sldMk cId="2443302714" sldId="263"/>
            <ac:picMk id="35" creationId="{043F3518-52E5-4271-AE86-3B957A5B95B7}"/>
          </ac:picMkLst>
        </pc:picChg>
        <pc:picChg chg="add del mod">
          <ac:chgData name="濵田　大治" userId="3dc346c6-a235-4d96-b756-7f3e038a9511" providerId="ADAL" clId="{EB08264F-7DBF-4F6D-8CCD-DE925D9217C7}" dt="2022-02-24T05:23:53.604" v="3368" actId="478"/>
          <ac:picMkLst>
            <pc:docMk/>
            <pc:sldMk cId="2443302714" sldId="263"/>
            <ac:picMk id="36" creationId="{0CB1E7A8-BCDA-4FF5-B3D7-2DD817CB9941}"/>
          </ac:picMkLst>
        </pc:picChg>
        <pc:picChg chg="add del mod modCrop">
          <ac:chgData name="濵田　大治" userId="3dc346c6-a235-4d96-b756-7f3e038a9511" providerId="ADAL" clId="{EB08264F-7DBF-4F6D-8CCD-DE925D9217C7}" dt="2022-02-24T05:12:28.395" v="3085" actId="478"/>
          <ac:picMkLst>
            <pc:docMk/>
            <pc:sldMk cId="2443302714" sldId="263"/>
            <ac:picMk id="38" creationId="{C58F103E-21BE-4936-B89C-74C386BCD123}"/>
          </ac:picMkLst>
        </pc:picChg>
        <pc:cxnChg chg="add mod topLvl">
          <ac:chgData name="濵田　大治" userId="3dc346c6-a235-4d96-b756-7f3e038a9511" providerId="ADAL" clId="{EB08264F-7DBF-4F6D-8CCD-DE925D9217C7}" dt="2022-02-10T05:04:37.211" v="431" actId="164"/>
          <ac:cxnSpMkLst>
            <pc:docMk/>
            <pc:sldMk cId="2443302714" sldId="263"/>
            <ac:cxnSpMk id="21" creationId="{D157BCFA-22FC-48BA-9596-DD989C9441C8}"/>
          </ac:cxnSpMkLst>
        </pc:cxnChg>
        <pc:cxnChg chg="add mod topLvl">
          <ac:chgData name="濵田　大治" userId="3dc346c6-a235-4d96-b756-7f3e038a9511" providerId="ADAL" clId="{EB08264F-7DBF-4F6D-8CCD-DE925D9217C7}" dt="2022-02-10T05:04:37.211" v="431" actId="164"/>
          <ac:cxnSpMkLst>
            <pc:docMk/>
            <pc:sldMk cId="2443302714" sldId="263"/>
            <ac:cxnSpMk id="23" creationId="{F39C9775-3F8E-4C57-9FAF-4011E315428A}"/>
          </ac:cxnSpMkLst>
        </pc:cxnChg>
        <pc:cxnChg chg="add mod ord">
          <ac:chgData name="濵田　大治" userId="3dc346c6-a235-4d96-b756-7f3e038a9511" providerId="ADAL" clId="{EB08264F-7DBF-4F6D-8CCD-DE925D9217C7}" dt="2022-02-24T05:45:11.658" v="3444" actId="1076"/>
          <ac:cxnSpMkLst>
            <pc:docMk/>
            <pc:sldMk cId="2443302714" sldId="263"/>
            <ac:cxnSpMk id="40" creationId="{CEC69749-E857-4113-A6B1-5CA6F63E9475}"/>
          </ac:cxnSpMkLst>
        </pc:cxnChg>
        <pc:cxnChg chg="add mod ord">
          <ac:chgData name="濵田　大治" userId="3dc346c6-a235-4d96-b756-7f3e038a9511" providerId="ADAL" clId="{EB08264F-7DBF-4F6D-8CCD-DE925D9217C7}" dt="2022-02-24T05:45:11.658" v="3444" actId="1076"/>
          <ac:cxnSpMkLst>
            <pc:docMk/>
            <pc:sldMk cId="2443302714" sldId="263"/>
            <ac:cxnSpMk id="42" creationId="{16A17BA7-1C1D-4B3B-B0BE-3A706DE2EF00}"/>
          </ac:cxnSpMkLst>
        </pc:cxnChg>
        <pc:cxnChg chg="add mod ord">
          <ac:chgData name="濵田　大治" userId="3dc346c6-a235-4d96-b756-7f3e038a9511" providerId="ADAL" clId="{EB08264F-7DBF-4F6D-8CCD-DE925D9217C7}" dt="2022-02-24T05:45:11.658" v="3444" actId="1076"/>
          <ac:cxnSpMkLst>
            <pc:docMk/>
            <pc:sldMk cId="2443302714" sldId="263"/>
            <ac:cxnSpMk id="44" creationId="{DDD3370F-E3E5-4598-B901-AFCA4B46A379}"/>
          </ac:cxnSpMkLst>
        </pc:cxnChg>
        <pc:cxnChg chg="add del mod">
          <ac:chgData name="濵田　大治" userId="3dc346c6-a235-4d96-b756-7f3e038a9511" providerId="ADAL" clId="{EB08264F-7DBF-4F6D-8CCD-DE925D9217C7}" dt="2022-02-24T05:23:46.211" v="3365" actId="478"/>
          <ac:cxnSpMkLst>
            <pc:docMk/>
            <pc:sldMk cId="2443302714" sldId="263"/>
            <ac:cxnSpMk id="50" creationId="{523F9947-6250-4448-899B-B0A95C331D83}"/>
          </ac:cxnSpMkLst>
        </pc:cxnChg>
        <pc:cxnChg chg="add del mod">
          <ac:chgData name="濵田　大治" userId="3dc346c6-a235-4d96-b756-7f3e038a9511" providerId="ADAL" clId="{EB08264F-7DBF-4F6D-8CCD-DE925D9217C7}" dt="2022-02-24T05:23:46.211" v="3365" actId="478"/>
          <ac:cxnSpMkLst>
            <pc:docMk/>
            <pc:sldMk cId="2443302714" sldId="263"/>
            <ac:cxnSpMk id="52" creationId="{C79A5FC7-29A5-45E8-8CF5-4637269505C7}"/>
          </ac:cxnSpMkLst>
        </pc:cxnChg>
        <pc:cxnChg chg="add mod">
          <ac:chgData name="濵田　大治" userId="3dc346c6-a235-4d96-b756-7f3e038a9511" providerId="ADAL" clId="{EB08264F-7DBF-4F6D-8CCD-DE925D9217C7}" dt="2022-02-24T05:45:11.658" v="3444" actId="1076"/>
          <ac:cxnSpMkLst>
            <pc:docMk/>
            <pc:sldMk cId="2443302714" sldId="263"/>
            <ac:cxnSpMk id="56" creationId="{16DDBB68-2AFA-49BA-9392-58A1BF3A0C18}"/>
          </ac:cxnSpMkLst>
        </pc:cxnChg>
      </pc:sldChg>
      <pc:sldChg chg="addSp delSp modSp new mod">
        <pc:chgData name="濵田　大治" userId="3dc346c6-a235-4d96-b756-7f3e038a9511" providerId="ADAL" clId="{EB08264F-7DBF-4F6D-8CCD-DE925D9217C7}" dt="2022-02-24T06:22:33.692" v="3737" actId="478"/>
        <pc:sldMkLst>
          <pc:docMk/>
          <pc:sldMk cId="1842683397" sldId="264"/>
        </pc:sldMkLst>
        <pc:spChg chg="add del mod">
          <ac:chgData name="濵田　大治" userId="3dc346c6-a235-4d96-b756-7f3e038a9511" providerId="ADAL" clId="{EB08264F-7DBF-4F6D-8CCD-DE925D9217C7}" dt="2022-02-24T06:22:33.692" v="3737" actId="478"/>
          <ac:spMkLst>
            <pc:docMk/>
            <pc:sldMk cId="1842683397" sldId="264"/>
            <ac:spMk id="3" creationId="{9B7634CD-91C3-4D0B-9C98-C6A3D1C315D0}"/>
          </ac:spMkLst>
        </pc:spChg>
        <pc:spChg chg="add del mod">
          <ac:chgData name="濵田　大治" userId="3dc346c6-a235-4d96-b756-7f3e038a9511" providerId="ADAL" clId="{EB08264F-7DBF-4F6D-8CCD-DE925D9217C7}" dt="2022-02-24T06:22:33.692" v="3737" actId="478"/>
          <ac:spMkLst>
            <pc:docMk/>
            <pc:sldMk cId="1842683397" sldId="264"/>
            <ac:spMk id="4" creationId="{60538CD9-FC02-48BA-B9BD-EA22DA5552EF}"/>
          </ac:spMkLst>
        </pc:spChg>
        <pc:spChg chg="add del mod">
          <ac:chgData name="濵田　大治" userId="3dc346c6-a235-4d96-b756-7f3e038a9511" providerId="ADAL" clId="{EB08264F-7DBF-4F6D-8CCD-DE925D9217C7}" dt="2022-02-24T06:22:33.692" v="3737" actId="478"/>
          <ac:spMkLst>
            <pc:docMk/>
            <pc:sldMk cId="1842683397" sldId="264"/>
            <ac:spMk id="5" creationId="{3CD5D186-4B19-44C6-90A2-39A7BD052FC8}"/>
          </ac:spMkLst>
        </pc:spChg>
        <pc:spChg chg="add del mod">
          <ac:chgData name="濵田　大治" userId="3dc346c6-a235-4d96-b756-7f3e038a9511" providerId="ADAL" clId="{EB08264F-7DBF-4F6D-8CCD-DE925D9217C7}" dt="2022-02-24T06:22:33.692" v="3737" actId="478"/>
          <ac:spMkLst>
            <pc:docMk/>
            <pc:sldMk cId="1842683397" sldId="264"/>
            <ac:spMk id="6" creationId="{2AF615DD-60F2-4355-887D-6C0F0E8C0AC3}"/>
          </ac:spMkLst>
        </pc:spChg>
        <pc:spChg chg="add del mod">
          <ac:chgData name="濵田　大治" userId="3dc346c6-a235-4d96-b756-7f3e038a9511" providerId="ADAL" clId="{EB08264F-7DBF-4F6D-8CCD-DE925D9217C7}" dt="2022-02-24T06:22:33.692" v="3737" actId="478"/>
          <ac:spMkLst>
            <pc:docMk/>
            <pc:sldMk cId="1842683397" sldId="264"/>
            <ac:spMk id="7" creationId="{05A78EE5-8E46-4D9B-94A9-365895F67034}"/>
          </ac:spMkLst>
        </pc:spChg>
        <pc:spChg chg="add del mod">
          <ac:chgData name="濵田　大治" userId="3dc346c6-a235-4d96-b756-7f3e038a9511" providerId="ADAL" clId="{EB08264F-7DBF-4F6D-8CCD-DE925D9217C7}" dt="2022-02-24T06:22:33.692" v="3737" actId="478"/>
          <ac:spMkLst>
            <pc:docMk/>
            <pc:sldMk cId="1842683397" sldId="264"/>
            <ac:spMk id="8" creationId="{4B66E264-2FCE-40D7-B194-3CB4EBA9044D}"/>
          </ac:spMkLst>
        </pc:spChg>
        <pc:spChg chg="add del mod">
          <ac:chgData name="濵田　大治" userId="3dc346c6-a235-4d96-b756-7f3e038a9511" providerId="ADAL" clId="{EB08264F-7DBF-4F6D-8CCD-DE925D9217C7}" dt="2022-02-24T06:22:33.692" v="3737" actId="478"/>
          <ac:spMkLst>
            <pc:docMk/>
            <pc:sldMk cId="1842683397" sldId="264"/>
            <ac:spMk id="9" creationId="{7626974C-A07B-48ED-AE36-9FF5F01A8E11}"/>
          </ac:spMkLst>
        </pc:spChg>
        <pc:spChg chg="add del mod">
          <ac:chgData name="濵田　大治" userId="3dc346c6-a235-4d96-b756-7f3e038a9511" providerId="ADAL" clId="{EB08264F-7DBF-4F6D-8CCD-DE925D9217C7}" dt="2022-02-24T06:22:33.692" v="3737" actId="478"/>
          <ac:spMkLst>
            <pc:docMk/>
            <pc:sldMk cId="1842683397" sldId="264"/>
            <ac:spMk id="10" creationId="{E35749E8-65F3-43B2-B090-32AD5B708D7D}"/>
          </ac:spMkLst>
        </pc:spChg>
        <pc:spChg chg="add del mod">
          <ac:chgData name="濵田　大治" userId="3dc346c6-a235-4d96-b756-7f3e038a9511" providerId="ADAL" clId="{EB08264F-7DBF-4F6D-8CCD-DE925D9217C7}" dt="2022-02-24T06:22:33.692" v="3737" actId="478"/>
          <ac:spMkLst>
            <pc:docMk/>
            <pc:sldMk cId="1842683397" sldId="264"/>
            <ac:spMk id="11" creationId="{D659D733-0FE9-49A5-879D-0D28CD6210B9}"/>
          </ac:spMkLst>
        </pc:spChg>
        <pc:spChg chg="add del mod">
          <ac:chgData name="濵田　大治" userId="3dc346c6-a235-4d96-b756-7f3e038a9511" providerId="ADAL" clId="{EB08264F-7DBF-4F6D-8CCD-DE925D9217C7}" dt="2022-02-24T06:22:33.692" v="3737" actId="478"/>
          <ac:spMkLst>
            <pc:docMk/>
            <pc:sldMk cId="1842683397" sldId="264"/>
            <ac:spMk id="12" creationId="{EEF1DDBC-DF59-4BE6-AABE-9C2B887315ED}"/>
          </ac:spMkLst>
        </pc:spChg>
        <pc:picChg chg="add del mod">
          <ac:chgData name="濵田　大治" userId="3dc346c6-a235-4d96-b756-7f3e038a9511" providerId="ADAL" clId="{EB08264F-7DBF-4F6D-8CCD-DE925D9217C7}" dt="2022-02-24T06:22:33.692" v="3737" actId="478"/>
          <ac:picMkLst>
            <pc:docMk/>
            <pc:sldMk cId="1842683397" sldId="264"/>
            <ac:picMk id="2" creationId="{33349B17-46ED-424C-951A-3057D0D7E242}"/>
          </ac:picMkLst>
        </pc:picChg>
      </pc:sldChg>
      <pc:sldChg chg="addSp modSp new del mod">
        <pc:chgData name="濵田　大治" userId="3dc346c6-a235-4d96-b756-7f3e038a9511" providerId="ADAL" clId="{EB08264F-7DBF-4F6D-8CCD-DE925D9217C7}" dt="2022-02-15T08:17:14.311" v="1439" actId="2696"/>
        <pc:sldMkLst>
          <pc:docMk/>
          <pc:sldMk cId="3354807153" sldId="265"/>
        </pc:sldMkLst>
        <pc:picChg chg="add mod">
          <ac:chgData name="濵田　大治" userId="3dc346c6-a235-4d96-b756-7f3e038a9511" providerId="ADAL" clId="{EB08264F-7DBF-4F6D-8CCD-DE925D9217C7}" dt="2022-02-15T08:15:25.640" v="1436" actId="1076"/>
          <ac:picMkLst>
            <pc:docMk/>
            <pc:sldMk cId="3354807153" sldId="265"/>
            <ac:picMk id="2" creationId="{C649390D-80A7-4134-BDB3-41C36925F4CD}"/>
          </ac:picMkLst>
        </pc:picChg>
      </pc:sldChg>
      <pc:sldChg chg="addSp delSp modSp new mod">
        <pc:chgData name="濵田　大治" userId="3dc346c6-a235-4d96-b756-7f3e038a9511" providerId="ADAL" clId="{EB08264F-7DBF-4F6D-8CCD-DE925D9217C7}" dt="2022-02-24T04:56:12.916" v="2918" actId="1076"/>
        <pc:sldMkLst>
          <pc:docMk/>
          <pc:sldMk cId="921231870" sldId="266"/>
        </pc:sldMkLst>
        <pc:spChg chg="mod">
          <ac:chgData name="濵田　大治" userId="3dc346c6-a235-4d96-b756-7f3e038a9511" providerId="ADAL" clId="{EB08264F-7DBF-4F6D-8CCD-DE925D9217C7}" dt="2022-02-24T04:56:12.916" v="2918" actId="1076"/>
          <ac:spMkLst>
            <pc:docMk/>
            <pc:sldMk cId="921231870" sldId="266"/>
            <ac:spMk id="2" creationId="{3236FBF3-CFED-4BBD-BE62-078CE8A2805F}"/>
          </ac:spMkLst>
        </pc:spChg>
        <pc:spChg chg="del">
          <ac:chgData name="濵田　大治" userId="3dc346c6-a235-4d96-b756-7f3e038a9511" providerId="ADAL" clId="{EB08264F-7DBF-4F6D-8CCD-DE925D9217C7}" dt="2022-02-15T08:26:02.830" v="1562" actId="22"/>
          <ac:spMkLst>
            <pc:docMk/>
            <pc:sldMk cId="921231870" sldId="266"/>
            <ac:spMk id="3" creationId="{F877A3C2-0123-4B1A-A0F2-EF9653127B5D}"/>
          </ac:spMkLst>
        </pc:spChg>
        <pc:spChg chg="del">
          <ac:chgData name="濵田　大治" userId="3dc346c6-a235-4d96-b756-7f3e038a9511" providerId="ADAL" clId="{EB08264F-7DBF-4F6D-8CCD-DE925D9217C7}" dt="2022-02-15T08:17:06.961" v="1438"/>
          <ac:spMkLst>
            <pc:docMk/>
            <pc:sldMk cId="921231870" sldId="266"/>
            <ac:spMk id="4" creationId="{3E8B5A51-E28D-4C49-B98F-B6A55CB2E94F}"/>
          </ac:spMkLst>
        </pc:spChg>
        <pc:spChg chg="add del mod">
          <ac:chgData name="濵田　大治" userId="3dc346c6-a235-4d96-b756-7f3e038a9511" providerId="ADAL" clId="{EB08264F-7DBF-4F6D-8CCD-DE925D9217C7}" dt="2022-02-15T08:27:45.521" v="1686"/>
          <ac:spMkLst>
            <pc:docMk/>
            <pc:sldMk cId="921231870" sldId="266"/>
            <ac:spMk id="10" creationId="{556AFAD1-8BD1-4004-84D3-C8A434A65FF6}"/>
          </ac:spMkLst>
        </pc:spChg>
        <pc:spChg chg="add mod">
          <ac:chgData name="濵田　大治" userId="3dc346c6-a235-4d96-b756-7f3e038a9511" providerId="ADAL" clId="{EB08264F-7DBF-4F6D-8CCD-DE925D9217C7}" dt="2022-02-16T05:58:27.574" v="2747" actId="1076"/>
          <ac:spMkLst>
            <pc:docMk/>
            <pc:sldMk cId="921231870" sldId="266"/>
            <ac:spMk id="15" creationId="{25C1483A-3F3C-4699-836C-9697229B3B2C}"/>
          </ac:spMkLst>
        </pc:spChg>
        <pc:spChg chg="add del mod">
          <ac:chgData name="濵田　大治" userId="3dc346c6-a235-4d96-b756-7f3e038a9511" providerId="ADAL" clId="{EB08264F-7DBF-4F6D-8CCD-DE925D9217C7}" dt="2022-02-15T09:16:28.093" v="2332"/>
          <ac:spMkLst>
            <pc:docMk/>
            <pc:sldMk cId="921231870" sldId="266"/>
            <ac:spMk id="20" creationId="{F7A808C2-A24F-4E08-AFA4-601545ED0E11}"/>
          </ac:spMkLst>
        </pc:spChg>
        <pc:spChg chg="add mod">
          <ac:chgData name="濵田　大治" userId="3dc346c6-a235-4d96-b756-7f3e038a9511" providerId="ADAL" clId="{EB08264F-7DBF-4F6D-8CCD-DE925D9217C7}" dt="2022-02-15T09:24:56.127" v="2734" actId="14100"/>
          <ac:spMkLst>
            <pc:docMk/>
            <pc:sldMk cId="921231870" sldId="266"/>
            <ac:spMk id="28" creationId="{970EC896-AB1E-4F69-92C0-D68066E2EFCA}"/>
          </ac:spMkLst>
        </pc:spChg>
        <pc:spChg chg="add mod">
          <ac:chgData name="濵田　大治" userId="3dc346c6-a235-4d96-b756-7f3e038a9511" providerId="ADAL" clId="{EB08264F-7DBF-4F6D-8CCD-DE925D9217C7}" dt="2022-02-15T09:26:41.259" v="2745" actId="1076"/>
          <ac:spMkLst>
            <pc:docMk/>
            <pc:sldMk cId="921231870" sldId="266"/>
            <ac:spMk id="29" creationId="{30066747-D064-45FE-8605-171AC2D0C4FC}"/>
          </ac:spMkLst>
        </pc:spChg>
        <pc:picChg chg="add mod">
          <ac:chgData name="濵田　大治" userId="3dc346c6-a235-4d96-b756-7f3e038a9511" providerId="ADAL" clId="{EB08264F-7DBF-4F6D-8CCD-DE925D9217C7}" dt="2022-02-15T09:18:53.437" v="2555" actId="1076"/>
          <ac:picMkLst>
            <pc:docMk/>
            <pc:sldMk cId="921231870" sldId="266"/>
            <ac:picMk id="5" creationId="{A42B1E08-99BA-46FC-86AB-2965F4D81F3E}"/>
          </ac:picMkLst>
        </pc:picChg>
        <pc:picChg chg="add del mod ord modCrop">
          <ac:chgData name="濵田　大治" userId="3dc346c6-a235-4d96-b756-7f3e038a9511" providerId="ADAL" clId="{EB08264F-7DBF-4F6D-8CCD-DE925D9217C7}" dt="2022-02-15T08:27:37.582" v="1685" actId="478"/>
          <ac:picMkLst>
            <pc:docMk/>
            <pc:sldMk cId="921231870" sldId="266"/>
            <ac:picMk id="7" creationId="{F78ECF01-426C-4DAD-9FAB-1A14859F71EC}"/>
          </ac:picMkLst>
        </pc:picChg>
        <pc:picChg chg="add del mod">
          <ac:chgData name="濵田　大治" userId="3dc346c6-a235-4d96-b756-7f3e038a9511" providerId="ADAL" clId="{EB08264F-7DBF-4F6D-8CCD-DE925D9217C7}" dt="2022-02-15T08:27:47.202" v="1687" actId="478"/>
          <ac:picMkLst>
            <pc:docMk/>
            <pc:sldMk cId="921231870" sldId="266"/>
            <ac:picMk id="8" creationId="{130C75AD-A8D2-47DC-B0D0-3592C9ED04E7}"/>
          </ac:picMkLst>
        </pc:picChg>
        <pc:picChg chg="add del mod modCrop">
          <ac:chgData name="濵田　大治" userId="3dc346c6-a235-4d96-b756-7f3e038a9511" providerId="ADAL" clId="{EB08264F-7DBF-4F6D-8CCD-DE925D9217C7}" dt="2022-02-15T09:16:23.848" v="2331" actId="478"/>
          <ac:picMkLst>
            <pc:docMk/>
            <pc:sldMk cId="921231870" sldId="266"/>
            <ac:picMk id="11" creationId="{28412D8E-43D9-47E0-A9CB-C1EDBD4EB71F}"/>
          </ac:picMkLst>
        </pc:picChg>
        <pc:picChg chg="add del mod modCrop">
          <ac:chgData name="濵田　大治" userId="3dc346c6-a235-4d96-b756-7f3e038a9511" providerId="ADAL" clId="{EB08264F-7DBF-4F6D-8CCD-DE925D9217C7}" dt="2022-02-15T08:29:59.280" v="1821" actId="478"/>
          <ac:picMkLst>
            <pc:docMk/>
            <pc:sldMk cId="921231870" sldId="266"/>
            <ac:picMk id="13" creationId="{EBC94FFD-1AEE-4102-9B0D-5804E2EC521B}"/>
          </ac:picMkLst>
        </pc:picChg>
        <pc:picChg chg="add del mod modCrop">
          <ac:chgData name="濵田　大治" userId="3dc346c6-a235-4d96-b756-7f3e038a9511" providerId="ADAL" clId="{EB08264F-7DBF-4F6D-8CCD-DE925D9217C7}" dt="2022-02-15T09:21:53.330" v="2711" actId="478"/>
          <ac:picMkLst>
            <pc:docMk/>
            <pc:sldMk cId="921231870" sldId="266"/>
            <ac:picMk id="14" creationId="{21D3DA29-D9AB-4914-9860-7D2C4BDB5D79}"/>
          </ac:picMkLst>
        </pc:picChg>
        <pc:picChg chg="add del mod modCrop">
          <ac:chgData name="濵田　大治" userId="3dc346c6-a235-4d96-b756-7f3e038a9511" providerId="ADAL" clId="{EB08264F-7DBF-4F6D-8CCD-DE925D9217C7}" dt="2022-02-15T09:05:50.408" v="2164" actId="478"/>
          <ac:picMkLst>
            <pc:docMk/>
            <pc:sldMk cId="921231870" sldId="266"/>
            <ac:picMk id="17" creationId="{CE2B59C0-3200-4B97-BE73-D62388D13C4A}"/>
          </ac:picMkLst>
        </pc:picChg>
        <pc:picChg chg="add mod">
          <ac:chgData name="濵田　大治" userId="3dc346c6-a235-4d96-b756-7f3e038a9511" providerId="ADAL" clId="{EB08264F-7DBF-4F6D-8CCD-DE925D9217C7}" dt="2022-02-15T09:24:43.960" v="2732" actId="1076"/>
          <ac:picMkLst>
            <pc:docMk/>
            <pc:sldMk cId="921231870" sldId="266"/>
            <ac:picMk id="18" creationId="{FCFBE054-3E47-4AFB-B2DD-6986CE1F99B1}"/>
          </ac:picMkLst>
        </pc:picChg>
        <pc:picChg chg="add mod">
          <ac:chgData name="濵田　大治" userId="3dc346c6-a235-4d96-b756-7f3e038a9511" providerId="ADAL" clId="{EB08264F-7DBF-4F6D-8CCD-DE925D9217C7}" dt="2022-02-16T05:58:27.574" v="2747" actId="1076"/>
          <ac:picMkLst>
            <pc:docMk/>
            <pc:sldMk cId="921231870" sldId="266"/>
            <ac:picMk id="21" creationId="{8127E63F-F54C-4429-AD1E-E5F5B2BC58D1}"/>
          </ac:picMkLst>
        </pc:picChg>
        <pc:picChg chg="add del mod modCrop">
          <ac:chgData name="濵田　大治" userId="3dc346c6-a235-4d96-b756-7f3e038a9511" providerId="ADAL" clId="{EB08264F-7DBF-4F6D-8CCD-DE925D9217C7}" dt="2022-02-15T09:18:21.085" v="2529" actId="478"/>
          <ac:picMkLst>
            <pc:docMk/>
            <pc:sldMk cId="921231870" sldId="266"/>
            <ac:picMk id="23" creationId="{0509E122-3B3D-4E56-B6AA-7D297BC683CB}"/>
          </ac:picMkLst>
        </pc:picChg>
        <pc:picChg chg="add mod">
          <ac:chgData name="濵田　大治" userId="3dc346c6-a235-4d96-b756-7f3e038a9511" providerId="ADAL" clId="{EB08264F-7DBF-4F6D-8CCD-DE925D9217C7}" dt="2022-02-16T05:58:27.574" v="2747" actId="1076"/>
          <ac:picMkLst>
            <pc:docMk/>
            <pc:sldMk cId="921231870" sldId="266"/>
            <ac:picMk id="24" creationId="{88A88522-C41C-4C5F-8F13-7F145D96F1C9}"/>
          </ac:picMkLst>
        </pc:picChg>
        <pc:picChg chg="add del mod modCrop">
          <ac:chgData name="濵田　大治" userId="3dc346c6-a235-4d96-b756-7f3e038a9511" providerId="ADAL" clId="{EB08264F-7DBF-4F6D-8CCD-DE925D9217C7}" dt="2022-02-15T09:21:53.330" v="2711" actId="478"/>
          <ac:picMkLst>
            <pc:docMk/>
            <pc:sldMk cId="921231870" sldId="266"/>
            <ac:picMk id="25" creationId="{B506E46F-328E-42F7-91D6-9FFCDA56EF79}"/>
          </ac:picMkLst>
        </pc:picChg>
        <pc:picChg chg="add mod">
          <ac:chgData name="濵田　大治" userId="3dc346c6-a235-4d96-b756-7f3e038a9511" providerId="ADAL" clId="{EB08264F-7DBF-4F6D-8CCD-DE925D9217C7}" dt="2022-02-16T05:58:27.574" v="2747" actId="1076"/>
          <ac:picMkLst>
            <pc:docMk/>
            <pc:sldMk cId="921231870" sldId="266"/>
            <ac:picMk id="26" creationId="{72F781FD-B39B-409E-A03C-63188D33D837}"/>
          </ac:picMkLst>
        </pc:picChg>
        <pc:picChg chg="add mod">
          <ac:chgData name="濵田　大治" userId="3dc346c6-a235-4d96-b756-7f3e038a9511" providerId="ADAL" clId="{EB08264F-7DBF-4F6D-8CCD-DE925D9217C7}" dt="2022-02-16T05:58:27.574" v="2747" actId="1076"/>
          <ac:picMkLst>
            <pc:docMk/>
            <pc:sldMk cId="921231870" sldId="266"/>
            <ac:picMk id="27" creationId="{4A51D40F-5BB9-4A2F-88D3-860ADAD7C66D}"/>
          </ac:picMkLst>
        </pc:picChg>
      </pc:sldChg>
      <pc:sldChg chg="addSp delSp modSp new mod">
        <pc:chgData name="濵田　大治" userId="3dc346c6-a235-4d96-b756-7f3e038a9511" providerId="ADAL" clId="{EB08264F-7DBF-4F6D-8CCD-DE925D9217C7}" dt="2022-02-24T06:30:31.564" v="3741" actId="20577"/>
        <pc:sldMkLst>
          <pc:docMk/>
          <pc:sldMk cId="678315744" sldId="267"/>
        </pc:sldMkLst>
        <pc:spChg chg="mod">
          <ac:chgData name="濵田　大治" userId="3dc346c6-a235-4d96-b756-7f3e038a9511" providerId="ADAL" clId="{EB08264F-7DBF-4F6D-8CCD-DE925D9217C7}" dt="2022-02-24T06:21:32.029" v="3736" actId="1076"/>
          <ac:spMkLst>
            <pc:docMk/>
            <pc:sldMk cId="678315744" sldId="267"/>
            <ac:spMk id="2" creationId="{3CB3DAAE-FBF7-449A-AB5F-2E204B01B83C}"/>
          </ac:spMkLst>
        </pc:spChg>
        <pc:spChg chg="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3" creationId="{93F99AF1-9278-42B3-A3DA-0336BE486541}"/>
          </ac:spMkLst>
        </pc:spChg>
        <pc:spChg chg="add del mod">
          <ac:chgData name="濵田　大治" userId="3dc346c6-a235-4d96-b756-7f3e038a9511" providerId="ADAL" clId="{EB08264F-7DBF-4F6D-8CCD-DE925D9217C7}" dt="2022-02-24T06:03:45.832" v="3531" actId="478"/>
          <ac:spMkLst>
            <pc:docMk/>
            <pc:sldMk cId="678315744" sldId="267"/>
            <ac:spMk id="4" creationId="{36A312BF-D5AF-4CE7-BAC3-C3896968F410}"/>
          </ac:spMkLst>
        </pc:spChg>
        <pc:spChg chg="add del mod">
          <ac:chgData name="濵田　大治" userId="3dc346c6-a235-4d96-b756-7f3e038a9511" providerId="ADAL" clId="{EB08264F-7DBF-4F6D-8CCD-DE925D9217C7}" dt="2022-02-24T06:03:45.832" v="3531" actId="478"/>
          <ac:spMkLst>
            <pc:docMk/>
            <pc:sldMk cId="678315744" sldId="267"/>
            <ac:spMk id="5" creationId="{89A12543-BA82-4C93-A205-B3799D266111}"/>
          </ac:spMkLst>
        </pc:spChg>
        <pc:spChg chg="add del mod">
          <ac:chgData name="濵田　大治" userId="3dc346c6-a235-4d96-b756-7f3e038a9511" providerId="ADAL" clId="{EB08264F-7DBF-4F6D-8CCD-DE925D9217C7}" dt="2022-02-24T06:03:45.832" v="3531" actId="478"/>
          <ac:spMkLst>
            <pc:docMk/>
            <pc:sldMk cId="678315744" sldId="267"/>
            <ac:spMk id="6" creationId="{FB082DFE-C18A-4BEF-8AC3-444FC64EEEFA}"/>
          </ac:spMkLst>
        </pc:spChg>
        <pc:spChg chg="add del mod">
          <ac:chgData name="濵田　大治" userId="3dc346c6-a235-4d96-b756-7f3e038a9511" providerId="ADAL" clId="{EB08264F-7DBF-4F6D-8CCD-DE925D9217C7}" dt="2022-02-24T06:03:45.832" v="3531" actId="478"/>
          <ac:spMkLst>
            <pc:docMk/>
            <pc:sldMk cId="678315744" sldId="267"/>
            <ac:spMk id="7" creationId="{25FB8A93-002A-42AF-8430-6E45D6D9AED9}"/>
          </ac:spMkLst>
        </pc:spChg>
        <pc:spChg chg="add del mod">
          <ac:chgData name="濵田　大治" userId="3dc346c6-a235-4d96-b756-7f3e038a9511" providerId="ADAL" clId="{EB08264F-7DBF-4F6D-8CCD-DE925D9217C7}" dt="2022-02-24T06:03:45.832" v="3531" actId="478"/>
          <ac:spMkLst>
            <pc:docMk/>
            <pc:sldMk cId="678315744" sldId="267"/>
            <ac:spMk id="8" creationId="{0810C439-03A9-4503-B849-3A4CD50DC014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9" creationId="{BB2FCF1D-DC43-43C9-A29A-BC0052BD5044}"/>
          </ac:spMkLst>
        </pc:spChg>
        <pc:spChg chg="add del mod">
          <ac:chgData name="濵田　大治" userId="3dc346c6-a235-4d96-b756-7f3e038a9511" providerId="ADAL" clId="{EB08264F-7DBF-4F6D-8CCD-DE925D9217C7}" dt="2022-02-24T06:03:45.832" v="3531" actId="478"/>
          <ac:spMkLst>
            <pc:docMk/>
            <pc:sldMk cId="678315744" sldId="267"/>
            <ac:spMk id="10" creationId="{540C739D-E7F3-42D2-82CC-67BB095FBB67}"/>
          </ac:spMkLst>
        </pc:spChg>
        <pc:spChg chg="add del mod">
          <ac:chgData name="濵田　大治" userId="3dc346c6-a235-4d96-b756-7f3e038a9511" providerId="ADAL" clId="{EB08264F-7DBF-4F6D-8CCD-DE925D9217C7}" dt="2022-02-24T06:03:45.832" v="3531" actId="478"/>
          <ac:spMkLst>
            <pc:docMk/>
            <pc:sldMk cId="678315744" sldId="267"/>
            <ac:spMk id="11" creationId="{8AFB7BF9-20B4-4117-A0AD-2B8CDC19F224}"/>
          </ac:spMkLst>
        </pc:spChg>
        <pc:spChg chg="add del mod">
          <ac:chgData name="濵田　大治" userId="3dc346c6-a235-4d96-b756-7f3e038a9511" providerId="ADAL" clId="{EB08264F-7DBF-4F6D-8CCD-DE925D9217C7}" dt="2022-02-24T06:03:45.832" v="3531" actId="478"/>
          <ac:spMkLst>
            <pc:docMk/>
            <pc:sldMk cId="678315744" sldId="267"/>
            <ac:spMk id="12" creationId="{2BE9A9F9-5CD3-42E5-8F0A-FEBFBE056AB6}"/>
          </ac:spMkLst>
        </pc:spChg>
        <pc:spChg chg="add mod">
          <ac:chgData name="濵田　大治" userId="3dc346c6-a235-4d96-b756-7f3e038a9511" providerId="ADAL" clId="{EB08264F-7DBF-4F6D-8CCD-DE925D9217C7}" dt="2022-02-24T06:30:26.294" v="3738" actId="20577"/>
          <ac:spMkLst>
            <pc:docMk/>
            <pc:sldMk cId="678315744" sldId="267"/>
            <ac:spMk id="13" creationId="{C147D0F7-CD5B-4FDB-8E95-89EC5CE278CE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14" creationId="{049CE294-890C-4CBE-BBCA-D18D9899581E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18" creationId="{2FB9823A-EA64-4141-9032-93192C95D940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19" creationId="{31CDEE2B-F65A-48DD-A509-BE119AACBD23}"/>
          </ac:spMkLst>
        </pc:spChg>
        <pc:spChg chg="add mod">
          <ac:chgData name="濵田　大治" userId="3dc346c6-a235-4d96-b756-7f3e038a9511" providerId="ADAL" clId="{EB08264F-7DBF-4F6D-8CCD-DE925D9217C7}" dt="2022-02-24T06:30:28.405" v="3739" actId="20577"/>
          <ac:spMkLst>
            <pc:docMk/>
            <pc:sldMk cId="678315744" sldId="267"/>
            <ac:spMk id="20" creationId="{DE5BE479-43D3-469C-B646-452956CA0542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21" creationId="{3174CFEA-7470-4B13-AC93-6C08216FE15F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25" creationId="{A21FC47B-EB67-4469-A86C-C5F0A7332F15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26" creationId="{8170D7F3-8A45-465B-9ECB-D19E40B90401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27" creationId="{F893671F-1721-4C9E-B14F-DC2497D63A99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28" creationId="{CC72C042-40DC-42CF-AD6F-20C2E3F2A532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29" creationId="{1BB65389-3F34-42BA-B79E-042DC7534434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30" creationId="{43B86B45-E2E3-4A17-95D8-C5F8CCB511AE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31" creationId="{8AF17EDC-D057-4614-B3DE-71AC19D1B0AE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32" creationId="{E1E7F469-0EE6-4457-914A-1EA7E5F18D5E}"/>
          </ac:spMkLst>
        </pc:spChg>
        <pc:spChg chg="add mod">
          <ac:chgData name="濵田　大治" userId="3dc346c6-a235-4d96-b756-7f3e038a9511" providerId="ADAL" clId="{EB08264F-7DBF-4F6D-8CCD-DE925D9217C7}" dt="2022-02-24T06:30:30.199" v="3740" actId="20577"/>
          <ac:spMkLst>
            <pc:docMk/>
            <pc:sldMk cId="678315744" sldId="267"/>
            <ac:spMk id="33" creationId="{19B7E728-0B02-4AF5-982F-2FA4311B0CA2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34" creationId="{53941DD3-7677-48E5-B313-BF4FA5E8A822}"/>
          </ac:spMkLst>
        </pc:spChg>
        <pc:spChg chg="add mod">
          <ac:chgData name="濵田　大治" userId="3dc346c6-a235-4d96-b756-7f3e038a9511" providerId="ADAL" clId="{EB08264F-7DBF-4F6D-8CCD-DE925D9217C7}" dt="2022-02-24T06:30:31.564" v="3741" actId="20577"/>
          <ac:spMkLst>
            <pc:docMk/>
            <pc:sldMk cId="678315744" sldId="267"/>
            <ac:spMk id="35" creationId="{C76F7607-1DE3-45D2-A524-585B535BD4E7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36" creationId="{FB58AD28-0870-4E94-8889-A07AE612DE2E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40" creationId="{1BEE7D2C-B09C-44D6-89EE-E5FD41656737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41" creationId="{ADA1D562-B6D1-40CD-8608-A73298528C80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42" creationId="{E1E73A7E-7622-4EB7-819A-2323F04F6221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46" creationId="{46E9F05A-A90E-474A-84E2-1420673CB872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47" creationId="{EB6629D1-4DB6-4087-A3C4-7EB12E10CD8A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48" creationId="{E52F2137-27AC-4D21-B58A-80914EAD900F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49" creationId="{9C73E2DD-B8F7-4F55-855E-38C56CD3955F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53" creationId="{B8247E9A-5452-407A-A093-109C7D67FF12}"/>
          </ac:spMkLst>
        </pc:spChg>
        <pc:spChg chg="add mod">
          <ac:chgData name="濵田　大治" userId="3dc346c6-a235-4d96-b756-7f3e038a9511" providerId="ADAL" clId="{EB08264F-7DBF-4F6D-8CCD-DE925D9217C7}" dt="2022-02-24T06:21:24.865" v="3735" actId="1076"/>
          <ac:spMkLst>
            <pc:docMk/>
            <pc:sldMk cId="678315744" sldId="267"/>
            <ac:spMk id="54" creationId="{2C7E9146-8631-4D6A-88A0-3EB64959FE1B}"/>
          </ac:spMkLst>
        </pc:spChg>
        <pc:spChg chg="add del mod">
          <ac:chgData name="濵田　大治" userId="3dc346c6-a235-4d96-b756-7f3e038a9511" providerId="ADAL" clId="{EB08264F-7DBF-4F6D-8CCD-DE925D9217C7}" dt="2022-02-24T06:19:02.874" v="3721"/>
          <ac:spMkLst>
            <pc:docMk/>
            <pc:sldMk cId="678315744" sldId="267"/>
            <ac:spMk id="56" creationId="{99259A79-0E66-4D8C-B3A4-B63E0FF2465E}"/>
          </ac:spMkLst>
        </pc:spChg>
        <pc:spChg chg="add del mod">
          <ac:chgData name="濵田　大治" userId="3dc346c6-a235-4d96-b756-7f3e038a9511" providerId="ADAL" clId="{EB08264F-7DBF-4F6D-8CCD-DE925D9217C7}" dt="2022-02-24T06:19:02.874" v="3721"/>
          <ac:spMkLst>
            <pc:docMk/>
            <pc:sldMk cId="678315744" sldId="267"/>
            <ac:spMk id="57" creationId="{7FD8C1B7-EC21-4BD5-8951-D1C8CFF871FB}"/>
          </ac:spMkLst>
        </pc:spChg>
        <pc:spChg chg="add del mod">
          <ac:chgData name="濵田　大治" userId="3dc346c6-a235-4d96-b756-7f3e038a9511" providerId="ADAL" clId="{EB08264F-7DBF-4F6D-8CCD-DE925D9217C7}" dt="2022-02-24T06:19:02.874" v="3721"/>
          <ac:spMkLst>
            <pc:docMk/>
            <pc:sldMk cId="678315744" sldId="267"/>
            <ac:spMk id="58" creationId="{01225037-69BA-45F8-8122-F8FB1A4DDDF5}"/>
          </ac:spMkLst>
        </pc:spChg>
        <pc:spChg chg="add del mod">
          <ac:chgData name="濵田　大治" userId="3dc346c6-a235-4d96-b756-7f3e038a9511" providerId="ADAL" clId="{EB08264F-7DBF-4F6D-8CCD-DE925D9217C7}" dt="2022-02-24T06:19:02.874" v="3721"/>
          <ac:spMkLst>
            <pc:docMk/>
            <pc:sldMk cId="678315744" sldId="267"/>
            <ac:spMk id="59" creationId="{E5902415-0E47-4303-9A9F-503FF7013761}"/>
          </ac:spMkLst>
        </pc:spChg>
        <pc:spChg chg="add del mod">
          <ac:chgData name="濵田　大治" userId="3dc346c6-a235-4d96-b756-7f3e038a9511" providerId="ADAL" clId="{EB08264F-7DBF-4F6D-8CCD-DE925D9217C7}" dt="2022-02-24T06:19:02.874" v="3721"/>
          <ac:spMkLst>
            <pc:docMk/>
            <pc:sldMk cId="678315744" sldId="267"/>
            <ac:spMk id="60" creationId="{0AFF4F41-8060-4A9B-8FC4-7512EAA0217D}"/>
          </ac:spMkLst>
        </pc:spChg>
        <pc:spChg chg="add del mod">
          <ac:chgData name="濵田　大治" userId="3dc346c6-a235-4d96-b756-7f3e038a9511" providerId="ADAL" clId="{EB08264F-7DBF-4F6D-8CCD-DE925D9217C7}" dt="2022-02-24T06:19:02.874" v="3721"/>
          <ac:spMkLst>
            <pc:docMk/>
            <pc:sldMk cId="678315744" sldId="267"/>
            <ac:spMk id="61" creationId="{DA2B1F50-ED98-49C6-BF17-DB19C294E762}"/>
          </ac:spMkLst>
        </pc:spChg>
        <pc:spChg chg="add del mod">
          <ac:chgData name="濵田　大治" userId="3dc346c6-a235-4d96-b756-7f3e038a9511" providerId="ADAL" clId="{EB08264F-7DBF-4F6D-8CCD-DE925D9217C7}" dt="2022-02-24T06:19:02.874" v="3721"/>
          <ac:spMkLst>
            <pc:docMk/>
            <pc:sldMk cId="678315744" sldId="267"/>
            <ac:spMk id="62" creationId="{70F3F5E7-DBBE-45A7-BB4F-3814F3CAFFB8}"/>
          </ac:spMkLst>
        </pc:spChg>
        <pc:spChg chg="add del mod">
          <ac:chgData name="濵田　大治" userId="3dc346c6-a235-4d96-b756-7f3e038a9511" providerId="ADAL" clId="{EB08264F-7DBF-4F6D-8CCD-DE925D9217C7}" dt="2022-02-24T06:19:02.874" v="3721"/>
          <ac:spMkLst>
            <pc:docMk/>
            <pc:sldMk cId="678315744" sldId="267"/>
            <ac:spMk id="63" creationId="{CE80D10B-9BC3-4C18-A343-B5048586E0E7}"/>
          </ac:spMkLst>
        </pc:spChg>
        <pc:spChg chg="add del mod">
          <ac:chgData name="濵田　大治" userId="3dc346c6-a235-4d96-b756-7f3e038a9511" providerId="ADAL" clId="{EB08264F-7DBF-4F6D-8CCD-DE925D9217C7}" dt="2022-02-24T06:19:02.874" v="3721"/>
          <ac:spMkLst>
            <pc:docMk/>
            <pc:sldMk cId="678315744" sldId="267"/>
            <ac:spMk id="64" creationId="{F2BFE81C-A8CC-4F62-916D-3177431799DC}"/>
          </ac:spMkLst>
        </pc:spChg>
        <pc:spChg chg="add del mod">
          <ac:chgData name="濵田　大治" userId="3dc346c6-a235-4d96-b756-7f3e038a9511" providerId="ADAL" clId="{EB08264F-7DBF-4F6D-8CCD-DE925D9217C7}" dt="2022-02-24T06:19:02.874" v="3721"/>
          <ac:spMkLst>
            <pc:docMk/>
            <pc:sldMk cId="678315744" sldId="267"/>
            <ac:spMk id="65" creationId="{DF8C3103-1B33-4E75-98BF-1E8574A267C2}"/>
          </ac:spMkLst>
        </pc:spChg>
        <pc:spChg chg="add mod">
          <ac:chgData name="濵田　大治" userId="3dc346c6-a235-4d96-b756-7f3e038a9511" providerId="ADAL" clId="{EB08264F-7DBF-4F6D-8CCD-DE925D9217C7}" dt="2022-02-24T06:20:49.031" v="3731" actId="1076"/>
          <ac:spMkLst>
            <pc:docMk/>
            <pc:sldMk cId="678315744" sldId="267"/>
            <ac:spMk id="67" creationId="{47ED4AC9-649B-41A4-916D-2775C1688ABE}"/>
          </ac:spMkLst>
        </pc:spChg>
        <pc:spChg chg="add mod">
          <ac:chgData name="濵田　大治" userId="3dc346c6-a235-4d96-b756-7f3e038a9511" providerId="ADAL" clId="{EB08264F-7DBF-4F6D-8CCD-DE925D9217C7}" dt="2022-02-24T06:20:49.031" v="3731" actId="1076"/>
          <ac:spMkLst>
            <pc:docMk/>
            <pc:sldMk cId="678315744" sldId="267"/>
            <ac:spMk id="68" creationId="{7670C91D-1A17-4A17-B568-BC527B391F7A}"/>
          </ac:spMkLst>
        </pc:spChg>
        <pc:spChg chg="add mod">
          <ac:chgData name="濵田　大治" userId="3dc346c6-a235-4d96-b756-7f3e038a9511" providerId="ADAL" clId="{EB08264F-7DBF-4F6D-8CCD-DE925D9217C7}" dt="2022-02-24T06:20:49.031" v="3731" actId="1076"/>
          <ac:spMkLst>
            <pc:docMk/>
            <pc:sldMk cId="678315744" sldId="267"/>
            <ac:spMk id="69" creationId="{5B554B13-4860-40A3-867B-02273CF71B31}"/>
          </ac:spMkLst>
        </pc:spChg>
        <pc:spChg chg="add mod">
          <ac:chgData name="濵田　大治" userId="3dc346c6-a235-4d96-b756-7f3e038a9511" providerId="ADAL" clId="{EB08264F-7DBF-4F6D-8CCD-DE925D9217C7}" dt="2022-02-24T06:20:49.031" v="3731" actId="1076"/>
          <ac:spMkLst>
            <pc:docMk/>
            <pc:sldMk cId="678315744" sldId="267"/>
            <ac:spMk id="70" creationId="{18B6A8C6-B792-4325-A48E-728B26D2CEA3}"/>
          </ac:spMkLst>
        </pc:spChg>
        <pc:spChg chg="add mod">
          <ac:chgData name="濵田　大治" userId="3dc346c6-a235-4d96-b756-7f3e038a9511" providerId="ADAL" clId="{EB08264F-7DBF-4F6D-8CCD-DE925D9217C7}" dt="2022-02-24T06:20:49.031" v="3731" actId="1076"/>
          <ac:spMkLst>
            <pc:docMk/>
            <pc:sldMk cId="678315744" sldId="267"/>
            <ac:spMk id="71" creationId="{4D3F8D7C-31C8-49EA-8707-CCB30066EE6E}"/>
          </ac:spMkLst>
        </pc:spChg>
        <pc:spChg chg="add mod">
          <ac:chgData name="濵田　大治" userId="3dc346c6-a235-4d96-b756-7f3e038a9511" providerId="ADAL" clId="{EB08264F-7DBF-4F6D-8CCD-DE925D9217C7}" dt="2022-02-24T06:20:49.031" v="3731" actId="1076"/>
          <ac:spMkLst>
            <pc:docMk/>
            <pc:sldMk cId="678315744" sldId="267"/>
            <ac:spMk id="72" creationId="{F53E3579-B86B-4454-875D-9FD85D7392C0}"/>
          </ac:spMkLst>
        </pc:spChg>
        <pc:spChg chg="add mod">
          <ac:chgData name="濵田　大治" userId="3dc346c6-a235-4d96-b756-7f3e038a9511" providerId="ADAL" clId="{EB08264F-7DBF-4F6D-8CCD-DE925D9217C7}" dt="2022-02-24T06:20:49.031" v="3731" actId="1076"/>
          <ac:spMkLst>
            <pc:docMk/>
            <pc:sldMk cId="678315744" sldId="267"/>
            <ac:spMk id="73" creationId="{05BD6B05-AB57-4351-A018-0C039366B42B}"/>
          </ac:spMkLst>
        </pc:spChg>
        <pc:spChg chg="add mod">
          <ac:chgData name="濵田　大治" userId="3dc346c6-a235-4d96-b756-7f3e038a9511" providerId="ADAL" clId="{EB08264F-7DBF-4F6D-8CCD-DE925D9217C7}" dt="2022-02-24T06:20:49.031" v="3731" actId="1076"/>
          <ac:spMkLst>
            <pc:docMk/>
            <pc:sldMk cId="678315744" sldId="267"/>
            <ac:spMk id="74" creationId="{509348B9-23B2-4A62-BA11-2FADD1BA591E}"/>
          </ac:spMkLst>
        </pc:spChg>
        <pc:spChg chg="add mod">
          <ac:chgData name="濵田　大治" userId="3dc346c6-a235-4d96-b756-7f3e038a9511" providerId="ADAL" clId="{EB08264F-7DBF-4F6D-8CCD-DE925D9217C7}" dt="2022-02-24T06:20:49.031" v="3731" actId="1076"/>
          <ac:spMkLst>
            <pc:docMk/>
            <pc:sldMk cId="678315744" sldId="267"/>
            <ac:spMk id="75" creationId="{F70E2A7E-D30A-4967-B7DE-3B0787C440B4}"/>
          </ac:spMkLst>
        </pc:spChg>
        <pc:spChg chg="add mod">
          <ac:chgData name="濵田　大治" userId="3dc346c6-a235-4d96-b756-7f3e038a9511" providerId="ADAL" clId="{EB08264F-7DBF-4F6D-8CCD-DE925D9217C7}" dt="2022-02-24T06:20:49.031" v="3731" actId="1076"/>
          <ac:spMkLst>
            <pc:docMk/>
            <pc:sldMk cId="678315744" sldId="267"/>
            <ac:spMk id="76" creationId="{6E3EAB61-D6A9-48FA-9023-0F1BE805F43F}"/>
          </ac:spMkLst>
        </pc:spChg>
        <pc:grpChg chg="add mod">
          <ac:chgData name="濵田　大治" userId="3dc346c6-a235-4d96-b756-7f3e038a9511" providerId="ADAL" clId="{EB08264F-7DBF-4F6D-8CCD-DE925D9217C7}" dt="2022-02-24T06:21:24.865" v="3735" actId="1076"/>
          <ac:grpSpMkLst>
            <pc:docMk/>
            <pc:sldMk cId="678315744" sldId="267"/>
            <ac:grpSpMk id="15" creationId="{955BC1F0-2AE4-4E59-9E7B-78B09D129A21}"/>
          </ac:grpSpMkLst>
        </pc:grpChg>
        <pc:grpChg chg="add mod">
          <ac:chgData name="濵田　大治" userId="3dc346c6-a235-4d96-b756-7f3e038a9511" providerId="ADAL" clId="{EB08264F-7DBF-4F6D-8CCD-DE925D9217C7}" dt="2022-02-24T06:21:24.865" v="3735" actId="1076"/>
          <ac:grpSpMkLst>
            <pc:docMk/>
            <pc:sldMk cId="678315744" sldId="267"/>
            <ac:grpSpMk id="22" creationId="{3BFFF9C4-2053-4B91-B3E1-DA814D69F889}"/>
          </ac:grpSpMkLst>
        </pc:grpChg>
        <pc:grpChg chg="add mod">
          <ac:chgData name="濵田　大治" userId="3dc346c6-a235-4d96-b756-7f3e038a9511" providerId="ADAL" clId="{EB08264F-7DBF-4F6D-8CCD-DE925D9217C7}" dt="2022-02-24T06:21:24.865" v="3735" actId="1076"/>
          <ac:grpSpMkLst>
            <pc:docMk/>
            <pc:sldMk cId="678315744" sldId="267"/>
            <ac:grpSpMk id="37" creationId="{2FA5C96F-17DA-4BC6-B999-EDEEAB2252AC}"/>
          </ac:grpSpMkLst>
        </pc:grpChg>
        <pc:grpChg chg="add mod">
          <ac:chgData name="濵田　大治" userId="3dc346c6-a235-4d96-b756-7f3e038a9511" providerId="ADAL" clId="{EB08264F-7DBF-4F6D-8CCD-DE925D9217C7}" dt="2022-02-24T06:21:24.865" v="3735" actId="1076"/>
          <ac:grpSpMkLst>
            <pc:docMk/>
            <pc:sldMk cId="678315744" sldId="267"/>
            <ac:grpSpMk id="43" creationId="{6EC78AF4-5023-4C34-A596-E4E3C32D0C4F}"/>
          </ac:grpSpMkLst>
        </pc:grpChg>
        <pc:grpChg chg="add mod">
          <ac:chgData name="濵田　大治" userId="3dc346c6-a235-4d96-b756-7f3e038a9511" providerId="ADAL" clId="{EB08264F-7DBF-4F6D-8CCD-DE925D9217C7}" dt="2022-02-24T06:21:24.865" v="3735" actId="1076"/>
          <ac:grpSpMkLst>
            <pc:docMk/>
            <pc:sldMk cId="678315744" sldId="267"/>
            <ac:grpSpMk id="50" creationId="{82B1D8FF-5AC8-446A-AAB3-BA9D0043B306}"/>
          </ac:grpSpMkLst>
        </pc:grpChg>
        <pc:picChg chg="add del mod">
          <ac:chgData name="濵田　大治" userId="3dc346c6-a235-4d96-b756-7f3e038a9511" providerId="ADAL" clId="{EB08264F-7DBF-4F6D-8CCD-DE925D9217C7}" dt="2022-02-24T06:19:02.874" v="3721"/>
          <ac:picMkLst>
            <pc:docMk/>
            <pc:sldMk cId="678315744" sldId="267"/>
            <ac:picMk id="55" creationId="{24BD54CE-8A6B-47A7-AF32-C8D81A3DCAEA}"/>
          </ac:picMkLst>
        </pc:picChg>
        <pc:picChg chg="add mod">
          <ac:chgData name="濵田　大治" userId="3dc346c6-a235-4d96-b756-7f3e038a9511" providerId="ADAL" clId="{EB08264F-7DBF-4F6D-8CCD-DE925D9217C7}" dt="2022-02-24T06:20:49.031" v="3731" actId="1076"/>
          <ac:picMkLst>
            <pc:docMk/>
            <pc:sldMk cId="678315744" sldId="267"/>
            <ac:picMk id="66" creationId="{0418B800-71E1-4190-8930-FB309DB09020}"/>
          </ac:picMkLst>
        </pc:picChg>
        <pc:cxnChg chg="mod">
          <ac:chgData name="濵田　大治" userId="3dc346c6-a235-4d96-b756-7f3e038a9511" providerId="ADAL" clId="{EB08264F-7DBF-4F6D-8CCD-DE925D9217C7}" dt="2022-02-24T06:03:08.946" v="3525"/>
          <ac:cxnSpMkLst>
            <pc:docMk/>
            <pc:sldMk cId="678315744" sldId="267"/>
            <ac:cxnSpMk id="16" creationId="{7B3714A1-C8DC-4965-9255-6B89DFF07708}"/>
          </ac:cxnSpMkLst>
        </pc:cxnChg>
        <pc:cxnChg chg="mod">
          <ac:chgData name="濵田　大治" userId="3dc346c6-a235-4d96-b756-7f3e038a9511" providerId="ADAL" clId="{EB08264F-7DBF-4F6D-8CCD-DE925D9217C7}" dt="2022-02-24T06:03:08.946" v="3525"/>
          <ac:cxnSpMkLst>
            <pc:docMk/>
            <pc:sldMk cId="678315744" sldId="267"/>
            <ac:cxnSpMk id="17" creationId="{7F8EE982-819F-4F79-ACFF-0514ABAD3CEF}"/>
          </ac:cxnSpMkLst>
        </pc:cxnChg>
        <pc:cxnChg chg="mod">
          <ac:chgData name="濵田　大治" userId="3dc346c6-a235-4d96-b756-7f3e038a9511" providerId="ADAL" clId="{EB08264F-7DBF-4F6D-8CCD-DE925D9217C7}" dt="2022-02-24T06:04:11.553" v="3534"/>
          <ac:cxnSpMkLst>
            <pc:docMk/>
            <pc:sldMk cId="678315744" sldId="267"/>
            <ac:cxnSpMk id="23" creationId="{20CB724A-4743-40E7-8D4D-21FCFBB3E3C1}"/>
          </ac:cxnSpMkLst>
        </pc:cxnChg>
        <pc:cxnChg chg="mod">
          <ac:chgData name="濵田　大治" userId="3dc346c6-a235-4d96-b756-7f3e038a9511" providerId="ADAL" clId="{EB08264F-7DBF-4F6D-8CCD-DE925D9217C7}" dt="2022-02-24T06:04:11.553" v="3534"/>
          <ac:cxnSpMkLst>
            <pc:docMk/>
            <pc:sldMk cId="678315744" sldId="267"/>
            <ac:cxnSpMk id="24" creationId="{67BB4CB4-22C4-4530-AD9B-784CF2A5F054}"/>
          </ac:cxnSpMkLst>
        </pc:cxnChg>
        <pc:cxnChg chg="mod">
          <ac:chgData name="濵田　大治" userId="3dc346c6-a235-4d96-b756-7f3e038a9511" providerId="ADAL" clId="{EB08264F-7DBF-4F6D-8CCD-DE925D9217C7}" dt="2022-02-24T06:11:25.199" v="3646"/>
          <ac:cxnSpMkLst>
            <pc:docMk/>
            <pc:sldMk cId="678315744" sldId="267"/>
            <ac:cxnSpMk id="38" creationId="{CB25ADEB-47C6-498D-9581-B3E0A19EFA5B}"/>
          </ac:cxnSpMkLst>
        </pc:cxnChg>
        <pc:cxnChg chg="mod">
          <ac:chgData name="濵田　大治" userId="3dc346c6-a235-4d96-b756-7f3e038a9511" providerId="ADAL" clId="{EB08264F-7DBF-4F6D-8CCD-DE925D9217C7}" dt="2022-02-24T06:11:25.199" v="3646"/>
          <ac:cxnSpMkLst>
            <pc:docMk/>
            <pc:sldMk cId="678315744" sldId="267"/>
            <ac:cxnSpMk id="39" creationId="{88852006-5388-409F-8B69-A1B0B8ACC41E}"/>
          </ac:cxnSpMkLst>
        </pc:cxnChg>
        <pc:cxnChg chg="mod">
          <ac:chgData name="濵田　大治" userId="3dc346c6-a235-4d96-b756-7f3e038a9511" providerId="ADAL" clId="{EB08264F-7DBF-4F6D-8CCD-DE925D9217C7}" dt="2022-02-24T06:14:06.844" v="3682"/>
          <ac:cxnSpMkLst>
            <pc:docMk/>
            <pc:sldMk cId="678315744" sldId="267"/>
            <ac:cxnSpMk id="44" creationId="{B91E7426-FE9C-4934-93EB-0BF3CC2638A5}"/>
          </ac:cxnSpMkLst>
        </pc:cxnChg>
        <pc:cxnChg chg="mod">
          <ac:chgData name="濵田　大治" userId="3dc346c6-a235-4d96-b756-7f3e038a9511" providerId="ADAL" clId="{EB08264F-7DBF-4F6D-8CCD-DE925D9217C7}" dt="2022-02-24T06:14:06.844" v="3682"/>
          <ac:cxnSpMkLst>
            <pc:docMk/>
            <pc:sldMk cId="678315744" sldId="267"/>
            <ac:cxnSpMk id="45" creationId="{3B3DB263-B643-4AC1-824A-9ABD84533DE0}"/>
          </ac:cxnSpMkLst>
        </pc:cxnChg>
        <pc:cxnChg chg="mod">
          <ac:chgData name="濵田　大治" userId="3dc346c6-a235-4d96-b756-7f3e038a9511" providerId="ADAL" clId="{EB08264F-7DBF-4F6D-8CCD-DE925D9217C7}" dt="2022-02-24T06:15:21.078" v="3695"/>
          <ac:cxnSpMkLst>
            <pc:docMk/>
            <pc:sldMk cId="678315744" sldId="267"/>
            <ac:cxnSpMk id="51" creationId="{497A609D-8085-456D-9472-16F782B99EC8}"/>
          </ac:cxnSpMkLst>
        </pc:cxnChg>
        <pc:cxnChg chg="mod">
          <ac:chgData name="濵田　大治" userId="3dc346c6-a235-4d96-b756-7f3e038a9511" providerId="ADAL" clId="{EB08264F-7DBF-4F6D-8CCD-DE925D9217C7}" dt="2022-02-24T06:15:21.078" v="3695"/>
          <ac:cxnSpMkLst>
            <pc:docMk/>
            <pc:sldMk cId="678315744" sldId="267"/>
            <ac:cxnSpMk id="52" creationId="{A0FC17D3-4E2C-47F8-A02D-D0F772D99899}"/>
          </ac:cxnSpMkLst>
        </pc:cxnChg>
      </pc:sldChg>
      <pc:sldChg chg="addSp modSp new mod modClrScheme chgLayout">
        <pc:chgData name="濵田　大治" userId="3dc346c6-a235-4d96-b756-7f3e038a9511" providerId="ADAL" clId="{EB08264F-7DBF-4F6D-8CCD-DE925D9217C7}" dt="2022-02-24T05:09:44.468" v="3081" actId="27636"/>
        <pc:sldMkLst>
          <pc:docMk/>
          <pc:sldMk cId="1259133253" sldId="268"/>
        </pc:sldMkLst>
        <pc:spChg chg="mod ord">
          <ac:chgData name="濵田　大治" userId="3dc346c6-a235-4d96-b756-7f3e038a9511" providerId="ADAL" clId="{EB08264F-7DBF-4F6D-8CCD-DE925D9217C7}" dt="2022-02-24T04:59:52.213" v="3009" actId="20577"/>
          <ac:spMkLst>
            <pc:docMk/>
            <pc:sldMk cId="1259133253" sldId="268"/>
            <ac:spMk id="2" creationId="{F5B3D20E-6956-4A10-A757-9BE0AA154EEB}"/>
          </ac:spMkLst>
        </pc:spChg>
        <pc:spChg chg="add mod ord">
          <ac:chgData name="濵田　大治" userId="3dc346c6-a235-4d96-b756-7f3e038a9511" providerId="ADAL" clId="{EB08264F-7DBF-4F6D-8CCD-DE925D9217C7}" dt="2022-02-24T05:09:44.468" v="3081" actId="27636"/>
          <ac:spMkLst>
            <pc:docMk/>
            <pc:sldMk cId="1259133253" sldId="268"/>
            <ac:spMk id="3" creationId="{83174847-E1D5-4F64-A563-3ABE493526E5}"/>
          </ac:spMkLst>
        </pc:spChg>
      </pc:sldChg>
      <pc:sldChg chg="addSp modSp new mod">
        <pc:chgData name="濵田　大治" userId="3dc346c6-a235-4d96-b756-7f3e038a9511" providerId="ADAL" clId="{EB08264F-7DBF-4F6D-8CCD-DE925D9217C7}" dt="2022-02-24T05:59:17.877" v="3524" actId="1076"/>
        <pc:sldMkLst>
          <pc:docMk/>
          <pc:sldMk cId="3343665853" sldId="269"/>
        </pc:sldMkLst>
        <pc:spChg chg="add mod">
          <ac:chgData name="濵田　大治" userId="3dc346c6-a235-4d96-b756-7f3e038a9511" providerId="ADAL" clId="{EB08264F-7DBF-4F6D-8CCD-DE925D9217C7}" dt="2022-02-24T05:59:03.204" v="3522" actId="14100"/>
          <ac:spMkLst>
            <pc:docMk/>
            <pc:sldMk cId="3343665853" sldId="269"/>
            <ac:spMk id="2" creationId="{3B6910D4-7B61-4A20-B61A-FEC21CAF19F6}"/>
          </ac:spMkLst>
        </pc:spChg>
        <pc:spChg chg="add mod">
          <ac:chgData name="濵田　大治" userId="3dc346c6-a235-4d96-b756-7f3e038a9511" providerId="ADAL" clId="{EB08264F-7DBF-4F6D-8CCD-DE925D9217C7}" dt="2022-02-24T05:58:08.732" v="3507" actId="113"/>
          <ac:spMkLst>
            <pc:docMk/>
            <pc:sldMk cId="3343665853" sldId="269"/>
            <ac:spMk id="6" creationId="{C77E28FC-B107-40C6-9879-0266957EE9F7}"/>
          </ac:spMkLst>
        </pc:spChg>
        <pc:spChg chg="add mod">
          <ac:chgData name="濵田　大治" userId="3dc346c6-a235-4d96-b756-7f3e038a9511" providerId="ADAL" clId="{EB08264F-7DBF-4F6D-8CCD-DE925D9217C7}" dt="2022-02-24T05:58:08.732" v="3507" actId="113"/>
          <ac:spMkLst>
            <pc:docMk/>
            <pc:sldMk cId="3343665853" sldId="269"/>
            <ac:spMk id="8" creationId="{90A73C83-BF68-4EA9-B76A-7E4A0D8B09AA}"/>
          </ac:spMkLst>
        </pc:spChg>
        <pc:spChg chg="add mod">
          <ac:chgData name="濵田　大治" userId="3dc346c6-a235-4d96-b756-7f3e038a9511" providerId="ADAL" clId="{EB08264F-7DBF-4F6D-8CCD-DE925D9217C7}" dt="2022-02-24T05:58:08.732" v="3507" actId="113"/>
          <ac:spMkLst>
            <pc:docMk/>
            <pc:sldMk cId="3343665853" sldId="269"/>
            <ac:spMk id="10" creationId="{36B4D082-3164-4780-8C4D-0601FB5D0803}"/>
          </ac:spMkLst>
        </pc:spChg>
        <pc:spChg chg="add mod">
          <ac:chgData name="濵田　大治" userId="3dc346c6-a235-4d96-b756-7f3e038a9511" providerId="ADAL" clId="{EB08264F-7DBF-4F6D-8CCD-DE925D9217C7}" dt="2022-02-24T05:58:08.732" v="3507" actId="113"/>
          <ac:spMkLst>
            <pc:docMk/>
            <pc:sldMk cId="3343665853" sldId="269"/>
            <ac:spMk id="12" creationId="{321373EA-99F9-4523-9346-51A2257AC52E}"/>
          </ac:spMkLst>
        </pc:spChg>
        <pc:spChg chg="add mod">
          <ac:chgData name="濵田　大治" userId="3dc346c6-a235-4d96-b756-7f3e038a9511" providerId="ADAL" clId="{EB08264F-7DBF-4F6D-8CCD-DE925D9217C7}" dt="2022-02-24T05:59:17.877" v="3524" actId="1076"/>
          <ac:spMkLst>
            <pc:docMk/>
            <pc:sldMk cId="3343665853" sldId="269"/>
            <ac:spMk id="13" creationId="{518F73EC-399C-4DB8-9B7C-0CC1E1891EDE}"/>
          </ac:spMkLst>
        </pc:spChg>
        <pc:picChg chg="add mod">
          <ac:chgData name="濵田　大治" userId="3dc346c6-a235-4d96-b756-7f3e038a9511" providerId="ADAL" clId="{EB08264F-7DBF-4F6D-8CCD-DE925D9217C7}" dt="2022-02-24T05:57:45.203" v="3505" actId="1076"/>
          <ac:picMkLst>
            <pc:docMk/>
            <pc:sldMk cId="3343665853" sldId="269"/>
            <ac:picMk id="3" creationId="{0F3C1417-5E81-4524-AB71-AFCEFABA144E}"/>
          </ac:picMkLst>
        </pc:picChg>
        <pc:picChg chg="add mod">
          <ac:chgData name="濵田　大治" userId="3dc346c6-a235-4d96-b756-7f3e038a9511" providerId="ADAL" clId="{EB08264F-7DBF-4F6D-8CCD-DE925D9217C7}" dt="2022-02-24T05:57:45.203" v="3505" actId="1076"/>
          <ac:picMkLst>
            <pc:docMk/>
            <pc:sldMk cId="3343665853" sldId="269"/>
            <ac:picMk id="5" creationId="{BCBEE5A9-B24A-4AA4-87B1-FFD34DEBBDEF}"/>
          </ac:picMkLst>
        </pc:picChg>
        <pc:cxnChg chg="add mod">
          <ac:chgData name="濵田　大治" userId="3dc346c6-a235-4d96-b756-7f3e038a9511" providerId="ADAL" clId="{EB08264F-7DBF-4F6D-8CCD-DE925D9217C7}" dt="2022-02-24T05:58:17.634" v="3508" actId="1582"/>
          <ac:cxnSpMkLst>
            <pc:docMk/>
            <pc:sldMk cId="3343665853" sldId="269"/>
            <ac:cxnSpMk id="4" creationId="{69A6AA4F-04C6-4502-A958-F899F50E7254}"/>
          </ac:cxnSpMkLst>
        </pc:cxnChg>
        <pc:cxnChg chg="add mod">
          <ac:chgData name="濵田　大治" userId="3dc346c6-a235-4d96-b756-7f3e038a9511" providerId="ADAL" clId="{EB08264F-7DBF-4F6D-8CCD-DE925D9217C7}" dt="2022-02-24T05:58:17.634" v="3508" actId="1582"/>
          <ac:cxnSpMkLst>
            <pc:docMk/>
            <pc:sldMk cId="3343665853" sldId="269"/>
            <ac:cxnSpMk id="7" creationId="{44554276-F33F-445F-9D68-5FA714B34AED}"/>
          </ac:cxnSpMkLst>
        </pc:cxnChg>
        <pc:cxnChg chg="add mod">
          <ac:chgData name="濵田　大治" userId="3dc346c6-a235-4d96-b756-7f3e038a9511" providerId="ADAL" clId="{EB08264F-7DBF-4F6D-8CCD-DE925D9217C7}" dt="2022-02-24T05:58:17.634" v="3508" actId="1582"/>
          <ac:cxnSpMkLst>
            <pc:docMk/>
            <pc:sldMk cId="3343665853" sldId="269"/>
            <ac:cxnSpMk id="9" creationId="{0EEA939F-52DA-4927-B2EE-A3E6B0DF0042}"/>
          </ac:cxnSpMkLst>
        </pc:cxnChg>
        <pc:cxnChg chg="add mod">
          <ac:chgData name="濵田　大治" userId="3dc346c6-a235-4d96-b756-7f3e038a9511" providerId="ADAL" clId="{EB08264F-7DBF-4F6D-8CCD-DE925D9217C7}" dt="2022-02-24T05:58:17.634" v="3508" actId="1582"/>
          <ac:cxnSpMkLst>
            <pc:docMk/>
            <pc:sldMk cId="3343665853" sldId="269"/>
            <ac:cxnSpMk id="11" creationId="{6D58F74D-FB56-4094-B65B-02D02C994468}"/>
          </ac:cxnSpMkLst>
        </pc:cxnChg>
      </pc:sldChg>
    </pc:docChg>
  </pc:docChgLst>
  <pc:docChgLst>
    <pc:chgData name="濵田　大治" userId="3dc346c6-a235-4d96-b756-7f3e038a9511" providerId="ADAL" clId="{9869E7B1-4B06-4F8D-807C-185B5646F956}"/>
    <pc:docChg chg="undo custSel addSld modSld sldOrd">
      <pc:chgData name="濵田　大治" userId="3dc346c6-a235-4d96-b756-7f3e038a9511" providerId="ADAL" clId="{9869E7B1-4B06-4F8D-807C-185B5646F956}" dt="2021-12-23T01:13:34.892" v="4228" actId="1076"/>
      <pc:docMkLst>
        <pc:docMk/>
      </pc:docMkLst>
      <pc:sldChg chg="addSp modSp mod ord">
        <pc:chgData name="濵田　大治" userId="3dc346c6-a235-4d96-b756-7f3e038a9511" providerId="ADAL" clId="{9869E7B1-4B06-4F8D-807C-185B5646F956}" dt="2021-11-11T08:08:28.256" v="1082"/>
        <pc:sldMkLst>
          <pc:docMk/>
          <pc:sldMk cId="3644056586" sldId="256"/>
        </pc:sldMkLst>
        <pc:spChg chg="add mod">
          <ac:chgData name="濵田　大治" userId="3dc346c6-a235-4d96-b756-7f3e038a9511" providerId="ADAL" clId="{9869E7B1-4B06-4F8D-807C-185B5646F956}" dt="2021-11-11T08:08:08.418" v="1080" actId="1076"/>
          <ac:spMkLst>
            <pc:docMk/>
            <pc:sldMk cId="3644056586" sldId="256"/>
            <ac:spMk id="12" creationId="{0A1D3FB7-C83D-4BDF-A32B-963E02A9C948}"/>
          </ac:spMkLst>
        </pc:spChg>
      </pc:sldChg>
      <pc:sldChg chg="addSp delSp modSp mod">
        <pc:chgData name="濵田　大治" userId="3dc346c6-a235-4d96-b756-7f3e038a9511" providerId="ADAL" clId="{9869E7B1-4B06-4F8D-807C-185B5646F956}" dt="2021-11-11T08:12:47.015" v="1294" actId="1076"/>
        <pc:sldMkLst>
          <pc:docMk/>
          <pc:sldMk cId="204084915" sldId="257"/>
        </pc:sldMkLst>
        <pc:spChg chg="add mod">
          <ac:chgData name="濵田　大治" userId="3dc346c6-a235-4d96-b756-7f3e038a9511" providerId="ADAL" clId="{9869E7B1-4B06-4F8D-807C-185B5646F956}" dt="2021-11-11T08:08:39.940" v="1083" actId="1076"/>
          <ac:spMkLst>
            <pc:docMk/>
            <pc:sldMk cId="204084915" sldId="257"/>
            <ac:spMk id="9" creationId="{C64C1069-40E7-4F01-876C-5AAD5E196FFF}"/>
          </ac:spMkLst>
        </pc:spChg>
        <pc:spChg chg="add mod">
          <ac:chgData name="濵田　大治" userId="3dc346c6-a235-4d96-b756-7f3e038a9511" providerId="ADAL" clId="{9869E7B1-4B06-4F8D-807C-185B5646F956}" dt="2021-11-11T08:04:50.333" v="972" actId="20577"/>
          <ac:spMkLst>
            <pc:docMk/>
            <pc:sldMk cId="204084915" sldId="257"/>
            <ac:spMk id="10" creationId="{1A9B46A0-AA73-4B75-B811-F1F51F53C532}"/>
          </ac:spMkLst>
        </pc:spChg>
        <pc:spChg chg="add mod">
          <ac:chgData name="濵田　大治" userId="3dc346c6-a235-4d96-b756-7f3e038a9511" providerId="ADAL" clId="{9869E7B1-4B06-4F8D-807C-185B5646F956}" dt="2021-11-11T08:11:33.844" v="1175" actId="1035"/>
          <ac:spMkLst>
            <pc:docMk/>
            <pc:sldMk cId="204084915" sldId="257"/>
            <ac:spMk id="11" creationId="{CD071225-9205-4532-A7BA-208EDC3F3C2D}"/>
          </ac:spMkLst>
        </pc:spChg>
        <pc:spChg chg="add mod">
          <ac:chgData name="濵田　大治" userId="3dc346c6-a235-4d96-b756-7f3e038a9511" providerId="ADAL" clId="{9869E7B1-4B06-4F8D-807C-185B5646F956}" dt="2021-11-11T08:11:29.813" v="1173" actId="1035"/>
          <ac:spMkLst>
            <pc:docMk/>
            <pc:sldMk cId="204084915" sldId="257"/>
            <ac:spMk id="12" creationId="{070C2E0E-103F-473E-B2BD-478FDA787BEE}"/>
          </ac:spMkLst>
        </pc:spChg>
        <pc:spChg chg="add mod">
          <ac:chgData name="濵田　大治" userId="3dc346c6-a235-4d96-b756-7f3e038a9511" providerId="ADAL" clId="{9869E7B1-4B06-4F8D-807C-185B5646F956}" dt="2021-11-11T08:12:12.869" v="1249" actId="404"/>
          <ac:spMkLst>
            <pc:docMk/>
            <pc:sldMk cId="204084915" sldId="257"/>
            <ac:spMk id="13" creationId="{B89B9F33-5605-450F-8BA8-8F0940B64B03}"/>
          </ac:spMkLst>
        </pc:spChg>
        <pc:spChg chg="add mod">
          <ac:chgData name="濵田　大治" userId="3dc346c6-a235-4d96-b756-7f3e038a9511" providerId="ADAL" clId="{9869E7B1-4B06-4F8D-807C-185B5646F956}" dt="2021-11-11T08:12:47.015" v="1294" actId="1076"/>
          <ac:spMkLst>
            <pc:docMk/>
            <pc:sldMk cId="204084915" sldId="257"/>
            <ac:spMk id="14" creationId="{F3C7BA57-0E7F-4F31-9CEB-20C1165F9AD1}"/>
          </ac:spMkLst>
        </pc:spChg>
        <pc:picChg chg="add del mod modCrop">
          <ac:chgData name="濵田　大治" userId="3dc346c6-a235-4d96-b756-7f3e038a9511" providerId="ADAL" clId="{9869E7B1-4B06-4F8D-807C-185B5646F956}" dt="2021-11-11T07:55:10.885" v="268" actId="478"/>
          <ac:picMkLst>
            <pc:docMk/>
            <pc:sldMk cId="204084915" sldId="257"/>
            <ac:picMk id="4" creationId="{AC164CEF-B720-4A92-A8ED-609F829E6D16}"/>
          </ac:picMkLst>
        </pc:picChg>
        <pc:picChg chg="add mod">
          <ac:chgData name="濵田　大治" userId="3dc346c6-a235-4d96-b756-7f3e038a9511" providerId="ADAL" clId="{9869E7B1-4B06-4F8D-807C-185B5646F956}" dt="2021-11-11T08:08:39.940" v="1083" actId="1076"/>
          <ac:picMkLst>
            <pc:docMk/>
            <pc:sldMk cId="204084915" sldId="257"/>
            <ac:picMk id="5" creationId="{E1D5A253-4F59-4B3C-811C-DE212A30DAAB}"/>
          </ac:picMkLst>
        </pc:picChg>
        <pc:picChg chg="add del mod modCrop">
          <ac:chgData name="濵田　大治" userId="3dc346c6-a235-4d96-b756-7f3e038a9511" providerId="ADAL" clId="{9869E7B1-4B06-4F8D-807C-185B5646F956}" dt="2021-11-11T07:58:03.571" v="618" actId="478"/>
          <ac:picMkLst>
            <pc:docMk/>
            <pc:sldMk cId="204084915" sldId="257"/>
            <ac:picMk id="7" creationId="{3E1A655F-36C5-4308-B3B2-DD7551C03197}"/>
          </ac:picMkLst>
        </pc:picChg>
        <pc:picChg chg="add mod">
          <ac:chgData name="濵田　大治" userId="3dc346c6-a235-4d96-b756-7f3e038a9511" providerId="ADAL" clId="{9869E7B1-4B06-4F8D-807C-185B5646F956}" dt="2021-11-11T08:08:39.940" v="1083" actId="1076"/>
          <ac:picMkLst>
            <pc:docMk/>
            <pc:sldMk cId="204084915" sldId="257"/>
            <ac:picMk id="8" creationId="{3A54DE01-5B92-49AA-B96A-D1C1B0218CED}"/>
          </ac:picMkLst>
        </pc:picChg>
      </pc:sldChg>
      <pc:sldChg chg="addSp delSp modSp new mod">
        <pc:chgData name="濵田　大治" userId="3dc346c6-a235-4d96-b756-7f3e038a9511" providerId="ADAL" clId="{9869E7B1-4B06-4F8D-807C-185B5646F956}" dt="2021-11-15T05:45:56.427" v="2691" actId="20577"/>
        <pc:sldMkLst>
          <pc:docMk/>
          <pc:sldMk cId="3341215467" sldId="258"/>
        </pc:sldMkLst>
        <pc:spChg chg="add mod">
          <ac:chgData name="濵田　大治" userId="3dc346c6-a235-4d96-b756-7f3e038a9511" providerId="ADAL" clId="{9869E7B1-4B06-4F8D-807C-185B5646F956}" dt="2021-11-11T08:16:34.735" v="1532" actId="1076"/>
          <ac:spMkLst>
            <pc:docMk/>
            <pc:sldMk cId="3341215467" sldId="258"/>
            <ac:spMk id="5" creationId="{947B63CA-DDCC-43C6-8BED-7F9A53B5E48A}"/>
          </ac:spMkLst>
        </pc:spChg>
        <pc:spChg chg="add mod">
          <ac:chgData name="濵田　大治" userId="3dc346c6-a235-4d96-b756-7f3e038a9511" providerId="ADAL" clId="{9869E7B1-4B06-4F8D-807C-185B5646F956}" dt="2021-11-11T08:22:56.462" v="2006" actId="20577"/>
          <ac:spMkLst>
            <pc:docMk/>
            <pc:sldMk cId="3341215467" sldId="258"/>
            <ac:spMk id="6" creationId="{E025239F-96E3-4124-9FB6-96602F13AB7C}"/>
          </ac:spMkLst>
        </pc:spChg>
        <pc:spChg chg="add mod">
          <ac:chgData name="濵田　大治" userId="3dc346c6-a235-4d96-b756-7f3e038a9511" providerId="ADAL" clId="{9869E7B1-4B06-4F8D-807C-185B5646F956}" dt="2021-11-15T05:45:56.427" v="2691" actId="20577"/>
          <ac:spMkLst>
            <pc:docMk/>
            <pc:sldMk cId="3341215467" sldId="258"/>
            <ac:spMk id="7" creationId="{3EDE2790-29FB-43EA-A912-506AE76E8D23}"/>
          </ac:spMkLst>
        </pc:spChg>
        <pc:picChg chg="add del mod modCrop">
          <ac:chgData name="濵田　大治" userId="3dc346c6-a235-4d96-b756-7f3e038a9511" providerId="ADAL" clId="{9869E7B1-4B06-4F8D-807C-185B5646F956}" dt="2021-11-11T08:14:43.523" v="1516" actId="478"/>
          <ac:picMkLst>
            <pc:docMk/>
            <pc:sldMk cId="3341215467" sldId="258"/>
            <ac:picMk id="3" creationId="{6126CEE2-E577-4A38-9DCD-2C0B8C11C25A}"/>
          </ac:picMkLst>
        </pc:picChg>
        <pc:picChg chg="add mod">
          <ac:chgData name="濵田　大治" userId="3dc346c6-a235-4d96-b756-7f3e038a9511" providerId="ADAL" clId="{9869E7B1-4B06-4F8D-807C-185B5646F956}" dt="2021-11-11T08:14:50.509" v="1518" actId="1076"/>
          <ac:picMkLst>
            <pc:docMk/>
            <pc:sldMk cId="3341215467" sldId="258"/>
            <ac:picMk id="4" creationId="{C9248361-4DB3-4AE1-925E-37C61621A63F}"/>
          </ac:picMkLst>
        </pc:picChg>
      </pc:sldChg>
      <pc:sldChg chg="addSp delSp modSp new mod">
        <pc:chgData name="濵田　大治" userId="3dc346c6-a235-4d96-b756-7f3e038a9511" providerId="ADAL" clId="{9869E7B1-4B06-4F8D-807C-185B5646F956}" dt="2021-11-15T07:33:44.034" v="3690" actId="1076"/>
        <pc:sldMkLst>
          <pc:docMk/>
          <pc:sldMk cId="2859862691" sldId="259"/>
        </pc:sldMkLst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4" creationId="{03067D5C-8FE8-4F8B-A9A3-6F7433F8C359}"/>
          </ac:spMkLst>
        </pc:spChg>
        <pc:spChg chg="add mod">
          <ac:chgData name="濵田　大治" userId="3dc346c6-a235-4d96-b756-7f3e038a9511" providerId="ADAL" clId="{9869E7B1-4B06-4F8D-807C-185B5646F956}" dt="2021-11-15T06:27:48.603" v="2972" actId="164"/>
          <ac:spMkLst>
            <pc:docMk/>
            <pc:sldMk cId="2859862691" sldId="259"/>
            <ac:spMk id="5" creationId="{68E985B9-E378-4699-888C-E641191ECA82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6" creationId="{31012A65-7AA5-4FB5-9138-6E983F5CF5E0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7" creationId="{3CDF3E68-5B7F-42D0-BB01-C3388CBD976B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8" creationId="{7B51818B-0D90-40F1-A2BE-CD44C6B3F334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9" creationId="{789F8085-5BFB-4B27-8DD0-EDAB4C42BFAB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10" creationId="{DD6C1FC9-72F2-4EB6-8A3A-67A167244FE7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11" creationId="{F7FF9A90-D367-4842-8994-6FED67595600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12" creationId="{D6D8AE61-88D6-4008-BE00-648262D20B8E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13" creationId="{CBD3F9A5-0406-4F8A-BACA-BA7DB6BBB61E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14" creationId="{38A83300-9E7A-4AA8-813A-3064E357E598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15" creationId="{C46C16E5-65BA-423E-87B7-FE89C858E9D8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16" creationId="{715C0D3F-A5DB-416C-80D0-186541C7481B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17" creationId="{BFB006AD-E5E5-450D-A406-AC32CE88C869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18" creationId="{3F989944-D54E-4C44-98D7-9394590A4096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19" creationId="{5C30FFDD-85C2-4F29-9FF3-2FDDFF1AC398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20" creationId="{03709504-B214-46F2-8E51-EA3CD062934E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21" creationId="{4BEE5515-C4F2-41E6-A5D2-872365DC9A30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22" creationId="{7A33B967-0C9C-4745-BFAB-9D47A6F799FA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23" creationId="{D6256DAD-BC01-44C8-9FE2-233B407EED26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24" creationId="{4AC5CCCB-6921-4EF5-8C3C-7E662FC3B157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25" creationId="{964E9EF6-B2AF-4963-9587-DED2A290C27B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26" creationId="{0F830FDE-45DD-435E-9619-F33C4A6ECA7A}"/>
          </ac:spMkLst>
        </pc:spChg>
        <pc:spChg chg="add mod">
          <ac:chgData name="濵田　大治" userId="3dc346c6-a235-4d96-b756-7f3e038a9511" providerId="ADAL" clId="{9869E7B1-4B06-4F8D-807C-185B5646F956}" dt="2021-11-15T06:27:48.603" v="2972" actId="164"/>
          <ac:spMkLst>
            <pc:docMk/>
            <pc:sldMk cId="2859862691" sldId="259"/>
            <ac:spMk id="27" creationId="{3ECA702F-A383-4DD8-A69E-E04F5B0F44A7}"/>
          </ac:spMkLst>
        </pc:spChg>
        <pc:spChg chg="add mod">
          <ac:chgData name="濵田　大治" userId="3dc346c6-a235-4d96-b756-7f3e038a9511" providerId="ADAL" clId="{9869E7B1-4B06-4F8D-807C-185B5646F956}" dt="2021-11-15T06:27:48.603" v="2972" actId="164"/>
          <ac:spMkLst>
            <pc:docMk/>
            <pc:sldMk cId="2859862691" sldId="259"/>
            <ac:spMk id="28" creationId="{A1C51C48-9486-4CBA-A8E3-C1E2C2D5EE1F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30" creationId="{E2253902-2C08-47E2-947D-FCC17944BAE2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31" creationId="{A90C5C2D-C74C-413A-8288-15A18C0FE980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32" creationId="{C91C5379-DC31-48D5-9175-45FDD9F165B3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33" creationId="{7D611341-A3A3-40BB-8222-A4198C693398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34" creationId="{B26F4A1E-8FED-41E1-91B2-BD6CD13C2EBD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35" creationId="{BF893B90-3C58-4A6F-B9AF-ECB35BE00B4F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36" creationId="{6FFFE5CC-3E36-4280-BCEA-5E5AA3F98E46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37" creationId="{DB616A89-517E-4181-8AB1-B08EBFC0E9F8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38" creationId="{E22C41AD-E378-4D4B-B002-DB8B10F438D4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39" creationId="{3699C9E1-B834-4E59-A20C-21DC00EA6F88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40" creationId="{BE060F07-4CE8-4022-8B0E-03A414720D7F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41" creationId="{31ADB4E2-4F70-45B9-AE42-785AB816D80A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42" creationId="{FF0C6480-931B-42ED-AF27-259BFEC114DB}"/>
          </ac:spMkLst>
        </pc:spChg>
        <pc:spChg chg="add mod">
          <ac:chgData name="濵田　大治" userId="3dc346c6-a235-4d96-b756-7f3e038a9511" providerId="ADAL" clId="{9869E7B1-4B06-4F8D-807C-185B5646F956}" dt="2021-11-15T06:49:37.245" v="3662" actId="1035"/>
          <ac:spMkLst>
            <pc:docMk/>
            <pc:sldMk cId="2859862691" sldId="259"/>
            <ac:spMk id="43" creationId="{C64C154E-CF86-47D6-954F-3114462AFFF2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44" creationId="{434A695A-017C-4F09-A921-587CA71F66BC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51" creationId="{3B2D9A60-B803-4187-9F7E-9D684B96B15F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52" creationId="{B7B00397-6381-4F4A-B902-6B49ACE8C3CF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53" creationId="{D3B31491-9BA6-442C-85D1-09A0756643F3}"/>
          </ac:spMkLst>
        </pc:spChg>
        <pc:spChg chg="add mod">
          <ac:chgData name="濵田　大治" userId="3dc346c6-a235-4d96-b756-7f3e038a9511" providerId="ADAL" clId="{9869E7B1-4B06-4F8D-807C-185B5646F956}" dt="2021-11-15T06:45:27.404" v="3269" actId="1076"/>
          <ac:spMkLst>
            <pc:docMk/>
            <pc:sldMk cId="2859862691" sldId="259"/>
            <ac:spMk id="54" creationId="{B76334AE-2C16-4AC7-8E19-01D7F47943F0}"/>
          </ac:spMkLst>
        </pc:spChg>
        <pc:spChg chg="add mod">
          <ac:chgData name="濵田　大治" userId="3dc346c6-a235-4d96-b756-7f3e038a9511" providerId="ADAL" clId="{9869E7B1-4B06-4F8D-807C-185B5646F956}" dt="2021-11-15T06:48:27.435" v="3620" actId="1076"/>
          <ac:spMkLst>
            <pc:docMk/>
            <pc:sldMk cId="2859862691" sldId="259"/>
            <ac:spMk id="60" creationId="{A652BA57-0064-4B34-BEE0-048C9EE00ABE}"/>
          </ac:spMkLst>
        </pc:spChg>
        <pc:spChg chg="add mod">
          <ac:chgData name="濵田　大治" userId="3dc346c6-a235-4d96-b756-7f3e038a9511" providerId="ADAL" clId="{9869E7B1-4B06-4F8D-807C-185B5646F956}" dt="2021-11-15T06:49:25.670" v="3660" actId="1076"/>
          <ac:spMkLst>
            <pc:docMk/>
            <pc:sldMk cId="2859862691" sldId="259"/>
            <ac:spMk id="62" creationId="{31F074CD-A7FB-45EF-9BE5-73F9EAE34761}"/>
          </ac:spMkLst>
        </pc:spChg>
        <pc:spChg chg="add mod">
          <ac:chgData name="濵田　大治" userId="3dc346c6-a235-4d96-b756-7f3e038a9511" providerId="ADAL" clId="{9869E7B1-4B06-4F8D-807C-185B5646F956}" dt="2021-11-15T07:33:44.034" v="3690" actId="1076"/>
          <ac:spMkLst>
            <pc:docMk/>
            <pc:sldMk cId="2859862691" sldId="259"/>
            <ac:spMk id="65" creationId="{B388AA90-017E-4FB9-9E40-6EB4DBC502F1}"/>
          </ac:spMkLst>
        </pc:spChg>
        <pc:grpChg chg="add mod">
          <ac:chgData name="濵田　大治" userId="3dc346c6-a235-4d96-b756-7f3e038a9511" providerId="ADAL" clId="{9869E7B1-4B06-4F8D-807C-185B5646F956}" dt="2021-11-15T06:45:27.404" v="3269" actId="1076"/>
          <ac:grpSpMkLst>
            <pc:docMk/>
            <pc:sldMk cId="2859862691" sldId="259"/>
            <ac:grpSpMk id="29" creationId="{9D15EDD9-051A-4882-A5AA-D1095C4F2694}"/>
          </ac:grpSpMkLst>
        </pc:grpChg>
        <pc:picChg chg="add del mod modCrop">
          <ac:chgData name="濵田　大治" userId="3dc346c6-a235-4d96-b756-7f3e038a9511" providerId="ADAL" clId="{9869E7B1-4B06-4F8D-807C-185B5646F956}" dt="2021-11-15T06:36:46.857" v="3113" actId="478"/>
          <ac:picMkLst>
            <pc:docMk/>
            <pc:sldMk cId="2859862691" sldId="259"/>
            <ac:picMk id="46" creationId="{87939C99-3795-483E-975C-B6177E19C790}"/>
          </ac:picMkLst>
        </pc:picChg>
        <pc:picChg chg="add del mod modCrop">
          <ac:chgData name="濵田　大治" userId="3dc346c6-a235-4d96-b756-7f3e038a9511" providerId="ADAL" clId="{9869E7B1-4B06-4F8D-807C-185B5646F956}" dt="2021-11-15T06:36:52.402" v="3115" actId="478"/>
          <ac:picMkLst>
            <pc:docMk/>
            <pc:sldMk cId="2859862691" sldId="259"/>
            <ac:picMk id="48" creationId="{B5ABD639-B5A6-44F2-B251-454AEA94634E}"/>
          </ac:picMkLst>
        </pc:picChg>
        <pc:picChg chg="add mod">
          <ac:chgData name="濵田　大治" userId="3dc346c6-a235-4d96-b756-7f3e038a9511" providerId="ADAL" clId="{9869E7B1-4B06-4F8D-807C-185B5646F956}" dt="2021-11-15T06:45:27.404" v="3269" actId="1076"/>
          <ac:picMkLst>
            <pc:docMk/>
            <pc:sldMk cId="2859862691" sldId="259"/>
            <ac:picMk id="49" creationId="{28574176-E2E6-4D5F-8E73-57FB24DC6C7D}"/>
          </ac:picMkLst>
        </pc:picChg>
        <pc:picChg chg="add mod">
          <ac:chgData name="濵田　大治" userId="3dc346c6-a235-4d96-b756-7f3e038a9511" providerId="ADAL" clId="{9869E7B1-4B06-4F8D-807C-185B5646F956}" dt="2021-11-15T06:45:27.404" v="3269" actId="1076"/>
          <ac:picMkLst>
            <pc:docMk/>
            <pc:sldMk cId="2859862691" sldId="259"/>
            <ac:picMk id="50" creationId="{3BF2C199-51BC-4956-8212-78307EA1360F}"/>
          </ac:picMkLst>
        </pc:picChg>
        <pc:picChg chg="add del mod modCrop">
          <ac:chgData name="濵田　大治" userId="3dc346c6-a235-4d96-b756-7f3e038a9511" providerId="ADAL" clId="{9869E7B1-4B06-4F8D-807C-185B5646F956}" dt="2021-11-15T06:46:56.291" v="3587" actId="478"/>
          <ac:picMkLst>
            <pc:docMk/>
            <pc:sldMk cId="2859862691" sldId="259"/>
            <ac:picMk id="56" creationId="{62FE1F58-BF8C-4E60-AB07-0648FC4C760F}"/>
          </ac:picMkLst>
        </pc:picChg>
        <pc:picChg chg="add mod">
          <ac:chgData name="濵田　大治" userId="3dc346c6-a235-4d96-b756-7f3e038a9511" providerId="ADAL" clId="{9869E7B1-4B06-4F8D-807C-185B5646F956}" dt="2021-11-15T06:47:12.293" v="3593" actId="1076"/>
          <ac:picMkLst>
            <pc:docMk/>
            <pc:sldMk cId="2859862691" sldId="259"/>
            <ac:picMk id="57" creationId="{57511DDA-8EBF-4845-A103-9599FAAAAE26}"/>
          </ac:picMkLst>
        </pc:picChg>
        <pc:cxnChg chg="add del mod">
          <ac:chgData name="濵田　大治" userId="3dc346c6-a235-4d96-b756-7f3e038a9511" providerId="ADAL" clId="{9869E7B1-4B06-4F8D-807C-185B5646F956}" dt="2021-11-15T06:15:49.204" v="2739" actId="478"/>
          <ac:cxnSpMkLst>
            <pc:docMk/>
            <pc:sldMk cId="2859862691" sldId="259"/>
            <ac:cxnSpMk id="3" creationId="{981A22BA-5020-469F-9FB8-6782244441D9}"/>
          </ac:cxnSpMkLst>
        </pc:cxnChg>
        <pc:cxnChg chg="add mod">
          <ac:chgData name="濵田　大治" userId="3dc346c6-a235-4d96-b756-7f3e038a9511" providerId="ADAL" clId="{9869E7B1-4B06-4F8D-807C-185B5646F956}" dt="2021-11-15T06:47:51.246" v="3602" actId="1037"/>
          <ac:cxnSpMkLst>
            <pc:docMk/>
            <pc:sldMk cId="2859862691" sldId="259"/>
            <ac:cxnSpMk id="59" creationId="{A2365406-7415-4B5E-BBA5-95132F33905C}"/>
          </ac:cxnSpMkLst>
        </pc:cxnChg>
        <pc:cxnChg chg="add mod">
          <ac:chgData name="濵田　大治" userId="3dc346c6-a235-4d96-b756-7f3e038a9511" providerId="ADAL" clId="{9869E7B1-4B06-4F8D-807C-185B5646F956}" dt="2021-11-15T06:48:59.588" v="3642" actId="1582"/>
          <ac:cxnSpMkLst>
            <pc:docMk/>
            <pc:sldMk cId="2859862691" sldId="259"/>
            <ac:cxnSpMk id="61" creationId="{03BF6A07-4E07-4151-A228-8AB48AC3BC6B}"/>
          </ac:cxnSpMkLst>
        </pc:cxnChg>
        <pc:cxnChg chg="add mod">
          <ac:chgData name="濵田　大治" userId="3dc346c6-a235-4d96-b756-7f3e038a9511" providerId="ADAL" clId="{9869E7B1-4B06-4F8D-807C-185B5646F956}" dt="2021-11-15T07:33:18.212" v="3676" actId="1037"/>
          <ac:cxnSpMkLst>
            <pc:docMk/>
            <pc:sldMk cId="2859862691" sldId="259"/>
            <ac:cxnSpMk id="64" creationId="{9047F43A-07EB-45EB-9FB0-C95201FBCE13}"/>
          </ac:cxnSpMkLst>
        </pc:cxnChg>
      </pc:sldChg>
      <pc:sldChg chg="new">
        <pc:chgData name="濵田　大治" userId="3dc346c6-a235-4d96-b756-7f3e038a9511" providerId="ADAL" clId="{9869E7B1-4B06-4F8D-807C-185B5646F956}" dt="2021-12-21T09:35:02.848" v="3691" actId="680"/>
        <pc:sldMkLst>
          <pc:docMk/>
          <pc:sldMk cId="4236205881" sldId="260"/>
        </pc:sldMkLst>
      </pc:sldChg>
      <pc:sldChg chg="addSp delSp modSp new mod">
        <pc:chgData name="濵田　大治" userId="3dc346c6-a235-4d96-b756-7f3e038a9511" providerId="ADAL" clId="{9869E7B1-4B06-4F8D-807C-185B5646F956}" dt="2021-12-21T09:42:37.083" v="3815" actId="1076"/>
        <pc:sldMkLst>
          <pc:docMk/>
          <pc:sldMk cId="1808267507" sldId="261"/>
        </pc:sldMkLst>
        <pc:spChg chg="add mod">
          <ac:chgData name="濵田　大治" userId="3dc346c6-a235-4d96-b756-7f3e038a9511" providerId="ADAL" clId="{9869E7B1-4B06-4F8D-807C-185B5646F956}" dt="2021-12-21T09:42:37.083" v="3815" actId="1076"/>
          <ac:spMkLst>
            <pc:docMk/>
            <pc:sldMk cId="1808267507" sldId="261"/>
            <ac:spMk id="8" creationId="{8138AE42-47C9-4227-9972-CCAD4CEE84FF}"/>
          </ac:spMkLst>
        </pc:spChg>
        <pc:spChg chg="add mod">
          <ac:chgData name="濵田　大治" userId="3dc346c6-a235-4d96-b756-7f3e038a9511" providerId="ADAL" clId="{9869E7B1-4B06-4F8D-807C-185B5646F956}" dt="2021-12-21T09:42:37.083" v="3815" actId="1076"/>
          <ac:spMkLst>
            <pc:docMk/>
            <pc:sldMk cId="1808267507" sldId="261"/>
            <ac:spMk id="9" creationId="{567F48C3-CB57-4ED7-85CD-43AD0FCF001E}"/>
          </ac:spMkLst>
        </pc:spChg>
        <pc:picChg chg="add del mod modCrop">
          <ac:chgData name="濵田　大治" userId="3dc346c6-a235-4d96-b756-7f3e038a9511" providerId="ADAL" clId="{9869E7B1-4B06-4F8D-807C-185B5646F956}" dt="2021-12-21T09:41:42.991" v="3799" actId="478"/>
          <ac:picMkLst>
            <pc:docMk/>
            <pc:sldMk cId="1808267507" sldId="261"/>
            <ac:picMk id="3" creationId="{D42803DD-CBA9-4E68-B6B5-B9240BE36EF6}"/>
          </ac:picMkLst>
        </pc:picChg>
        <pc:picChg chg="add del mod modCrop">
          <ac:chgData name="濵田　大治" userId="3dc346c6-a235-4d96-b756-7f3e038a9511" providerId="ADAL" clId="{9869E7B1-4B06-4F8D-807C-185B5646F956}" dt="2021-12-21T09:40:46.161" v="3720" actId="478"/>
          <ac:picMkLst>
            <pc:docMk/>
            <pc:sldMk cId="1808267507" sldId="261"/>
            <ac:picMk id="5" creationId="{579E21CD-7A2A-4089-98A2-C73CDD962ACB}"/>
          </ac:picMkLst>
        </pc:picChg>
        <pc:picChg chg="add mod">
          <ac:chgData name="濵田　大治" userId="3dc346c6-a235-4d96-b756-7f3e038a9511" providerId="ADAL" clId="{9869E7B1-4B06-4F8D-807C-185B5646F956}" dt="2021-12-21T09:42:37.083" v="3815" actId="1076"/>
          <ac:picMkLst>
            <pc:docMk/>
            <pc:sldMk cId="1808267507" sldId="261"/>
            <ac:picMk id="6" creationId="{C0F569F2-D9CB-4625-8639-88B04EB17B56}"/>
          </ac:picMkLst>
        </pc:picChg>
        <pc:picChg chg="add mod">
          <ac:chgData name="濵田　大治" userId="3dc346c6-a235-4d96-b756-7f3e038a9511" providerId="ADAL" clId="{9869E7B1-4B06-4F8D-807C-185B5646F956}" dt="2021-12-21T09:42:37.083" v="3815" actId="1076"/>
          <ac:picMkLst>
            <pc:docMk/>
            <pc:sldMk cId="1808267507" sldId="261"/>
            <ac:picMk id="7" creationId="{A1666A6E-D6C6-4A06-B9CC-5D3E7EDE8853}"/>
          </ac:picMkLst>
        </pc:picChg>
      </pc:sldChg>
      <pc:sldChg chg="addSp delSp modSp new mod">
        <pc:chgData name="濵田　大治" userId="3dc346c6-a235-4d96-b756-7f3e038a9511" providerId="ADAL" clId="{9869E7B1-4B06-4F8D-807C-185B5646F956}" dt="2021-12-23T01:13:34.892" v="4228" actId="1076"/>
        <pc:sldMkLst>
          <pc:docMk/>
          <pc:sldMk cId="390626004" sldId="262"/>
        </pc:sldMkLst>
        <pc:spChg chg="add mod">
          <ac:chgData name="濵田　大治" userId="3dc346c6-a235-4d96-b756-7f3e038a9511" providerId="ADAL" clId="{9869E7B1-4B06-4F8D-807C-185B5646F956}" dt="2021-12-23T01:12:52.645" v="4199" actId="1076"/>
          <ac:spMkLst>
            <pc:docMk/>
            <pc:sldMk cId="390626004" sldId="262"/>
            <ac:spMk id="13" creationId="{FF1D8AAE-C547-447F-9EE5-C09D3A50021D}"/>
          </ac:spMkLst>
        </pc:spChg>
        <pc:spChg chg="add mod">
          <ac:chgData name="濵田　大治" userId="3dc346c6-a235-4d96-b756-7f3e038a9511" providerId="ADAL" clId="{9869E7B1-4B06-4F8D-807C-185B5646F956}" dt="2021-12-23T01:12:28.827" v="4196" actId="1076"/>
          <ac:spMkLst>
            <pc:docMk/>
            <pc:sldMk cId="390626004" sldId="262"/>
            <ac:spMk id="14" creationId="{608AD8CD-7C80-4886-99FE-91068C282F33}"/>
          </ac:spMkLst>
        </pc:spChg>
        <pc:spChg chg="add mod">
          <ac:chgData name="濵田　大治" userId="3dc346c6-a235-4d96-b756-7f3e038a9511" providerId="ADAL" clId="{9869E7B1-4B06-4F8D-807C-185B5646F956}" dt="2021-12-23T01:12:44.917" v="4198" actId="1076"/>
          <ac:spMkLst>
            <pc:docMk/>
            <pc:sldMk cId="390626004" sldId="262"/>
            <ac:spMk id="15" creationId="{3155C767-7619-4286-9FC1-FCE1F4A6EA21}"/>
          </ac:spMkLst>
        </pc:spChg>
        <pc:spChg chg="add del mod">
          <ac:chgData name="濵田　大治" userId="3dc346c6-a235-4d96-b756-7f3e038a9511" providerId="ADAL" clId="{9869E7B1-4B06-4F8D-807C-185B5646F956}" dt="2021-12-23T01:11:15.300" v="4174" actId="478"/>
          <ac:spMkLst>
            <pc:docMk/>
            <pc:sldMk cId="390626004" sldId="262"/>
            <ac:spMk id="16" creationId="{EEA1889E-6340-4BB7-8071-C0583913400D}"/>
          </ac:spMkLst>
        </pc:spChg>
        <pc:spChg chg="add mod">
          <ac:chgData name="濵田　大治" userId="3dc346c6-a235-4d96-b756-7f3e038a9511" providerId="ADAL" clId="{9869E7B1-4B06-4F8D-807C-185B5646F956}" dt="2021-12-23T01:12:13.393" v="4193" actId="164"/>
          <ac:spMkLst>
            <pc:docMk/>
            <pc:sldMk cId="390626004" sldId="262"/>
            <ac:spMk id="17" creationId="{042E28F6-086C-46A5-B264-4524EC7F209C}"/>
          </ac:spMkLst>
        </pc:spChg>
        <pc:spChg chg="add mod">
          <ac:chgData name="濵田　大治" userId="3dc346c6-a235-4d96-b756-7f3e038a9511" providerId="ADAL" clId="{9869E7B1-4B06-4F8D-807C-185B5646F956}" dt="2021-12-23T01:12:13.393" v="4193" actId="164"/>
          <ac:spMkLst>
            <pc:docMk/>
            <pc:sldMk cId="390626004" sldId="262"/>
            <ac:spMk id="18" creationId="{CF5D8629-73C9-45D4-9B5B-5DB74C197CCE}"/>
          </ac:spMkLst>
        </pc:spChg>
        <pc:spChg chg="add mod">
          <ac:chgData name="濵田　大治" userId="3dc346c6-a235-4d96-b756-7f3e038a9511" providerId="ADAL" clId="{9869E7B1-4B06-4F8D-807C-185B5646F956}" dt="2021-12-23T01:13:31.064" v="4227" actId="164"/>
          <ac:spMkLst>
            <pc:docMk/>
            <pc:sldMk cId="390626004" sldId="262"/>
            <ac:spMk id="20" creationId="{7513E4BA-F445-4796-8E8B-407A001B1153}"/>
          </ac:spMkLst>
        </pc:spChg>
        <pc:grpChg chg="add mod">
          <ac:chgData name="濵田　大治" userId="3dc346c6-a235-4d96-b756-7f3e038a9511" providerId="ADAL" clId="{9869E7B1-4B06-4F8D-807C-185B5646F956}" dt="2021-12-23T01:13:31.064" v="4227" actId="164"/>
          <ac:grpSpMkLst>
            <pc:docMk/>
            <pc:sldMk cId="390626004" sldId="262"/>
            <ac:grpSpMk id="19" creationId="{D6B19E40-4C73-41CA-96F6-929B243EA8F2}"/>
          </ac:grpSpMkLst>
        </pc:grpChg>
        <pc:grpChg chg="add mod">
          <ac:chgData name="濵田　大治" userId="3dc346c6-a235-4d96-b756-7f3e038a9511" providerId="ADAL" clId="{9869E7B1-4B06-4F8D-807C-185B5646F956}" dt="2021-12-23T01:13:34.892" v="4228" actId="1076"/>
          <ac:grpSpMkLst>
            <pc:docMk/>
            <pc:sldMk cId="390626004" sldId="262"/>
            <ac:grpSpMk id="21" creationId="{CADDD060-DE40-4174-A9DA-8EECC56D5BDB}"/>
          </ac:grpSpMkLst>
        </pc:grpChg>
        <pc:picChg chg="add del mod modCrop">
          <ac:chgData name="濵田　大治" userId="3dc346c6-a235-4d96-b756-7f3e038a9511" providerId="ADAL" clId="{9869E7B1-4B06-4F8D-807C-185B5646F956}" dt="2021-12-23T01:00:31.911" v="4050" actId="478"/>
          <ac:picMkLst>
            <pc:docMk/>
            <pc:sldMk cId="390626004" sldId="262"/>
            <ac:picMk id="3" creationId="{EF8ACCFB-9282-47B6-BA35-0998208C9685}"/>
          </ac:picMkLst>
        </pc:picChg>
        <pc:picChg chg="add del mod modCrop">
          <ac:chgData name="濵田　大治" userId="3dc346c6-a235-4d96-b756-7f3e038a9511" providerId="ADAL" clId="{9869E7B1-4B06-4F8D-807C-185B5646F956}" dt="2021-12-23T01:00:15.922" v="4047" actId="478"/>
          <ac:picMkLst>
            <pc:docMk/>
            <pc:sldMk cId="390626004" sldId="262"/>
            <ac:picMk id="5" creationId="{B1F19423-38F1-4699-9FE5-51EF31BB1587}"/>
          </ac:picMkLst>
        </pc:picChg>
        <pc:picChg chg="add del mod modCrop">
          <ac:chgData name="濵田　大治" userId="3dc346c6-a235-4d96-b756-7f3e038a9511" providerId="ADAL" clId="{9869E7B1-4B06-4F8D-807C-185B5646F956}" dt="2021-12-23T00:53:55.070" v="3986" actId="478"/>
          <ac:picMkLst>
            <pc:docMk/>
            <pc:sldMk cId="390626004" sldId="262"/>
            <ac:picMk id="7" creationId="{1ED96CCB-F3DC-4845-9CE0-7F144FF5D725}"/>
          </ac:picMkLst>
        </pc:picChg>
        <pc:picChg chg="add del mod modCrop">
          <ac:chgData name="濵田　大治" userId="3dc346c6-a235-4d96-b756-7f3e038a9511" providerId="ADAL" clId="{9869E7B1-4B06-4F8D-807C-185B5646F956}" dt="2021-12-23T00:59:56.462" v="4043" actId="478"/>
          <ac:picMkLst>
            <pc:docMk/>
            <pc:sldMk cId="390626004" sldId="262"/>
            <ac:picMk id="9" creationId="{75DBCD43-E758-455B-BB66-396F30AFA197}"/>
          </ac:picMkLst>
        </pc:picChg>
        <pc:picChg chg="add mod">
          <ac:chgData name="濵田　大治" userId="3dc346c6-a235-4d96-b756-7f3e038a9511" providerId="ADAL" clId="{9869E7B1-4B06-4F8D-807C-185B5646F956}" dt="2021-12-23T01:12:44.917" v="4198" actId="1076"/>
          <ac:picMkLst>
            <pc:docMk/>
            <pc:sldMk cId="390626004" sldId="262"/>
            <ac:picMk id="10" creationId="{F882F491-72F6-43DC-A6BD-FD04D8399C72}"/>
          </ac:picMkLst>
        </pc:picChg>
        <pc:picChg chg="add mod">
          <ac:chgData name="濵田　大治" userId="3dc346c6-a235-4d96-b756-7f3e038a9511" providerId="ADAL" clId="{9869E7B1-4B06-4F8D-807C-185B5646F956}" dt="2021-12-23T01:12:28.827" v="4196" actId="1076"/>
          <ac:picMkLst>
            <pc:docMk/>
            <pc:sldMk cId="390626004" sldId="262"/>
            <ac:picMk id="11" creationId="{69D2E9B9-921E-40EE-A7A8-BD08D79C7233}"/>
          </ac:picMkLst>
        </pc:picChg>
        <pc:picChg chg="add mod">
          <ac:chgData name="濵田　大治" userId="3dc346c6-a235-4d96-b756-7f3e038a9511" providerId="ADAL" clId="{9869E7B1-4B06-4F8D-807C-185B5646F956}" dt="2021-12-23T01:12:52.645" v="4199" actId="1076"/>
          <ac:picMkLst>
            <pc:docMk/>
            <pc:sldMk cId="390626004" sldId="262"/>
            <ac:picMk id="12" creationId="{E57B0AC6-1B4D-45C3-905A-7A4AB5CED91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522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8888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3399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2080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4956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1603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1029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378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2046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1486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5145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F69AC8-A960-40E3-A8D4-66F2C40CE779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BB308C-0D0B-4A5D-A31B-0E7DFC7687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6320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C79DB1C-DF12-E647-C821-69555A50667A}"/>
              </a:ext>
            </a:extLst>
          </p:cNvPr>
          <p:cNvSpPr txBox="1"/>
          <p:nvPr/>
        </p:nvSpPr>
        <p:spPr>
          <a:xfrm>
            <a:off x="1501646" y="4408722"/>
            <a:ext cx="7185153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thological findings of plexiform </a:t>
            </a:r>
            <a:r>
              <a:rPr lang="en-US" altLang="ja-JP" sz="1400" b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bromyxoma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) </a:t>
            </a:r>
            <a:r>
              <a:rPr lang="en-US" altLang="ja-JP" sz="1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se of esophageal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lexiform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bromyxoma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atoxylin-eosin staining, 100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×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</a:t>
            </a:r>
          </a:p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)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umor cell nuclei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re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ositive for GLI1 (100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×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. 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B93677ED-B6D2-5E42-705C-68863EC5F3DB}"/>
              </a:ext>
            </a:extLst>
          </p:cNvPr>
          <p:cNvGrpSpPr/>
          <p:nvPr/>
        </p:nvGrpSpPr>
        <p:grpSpPr>
          <a:xfrm>
            <a:off x="1501646" y="1729653"/>
            <a:ext cx="3425952" cy="2538316"/>
            <a:chOff x="1418369" y="307884"/>
            <a:chExt cx="3425952" cy="2538316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66C4264C-E860-28BA-7D23-B7D2BA02E2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18369" y="307884"/>
              <a:ext cx="3425952" cy="2538316"/>
            </a:xfrm>
            <a:prstGeom prst="rect">
              <a:avLst/>
            </a:prstGeom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DE3CA26C-97E5-5F82-B427-4F688EC2DFD4}"/>
                </a:ext>
              </a:extLst>
            </p:cNvPr>
            <p:cNvSpPr txBox="1"/>
            <p:nvPr/>
          </p:nvSpPr>
          <p:spPr>
            <a:xfrm>
              <a:off x="4402906" y="2435192"/>
              <a:ext cx="44141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000" b="1" dirty="0">
                  <a:latin typeface="Calibri" panose="020F0502020204030204" pitchFamily="34" charset="0"/>
                  <a:cs typeface="Calibri" panose="020F0502020204030204" pitchFamily="34" charset="0"/>
                </a:rPr>
                <a:t>A</a:t>
              </a:r>
              <a:endParaRPr kumimoji="1" lang="ja-JP" altLang="en-US" sz="20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9B548C8A-1153-F6FE-0882-23A0987B9362}"/>
              </a:ext>
            </a:extLst>
          </p:cNvPr>
          <p:cNvGrpSpPr/>
          <p:nvPr/>
        </p:nvGrpSpPr>
        <p:grpSpPr>
          <a:xfrm>
            <a:off x="4978399" y="1729653"/>
            <a:ext cx="3425952" cy="2538316"/>
            <a:chOff x="1418369" y="2872653"/>
            <a:chExt cx="3425952" cy="2538316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EF86190F-CE27-4BE4-2FF0-4141D4494A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18369" y="2872653"/>
              <a:ext cx="3425952" cy="2538316"/>
            </a:xfrm>
            <a:prstGeom prst="rect">
              <a:avLst/>
            </a:prstGeom>
          </p:spPr>
        </p:pic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68336847-C564-71F2-7D3D-A6101638167D}"/>
                </a:ext>
              </a:extLst>
            </p:cNvPr>
            <p:cNvSpPr txBox="1"/>
            <p:nvPr/>
          </p:nvSpPr>
          <p:spPr>
            <a:xfrm>
              <a:off x="4402905" y="5010859"/>
              <a:ext cx="44141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000" b="1" dirty="0">
                  <a:latin typeface="Calibri" panose="020F0502020204030204" pitchFamily="34" charset="0"/>
                  <a:cs typeface="Calibri" panose="020F0502020204030204" pitchFamily="34" charset="0"/>
                </a:rPr>
                <a:t>B</a:t>
              </a:r>
              <a:endParaRPr kumimoji="1" lang="ja-JP" altLang="en-US" sz="20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65306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3">
      <a:majorFont>
        <a:latin typeface="Arial"/>
        <a:ea typeface="游ゴシック"/>
        <a:cs typeface=""/>
      </a:majorFont>
      <a:minorFont>
        <a:latin typeface="Arial"/>
        <a:ea typeface="游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9</TotalTime>
  <Words>35</Words>
  <Application>Microsoft Office PowerPoint</Application>
  <PresentationFormat>A4 210 x 297 mm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明朝</vt:lpstr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濵田　大治</dc:creator>
  <cp:lastModifiedBy>濵田　大治</cp:lastModifiedBy>
  <cp:revision>189</cp:revision>
  <cp:lastPrinted>2022-12-11T23:06:08Z</cp:lastPrinted>
  <dcterms:created xsi:type="dcterms:W3CDTF">2021-11-11T07:42:40Z</dcterms:created>
  <dcterms:modified xsi:type="dcterms:W3CDTF">2023-01-31T03:33:04Z</dcterms:modified>
</cp:coreProperties>
</file>